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37"/>
  </p:notesMasterIdLst>
  <p:sldIdLst>
    <p:sldId id="357" r:id="rId2"/>
    <p:sldId id="259" r:id="rId3"/>
    <p:sldId id="339" r:id="rId4"/>
    <p:sldId id="371" r:id="rId5"/>
    <p:sldId id="267" r:id="rId6"/>
    <p:sldId id="341" r:id="rId7"/>
    <p:sldId id="342" r:id="rId8"/>
    <p:sldId id="344" r:id="rId9"/>
    <p:sldId id="345" r:id="rId10"/>
    <p:sldId id="346" r:id="rId11"/>
    <p:sldId id="352" r:id="rId12"/>
    <p:sldId id="310" r:id="rId13"/>
    <p:sldId id="309" r:id="rId14"/>
    <p:sldId id="370" r:id="rId15"/>
    <p:sldId id="311" r:id="rId16"/>
    <p:sldId id="353" r:id="rId17"/>
    <p:sldId id="314" r:id="rId18"/>
    <p:sldId id="355" r:id="rId19"/>
    <p:sldId id="366" r:id="rId20"/>
    <p:sldId id="365" r:id="rId21"/>
    <p:sldId id="289" r:id="rId22"/>
    <p:sldId id="358" r:id="rId23"/>
    <p:sldId id="290" r:id="rId24"/>
    <p:sldId id="361" r:id="rId25"/>
    <p:sldId id="372" r:id="rId26"/>
    <p:sldId id="302" r:id="rId27"/>
    <p:sldId id="303" r:id="rId28"/>
    <p:sldId id="359" r:id="rId29"/>
    <p:sldId id="360" r:id="rId30"/>
    <p:sldId id="363" r:id="rId31"/>
    <p:sldId id="315" r:id="rId32"/>
    <p:sldId id="369" r:id="rId33"/>
    <p:sldId id="301" r:id="rId34"/>
    <p:sldId id="270" r:id="rId35"/>
    <p:sldId id="337" r:id="rId36"/>
  </p:sldIdLst>
  <p:sldSz cx="12192000" cy="6858000"/>
  <p:notesSz cx="6858000" cy="13716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F9D32E15-FB0B-FD4C-81A0-DDC852977248}">
          <p14:sldIdLst>
            <p14:sldId id="357"/>
            <p14:sldId id="259"/>
            <p14:sldId id="339"/>
            <p14:sldId id="371"/>
            <p14:sldId id="267"/>
            <p14:sldId id="341"/>
            <p14:sldId id="342"/>
            <p14:sldId id="344"/>
            <p14:sldId id="345"/>
            <p14:sldId id="346"/>
            <p14:sldId id="352"/>
            <p14:sldId id="310"/>
            <p14:sldId id="309"/>
            <p14:sldId id="370"/>
            <p14:sldId id="311"/>
            <p14:sldId id="353"/>
            <p14:sldId id="314"/>
            <p14:sldId id="355"/>
            <p14:sldId id="366"/>
            <p14:sldId id="365"/>
            <p14:sldId id="289"/>
            <p14:sldId id="358"/>
            <p14:sldId id="290"/>
            <p14:sldId id="361"/>
            <p14:sldId id="372"/>
            <p14:sldId id="302"/>
            <p14:sldId id="303"/>
            <p14:sldId id="359"/>
            <p14:sldId id="360"/>
            <p14:sldId id="363"/>
            <p14:sldId id="315"/>
            <p14:sldId id="369"/>
            <p14:sldId id="301"/>
            <p14:sldId id="270"/>
            <p14:sldId id="337"/>
          </p14:sldIdLst>
        </p14:section>
      </p14:sectionLst>
    </p:ex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AECA8"/>
    <a:srgbClr val="F6D332"/>
    <a:srgbClr val="FFD51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D0E1944-A436-4086-1FD6-BCE66B24F47F}" v="18" dt="2019-11-27T00:12:39.774"/>
    <p1510:client id="{522B3B1C-5510-FBBD-9C6C-85CC7F19DCDC}" v="68" dt="2019-11-26T02:05:15.494"/>
    <p1510:client id="{41DCF99D-C7B8-3863-D038-D034823D7A47}" v="4" dt="2020-03-03T21:21:44.404"/>
    <p1510:client id="{848FCD76-0A58-DC5B-2A0C-2E3FA89A3916}" v="128" dt="2019-11-26T20:59:56.407"/>
    <p1510:client id="{84BFF494-ECFE-3071-8484-1277BDE32BDC}" v="5" dt="2020-03-03T17:41:03.079"/>
    <p1510:client id="{9160A197-E966-4928-62D7-E88F7A4E512D}" v="527" dt="2019-11-26T02:16:18.158"/>
    <p1510:client id="{BCED6139-ABA6-809E-F18A-468583E7D54A}" v="4" dt="2020-03-03T21:20:09.487"/>
    <p1510:client id="{FBFC6861-664A-9E41-9E3D-2C938E7FF7FB}" v="588" dt="2019-11-26T21:51:32.91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5850" autoAdjust="0"/>
  </p:normalViewPr>
  <p:slideViewPr>
    <p:cSldViewPr snapToGrid="0">
      <p:cViewPr varScale="1">
        <p:scale>
          <a:sx n="77" d="100"/>
          <a:sy n="77" d="100"/>
        </p:scale>
        <p:origin x="474" y="60"/>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ockfeld, Jennifer Prof." userId="S::jrockfeld@quinnipiac.edu::17f6105e-8432-4431-969a-4424c976ccf7" providerId="AD" clId="Web-{9160A197-E966-4928-62D7-E88F7A4E512D}"/>
    <pc:docChg chg="delSld modSld modSection">
      <pc:chgData name="Rockfeld, Jennifer Prof." userId="S::jrockfeld@quinnipiac.edu::17f6105e-8432-4431-969a-4424c976ccf7" providerId="AD" clId="Web-{9160A197-E966-4928-62D7-E88F7A4E512D}" dt="2019-11-26T02:16:18.158" v="519"/>
      <pc:docMkLst>
        <pc:docMk/>
      </pc:docMkLst>
      <pc:sldChg chg="modNotes">
        <pc:chgData name="Rockfeld, Jennifer Prof." userId="S::jrockfeld@quinnipiac.edu::17f6105e-8432-4431-969a-4424c976ccf7" providerId="AD" clId="Web-{9160A197-E966-4928-62D7-E88F7A4E512D}" dt="2019-11-26T02:10:57.029" v="489"/>
        <pc:sldMkLst>
          <pc:docMk/>
          <pc:sldMk cId="117955124" sldId="302"/>
        </pc:sldMkLst>
      </pc:sldChg>
      <pc:sldChg chg="modNotes">
        <pc:chgData name="Rockfeld, Jennifer Prof." userId="S::jrockfeld@quinnipiac.edu::17f6105e-8432-4431-969a-4424c976ccf7" providerId="AD" clId="Web-{9160A197-E966-4928-62D7-E88F7A4E512D}" dt="2019-11-26T02:11:00.091" v="491"/>
        <pc:sldMkLst>
          <pc:docMk/>
          <pc:sldMk cId="2974721392" sldId="303"/>
        </pc:sldMkLst>
      </pc:sldChg>
      <pc:sldChg chg="modSp modNotes">
        <pc:chgData name="Rockfeld, Jennifer Prof." userId="S::jrockfeld@quinnipiac.edu::17f6105e-8432-4431-969a-4424c976ccf7" providerId="AD" clId="Web-{9160A197-E966-4928-62D7-E88F7A4E512D}" dt="2019-11-26T02:11:52.420" v="518" actId="1076"/>
        <pc:sldMkLst>
          <pc:docMk/>
          <pc:sldMk cId="1214623804" sldId="315"/>
        </pc:sldMkLst>
        <pc:spChg chg="mod">
          <ac:chgData name="Rockfeld, Jennifer Prof." userId="S::jrockfeld@quinnipiac.edu::17f6105e-8432-4431-969a-4424c976ccf7" providerId="AD" clId="Web-{9160A197-E966-4928-62D7-E88F7A4E512D}" dt="2019-11-26T02:11:52.420" v="518" actId="1076"/>
          <ac:spMkLst>
            <pc:docMk/>
            <pc:sldMk cId="1214623804" sldId="315"/>
            <ac:spMk id="7" creationId="{63DD1EA6-777D-4553-8F90-B65D976E819D}"/>
          </ac:spMkLst>
        </pc:spChg>
      </pc:sldChg>
      <pc:sldChg chg="del">
        <pc:chgData name="Rockfeld, Jennifer Prof." userId="S::jrockfeld@quinnipiac.edu::17f6105e-8432-4431-969a-4424c976ccf7" providerId="AD" clId="Web-{9160A197-E966-4928-62D7-E88F7A4E512D}" dt="2019-11-26T02:16:18.158" v="519"/>
        <pc:sldMkLst>
          <pc:docMk/>
          <pc:sldMk cId="1034359062" sldId="362"/>
        </pc:sldMkLst>
      </pc:sldChg>
      <pc:sldChg chg="addSp delSp modSp modNotes">
        <pc:chgData name="Rockfeld, Jennifer Prof." userId="S::jrockfeld@quinnipiac.edu::17f6105e-8432-4431-969a-4424c976ccf7" providerId="AD" clId="Web-{9160A197-E966-4928-62D7-E88F7A4E512D}" dt="2019-11-26T02:10:29.310" v="487"/>
        <pc:sldMkLst>
          <pc:docMk/>
          <pc:sldMk cId="1463992610" sldId="372"/>
        </pc:sldMkLst>
        <pc:spChg chg="add mod">
          <ac:chgData name="Rockfeld, Jennifer Prof." userId="S::jrockfeld@quinnipiac.edu::17f6105e-8432-4431-969a-4424c976ccf7" providerId="AD" clId="Web-{9160A197-E966-4928-62D7-E88F7A4E512D}" dt="2019-11-26T02:08:10.792" v="354" actId="20577"/>
          <ac:spMkLst>
            <pc:docMk/>
            <pc:sldMk cId="1463992610" sldId="372"/>
            <ac:spMk id="5" creationId="{CC84385C-BD8B-444E-9164-8406A73AB2CB}"/>
          </ac:spMkLst>
        </pc:spChg>
        <pc:graphicFrameChg chg="del mod modGraphic">
          <ac:chgData name="Rockfeld, Jennifer Prof." userId="S::jrockfeld@quinnipiac.edu::17f6105e-8432-4431-969a-4424c976ccf7" providerId="AD" clId="Web-{9160A197-E966-4928-62D7-E88F7A4E512D}" dt="2019-11-26T02:05:41.790" v="10"/>
          <ac:graphicFrameMkLst>
            <pc:docMk/>
            <pc:sldMk cId="1463992610" sldId="372"/>
            <ac:graphicFrameMk id="4" creationId="{7AAB06A5-44CC-469D-9231-27E9FCB6C382}"/>
          </ac:graphicFrameMkLst>
        </pc:graphicFrameChg>
      </pc:sldChg>
    </pc:docChg>
  </pc:docChgLst>
  <pc:docChgLst>
    <pc:chgData name="Rockfeld, Jennifer Prof." userId="S::jrockfeld@quinnipiac.edu::17f6105e-8432-4431-969a-4424c976ccf7" providerId="AD" clId="Web-{3BE59770-0030-BE7C-655B-5AD2F6887CC5}"/>
  </pc:docChgLst>
  <pc:docChgLst>
    <pc:chgData name="Rockfeld, Jennifer Prof." userId="10033FFF99E828B0@LIVE.COM" providerId="AD" clId="Web-{3B263834-86CA-408F-91CE-EE3A53F31431}"/>
  </pc:docChgLst>
  <pc:docChgLst>
    <pc:chgData name="Zucconi, Rebecca Prof." userId="765a1284-d6e0-43b3-8745-3b830b318731" providerId="ADAL" clId="{F102CE64-181A-BE41-B246-983AA881CEE9}"/>
  </pc:docChgLst>
  <pc:docChgLst>
    <pc:chgData name="Zucconi, Rebecca Prof." userId="10033FFF99E82C13@LIVE.COM" providerId="AD" clId="Web-{106D148E-34DA-440F-8340-02A76830FA97}"/>
  </pc:docChgLst>
  <pc:docChgLst>
    <pc:chgData name="Zucconi, Rebecca Prof." userId="S::rzucconi@quinnipiac.edu::765a1284-d6e0-43b3-8745-3b830b318731" providerId="AD" clId="Web-{BCED6139-ABA6-809E-F18A-468583E7D54A}"/>
    <pc:docChg chg="modSld">
      <pc:chgData name="Zucconi, Rebecca Prof." userId="S::rzucconi@quinnipiac.edu::765a1284-d6e0-43b3-8745-3b830b318731" providerId="AD" clId="Web-{BCED6139-ABA6-809E-F18A-468583E7D54A}" dt="2020-03-03T21:20:09.487" v="133" actId="1076"/>
      <pc:docMkLst>
        <pc:docMk/>
      </pc:docMkLst>
      <pc:sldChg chg="addSp modSp">
        <pc:chgData name="Zucconi, Rebecca Prof." userId="S::rzucconi@quinnipiac.edu::765a1284-d6e0-43b3-8745-3b830b318731" providerId="AD" clId="Web-{BCED6139-ABA6-809E-F18A-468583E7D54A}" dt="2020-03-03T21:20:09.487" v="133" actId="1076"/>
        <pc:sldMkLst>
          <pc:docMk/>
          <pc:sldMk cId="1214623804" sldId="315"/>
        </pc:sldMkLst>
        <pc:picChg chg="add mod">
          <ac:chgData name="Zucconi, Rebecca Prof." userId="S::rzucconi@quinnipiac.edu::765a1284-d6e0-43b3-8745-3b830b318731" providerId="AD" clId="Web-{BCED6139-ABA6-809E-F18A-468583E7D54A}" dt="2020-03-03T21:20:09.487" v="133" actId="1076"/>
          <ac:picMkLst>
            <pc:docMk/>
            <pc:sldMk cId="1214623804" sldId="315"/>
            <ac:picMk id="2" creationId="{529BB9A6-F595-4BBE-A752-2C3F38DDA23E}"/>
          </ac:picMkLst>
        </pc:picChg>
      </pc:sldChg>
      <pc:sldChg chg="modNotes">
        <pc:chgData name="Zucconi, Rebecca Prof." userId="S::rzucconi@quinnipiac.edu::765a1284-d6e0-43b3-8745-3b830b318731" providerId="AD" clId="Web-{BCED6139-ABA6-809E-F18A-468583E7D54A}" dt="2020-03-03T21:04:54.632" v="130"/>
        <pc:sldMkLst>
          <pc:docMk/>
          <pc:sldMk cId="76843926" sldId="360"/>
        </pc:sldMkLst>
      </pc:sldChg>
    </pc:docChg>
  </pc:docChgLst>
  <pc:docChgLst>
    <pc:chgData name="Rockfeld, Jennifer Prof." userId="S::jrockfeld@quinnipiac.edu::17f6105e-8432-4431-969a-4424c976ccf7" providerId="AD" clId="Web-{2D0E1944-A436-4086-1FD6-BCE66B24F47F}"/>
    <pc:docChg chg="modSld sldOrd">
      <pc:chgData name="Rockfeld, Jennifer Prof." userId="S::jrockfeld@quinnipiac.edu::17f6105e-8432-4431-969a-4424c976ccf7" providerId="AD" clId="Web-{2D0E1944-A436-4086-1FD6-BCE66B24F47F}" dt="2019-11-27T00:12:39.774" v="17"/>
      <pc:docMkLst>
        <pc:docMk/>
      </pc:docMkLst>
      <pc:sldChg chg="modNotes">
        <pc:chgData name="Rockfeld, Jennifer Prof." userId="S::jrockfeld@quinnipiac.edu::17f6105e-8432-4431-969a-4424c976ccf7" providerId="AD" clId="Web-{2D0E1944-A436-4086-1FD6-BCE66B24F47F}" dt="2019-11-27T00:12:39.774" v="17"/>
        <pc:sldMkLst>
          <pc:docMk/>
          <pc:sldMk cId="3664890781" sldId="270"/>
        </pc:sldMkLst>
      </pc:sldChg>
      <pc:sldChg chg="ord">
        <pc:chgData name="Rockfeld, Jennifer Prof." userId="S::jrockfeld@quinnipiac.edu::17f6105e-8432-4431-969a-4424c976ccf7" providerId="AD" clId="Web-{2D0E1944-A436-4086-1FD6-BCE66B24F47F}" dt="2019-11-27T00:05:36.179" v="1"/>
        <pc:sldMkLst>
          <pc:docMk/>
          <pc:sldMk cId="3737179732" sldId="371"/>
        </pc:sldMkLst>
      </pc:sldChg>
    </pc:docChg>
  </pc:docChgLst>
  <pc:docChgLst>
    <pc:chgData name="Rockfeld, Jennifer Prof." userId="S::jrockfeld@quinnipiac.edu::17f6105e-8432-4431-969a-4424c976ccf7" providerId="AD" clId="Web-{CB475C99-CC00-F7BE-B948-2A8F84F23948}"/>
  </pc:docChgLst>
  <pc:docChgLst>
    <pc:chgData name="Zucconi, Rebecca Prof." userId="765a1284-d6e0-43b3-8745-3b830b318731" providerId="ADAL" clId="{1137CCCD-7DC8-AB49-B102-F56164A8F574}"/>
  </pc:docChgLst>
  <pc:docChgLst>
    <pc:chgData name="Rockfeld, Jennifer Prof." userId="S::jrockfeld@quinnipiac.edu::17f6105e-8432-4431-969a-4424c976ccf7" providerId="AD" clId="Web-{848FCD76-0A58-DC5B-2A0C-2E3FA89A3916}"/>
    <pc:docChg chg="modSld">
      <pc:chgData name="Rockfeld, Jennifer Prof." userId="S::jrockfeld@quinnipiac.edu::17f6105e-8432-4431-969a-4424c976ccf7" providerId="AD" clId="Web-{848FCD76-0A58-DC5B-2A0C-2E3FA89A3916}" dt="2019-11-26T20:59:56.407" v="123"/>
      <pc:docMkLst>
        <pc:docMk/>
      </pc:docMkLst>
      <pc:sldChg chg="addSp delSp">
        <pc:chgData name="Rockfeld, Jennifer Prof." userId="S::jrockfeld@quinnipiac.edu::17f6105e-8432-4431-969a-4424c976ccf7" providerId="AD" clId="Web-{848FCD76-0A58-DC5B-2A0C-2E3FA89A3916}" dt="2019-11-26T20:59:56.407" v="123"/>
        <pc:sldMkLst>
          <pc:docMk/>
          <pc:sldMk cId="746357920" sldId="267"/>
        </pc:sldMkLst>
        <pc:spChg chg="del">
          <ac:chgData name="Rockfeld, Jennifer Prof." userId="S::jrockfeld@quinnipiac.edu::17f6105e-8432-4431-969a-4424c976ccf7" providerId="AD" clId="Web-{848FCD76-0A58-DC5B-2A0C-2E3FA89A3916}" dt="2019-11-26T20:59:56.407" v="123"/>
          <ac:spMkLst>
            <pc:docMk/>
            <pc:sldMk cId="746357920" sldId="267"/>
            <ac:spMk id="2" creationId="{00000000-0000-0000-0000-000000000000}"/>
          </ac:spMkLst>
        </pc:spChg>
        <pc:spChg chg="add">
          <ac:chgData name="Rockfeld, Jennifer Prof." userId="S::jrockfeld@quinnipiac.edu::17f6105e-8432-4431-969a-4424c976ccf7" providerId="AD" clId="Web-{848FCD76-0A58-DC5B-2A0C-2E3FA89A3916}" dt="2019-11-26T20:59:54.626" v="122"/>
          <ac:spMkLst>
            <pc:docMk/>
            <pc:sldMk cId="746357920" sldId="267"/>
            <ac:spMk id="3" creationId="{D7B70AED-5C58-40D6-A67E-2A09D381B525}"/>
          </ac:spMkLst>
        </pc:spChg>
      </pc:sldChg>
      <pc:sldChg chg="modSp modNotes">
        <pc:chgData name="Rockfeld, Jennifer Prof." userId="S::jrockfeld@quinnipiac.edu::17f6105e-8432-4431-969a-4424c976ccf7" providerId="AD" clId="Web-{848FCD76-0A58-DC5B-2A0C-2E3FA89A3916}" dt="2019-11-26T20:59:48.641" v="120" actId="20577"/>
        <pc:sldMkLst>
          <pc:docMk/>
          <pc:sldMk cId="1599298893" sldId="339"/>
        </pc:sldMkLst>
        <pc:spChg chg="mod">
          <ac:chgData name="Rockfeld, Jennifer Prof." userId="S::jrockfeld@quinnipiac.edu::17f6105e-8432-4431-969a-4424c976ccf7" providerId="AD" clId="Web-{848FCD76-0A58-DC5B-2A0C-2E3FA89A3916}" dt="2019-11-26T20:59:48.641" v="120" actId="20577"/>
          <ac:spMkLst>
            <pc:docMk/>
            <pc:sldMk cId="1599298893" sldId="339"/>
            <ac:spMk id="2" creationId="{E9E62D93-103E-7C4F-9BE0-BEE05DB7D845}"/>
          </ac:spMkLst>
        </pc:spChg>
      </pc:sldChg>
    </pc:docChg>
  </pc:docChgLst>
  <pc:docChgLst>
    <pc:chgData name="Rockfeld, Jennifer Prof." userId="S::jrockfeld@quinnipiac.edu::17f6105e-8432-4431-969a-4424c976ccf7" providerId="AD" clId="Web-{168CFF67-CAC4-4CA1-B611-6604E768198F}"/>
  </pc:docChgLst>
  <pc:docChgLst>
    <pc:chgData name="Zucconi, Rebecca Prof." userId="S::rzucconi@quinnipiac.edu::765a1284-d6e0-43b3-8745-3b830b318731" providerId="AD" clId="Web-{41DCF99D-C7B8-3863-D038-D034823D7A47}"/>
    <pc:docChg chg="modSld">
      <pc:chgData name="Zucconi, Rebecca Prof." userId="S::rzucconi@quinnipiac.edu::765a1284-d6e0-43b3-8745-3b830b318731" providerId="AD" clId="Web-{41DCF99D-C7B8-3863-D038-D034823D7A47}" dt="2020-03-03T21:21:44.404" v="3" actId="20577"/>
      <pc:docMkLst>
        <pc:docMk/>
      </pc:docMkLst>
      <pc:sldChg chg="delSp">
        <pc:chgData name="Zucconi, Rebecca Prof." userId="S::rzucconi@quinnipiac.edu::765a1284-d6e0-43b3-8745-3b830b318731" providerId="AD" clId="Web-{41DCF99D-C7B8-3863-D038-D034823D7A47}" dt="2020-03-03T21:21:31.248" v="0"/>
        <pc:sldMkLst>
          <pc:docMk/>
          <pc:sldMk cId="1214623804" sldId="315"/>
        </pc:sldMkLst>
        <pc:picChg chg="del">
          <ac:chgData name="Zucconi, Rebecca Prof." userId="S::rzucconi@quinnipiac.edu::765a1284-d6e0-43b3-8745-3b830b318731" providerId="AD" clId="Web-{41DCF99D-C7B8-3863-D038-D034823D7A47}" dt="2020-03-03T21:21:31.248" v="0"/>
          <ac:picMkLst>
            <pc:docMk/>
            <pc:sldMk cId="1214623804" sldId="315"/>
            <ac:picMk id="2" creationId="{529BB9A6-F595-4BBE-A752-2C3F38DDA23E}"/>
          </ac:picMkLst>
        </pc:picChg>
      </pc:sldChg>
      <pc:sldChg chg="modSp">
        <pc:chgData name="Zucconi, Rebecca Prof." userId="S::rzucconi@quinnipiac.edu::765a1284-d6e0-43b3-8745-3b830b318731" providerId="AD" clId="Web-{41DCF99D-C7B8-3863-D038-D034823D7A47}" dt="2020-03-03T21:21:42.436" v="1" actId="20577"/>
        <pc:sldMkLst>
          <pc:docMk/>
          <pc:sldMk cId="3869180342" sldId="369"/>
        </pc:sldMkLst>
        <pc:spChg chg="mod">
          <ac:chgData name="Zucconi, Rebecca Prof." userId="S::rzucconi@quinnipiac.edu::765a1284-d6e0-43b3-8745-3b830b318731" providerId="AD" clId="Web-{41DCF99D-C7B8-3863-D038-D034823D7A47}" dt="2020-03-03T21:21:42.436" v="1" actId="20577"/>
          <ac:spMkLst>
            <pc:docMk/>
            <pc:sldMk cId="3869180342" sldId="369"/>
            <ac:spMk id="4" creationId="{00000000-0000-0000-0000-000000000000}"/>
          </ac:spMkLst>
        </pc:spChg>
      </pc:sldChg>
    </pc:docChg>
  </pc:docChgLst>
  <pc:docChgLst>
    <pc:chgData name="Rockfeld, Jennifer Prof." userId="S::jrockfeld@quinnipiac.edu::17f6105e-8432-4431-969a-4424c976ccf7" providerId="AD" clId="Web-{CADDEA40-130F-C64F-5217-4646A79FE82E}"/>
    <pc:docChg chg="modSld sldOrd">
      <pc:chgData name="Rockfeld, Jennifer Prof." userId="S::jrockfeld@quinnipiac.edu::17f6105e-8432-4431-969a-4424c976ccf7" providerId="AD" clId="Web-{CADDEA40-130F-C64F-5217-4646A79FE82E}" dt="2019-09-12T13:40:12.039" v="726"/>
      <pc:docMkLst>
        <pc:docMk/>
      </pc:docMkLst>
      <pc:sldChg chg="ord">
        <pc:chgData name="Rockfeld, Jennifer Prof." userId="S::jrockfeld@quinnipiac.edu::17f6105e-8432-4431-969a-4424c976ccf7" providerId="AD" clId="Web-{CADDEA40-130F-C64F-5217-4646A79FE82E}" dt="2019-09-12T13:18:17.663" v="0"/>
        <pc:sldMkLst>
          <pc:docMk/>
          <pc:sldMk cId="1743602375" sldId="259"/>
        </pc:sldMkLst>
      </pc:sldChg>
      <pc:sldChg chg="modSp">
        <pc:chgData name="Rockfeld, Jennifer Prof." userId="S::jrockfeld@quinnipiac.edu::17f6105e-8432-4431-969a-4424c976ccf7" providerId="AD" clId="Web-{CADDEA40-130F-C64F-5217-4646A79FE82E}" dt="2019-09-12T13:22:23.320" v="66" actId="20577"/>
        <pc:sldMkLst>
          <pc:docMk/>
          <pc:sldMk cId="746357920" sldId="267"/>
        </pc:sldMkLst>
        <pc:spChg chg="mod">
          <ac:chgData name="Rockfeld, Jennifer Prof." userId="S::jrockfeld@quinnipiac.edu::17f6105e-8432-4431-969a-4424c976ccf7" providerId="AD" clId="Web-{CADDEA40-130F-C64F-5217-4646A79FE82E}" dt="2019-09-12T13:22:23.320" v="66" actId="20577"/>
          <ac:spMkLst>
            <pc:docMk/>
            <pc:sldMk cId="746357920" sldId="267"/>
            <ac:spMk id="2" creationId="{00000000-0000-0000-0000-000000000000}"/>
          </ac:spMkLst>
        </pc:spChg>
      </pc:sldChg>
      <pc:sldChg chg="modNotes">
        <pc:chgData name="Rockfeld, Jennifer Prof." userId="S::jrockfeld@quinnipiac.edu::17f6105e-8432-4431-969a-4424c976ccf7" providerId="AD" clId="Web-{CADDEA40-130F-C64F-5217-4646A79FE82E}" dt="2019-09-12T13:25:19.335" v="232"/>
        <pc:sldMkLst>
          <pc:docMk/>
          <pc:sldMk cId="23615817" sldId="309"/>
        </pc:sldMkLst>
      </pc:sldChg>
      <pc:sldChg chg="modNotes">
        <pc:chgData name="Rockfeld, Jennifer Prof." userId="S::jrockfeld@quinnipiac.edu::17f6105e-8432-4431-969a-4424c976ccf7" providerId="AD" clId="Web-{CADDEA40-130F-C64F-5217-4646A79FE82E}" dt="2019-09-12T13:24:48.664" v="192"/>
        <pc:sldMkLst>
          <pc:docMk/>
          <pc:sldMk cId="3008616477" sldId="310"/>
        </pc:sldMkLst>
      </pc:sldChg>
      <pc:sldChg chg="modNotes">
        <pc:chgData name="Rockfeld, Jennifer Prof." userId="S::jrockfeld@quinnipiac.edu::17f6105e-8432-4431-969a-4424c976ccf7" providerId="AD" clId="Web-{CADDEA40-130F-C64F-5217-4646A79FE82E}" dt="2019-09-12T13:25:35.710" v="242"/>
        <pc:sldMkLst>
          <pc:docMk/>
          <pc:sldMk cId="954280296" sldId="311"/>
        </pc:sldMkLst>
      </pc:sldChg>
      <pc:sldChg chg="modNotes">
        <pc:chgData name="Rockfeld, Jennifer Prof." userId="S::jrockfeld@quinnipiac.edu::17f6105e-8432-4431-969a-4424c976ccf7" providerId="AD" clId="Web-{CADDEA40-130F-C64F-5217-4646A79FE82E}" dt="2019-09-12T13:22:38.492" v="70"/>
        <pc:sldMkLst>
          <pc:docMk/>
          <pc:sldMk cId="1599298893" sldId="339"/>
        </pc:sldMkLst>
      </pc:sldChg>
      <pc:sldChg chg="modSp">
        <pc:chgData name="Rockfeld, Jennifer Prof." userId="S::jrockfeld@quinnipiac.edu::17f6105e-8432-4431-969a-4424c976ccf7" providerId="AD" clId="Web-{CADDEA40-130F-C64F-5217-4646A79FE82E}" dt="2019-09-12T13:22:18.024" v="63" actId="20577"/>
        <pc:sldMkLst>
          <pc:docMk/>
          <pc:sldMk cId="1012685030" sldId="341"/>
        </pc:sldMkLst>
        <pc:spChg chg="mod">
          <ac:chgData name="Rockfeld, Jennifer Prof." userId="S::jrockfeld@quinnipiac.edu::17f6105e-8432-4431-969a-4424c976ccf7" providerId="AD" clId="Web-{CADDEA40-130F-C64F-5217-4646A79FE82E}" dt="2019-09-12T13:22:18.024" v="63" actId="20577"/>
          <ac:spMkLst>
            <pc:docMk/>
            <pc:sldMk cId="1012685030" sldId="341"/>
            <ac:spMk id="5" creationId="{00000000-0000-0000-0000-000000000000}"/>
          </ac:spMkLst>
        </pc:spChg>
      </pc:sldChg>
      <pc:sldChg chg="modSp">
        <pc:chgData name="Rockfeld, Jennifer Prof." userId="S::jrockfeld@quinnipiac.edu::17f6105e-8432-4431-969a-4424c976ccf7" providerId="AD" clId="Web-{CADDEA40-130F-C64F-5217-4646A79FE82E}" dt="2019-09-12T13:22:12.945" v="60" actId="20577"/>
        <pc:sldMkLst>
          <pc:docMk/>
          <pc:sldMk cId="586387317" sldId="342"/>
        </pc:sldMkLst>
        <pc:spChg chg="mod">
          <ac:chgData name="Rockfeld, Jennifer Prof." userId="S::jrockfeld@quinnipiac.edu::17f6105e-8432-4431-969a-4424c976ccf7" providerId="AD" clId="Web-{CADDEA40-130F-C64F-5217-4646A79FE82E}" dt="2019-09-12T13:22:12.945" v="60" actId="20577"/>
          <ac:spMkLst>
            <pc:docMk/>
            <pc:sldMk cId="586387317" sldId="342"/>
            <ac:spMk id="5" creationId="{00000000-0000-0000-0000-000000000000}"/>
          </ac:spMkLst>
        </pc:spChg>
      </pc:sldChg>
      <pc:sldChg chg="modSp">
        <pc:chgData name="Rockfeld, Jennifer Prof." userId="S::jrockfeld@quinnipiac.edu::17f6105e-8432-4431-969a-4424c976ccf7" providerId="AD" clId="Web-{CADDEA40-130F-C64F-5217-4646A79FE82E}" dt="2019-09-12T13:22:06.163" v="57" actId="20577"/>
        <pc:sldMkLst>
          <pc:docMk/>
          <pc:sldMk cId="1160470871" sldId="344"/>
        </pc:sldMkLst>
        <pc:spChg chg="mod">
          <ac:chgData name="Rockfeld, Jennifer Prof." userId="S::jrockfeld@quinnipiac.edu::17f6105e-8432-4431-969a-4424c976ccf7" providerId="AD" clId="Web-{CADDEA40-130F-C64F-5217-4646A79FE82E}" dt="2019-09-12T13:22:06.163" v="57" actId="20577"/>
          <ac:spMkLst>
            <pc:docMk/>
            <pc:sldMk cId="1160470871" sldId="344"/>
            <ac:spMk id="4" creationId="{00000000-0000-0000-0000-000000000000}"/>
          </ac:spMkLst>
        </pc:spChg>
      </pc:sldChg>
      <pc:sldChg chg="modSp">
        <pc:chgData name="Rockfeld, Jennifer Prof." userId="S::jrockfeld@quinnipiac.edu::17f6105e-8432-4431-969a-4424c976ccf7" providerId="AD" clId="Web-{CADDEA40-130F-C64F-5217-4646A79FE82E}" dt="2019-09-12T13:22:01.476" v="54" actId="20577"/>
        <pc:sldMkLst>
          <pc:docMk/>
          <pc:sldMk cId="1635000195" sldId="345"/>
        </pc:sldMkLst>
        <pc:spChg chg="mod">
          <ac:chgData name="Rockfeld, Jennifer Prof." userId="S::jrockfeld@quinnipiac.edu::17f6105e-8432-4431-969a-4424c976ccf7" providerId="AD" clId="Web-{CADDEA40-130F-C64F-5217-4646A79FE82E}" dt="2019-09-12T13:22:01.476" v="54" actId="20577"/>
          <ac:spMkLst>
            <pc:docMk/>
            <pc:sldMk cId="1635000195" sldId="345"/>
            <ac:spMk id="4" creationId="{00000000-0000-0000-0000-000000000000}"/>
          </ac:spMkLst>
        </pc:spChg>
      </pc:sldChg>
      <pc:sldChg chg="modSp">
        <pc:chgData name="Rockfeld, Jennifer Prof." userId="S::jrockfeld@quinnipiac.edu::17f6105e-8432-4431-969a-4424c976ccf7" providerId="AD" clId="Web-{CADDEA40-130F-C64F-5217-4646A79FE82E}" dt="2019-09-12T13:21:53.570" v="51" actId="20577"/>
        <pc:sldMkLst>
          <pc:docMk/>
          <pc:sldMk cId="2146478956" sldId="346"/>
        </pc:sldMkLst>
        <pc:spChg chg="mod">
          <ac:chgData name="Rockfeld, Jennifer Prof." userId="S::jrockfeld@quinnipiac.edu::17f6105e-8432-4431-969a-4424c976ccf7" providerId="AD" clId="Web-{CADDEA40-130F-C64F-5217-4646A79FE82E}" dt="2019-09-12T13:21:53.570" v="51" actId="20577"/>
          <ac:spMkLst>
            <pc:docMk/>
            <pc:sldMk cId="2146478956" sldId="346"/>
            <ac:spMk id="4" creationId="{00000000-0000-0000-0000-000000000000}"/>
          </ac:spMkLst>
        </pc:spChg>
      </pc:sldChg>
      <pc:sldChg chg="modSp modNotes">
        <pc:chgData name="Rockfeld, Jennifer Prof." userId="S::jrockfeld@quinnipiac.edu::17f6105e-8432-4431-969a-4424c976ccf7" providerId="AD" clId="Web-{CADDEA40-130F-C64F-5217-4646A79FE82E}" dt="2019-09-12T13:23:46.757" v="152"/>
        <pc:sldMkLst>
          <pc:docMk/>
          <pc:sldMk cId="1870862177" sldId="352"/>
        </pc:sldMkLst>
        <pc:spChg chg="mod">
          <ac:chgData name="Rockfeld, Jennifer Prof." userId="S::jrockfeld@quinnipiac.edu::17f6105e-8432-4431-969a-4424c976ccf7" providerId="AD" clId="Web-{CADDEA40-130F-C64F-5217-4646A79FE82E}" dt="2019-09-12T13:21:46.476" v="48" actId="20577"/>
          <ac:spMkLst>
            <pc:docMk/>
            <pc:sldMk cId="1870862177" sldId="352"/>
            <ac:spMk id="7" creationId="{00000000-0000-0000-0000-000000000000}"/>
          </ac:spMkLst>
        </pc:spChg>
      </pc:sldChg>
      <pc:sldChg chg="modSp modNotes">
        <pc:chgData name="Rockfeld, Jennifer Prof." userId="S::jrockfeld@quinnipiac.edu::17f6105e-8432-4431-969a-4424c976ccf7" providerId="AD" clId="Web-{CADDEA40-130F-C64F-5217-4646A79FE82E}" dt="2019-09-12T13:40:12.039" v="726"/>
        <pc:sldMkLst>
          <pc:docMk/>
          <pc:sldMk cId="206664175" sldId="355"/>
        </pc:sldMkLst>
        <pc:spChg chg="mod">
          <ac:chgData name="Rockfeld, Jennifer Prof." userId="S::jrockfeld@quinnipiac.edu::17f6105e-8432-4431-969a-4424c976ccf7" providerId="AD" clId="Web-{CADDEA40-130F-C64F-5217-4646A79FE82E}" dt="2019-09-12T13:39:00.523" v="567" actId="20577"/>
          <ac:spMkLst>
            <pc:docMk/>
            <pc:sldMk cId="206664175" sldId="355"/>
            <ac:spMk id="3" creationId="{00000000-0000-0000-0000-000000000000}"/>
          </ac:spMkLst>
        </pc:spChg>
        <pc:spChg chg="mod">
          <ac:chgData name="Rockfeld, Jennifer Prof." userId="S::jrockfeld@quinnipiac.edu::17f6105e-8432-4431-969a-4424c976ccf7" providerId="AD" clId="Web-{CADDEA40-130F-C64F-5217-4646A79FE82E}" dt="2019-09-12T13:39:12.492" v="571" actId="14100"/>
          <ac:spMkLst>
            <pc:docMk/>
            <pc:sldMk cId="206664175" sldId="355"/>
            <ac:spMk id="7" creationId="{4AE4C641-27A2-9A45-9C36-38F0636A284C}"/>
          </ac:spMkLst>
        </pc:spChg>
      </pc:sldChg>
    </pc:docChg>
  </pc:docChgLst>
  <pc:docChgLst>
    <pc:chgData name="Rockfeld, Jennifer Prof." userId="S::jrockfeld@quinnipiac.edu::17f6105e-8432-4431-969a-4424c976ccf7" providerId="AD" clId="Web-{BD9D0397-ADF2-A137-7C22-A1D24B659A82}"/>
  </pc:docChgLst>
  <pc:docChgLst>
    <pc:chgData name="Rockfeld, Jennifer Prof." userId="17f6105e-8432-4431-969a-4424c976ccf7" providerId="ADAL" clId="{FBFC6861-664A-9E41-9E3D-2C938E7FF7FB}"/>
    <pc:docChg chg="undo custSel delSld modSld sldOrd modMainMaster modSection">
      <pc:chgData name="Rockfeld, Jennifer Prof." userId="17f6105e-8432-4431-969a-4424c976ccf7" providerId="ADAL" clId="{FBFC6861-664A-9E41-9E3D-2C938E7FF7FB}" dt="2019-11-26T21:51:32.916" v="902" actId="20577"/>
      <pc:docMkLst>
        <pc:docMk/>
      </pc:docMkLst>
      <pc:sldChg chg="modSp">
        <pc:chgData name="Rockfeld, Jennifer Prof." userId="17f6105e-8432-4431-969a-4424c976ccf7" providerId="ADAL" clId="{FBFC6861-664A-9E41-9E3D-2C938E7FF7FB}" dt="2019-11-26T21:00:43.855" v="179" actId="1035"/>
        <pc:sldMkLst>
          <pc:docMk/>
          <pc:sldMk cId="746357920" sldId="267"/>
        </pc:sldMkLst>
        <pc:spChg chg="mod">
          <ac:chgData name="Rockfeld, Jennifer Prof." userId="17f6105e-8432-4431-969a-4424c976ccf7" providerId="ADAL" clId="{FBFC6861-664A-9E41-9E3D-2C938E7FF7FB}" dt="2019-11-26T21:00:43.855" v="179" actId="1035"/>
          <ac:spMkLst>
            <pc:docMk/>
            <pc:sldMk cId="746357920" sldId="267"/>
            <ac:spMk id="3" creationId="{D7B70AED-5C58-40D6-A67E-2A09D381B525}"/>
          </ac:spMkLst>
        </pc:spChg>
      </pc:sldChg>
      <pc:sldChg chg="modSp modNotesTx">
        <pc:chgData name="Rockfeld, Jennifer Prof." userId="17f6105e-8432-4431-969a-4424c976ccf7" providerId="ADAL" clId="{FBFC6861-664A-9E41-9E3D-2C938E7FF7FB}" dt="2019-11-26T21:48:30.734" v="896" actId="20577"/>
        <pc:sldMkLst>
          <pc:docMk/>
          <pc:sldMk cId="3664890781" sldId="270"/>
        </pc:sldMkLst>
        <pc:spChg chg="mod">
          <ac:chgData name="Rockfeld, Jennifer Prof." userId="17f6105e-8432-4431-969a-4424c976ccf7" providerId="ADAL" clId="{FBFC6861-664A-9E41-9E3D-2C938E7FF7FB}" dt="2019-11-26T21:47:55.753" v="895" actId="20577"/>
          <ac:spMkLst>
            <pc:docMk/>
            <pc:sldMk cId="3664890781" sldId="270"/>
            <ac:spMk id="8" creationId="{00000000-0000-0000-0000-000000000000}"/>
          </ac:spMkLst>
        </pc:spChg>
      </pc:sldChg>
      <pc:sldChg chg="addSp delSp modSp">
        <pc:chgData name="Rockfeld, Jennifer Prof." userId="17f6105e-8432-4431-969a-4424c976ccf7" providerId="ADAL" clId="{FBFC6861-664A-9E41-9E3D-2C938E7FF7FB}" dt="2019-11-26T21:36:44.281" v="666" actId="5793"/>
        <pc:sldMkLst>
          <pc:docMk/>
          <pc:sldMk cId="2602544536" sldId="289"/>
        </pc:sldMkLst>
        <pc:spChg chg="add">
          <ac:chgData name="Rockfeld, Jennifer Prof." userId="17f6105e-8432-4431-969a-4424c976ccf7" providerId="ADAL" clId="{FBFC6861-664A-9E41-9E3D-2C938E7FF7FB}" dt="2019-11-26T21:33:32.293" v="624"/>
          <ac:spMkLst>
            <pc:docMk/>
            <pc:sldMk cId="2602544536" sldId="289"/>
            <ac:spMk id="4" creationId="{2FF894FD-7D7A-4544-8140-D0CEE1DB7637}"/>
          </ac:spMkLst>
        </pc:spChg>
        <pc:spChg chg="mod">
          <ac:chgData name="Rockfeld, Jennifer Prof." userId="17f6105e-8432-4431-969a-4424c976ccf7" providerId="ADAL" clId="{FBFC6861-664A-9E41-9E3D-2C938E7FF7FB}" dt="2019-11-26T21:36:44.281" v="666" actId="5793"/>
          <ac:spMkLst>
            <pc:docMk/>
            <pc:sldMk cId="2602544536" sldId="289"/>
            <ac:spMk id="6" creationId="{00000000-0000-0000-0000-000000000000}"/>
          </ac:spMkLst>
        </pc:spChg>
        <pc:spChg chg="add del">
          <ac:chgData name="Rockfeld, Jennifer Prof." userId="17f6105e-8432-4431-969a-4424c976ccf7" providerId="ADAL" clId="{FBFC6861-664A-9E41-9E3D-2C938E7FF7FB}" dt="2019-11-26T21:36:24.403" v="664"/>
          <ac:spMkLst>
            <pc:docMk/>
            <pc:sldMk cId="2602544536" sldId="289"/>
            <ac:spMk id="7" creationId="{AE32DFF2-3D2F-C246-AA18-B318EA5BECD5}"/>
          </ac:spMkLst>
        </pc:spChg>
        <pc:picChg chg="del">
          <ac:chgData name="Rockfeld, Jennifer Prof." userId="17f6105e-8432-4431-969a-4424c976ccf7" providerId="ADAL" clId="{FBFC6861-664A-9E41-9E3D-2C938E7FF7FB}" dt="2019-11-21T22:26:23.015" v="167" actId="478"/>
          <ac:picMkLst>
            <pc:docMk/>
            <pc:sldMk cId="2602544536" sldId="289"/>
            <ac:picMk id="1026" creationId="{00000000-0000-0000-0000-000000000000}"/>
          </ac:picMkLst>
        </pc:picChg>
      </pc:sldChg>
      <pc:sldChg chg="addSp modNotesTx">
        <pc:chgData name="Rockfeld, Jennifer Prof." userId="17f6105e-8432-4431-969a-4424c976ccf7" providerId="ADAL" clId="{FBFC6861-664A-9E41-9E3D-2C938E7FF7FB}" dt="2019-11-26T21:50:53.974" v="899" actId="20577"/>
        <pc:sldMkLst>
          <pc:docMk/>
          <pc:sldMk cId="4088866050" sldId="290"/>
        </pc:sldMkLst>
        <pc:spChg chg="add">
          <ac:chgData name="Rockfeld, Jennifer Prof." userId="17f6105e-8432-4431-969a-4424c976ccf7" providerId="ADAL" clId="{FBFC6861-664A-9E41-9E3D-2C938E7FF7FB}" dt="2019-11-26T21:33:24.603" v="621"/>
          <ac:spMkLst>
            <pc:docMk/>
            <pc:sldMk cId="4088866050" sldId="290"/>
            <ac:spMk id="4" creationId="{35455D60-9668-FA41-87A2-41CB745580B2}"/>
          </ac:spMkLst>
        </pc:spChg>
      </pc:sldChg>
      <pc:sldChg chg="delSp">
        <pc:chgData name="Rockfeld, Jennifer Prof." userId="17f6105e-8432-4431-969a-4424c976ccf7" providerId="ADAL" clId="{FBFC6861-664A-9E41-9E3D-2C938E7FF7FB}" dt="2019-11-21T22:26:59.650" v="172" actId="478"/>
        <pc:sldMkLst>
          <pc:docMk/>
          <pc:sldMk cId="1899589041" sldId="301"/>
        </pc:sldMkLst>
        <pc:picChg chg="del">
          <ac:chgData name="Rockfeld, Jennifer Prof." userId="17f6105e-8432-4431-969a-4424c976ccf7" providerId="ADAL" clId="{FBFC6861-664A-9E41-9E3D-2C938E7FF7FB}" dt="2019-11-21T22:26:59.650" v="172" actId="478"/>
          <ac:picMkLst>
            <pc:docMk/>
            <pc:sldMk cId="1899589041" sldId="301"/>
            <ac:picMk id="9218" creationId="{00000000-0000-0000-0000-000000000000}"/>
          </ac:picMkLst>
        </pc:picChg>
      </pc:sldChg>
      <pc:sldChg chg="addSp ord modNotesTx">
        <pc:chgData name="Rockfeld, Jennifer Prof." userId="17f6105e-8432-4431-969a-4424c976ccf7" providerId="ADAL" clId="{FBFC6861-664A-9E41-9E3D-2C938E7FF7FB}" dt="2019-11-26T21:51:27.310" v="901" actId="20577"/>
        <pc:sldMkLst>
          <pc:docMk/>
          <pc:sldMk cId="117955124" sldId="302"/>
        </pc:sldMkLst>
        <pc:spChg chg="add">
          <ac:chgData name="Rockfeld, Jennifer Prof." userId="17f6105e-8432-4431-969a-4424c976ccf7" providerId="ADAL" clId="{FBFC6861-664A-9E41-9E3D-2C938E7FF7FB}" dt="2019-11-26T21:33:09.848" v="618"/>
          <ac:spMkLst>
            <pc:docMk/>
            <pc:sldMk cId="117955124" sldId="302"/>
            <ac:spMk id="5" creationId="{FC3F6B69-8CDE-D246-BD55-DF054BCD4379}"/>
          </ac:spMkLst>
        </pc:spChg>
      </pc:sldChg>
      <pc:sldChg chg="addSp ord modNotesTx">
        <pc:chgData name="Rockfeld, Jennifer Prof." userId="17f6105e-8432-4431-969a-4424c976ccf7" providerId="ADAL" clId="{FBFC6861-664A-9E41-9E3D-2C938E7FF7FB}" dt="2019-11-26T21:51:32.916" v="902" actId="20577"/>
        <pc:sldMkLst>
          <pc:docMk/>
          <pc:sldMk cId="2974721392" sldId="303"/>
        </pc:sldMkLst>
        <pc:spChg chg="add">
          <ac:chgData name="Rockfeld, Jennifer Prof." userId="17f6105e-8432-4431-969a-4424c976ccf7" providerId="ADAL" clId="{FBFC6861-664A-9E41-9E3D-2C938E7FF7FB}" dt="2019-11-26T21:33:04.682" v="617"/>
          <ac:spMkLst>
            <pc:docMk/>
            <pc:sldMk cId="2974721392" sldId="303"/>
            <ac:spMk id="5" creationId="{279303D9-D85D-6145-B2A1-6309257CB12F}"/>
          </ac:spMkLst>
        </pc:spChg>
      </pc:sldChg>
      <pc:sldChg chg="modSp modNotesTx">
        <pc:chgData name="Rockfeld, Jennifer Prof." userId="17f6105e-8432-4431-969a-4424c976ccf7" providerId="ADAL" clId="{FBFC6861-664A-9E41-9E3D-2C938E7FF7FB}" dt="2019-11-26T21:09:33.923" v="242" actId="20577"/>
        <pc:sldMkLst>
          <pc:docMk/>
          <pc:sldMk cId="23615817" sldId="309"/>
        </pc:sldMkLst>
        <pc:spChg chg="mod">
          <ac:chgData name="Rockfeld, Jennifer Prof." userId="17f6105e-8432-4431-969a-4424c976ccf7" providerId="ADAL" clId="{FBFC6861-664A-9E41-9E3D-2C938E7FF7FB}" dt="2019-11-26T21:09:31.616" v="241"/>
          <ac:spMkLst>
            <pc:docMk/>
            <pc:sldMk cId="23615817" sldId="309"/>
            <ac:spMk id="9" creationId="{6FC60F52-312A-4506-9BAC-178F285F4FEB}"/>
          </ac:spMkLst>
        </pc:spChg>
      </pc:sldChg>
      <pc:sldChg chg="modSp modNotesTx">
        <pc:chgData name="Rockfeld, Jennifer Prof." userId="17f6105e-8432-4431-969a-4424c976ccf7" providerId="ADAL" clId="{FBFC6861-664A-9E41-9E3D-2C938E7FF7FB}" dt="2019-11-26T21:09:13.260" v="239" actId="20577"/>
        <pc:sldMkLst>
          <pc:docMk/>
          <pc:sldMk cId="3008616477" sldId="310"/>
        </pc:sldMkLst>
        <pc:spChg chg="mod">
          <ac:chgData name="Rockfeld, Jennifer Prof." userId="17f6105e-8432-4431-969a-4424c976ccf7" providerId="ADAL" clId="{FBFC6861-664A-9E41-9E3D-2C938E7FF7FB}" dt="2019-11-26T21:09:01.681" v="237"/>
          <ac:spMkLst>
            <pc:docMk/>
            <pc:sldMk cId="3008616477" sldId="310"/>
            <ac:spMk id="5" creationId="{00000000-0000-0000-0000-000000000000}"/>
          </ac:spMkLst>
        </pc:spChg>
      </pc:sldChg>
      <pc:sldChg chg="modSp modNotesTx">
        <pc:chgData name="Rockfeld, Jennifer Prof." userId="17f6105e-8432-4431-969a-4424c976ccf7" providerId="ADAL" clId="{FBFC6861-664A-9E41-9E3D-2C938E7FF7FB}" dt="2019-11-26T21:09:56.658" v="249" actId="20577"/>
        <pc:sldMkLst>
          <pc:docMk/>
          <pc:sldMk cId="954280296" sldId="311"/>
        </pc:sldMkLst>
        <pc:spChg chg="mod">
          <ac:chgData name="Rockfeld, Jennifer Prof." userId="17f6105e-8432-4431-969a-4424c976ccf7" providerId="ADAL" clId="{FBFC6861-664A-9E41-9E3D-2C938E7FF7FB}" dt="2019-11-26T21:09:55.206" v="248"/>
          <ac:spMkLst>
            <pc:docMk/>
            <pc:sldMk cId="954280296" sldId="311"/>
            <ac:spMk id="2" creationId="{B5692F45-49DA-4C23-A130-DC47F5B4357E}"/>
          </ac:spMkLst>
        </pc:spChg>
      </pc:sldChg>
      <pc:sldChg chg="delSp modNotesTx">
        <pc:chgData name="Rockfeld, Jennifer Prof." userId="17f6105e-8432-4431-969a-4424c976ccf7" providerId="ADAL" clId="{FBFC6861-664A-9E41-9E3D-2C938E7FF7FB}" dt="2019-11-26T21:14:49.654" v="346" actId="20577"/>
        <pc:sldMkLst>
          <pc:docMk/>
          <pc:sldMk cId="432940344" sldId="314"/>
        </pc:sldMkLst>
        <pc:picChg chg="del">
          <ac:chgData name="Rockfeld, Jennifer Prof." userId="17f6105e-8432-4431-969a-4424c976ccf7" providerId="ADAL" clId="{FBFC6861-664A-9E41-9E3D-2C938E7FF7FB}" dt="2019-11-21T22:26:09.797" v="160" actId="478"/>
          <ac:picMkLst>
            <pc:docMk/>
            <pc:sldMk cId="432940344" sldId="314"/>
            <ac:picMk id="6" creationId="{00000000-0000-0000-0000-000000000000}"/>
          </ac:picMkLst>
        </pc:picChg>
      </pc:sldChg>
      <pc:sldChg chg="delSp modSp modNotesTx">
        <pc:chgData name="Rockfeld, Jennifer Prof." userId="17f6105e-8432-4431-969a-4424c976ccf7" providerId="ADAL" clId="{FBFC6861-664A-9E41-9E3D-2C938E7FF7FB}" dt="2019-11-26T21:44:03.843" v="803" actId="20577"/>
        <pc:sldMkLst>
          <pc:docMk/>
          <pc:sldMk cId="1214623804" sldId="315"/>
        </pc:sldMkLst>
        <pc:spChg chg="mod">
          <ac:chgData name="Rockfeld, Jennifer Prof." userId="17f6105e-8432-4431-969a-4424c976ccf7" providerId="ADAL" clId="{FBFC6861-664A-9E41-9E3D-2C938E7FF7FB}" dt="2019-11-26T21:30:31.295" v="427" actId="14100"/>
          <ac:spMkLst>
            <pc:docMk/>
            <pc:sldMk cId="1214623804" sldId="315"/>
            <ac:spMk id="3" creationId="{00000000-0000-0000-0000-000000000000}"/>
          </ac:spMkLst>
        </pc:spChg>
        <pc:spChg chg="mod">
          <ac:chgData name="Rockfeld, Jennifer Prof." userId="17f6105e-8432-4431-969a-4424c976ccf7" providerId="ADAL" clId="{FBFC6861-664A-9E41-9E3D-2C938E7FF7FB}" dt="2019-11-26T21:32:31.796" v="613" actId="20577"/>
          <ac:spMkLst>
            <pc:docMk/>
            <pc:sldMk cId="1214623804" sldId="315"/>
            <ac:spMk id="7" creationId="{63DD1EA6-777D-4553-8F90-B65D976E819D}"/>
          </ac:spMkLst>
        </pc:spChg>
        <pc:picChg chg="del">
          <ac:chgData name="Rockfeld, Jennifer Prof." userId="17f6105e-8432-4431-969a-4424c976ccf7" providerId="ADAL" clId="{FBFC6861-664A-9E41-9E3D-2C938E7FF7FB}" dt="2019-11-26T21:30:27.459" v="426" actId="478"/>
          <ac:picMkLst>
            <pc:docMk/>
            <pc:sldMk cId="1214623804" sldId="315"/>
            <ac:picMk id="2" creationId="{21AFA314-7E12-40B3-8A49-A9338E963A88}"/>
          </ac:picMkLst>
        </pc:picChg>
      </pc:sldChg>
      <pc:sldChg chg="modNotesTx">
        <pc:chgData name="Rockfeld, Jennifer Prof." userId="17f6105e-8432-4431-969a-4424c976ccf7" providerId="ADAL" clId="{FBFC6861-664A-9E41-9E3D-2C938E7FF7FB}" dt="2019-11-26T21:00:23.903" v="173" actId="20577"/>
        <pc:sldMkLst>
          <pc:docMk/>
          <pc:sldMk cId="1648010966" sldId="338"/>
        </pc:sldMkLst>
      </pc:sldChg>
      <pc:sldChg chg="addSp modSp modNotesTx">
        <pc:chgData name="Rockfeld, Jennifer Prof." userId="17f6105e-8432-4431-969a-4424c976ccf7" providerId="ADAL" clId="{FBFC6861-664A-9E41-9E3D-2C938E7FF7FB}" dt="2019-11-26T21:00:38.053" v="175" actId="1035"/>
        <pc:sldMkLst>
          <pc:docMk/>
          <pc:sldMk cId="1599298893" sldId="339"/>
        </pc:sldMkLst>
        <pc:spChg chg="add mod">
          <ac:chgData name="Rockfeld, Jennifer Prof." userId="17f6105e-8432-4431-969a-4424c976ccf7" providerId="ADAL" clId="{FBFC6861-664A-9E41-9E3D-2C938E7FF7FB}" dt="2019-11-26T21:00:38.053" v="175" actId="1035"/>
          <ac:spMkLst>
            <pc:docMk/>
            <pc:sldMk cId="1599298893" sldId="339"/>
            <ac:spMk id="2" creationId="{E9E62D93-103E-7C4F-9BE0-BEE05DB7D845}"/>
          </ac:spMkLst>
        </pc:spChg>
        <pc:picChg chg="mod">
          <ac:chgData name="Rockfeld, Jennifer Prof." userId="17f6105e-8432-4431-969a-4424c976ccf7" providerId="ADAL" clId="{FBFC6861-664A-9E41-9E3D-2C938E7FF7FB}" dt="2019-11-21T22:18:37.891" v="81" actId="1076"/>
          <ac:picMkLst>
            <pc:docMk/>
            <pc:sldMk cId="1599298893" sldId="339"/>
            <ac:picMk id="2050" creationId="{00000000-0000-0000-0000-000000000000}"/>
          </ac:picMkLst>
        </pc:picChg>
      </pc:sldChg>
      <pc:sldChg chg="addSp delSp modSp">
        <pc:chgData name="Rockfeld, Jennifer Prof." userId="17f6105e-8432-4431-969a-4424c976ccf7" providerId="ADAL" clId="{FBFC6861-664A-9E41-9E3D-2C938E7FF7FB}" dt="2019-11-26T21:03:05.671" v="202"/>
        <pc:sldMkLst>
          <pc:docMk/>
          <pc:sldMk cId="1012685030" sldId="341"/>
        </pc:sldMkLst>
        <pc:spChg chg="add del mod">
          <ac:chgData name="Rockfeld, Jennifer Prof." userId="17f6105e-8432-4431-969a-4424c976ccf7" providerId="ADAL" clId="{FBFC6861-664A-9E41-9E3D-2C938E7FF7FB}" dt="2019-11-26T21:01:01.924" v="185" actId="478"/>
          <ac:spMkLst>
            <pc:docMk/>
            <pc:sldMk cId="1012685030" sldId="341"/>
            <ac:spMk id="2" creationId="{7904BA50-540D-9A4C-BDA5-E153E05AB302}"/>
          </ac:spMkLst>
        </pc:spChg>
        <pc:spChg chg="mod">
          <ac:chgData name="Rockfeld, Jennifer Prof." userId="17f6105e-8432-4431-969a-4424c976ccf7" providerId="ADAL" clId="{FBFC6861-664A-9E41-9E3D-2C938E7FF7FB}" dt="2019-11-26T21:01:18.176" v="189"/>
          <ac:spMkLst>
            <pc:docMk/>
            <pc:sldMk cId="1012685030" sldId="341"/>
            <ac:spMk id="3" creationId="{00000000-0000-0000-0000-000000000000}"/>
          </ac:spMkLst>
        </pc:spChg>
        <pc:spChg chg="del mod">
          <ac:chgData name="Rockfeld, Jennifer Prof." userId="17f6105e-8432-4431-969a-4424c976ccf7" providerId="ADAL" clId="{FBFC6861-664A-9E41-9E3D-2C938E7FF7FB}" dt="2019-11-26T21:00:53.267" v="181" actId="478"/>
          <ac:spMkLst>
            <pc:docMk/>
            <pc:sldMk cId="1012685030" sldId="341"/>
            <ac:spMk id="5" creationId="{00000000-0000-0000-0000-000000000000}"/>
          </ac:spMkLst>
        </pc:spChg>
        <pc:spChg chg="add del mod">
          <ac:chgData name="Rockfeld, Jennifer Prof." userId="17f6105e-8432-4431-969a-4424c976ccf7" providerId="ADAL" clId="{FBFC6861-664A-9E41-9E3D-2C938E7FF7FB}" dt="2019-11-26T21:01:26.245" v="192"/>
          <ac:spMkLst>
            <pc:docMk/>
            <pc:sldMk cId="1012685030" sldId="341"/>
            <ac:spMk id="6" creationId="{9F9EDAA7-EE6A-1349-BFEB-5FC66237A765}"/>
          </ac:spMkLst>
        </pc:spChg>
        <pc:spChg chg="add del mod">
          <ac:chgData name="Rockfeld, Jennifer Prof." userId="17f6105e-8432-4431-969a-4424c976ccf7" providerId="ADAL" clId="{FBFC6861-664A-9E41-9E3D-2C938E7FF7FB}" dt="2019-11-26T21:02:19.967" v="196"/>
          <ac:spMkLst>
            <pc:docMk/>
            <pc:sldMk cId="1012685030" sldId="341"/>
            <ac:spMk id="8" creationId="{5B301F18-BA3F-F94C-A4F4-F2573412D020}"/>
          </ac:spMkLst>
        </pc:spChg>
        <pc:spChg chg="add">
          <ac:chgData name="Rockfeld, Jennifer Prof." userId="17f6105e-8432-4431-969a-4424c976ccf7" providerId="ADAL" clId="{FBFC6861-664A-9E41-9E3D-2C938E7FF7FB}" dt="2019-11-26T21:03:05.671" v="202"/>
          <ac:spMkLst>
            <pc:docMk/>
            <pc:sldMk cId="1012685030" sldId="341"/>
            <ac:spMk id="9" creationId="{4B0153DB-B0AC-444E-8B24-3F80EF1ADC62}"/>
          </ac:spMkLst>
        </pc:spChg>
      </pc:sldChg>
      <pc:sldChg chg="addSp modSp">
        <pc:chgData name="Rockfeld, Jennifer Prof." userId="17f6105e-8432-4431-969a-4424c976ccf7" providerId="ADAL" clId="{FBFC6861-664A-9E41-9E3D-2C938E7FF7FB}" dt="2019-11-26T21:03:01.640" v="201"/>
        <pc:sldMkLst>
          <pc:docMk/>
          <pc:sldMk cId="586387317" sldId="342"/>
        </pc:sldMkLst>
        <pc:spChg chg="mod">
          <ac:chgData name="Rockfeld, Jennifer Prof." userId="17f6105e-8432-4431-969a-4424c976ccf7" providerId="ADAL" clId="{FBFC6861-664A-9E41-9E3D-2C938E7FF7FB}" dt="2019-11-26T21:02:50.962" v="200" actId="1076"/>
          <ac:spMkLst>
            <pc:docMk/>
            <pc:sldMk cId="586387317" sldId="342"/>
            <ac:spMk id="5" creationId="{00000000-0000-0000-0000-000000000000}"/>
          </ac:spMkLst>
        </pc:spChg>
        <pc:spChg chg="add">
          <ac:chgData name="Rockfeld, Jennifer Prof." userId="17f6105e-8432-4431-969a-4424c976ccf7" providerId="ADAL" clId="{FBFC6861-664A-9E41-9E3D-2C938E7FF7FB}" dt="2019-11-26T21:03:01.640" v="201"/>
          <ac:spMkLst>
            <pc:docMk/>
            <pc:sldMk cId="586387317" sldId="342"/>
            <ac:spMk id="6" creationId="{DF2ECC5A-14D7-6B41-96B1-346C02BC447A}"/>
          </ac:spMkLst>
        </pc:spChg>
      </pc:sldChg>
      <pc:sldChg chg="addSp delSp">
        <pc:chgData name="Rockfeld, Jennifer Prof." userId="17f6105e-8432-4431-969a-4424c976ccf7" providerId="ADAL" clId="{FBFC6861-664A-9E41-9E3D-2C938E7FF7FB}" dt="2019-11-26T21:03:12.014" v="204"/>
        <pc:sldMkLst>
          <pc:docMk/>
          <pc:sldMk cId="1160470871" sldId="344"/>
        </pc:sldMkLst>
        <pc:spChg chg="del">
          <ac:chgData name="Rockfeld, Jennifer Prof." userId="17f6105e-8432-4431-969a-4424c976ccf7" providerId="ADAL" clId="{FBFC6861-664A-9E41-9E3D-2C938E7FF7FB}" dt="2019-11-26T21:03:11.482" v="203" actId="478"/>
          <ac:spMkLst>
            <pc:docMk/>
            <pc:sldMk cId="1160470871" sldId="344"/>
            <ac:spMk id="4" creationId="{00000000-0000-0000-0000-000000000000}"/>
          </ac:spMkLst>
        </pc:spChg>
        <pc:spChg chg="add">
          <ac:chgData name="Rockfeld, Jennifer Prof." userId="17f6105e-8432-4431-969a-4424c976ccf7" providerId="ADAL" clId="{FBFC6861-664A-9E41-9E3D-2C938E7FF7FB}" dt="2019-11-26T21:03:12.014" v="204"/>
          <ac:spMkLst>
            <pc:docMk/>
            <pc:sldMk cId="1160470871" sldId="344"/>
            <ac:spMk id="6" creationId="{09ADDFDC-137E-7B4C-B49E-89AF358B499F}"/>
          </ac:spMkLst>
        </pc:spChg>
      </pc:sldChg>
      <pc:sldChg chg="addSp delSp">
        <pc:chgData name="Rockfeld, Jennifer Prof." userId="17f6105e-8432-4431-969a-4424c976ccf7" providerId="ADAL" clId="{FBFC6861-664A-9E41-9E3D-2C938E7FF7FB}" dt="2019-11-26T21:03:18.732" v="206"/>
        <pc:sldMkLst>
          <pc:docMk/>
          <pc:sldMk cId="1635000195" sldId="345"/>
        </pc:sldMkLst>
        <pc:spChg chg="del">
          <ac:chgData name="Rockfeld, Jennifer Prof." userId="17f6105e-8432-4431-969a-4424c976ccf7" providerId="ADAL" clId="{FBFC6861-664A-9E41-9E3D-2C938E7FF7FB}" dt="2019-11-26T21:03:17.853" v="205" actId="478"/>
          <ac:spMkLst>
            <pc:docMk/>
            <pc:sldMk cId="1635000195" sldId="345"/>
            <ac:spMk id="4" creationId="{00000000-0000-0000-0000-000000000000}"/>
          </ac:spMkLst>
        </pc:spChg>
        <pc:spChg chg="add">
          <ac:chgData name="Rockfeld, Jennifer Prof." userId="17f6105e-8432-4431-969a-4424c976ccf7" providerId="ADAL" clId="{FBFC6861-664A-9E41-9E3D-2C938E7FF7FB}" dt="2019-11-26T21:03:18.732" v="206"/>
          <ac:spMkLst>
            <pc:docMk/>
            <pc:sldMk cId="1635000195" sldId="345"/>
            <ac:spMk id="6" creationId="{473D8410-4C25-344D-AA25-147520B8B4EC}"/>
          </ac:spMkLst>
        </pc:spChg>
      </pc:sldChg>
      <pc:sldChg chg="addSp delSp">
        <pc:chgData name="Rockfeld, Jennifer Prof." userId="17f6105e-8432-4431-969a-4424c976ccf7" providerId="ADAL" clId="{FBFC6861-664A-9E41-9E3D-2C938E7FF7FB}" dt="2019-11-26T21:03:26.292" v="208"/>
        <pc:sldMkLst>
          <pc:docMk/>
          <pc:sldMk cId="2146478956" sldId="346"/>
        </pc:sldMkLst>
        <pc:spChg chg="del">
          <ac:chgData name="Rockfeld, Jennifer Prof." userId="17f6105e-8432-4431-969a-4424c976ccf7" providerId="ADAL" clId="{FBFC6861-664A-9E41-9E3D-2C938E7FF7FB}" dt="2019-11-26T21:03:25.310" v="207" actId="478"/>
          <ac:spMkLst>
            <pc:docMk/>
            <pc:sldMk cId="2146478956" sldId="346"/>
            <ac:spMk id="4" creationId="{00000000-0000-0000-0000-000000000000}"/>
          </ac:spMkLst>
        </pc:spChg>
        <pc:spChg chg="add">
          <ac:chgData name="Rockfeld, Jennifer Prof." userId="17f6105e-8432-4431-969a-4424c976ccf7" providerId="ADAL" clId="{FBFC6861-664A-9E41-9E3D-2C938E7FF7FB}" dt="2019-11-26T21:03:26.292" v="208"/>
          <ac:spMkLst>
            <pc:docMk/>
            <pc:sldMk cId="2146478956" sldId="346"/>
            <ac:spMk id="6" creationId="{B0475463-0D14-9548-A243-1FF95889E6AC}"/>
          </ac:spMkLst>
        </pc:spChg>
      </pc:sldChg>
      <pc:sldChg chg="addSp delSp modSp">
        <pc:chgData name="Rockfeld, Jennifer Prof." userId="17f6105e-8432-4431-969a-4424c976ccf7" providerId="ADAL" clId="{FBFC6861-664A-9E41-9E3D-2C938E7FF7FB}" dt="2019-11-26T21:05:08.289" v="215" actId="1076"/>
        <pc:sldMkLst>
          <pc:docMk/>
          <pc:sldMk cId="1870862177" sldId="352"/>
        </pc:sldMkLst>
        <pc:spChg chg="add mod">
          <ac:chgData name="Rockfeld, Jennifer Prof." userId="17f6105e-8432-4431-969a-4424c976ccf7" providerId="ADAL" clId="{FBFC6861-664A-9E41-9E3D-2C938E7FF7FB}" dt="2019-11-26T21:05:08.289" v="215" actId="1076"/>
          <ac:spMkLst>
            <pc:docMk/>
            <pc:sldMk cId="1870862177" sldId="352"/>
            <ac:spMk id="6" creationId="{8549EB7F-27D1-CB4B-BBA5-E16CEAA1B051}"/>
          </ac:spMkLst>
        </pc:spChg>
        <pc:spChg chg="del">
          <ac:chgData name="Rockfeld, Jennifer Prof." userId="17f6105e-8432-4431-969a-4424c976ccf7" providerId="ADAL" clId="{FBFC6861-664A-9E41-9E3D-2C938E7FF7FB}" dt="2019-11-26T21:03:32.728" v="209" actId="478"/>
          <ac:spMkLst>
            <pc:docMk/>
            <pc:sldMk cId="1870862177" sldId="352"/>
            <ac:spMk id="7" creationId="{00000000-0000-0000-0000-000000000000}"/>
          </ac:spMkLst>
        </pc:spChg>
      </pc:sldChg>
      <pc:sldChg chg="addSp delSp modSp modNotesTx">
        <pc:chgData name="Rockfeld, Jennifer Prof." userId="17f6105e-8432-4431-969a-4424c976ccf7" providerId="ADAL" clId="{FBFC6861-664A-9E41-9E3D-2C938E7FF7FB}" dt="2019-11-26T21:13:56.742" v="324" actId="20577"/>
        <pc:sldMkLst>
          <pc:docMk/>
          <pc:sldMk cId="1421912527" sldId="353"/>
        </pc:sldMkLst>
        <pc:spChg chg="del">
          <ac:chgData name="Rockfeld, Jennifer Prof." userId="17f6105e-8432-4431-969a-4424c976ccf7" providerId="ADAL" clId="{FBFC6861-664A-9E41-9E3D-2C938E7FF7FB}" dt="2019-11-26T21:12:17.119" v="254" actId="478"/>
          <ac:spMkLst>
            <pc:docMk/>
            <pc:sldMk cId="1421912527" sldId="353"/>
            <ac:spMk id="3" creationId="{00000000-0000-0000-0000-000000000000}"/>
          </ac:spMkLst>
        </pc:spChg>
        <pc:spChg chg="add mod">
          <ac:chgData name="Rockfeld, Jennifer Prof." userId="17f6105e-8432-4431-969a-4424c976ccf7" providerId="ADAL" clId="{FBFC6861-664A-9E41-9E3D-2C938E7FF7FB}" dt="2019-11-26T21:13:40.329" v="320" actId="20577"/>
          <ac:spMkLst>
            <pc:docMk/>
            <pc:sldMk cId="1421912527" sldId="353"/>
            <ac:spMk id="6" creationId="{1829A6C8-4922-CD4E-AB13-90DD2A333647}"/>
          </ac:spMkLst>
        </pc:spChg>
      </pc:sldChg>
      <pc:sldChg chg="del">
        <pc:chgData name="Rockfeld, Jennifer Prof." userId="17f6105e-8432-4431-969a-4424c976ccf7" providerId="ADAL" clId="{FBFC6861-664A-9E41-9E3D-2C938E7FF7FB}" dt="2019-11-26T21:03:39.016" v="211" actId="2696"/>
        <pc:sldMkLst>
          <pc:docMk/>
          <pc:sldMk cId="1373805970" sldId="354"/>
        </pc:sldMkLst>
      </pc:sldChg>
      <pc:sldChg chg="delSp">
        <pc:chgData name="Rockfeld, Jennifer Prof." userId="17f6105e-8432-4431-969a-4424c976ccf7" providerId="ADAL" clId="{FBFC6861-664A-9E41-9E3D-2C938E7FF7FB}" dt="2019-11-21T22:26:12.239" v="161" actId="478"/>
        <pc:sldMkLst>
          <pc:docMk/>
          <pc:sldMk cId="206664175" sldId="355"/>
        </pc:sldMkLst>
        <pc:picChg chg="del">
          <ac:chgData name="Rockfeld, Jennifer Prof." userId="17f6105e-8432-4431-969a-4424c976ccf7" providerId="ADAL" clId="{FBFC6861-664A-9E41-9E3D-2C938E7FF7FB}" dt="2019-11-21T22:26:12.239" v="161" actId="478"/>
          <ac:picMkLst>
            <pc:docMk/>
            <pc:sldMk cId="206664175" sldId="355"/>
            <ac:picMk id="6" creationId="{00000000-0000-0000-0000-000000000000}"/>
          </ac:picMkLst>
        </pc:picChg>
      </pc:sldChg>
      <pc:sldChg chg="delSp">
        <pc:chgData name="Rockfeld, Jennifer Prof." userId="17f6105e-8432-4431-969a-4424c976ccf7" providerId="ADAL" clId="{FBFC6861-664A-9E41-9E3D-2C938E7FF7FB}" dt="2019-11-21T22:01:20.140" v="3" actId="478"/>
        <pc:sldMkLst>
          <pc:docMk/>
          <pc:sldMk cId="593161502" sldId="357"/>
        </pc:sldMkLst>
        <pc:picChg chg="del">
          <ac:chgData name="Rockfeld, Jennifer Prof." userId="17f6105e-8432-4431-969a-4424c976ccf7" providerId="ADAL" clId="{FBFC6861-664A-9E41-9E3D-2C938E7FF7FB}" dt="2019-11-21T22:01:20.140" v="3" actId="478"/>
          <ac:picMkLst>
            <pc:docMk/>
            <pc:sldMk cId="593161502" sldId="357"/>
            <ac:picMk id="4" creationId="{00000000-0000-0000-0000-000000000000}"/>
          </ac:picMkLst>
        </pc:picChg>
      </pc:sldChg>
      <pc:sldChg chg="addSp delSp modSp">
        <pc:chgData name="Rockfeld, Jennifer Prof." userId="17f6105e-8432-4431-969a-4424c976ccf7" providerId="ADAL" clId="{FBFC6861-664A-9E41-9E3D-2C938E7FF7FB}" dt="2019-11-26T21:36:54.341" v="668" actId="207"/>
        <pc:sldMkLst>
          <pc:docMk/>
          <pc:sldMk cId="755402285" sldId="358"/>
        </pc:sldMkLst>
        <pc:spChg chg="add mod">
          <ac:chgData name="Rockfeld, Jennifer Prof." userId="17f6105e-8432-4431-969a-4424c976ccf7" providerId="ADAL" clId="{FBFC6861-664A-9E41-9E3D-2C938E7FF7FB}" dt="2019-11-26T21:33:28.401" v="623" actId="1035"/>
          <ac:spMkLst>
            <pc:docMk/>
            <pc:sldMk cId="755402285" sldId="358"/>
            <ac:spMk id="4" creationId="{E8FB79E5-FE6F-CE49-AA0E-98F41C39BDEE}"/>
          </ac:spMkLst>
        </pc:spChg>
        <pc:spChg chg="mod">
          <ac:chgData name="Rockfeld, Jennifer Prof." userId="17f6105e-8432-4431-969a-4424c976ccf7" providerId="ADAL" clId="{FBFC6861-664A-9E41-9E3D-2C938E7FF7FB}" dt="2019-11-26T21:36:54.341" v="668" actId="207"/>
          <ac:spMkLst>
            <pc:docMk/>
            <pc:sldMk cId="755402285" sldId="358"/>
            <ac:spMk id="6" creationId="{00000000-0000-0000-0000-000000000000}"/>
          </ac:spMkLst>
        </pc:spChg>
        <pc:picChg chg="del">
          <ac:chgData name="Rockfeld, Jennifer Prof." userId="17f6105e-8432-4431-969a-4424c976ccf7" providerId="ADAL" clId="{FBFC6861-664A-9E41-9E3D-2C938E7FF7FB}" dt="2019-11-21T22:26:25.977" v="168" actId="478"/>
          <ac:picMkLst>
            <pc:docMk/>
            <pc:sldMk cId="755402285" sldId="358"/>
            <ac:picMk id="1026" creationId="{00000000-0000-0000-0000-000000000000}"/>
          </ac:picMkLst>
        </pc:picChg>
      </pc:sldChg>
      <pc:sldChg chg="addSp delSp modSp ord">
        <pc:chgData name="Rockfeld, Jennifer Prof." userId="17f6105e-8432-4431-969a-4424c976ccf7" providerId="ADAL" clId="{FBFC6861-664A-9E41-9E3D-2C938E7FF7FB}" dt="2019-11-26T21:38:11.107" v="672" actId="207"/>
        <pc:sldMkLst>
          <pc:docMk/>
          <pc:sldMk cId="781704880" sldId="359"/>
        </pc:sldMkLst>
        <pc:spChg chg="add">
          <ac:chgData name="Rockfeld, Jennifer Prof." userId="17f6105e-8432-4431-969a-4424c976ccf7" providerId="ADAL" clId="{FBFC6861-664A-9E41-9E3D-2C938E7FF7FB}" dt="2019-11-26T21:32:59.762" v="616"/>
          <ac:spMkLst>
            <pc:docMk/>
            <pc:sldMk cId="781704880" sldId="359"/>
            <ac:spMk id="4" creationId="{5D473BCD-BB95-AA41-BBAF-EEEF950275D1}"/>
          </ac:spMkLst>
        </pc:spChg>
        <pc:spChg chg="mod">
          <ac:chgData name="Rockfeld, Jennifer Prof." userId="17f6105e-8432-4431-969a-4424c976ccf7" providerId="ADAL" clId="{FBFC6861-664A-9E41-9E3D-2C938E7FF7FB}" dt="2019-11-26T21:38:11.107" v="672" actId="207"/>
          <ac:spMkLst>
            <pc:docMk/>
            <pc:sldMk cId="781704880" sldId="359"/>
            <ac:spMk id="6" creationId="{00000000-0000-0000-0000-000000000000}"/>
          </ac:spMkLst>
        </pc:spChg>
        <pc:picChg chg="del">
          <ac:chgData name="Rockfeld, Jennifer Prof." userId="17f6105e-8432-4431-969a-4424c976ccf7" providerId="ADAL" clId="{FBFC6861-664A-9E41-9E3D-2C938E7FF7FB}" dt="2019-11-21T22:26:29.864" v="169" actId="478"/>
          <ac:picMkLst>
            <pc:docMk/>
            <pc:sldMk cId="781704880" sldId="359"/>
            <ac:picMk id="1026" creationId="{00000000-0000-0000-0000-000000000000}"/>
          </ac:picMkLst>
        </pc:picChg>
      </pc:sldChg>
      <pc:sldChg chg="addSp modSp ord modNotesTx">
        <pc:chgData name="Rockfeld, Jennifer Prof." userId="17f6105e-8432-4431-969a-4424c976ccf7" providerId="ADAL" clId="{FBFC6861-664A-9E41-9E3D-2C938E7FF7FB}" dt="2019-11-26T21:43:10.006" v="735" actId="20577"/>
        <pc:sldMkLst>
          <pc:docMk/>
          <pc:sldMk cId="76843926" sldId="360"/>
        </pc:sldMkLst>
        <pc:spChg chg="mod">
          <ac:chgData name="Rockfeld, Jennifer Prof." userId="17f6105e-8432-4431-969a-4424c976ccf7" providerId="ADAL" clId="{FBFC6861-664A-9E41-9E3D-2C938E7FF7FB}" dt="2019-11-26T21:42:16.626" v="724" actId="20577"/>
          <ac:spMkLst>
            <pc:docMk/>
            <pc:sldMk cId="76843926" sldId="360"/>
            <ac:spMk id="3" creationId="{60549520-1119-4687-8F89-050540538F38}"/>
          </ac:spMkLst>
        </pc:spChg>
        <pc:spChg chg="add">
          <ac:chgData name="Rockfeld, Jennifer Prof." userId="17f6105e-8432-4431-969a-4424c976ccf7" providerId="ADAL" clId="{FBFC6861-664A-9E41-9E3D-2C938E7FF7FB}" dt="2019-11-26T21:32:55.936" v="615"/>
          <ac:spMkLst>
            <pc:docMk/>
            <pc:sldMk cId="76843926" sldId="360"/>
            <ac:spMk id="6" creationId="{72025FD6-8F62-2448-B890-FBAEFA869D21}"/>
          </ac:spMkLst>
        </pc:spChg>
      </pc:sldChg>
      <pc:sldChg chg="addSp delSp modSp ord modNotesTx">
        <pc:chgData name="Rockfeld, Jennifer Prof." userId="17f6105e-8432-4431-969a-4424c976ccf7" providerId="ADAL" clId="{FBFC6861-664A-9E41-9E3D-2C938E7FF7FB}" dt="2019-11-26T21:49:37.324" v="897" actId="20577"/>
        <pc:sldMkLst>
          <pc:docMk/>
          <pc:sldMk cId="1533612955" sldId="361"/>
        </pc:sldMkLst>
        <pc:spChg chg="add">
          <ac:chgData name="Rockfeld, Jennifer Prof." userId="17f6105e-8432-4431-969a-4424c976ccf7" providerId="ADAL" clId="{FBFC6861-664A-9E41-9E3D-2C938E7FF7FB}" dt="2019-11-26T21:33:20.921" v="620"/>
          <ac:spMkLst>
            <pc:docMk/>
            <pc:sldMk cId="1533612955" sldId="361"/>
            <ac:spMk id="4" creationId="{90F5931C-5254-734A-B654-F9167ED5D91C}"/>
          </ac:spMkLst>
        </pc:spChg>
        <pc:spChg chg="mod">
          <ac:chgData name="Rockfeld, Jennifer Prof." userId="17f6105e-8432-4431-969a-4424c976ccf7" providerId="ADAL" clId="{FBFC6861-664A-9E41-9E3D-2C938E7FF7FB}" dt="2019-11-26T21:37:04.972" v="670" actId="207"/>
          <ac:spMkLst>
            <pc:docMk/>
            <pc:sldMk cId="1533612955" sldId="361"/>
            <ac:spMk id="6" creationId="{00000000-0000-0000-0000-000000000000}"/>
          </ac:spMkLst>
        </pc:spChg>
        <pc:picChg chg="del">
          <ac:chgData name="Rockfeld, Jennifer Prof." userId="17f6105e-8432-4431-969a-4424c976ccf7" providerId="ADAL" clId="{FBFC6861-664A-9E41-9E3D-2C938E7FF7FB}" dt="2019-11-21T22:26:35.134" v="170" actId="478"/>
          <ac:picMkLst>
            <pc:docMk/>
            <pc:sldMk cId="1533612955" sldId="361"/>
            <ac:picMk id="1026" creationId="{00000000-0000-0000-0000-000000000000}"/>
          </ac:picMkLst>
        </pc:picChg>
      </pc:sldChg>
      <pc:sldChg chg="addSp delSp modSp">
        <pc:chgData name="Rockfeld, Jennifer Prof." userId="17f6105e-8432-4431-969a-4424c976ccf7" providerId="ADAL" clId="{FBFC6861-664A-9E41-9E3D-2C938E7FF7FB}" dt="2019-11-26T21:38:26.627" v="674" actId="207"/>
        <pc:sldMkLst>
          <pc:docMk/>
          <pc:sldMk cId="759538250" sldId="363"/>
        </pc:sldMkLst>
        <pc:spChg chg="add">
          <ac:chgData name="Rockfeld, Jennifer Prof." userId="17f6105e-8432-4431-969a-4424c976ccf7" providerId="ADAL" clId="{FBFC6861-664A-9E41-9E3D-2C938E7FF7FB}" dt="2019-11-26T21:32:52.869" v="614"/>
          <ac:spMkLst>
            <pc:docMk/>
            <pc:sldMk cId="759538250" sldId="363"/>
            <ac:spMk id="4" creationId="{A487708C-CD97-1949-ABE1-1300C848E308}"/>
          </ac:spMkLst>
        </pc:spChg>
        <pc:spChg chg="mod">
          <ac:chgData name="Rockfeld, Jennifer Prof." userId="17f6105e-8432-4431-969a-4424c976ccf7" providerId="ADAL" clId="{FBFC6861-664A-9E41-9E3D-2C938E7FF7FB}" dt="2019-11-26T21:38:26.627" v="674" actId="207"/>
          <ac:spMkLst>
            <pc:docMk/>
            <pc:sldMk cId="759538250" sldId="363"/>
            <ac:spMk id="6" creationId="{00000000-0000-0000-0000-000000000000}"/>
          </ac:spMkLst>
        </pc:spChg>
        <pc:picChg chg="del">
          <ac:chgData name="Rockfeld, Jennifer Prof." userId="17f6105e-8432-4431-969a-4424c976ccf7" providerId="ADAL" clId="{FBFC6861-664A-9E41-9E3D-2C938E7FF7FB}" dt="2019-11-21T22:26:54.382" v="171" actId="478"/>
          <ac:picMkLst>
            <pc:docMk/>
            <pc:sldMk cId="759538250" sldId="363"/>
            <ac:picMk id="1026" creationId="{00000000-0000-0000-0000-000000000000}"/>
          </ac:picMkLst>
        </pc:picChg>
      </pc:sldChg>
      <pc:sldChg chg="modSp del">
        <pc:chgData name="Rockfeld, Jennifer Prof." userId="17f6105e-8432-4431-969a-4424c976ccf7" providerId="ADAL" clId="{FBFC6861-664A-9E41-9E3D-2C938E7FF7FB}" dt="2019-11-26T21:38:37.883" v="675" actId="2696"/>
        <pc:sldMkLst>
          <pc:docMk/>
          <pc:sldMk cId="461136317" sldId="364"/>
        </pc:sldMkLst>
        <pc:spChg chg="mod">
          <ac:chgData name="Rockfeld, Jennifer Prof." userId="17f6105e-8432-4431-969a-4424c976ccf7" providerId="ADAL" clId="{FBFC6861-664A-9E41-9E3D-2C938E7FF7FB}" dt="2019-11-26T21:35:57.471" v="662" actId="20577"/>
          <ac:spMkLst>
            <pc:docMk/>
            <pc:sldMk cId="461136317" sldId="364"/>
            <ac:spMk id="6" creationId="{00000000-0000-0000-0000-000000000000}"/>
          </ac:spMkLst>
        </pc:spChg>
      </pc:sldChg>
      <pc:sldChg chg="delSp modNotesTx">
        <pc:chgData name="Rockfeld, Jennifer Prof." userId="17f6105e-8432-4431-969a-4424c976ccf7" providerId="ADAL" clId="{FBFC6861-664A-9E41-9E3D-2C938E7FF7FB}" dt="2019-11-26T21:17:01.104" v="348" actId="20577"/>
        <pc:sldMkLst>
          <pc:docMk/>
          <pc:sldMk cId="3783050495" sldId="365"/>
        </pc:sldMkLst>
        <pc:picChg chg="del">
          <ac:chgData name="Rockfeld, Jennifer Prof." userId="17f6105e-8432-4431-969a-4424c976ccf7" providerId="ADAL" clId="{FBFC6861-664A-9E41-9E3D-2C938E7FF7FB}" dt="2019-11-21T22:26:19.183" v="165" actId="478"/>
          <ac:picMkLst>
            <pc:docMk/>
            <pc:sldMk cId="3783050495" sldId="365"/>
            <ac:picMk id="5" creationId="{00000000-0000-0000-0000-000000000000}"/>
          </ac:picMkLst>
        </pc:picChg>
        <pc:picChg chg="del">
          <ac:chgData name="Rockfeld, Jennifer Prof." userId="17f6105e-8432-4431-969a-4424c976ccf7" providerId="ADAL" clId="{FBFC6861-664A-9E41-9E3D-2C938E7FF7FB}" dt="2019-11-21T22:26:18.499" v="164" actId="478"/>
          <ac:picMkLst>
            <pc:docMk/>
            <pc:sldMk cId="3783050495" sldId="365"/>
            <ac:picMk id="6" creationId="{00000000-0000-0000-0000-000000000000}"/>
          </ac:picMkLst>
        </pc:picChg>
        <pc:picChg chg="del">
          <ac:chgData name="Rockfeld, Jennifer Prof." userId="17f6105e-8432-4431-969a-4424c976ccf7" providerId="ADAL" clId="{FBFC6861-664A-9E41-9E3D-2C938E7FF7FB}" dt="2019-11-21T22:26:19.862" v="166" actId="478"/>
          <ac:picMkLst>
            <pc:docMk/>
            <pc:sldMk cId="3783050495" sldId="365"/>
            <ac:picMk id="9" creationId="{00000000-0000-0000-0000-000000000000}"/>
          </ac:picMkLst>
        </pc:picChg>
      </pc:sldChg>
      <pc:sldChg chg="delSp modNotesTx">
        <pc:chgData name="Rockfeld, Jennifer Prof." userId="17f6105e-8432-4431-969a-4424c976ccf7" providerId="ADAL" clId="{FBFC6861-664A-9E41-9E3D-2C938E7FF7FB}" dt="2019-11-26T21:25:33.838" v="413" actId="20577"/>
        <pc:sldMkLst>
          <pc:docMk/>
          <pc:sldMk cId="3796121160" sldId="366"/>
        </pc:sldMkLst>
        <pc:picChg chg="del">
          <ac:chgData name="Rockfeld, Jennifer Prof." userId="17f6105e-8432-4431-969a-4424c976ccf7" providerId="ADAL" clId="{FBFC6861-664A-9E41-9E3D-2C938E7FF7FB}" dt="2019-11-21T22:26:15.966" v="163" actId="478"/>
          <ac:picMkLst>
            <pc:docMk/>
            <pc:sldMk cId="3796121160" sldId="366"/>
            <ac:picMk id="4" creationId="{4CFA2FEA-064F-450B-AA0C-2B79C06865EE}"/>
          </ac:picMkLst>
        </pc:picChg>
        <pc:picChg chg="del">
          <ac:chgData name="Rockfeld, Jennifer Prof." userId="17f6105e-8432-4431-969a-4424c976ccf7" providerId="ADAL" clId="{FBFC6861-664A-9E41-9E3D-2C938E7FF7FB}" dt="2019-11-21T22:26:15.183" v="162" actId="478"/>
          <ac:picMkLst>
            <pc:docMk/>
            <pc:sldMk cId="3796121160" sldId="366"/>
            <ac:picMk id="6" creationId="{00000000-0000-0000-0000-000000000000}"/>
          </ac:picMkLst>
        </pc:picChg>
      </pc:sldChg>
      <pc:sldChg chg="addSp delSp modSp">
        <pc:chgData name="Rockfeld, Jennifer Prof." userId="17f6105e-8432-4431-969a-4424c976ccf7" providerId="ADAL" clId="{FBFC6861-664A-9E41-9E3D-2C938E7FF7FB}" dt="2019-11-26T21:39:04.952" v="680"/>
        <pc:sldMkLst>
          <pc:docMk/>
          <pc:sldMk cId="3869180342" sldId="369"/>
        </pc:sldMkLst>
        <pc:spChg chg="mod">
          <ac:chgData name="Rockfeld, Jennifer Prof." userId="17f6105e-8432-4431-969a-4424c976ccf7" providerId="ADAL" clId="{FBFC6861-664A-9E41-9E3D-2C938E7FF7FB}" dt="2019-11-26T21:38:56.162" v="679" actId="14100"/>
          <ac:spMkLst>
            <pc:docMk/>
            <pc:sldMk cId="3869180342" sldId="369"/>
            <ac:spMk id="5" creationId="{00000000-0000-0000-0000-000000000000}"/>
          </ac:spMkLst>
        </pc:spChg>
        <pc:spChg chg="add">
          <ac:chgData name="Rockfeld, Jennifer Prof." userId="17f6105e-8432-4431-969a-4424c976ccf7" providerId="ADAL" clId="{FBFC6861-664A-9E41-9E3D-2C938E7FF7FB}" dt="2019-11-26T21:39:04.952" v="680"/>
          <ac:spMkLst>
            <pc:docMk/>
            <pc:sldMk cId="3869180342" sldId="369"/>
            <ac:spMk id="6" creationId="{13B411DE-07E0-5846-8433-E4F2A8F2F1B6}"/>
          </ac:spMkLst>
        </pc:spChg>
        <pc:picChg chg="del">
          <ac:chgData name="Rockfeld, Jennifer Prof." userId="17f6105e-8432-4431-969a-4424c976ccf7" providerId="ADAL" clId="{FBFC6861-664A-9E41-9E3D-2C938E7FF7FB}" dt="2019-11-26T21:38:44.426" v="676" actId="478"/>
          <ac:picMkLst>
            <pc:docMk/>
            <pc:sldMk cId="3869180342" sldId="369"/>
            <ac:picMk id="2" creationId="{00000000-0000-0000-0000-000000000000}"/>
          </ac:picMkLst>
        </pc:picChg>
      </pc:sldChg>
      <pc:sldChg chg="modSp modNotesTx">
        <pc:chgData name="Rockfeld, Jennifer Prof." userId="17f6105e-8432-4431-969a-4424c976ccf7" providerId="ADAL" clId="{FBFC6861-664A-9E41-9E3D-2C938E7FF7FB}" dt="2019-11-26T21:09:46.125" v="246" actId="20577"/>
        <pc:sldMkLst>
          <pc:docMk/>
          <pc:sldMk cId="3116183296" sldId="370"/>
        </pc:sldMkLst>
        <pc:spChg chg="mod">
          <ac:chgData name="Rockfeld, Jennifer Prof." userId="17f6105e-8432-4431-969a-4424c976ccf7" providerId="ADAL" clId="{FBFC6861-664A-9E41-9E3D-2C938E7FF7FB}" dt="2019-11-26T21:09:44.466" v="244"/>
          <ac:spMkLst>
            <pc:docMk/>
            <pc:sldMk cId="3116183296" sldId="370"/>
            <ac:spMk id="3" creationId="{C815C8FE-447B-4A31-ACB3-C25D905AA430}"/>
          </ac:spMkLst>
        </pc:spChg>
      </pc:sldChg>
      <pc:sldChg chg="modSp modNotesTx">
        <pc:chgData name="Rockfeld, Jennifer Prof." userId="17f6105e-8432-4431-969a-4424c976ccf7" providerId="ADAL" clId="{FBFC6861-664A-9E41-9E3D-2C938E7FF7FB}" dt="2019-11-26T21:50:15.750" v="898" actId="20577"/>
        <pc:sldMkLst>
          <pc:docMk/>
          <pc:sldMk cId="3737179732" sldId="371"/>
        </pc:sldMkLst>
        <pc:spChg chg="mod">
          <ac:chgData name="Rockfeld, Jennifer Prof." userId="17f6105e-8432-4431-969a-4424c976ccf7" providerId="ADAL" clId="{FBFC6861-664A-9E41-9E3D-2C938E7FF7FB}" dt="2019-11-26T21:06:33.989" v="226" actId="122"/>
          <ac:spMkLst>
            <pc:docMk/>
            <pc:sldMk cId="3737179732" sldId="371"/>
            <ac:spMk id="12" creationId="{3E7A736E-981B-43A6-9AA8-9DC6255B88FE}"/>
          </ac:spMkLst>
        </pc:spChg>
      </pc:sldChg>
      <pc:sldChg chg="addSp ord modNotesTx">
        <pc:chgData name="Rockfeld, Jennifer Prof." userId="17f6105e-8432-4431-969a-4424c976ccf7" providerId="ADAL" clId="{FBFC6861-664A-9E41-9E3D-2C938E7FF7FB}" dt="2019-11-26T21:51:04.126" v="900" actId="20577"/>
        <pc:sldMkLst>
          <pc:docMk/>
          <pc:sldMk cId="1463992610" sldId="372"/>
        </pc:sldMkLst>
        <pc:spChg chg="add">
          <ac:chgData name="Rockfeld, Jennifer Prof." userId="17f6105e-8432-4431-969a-4424c976ccf7" providerId="ADAL" clId="{FBFC6861-664A-9E41-9E3D-2C938E7FF7FB}" dt="2019-11-26T21:33:16.935" v="619"/>
          <ac:spMkLst>
            <pc:docMk/>
            <pc:sldMk cId="1463992610" sldId="372"/>
            <ac:spMk id="4" creationId="{F016796E-617E-1341-86C3-B668BD872908}"/>
          </ac:spMkLst>
        </pc:spChg>
      </pc:sldChg>
      <pc:sldMasterChg chg="modSldLayout">
        <pc:chgData name="Rockfeld, Jennifer Prof." userId="17f6105e-8432-4431-969a-4424c976ccf7" providerId="ADAL" clId="{FBFC6861-664A-9E41-9E3D-2C938E7FF7FB}" dt="2019-11-21T22:00:52.866" v="2" actId="478"/>
        <pc:sldMasterMkLst>
          <pc:docMk/>
          <pc:sldMasterMk cId="941317310" sldId="2147483684"/>
        </pc:sldMasterMkLst>
        <pc:sldLayoutChg chg="delSp">
          <pc:chgData name="Rockfeld, Jennifer Prof." userId="17f6105e-8432-4431-969a-4424c976ccf7" providerId="ADAL" clId="{FBFC6861-664A-9E41-9E3D-2C938E7FF7FB}" dt="2019-11-21T22:00:47.949" v="0" actId="478"/>
          <pc:sldLayoutMkLst>
            <pc:docMk/>
            <pc:sldMasterMk cId="941317310" sldId="2147483684"/>
            <pc:sldLayoutMk cId="0" sldId="2147483686"/>
          </pc:sldLayoutMkLst>
          <pc:picChg chg="del">
            <ac:chgData name="Rockfeld, Jennifer Prof." userId="17f6105e-8432-4431-969a-4424c976ccf7" providerId="ADAL" clId="{FBFC6861-664A-9E41-9E3D-2C938E7FF7FB}" dt="2019-11-21T22:00:47.949" v="0" actId="478"/>
            <ac:picMkLst>
              <pc:docMk/>
              <pc:sldMasterMk cId="941317310" sldId="2147483684"/>
              <pc:sldLayoutMk cId="0" sldId="2147483686"/>
              <ac:picMk id="7" creationId="{00000000-0000-0000-0000-000000000000}"/>
            </ac:picMkLst>
          </pc:picChg>
        </pc:sldLayoutChg>
        <pc:sldLayoutChg chg="delSp">
          <pc:chgData name="Rockfeld, Jennifer Prof." userId="17f6105e-8432-4431-969a-4424c976ccf7" providerId="ADAL" clId="{FBFC6861-664A-9E41-9E3D-2C938E7FF7FB}" dt="2019-11-21T22:00:50.736" v="1" actId="478"/>
          <pc:sldLayoutMkLst>
            <pc:docMk/>
            <pc:sldMasterMk cId="941317310" sldId="2147483684"/>
            <pc:sldLayoutMk cId="0" sldId="2147483690"/>
          </pc:sldLayoutMkLst>
          <pc:picChg chg="del">
            <ac:chgData name="Rockfeld, Jennifer Prof." userId="17f6105e-8432-4431-969a-4424c976ccf7" providerId="ADAL" clId="{FBFC6861-664A-9E41-9E3D-2C938E7FF7FB}" dt="2019-11-21T22:00:50.736" v="1" actId="478"/>
            <ac:picMkLst>
              <pc:docMk/>
              <pc:sldMasterMk cId="941317310" sldId="2147483684"/>
              <pc:sldLayoutMk cId="0" sldId="2147483690"/>
              <ac:picMk id="6" creationId="{00000000-0000-0000-0000-000000000000}"/>
            </ac:picMkLst>
          </pc:picChg>
        </pc:sldLayoutChg>
        <pc:sldLayoutChg chg="delSp">
          <pc:chgData name="Rockfeld, Jennifer Prof." userId="17f6105e-8432-4431-969a-4424c976ccf7" providerId="ADAL" clId="{FBFC6861-664A-9E41-9E3D-2C938E7FF7FB}" dt="2019-11-21T22:00:52.866" v="2" actId="478"/>
          <pc:sldLayoutMkLst>
            <pc:docMk/>
            <pc:sldMasterMk cId="941317310" sldId="2147483684"/>
            <pc:sldLayoutMk cId="0" sldId="2147483691"/>
          </pc:sldLayoutMkLst>
          <pc:picChg chg="del">
            <ac:chgData name="Rockfeld, Jennifer Prof." userId="17f6105e-8432-4431-969a-4424c976ccf7" providerId="ADAL" clId="{FBFC6861-664A-9E41-9E3D-2C938E7FF7FB}" dt="2019-11-21T22:00:52.866" v="2" actId="478"/>
            <ac:picMkLst>
              <pc:docMk/>
              <pc:sldMasterMk cId="941317310" sldId="2147483684"/>
              <pc:sldLayoutMk cId="0" sldId="2147483691"/>
              <ac:picMk id="5" creationId="{00000000-0000-0000-0000-000000000000}"/>
            </ac:picMkLst>
          </pc:picChg>
        </pc:sldLayoutChg>
      </pc:sldMasterChg>
    </pc:docChg>
  </pc:docChgLst>
  <pc:docChgLst>
    <pc:chgData name="Rockfeld, Jennifer Prof." userId="S::jrockfeld@quinnipiac.edu::17f6105e-8432-4431-969a-4424c976ccf7" providerId="AD" clId="Web-{522B3B1C-5510-FBBD-9C6C-85CC7F19DCDC}"/>
    <pc:docChg chg="addSld delSld modSld modSection">
      <pc:chgData name="Rockfeld, Jennifer Prof." userId="S::jrockfeld@quinnipiac.edu::17f6105e-8432-4431-969a-4424c976ccf7" providerId="AD" clId="Web-{522B3B1C-5510-FBBD-9C6C-85CC7F19DCDC}" dt="2019-11-26T02:05:15.494" v="64"/>
      <pc:docMkLst>
        <pc:docMk/>
      </pc:docMkLst>
      <pc:sldChg chg="modSp">
        <pc:chgData name="Rockfeld, Jennifer Prof." userId="S::jrockfeld@quinnipiac.edu::17f6105e-8432-4431-969a-4424c976ccf7" providerId="AD" clId="Web-{522B3B1C-5510-FBBD-9C6C-85CC7F19DCDC}" dt="2019-11-26T02:04:25.086" v="58" actId="1076"/>
        <pc:sldMkLst>
          <pc:docMk/>
          <pc:sldMk cId="1034359062" sldId="362"/>
        </pc:sldMkLst>
        <pc:picChg chg="mod">
          <ac:chgData name="Rockfeld, Jennifer Prof." userId="S::jrockfeld@quinnipiac.edu::17f6105e-8432-4431-969a-4424c976ccf7" providerId="AD" clId="Web-{522B3B1C-5510-FBBD-9C6C-85CC7F19DCDC}" dt="2019-11-26T02:04:25.086" v="58" actId="1076"/>
          <ac:picMkLst>
            <pc:docMk/>
            <pc:sldMk cId="1034359062" sldId="362"/>
            <ac:picMk id="4" creationId="{00000000-0000-0000-0000-000000000000}"/>
          </ac:picMkLst>
        </pc:picChg>
      </pc:sldChg>
      <pc:sldChg chg="del">
        <pc:chgData name="Rockfeld, Jennifer Prof." userId="S::jrockfeld@quinnipiac.edu::17f6105e-8432-4431-969a-4424c976ccf7" providerId="AD" clId="Web-{522B3B1C-5510-FBBD-9C6C-85CC7F19DCDC}" dt="2019-11-26T02:03:43.897" v="56"/>
        <pc:sldMkLst>
          <pc:docMk/>
          <pc:sldMk cId="79039408" sldId="367"/>
        </pc:sldMkLst>
      </pc:sldChg>
      <pc:sldChg chg="addSp delSp modSp add replId modNotes">
        <pc:chgData name="Rockfeld, Jennifer Prof." userId="S::jrockfeld@quinnipiac.edu::17f6105e-8432-4431-969a-4424c976ccf7" providerId="AD" clId="Web-{522B3B1C-5510-FBBD-9C6C-85CC7F19DCDC}" dt="2019-11-26T02:02:57.661" v="54"/>
        <pc:sldMkLst>
          <pc:docMk/>
          <pc:sldMk cId="3737179732" sldId="371"/>
        </pc:sldMkLst>
        <pc:spChg chg="del mod">
          <ac:chgData name="Rockfeld, Jennifer Prof." userId="S::jrockfeld@quinnipiac.edu::17f6105e-8432-4431-969a-4424c976ccf7" providerId="AD" clId="Web-{522B3B1C-5510-FBBD-9C6C-85CC7F19DCDC}" dt="2019-11-26T01:59:57.436" v="5"/>
          <ac:spMkLst>
            <pc:docMk/>
            <pc:sldMk cId="3737179732" sldId="371"/>
            <ac:spMk id="4" creationId="{00000000-0000-0000-0000-000000000000}"/>
          </ac:spMkLst>
        </pc:spChg>
        <pc:spChg chg="add del mod">
          <ac:chgData name="Rockfeld, Jennifer Prof." userId="S::jrockfeld@quinnipiac.edu::17f6105e-8432-4431-969a-4424c976ccf7" providerId="AD" clId="Web-{522B3B1C-5510-FBBD-9C6C-85CC7F19DCDC}" dt="2019-11-26T01:59:51.233" v="2"/>
          <ac:spMkLst>
            <pc:docMk/>
            <pc:sldMk cId="3737179732" sldId="371"/>
            <ac:spMk id="8" creationId="{03E69090-376E-422D-BF67-22A202B80B51}"/>
          </ac:spMkLst>
        </pc:spChg>
        <pc:spChg chg="add">
          <ac:chgData name="Rockfeld, Jennifer Prof." userId="S::jrockfeld@quinnipiac.edu::17f6105e-8432-4431-969a-4424c976ccf7" providerId="AD" clId="Web-{522B3B1C-5510-FBBD-9C6C-85CC7F19DCDC}" dt="2019-11-26T02:01:57.315" v="47"/>
          <ac:spMkLst>
            <pc:docMk/>
            <pc:sldMk cId="3737179732" sldId="371"/>
            <ac:spMk id="11" creationId="{F5EA22B2-CD55-4CDC-8F42-61D33293755B}"/>
          </ac:spMkLst>
        </pc:spChg>
        <pc:spChg chg="add mod">
          <ac:chgData name="Rockfeld, Jennifer Prof." userId="S::jrockfeld@quinnipiac.edu::17f6105e-8432-4431-969a-4424c976ccf7" providerId="AD" clId="Web-{522B3B1C-5510-FBBD-9C6C-85CC7F19DCDC}" dt="2019-11-26T02:02:57.661" v="54"/>
          <ac:spMkLst>
            <pc:docMk/>
            <pc:sldMk cId="3737179732" sldId="371"/>
            <ac:spMk id="12" creationId="{3E7A736E-981B-43A6-9AA8-9DC6255B88FE}"/>
          </ac:spMkLst>
        </pc:spChg>
        <pc:picChg chg="del">
          <ac:chgData name="Rockfeld, Jennifer Prof." userId="S::jrockfeld@quinnipiac.edu::17f6105e-8432-4431-969a-4424c976ccf7" providerId="AD" clId="Web-{522B3B1C-5510-FBBD-9C6C-85CC7F19DCDC}" dt="2019-11-26T01:59:24.497" v="1"/>
          <ac:picMkLst>
            <pc:docMk/>
            <pc:sldMk cId="3737179732" sldId="371"/>
            <ac:picMk id="7" creationId="{00000000-0000-0000-0000-000000000000}"/>
          </ac:picMkLst>
        </pc:picChg>
        <pc:picChg chg="add mod ord">
          <ac:chgData name="Rockfeld, Jennifer Prof." userId="S::jrockfeld@quinnipiac.edu::17f6105e-8432-4431-969a-4424c976ccf7" providerId="AD" clId="Web-{522B3B1C-5510-FBBD-9C6C-85CC7F19DCDC}" dt="2019-11-26T02:00:01.608" v="6" actId="1076"/>
          <ac:picMkLst>
            <pc:docMk/>
            <pc:sldMk cId="3737179732" sldId="371"/>
            <ac:picMk id="9" creationId="{9BDA4E6B-B6CF-44AC-8556-8418FD97AFC7}"/>
          </ac:picMkLst>
        </pc:picChg>
      </pc:sldChg>
      <pc:sldChg chg="addSp delSp modSp new">
        <pc:chgData name="Rockfeld, Jennifer Prof." userId="S::jrockfeld@quinnipiac.edu::17f6105e-8432-4431-969a-4424c976ccf7" providerId="AD" clId="Web-{522B3B1C-5510-FBBD-9C6C-85CC7F19DCDC}" dt="2019-11-26T02:05:15.494" v="64"/>
        <pc:sldMkLst>
          <pc:docMk/>
          <pc:sldMk cId="1463992610" sldId="372"/>
        </pc:sldMkLst>
        <pc:spChg chg="mod">
          <ac:chgData name="Rockfeld, Jennifer Prof." userId="S::jrockfeld@quinnipiac.edu::17f6105e-8432-4431-969a-4424c976ccf7" providerId="AD" clId="Web-{522B3B1C-5510-FBBD-9C6C-85CC7F19DCDC}" dt="2019-11-26T02:05:15.307" v="60" actId="20577"/>
          <ac:spMkLst>
            <pc:docMk/>
            <pc:sldMk cId="1463992610" sldId="372"/>
            <ac:spMk id="2" creationId="{DBB9898C-21EF-4304-BC5A-BC227DC8CA6F}"/>
          </ac:spMkLst>
        </pc:spChg>
        <pc:spChg chg="del mod">
          <ac:chgData name="Rockfeld, Jennifer Prof." userId="S::jrockfeld@quinnipiac.edu::17f6105e-8432-4431-969a-4424c976ccf7" providerId="AD" clId="Web-{522B3B1C-5510-FBBD-9C6C-85CC7F19DCDC}" dt="2019-11-26T02:05:15.494" v="64"/>
          <ac:spMkLst>
            <pc:docMk/>
            <pc:sldMk cId="1463992610" sldId="372"/>
            <ac:spMk id="3" creationId="{2292801D-BEA2-4EF2-BF97-B3C1148115E5}"/>
          </ac:spMkLst>
        </pc:spChg>
        <pc:graphicFrameChg chg="add mod ord modGraphic">
          <ac:chgData name="Rockfeld, Jennifer Prof." userId="S::jrockfeld@quinnipiac.edu::17f6105e-8432-4431-969a-4424c976ccf7" providerId="AD" clId="Web-{522B3B1C-5510-FBBD-9C6C-85CC7F19DCDC}" dt="2019-11-26T02:05:15.494" v="64"/>
          <ac:graphicFrameMkLst>
            <pc:docMk/>
            <pc:sldMk cId="1463992610" sldId="372"/>
            <ac:graphicFrameMk id="4" creationId="{7AAB06A5-44CC-469D-9231-27E9FCB6C382}"/>
          </ac:graphicFrameMkLst>
        </pc:graphicFrameChg>
      </pc:sldChg>
    </pc:docChg>
  </pc:docChgLst>
  <pc:docChgLst>
    <pc:chgData name="Rockfeld, Jennifer Prof." userId="S::jrockfeld@quinnipiac.edu::17f6105e-8432-4431-969a-4424c976ccf7" providerId="AD" clId="Web-{776A4B80-52B9-90C4-FA22-1B0898C37FBA}"/>
    <pc:docChg chg="addSld delSld modSld sldOrd modSection">
      <pc:chgData name="Rockfeld, Jennifer Prof." userId="S::jrockfeld@quinnipiac.edu::17f6105e-8432-4431-969a-4424c976ccf7" providerId="AD" clId="Web-{776A4B80-52B9-90C4-FA22-1B0898C37FBA}" dt="2019-09-12T15:32:32.745" v="960"/>
      <pc:docMkLst>
        <pc:docMk/>
      </pc:docMkLst>
      <pc:sldChg chg="modNotes">
        <pc:chgData name="Rockfeld, Jennifer Prof." userId="S::jrockfeld@quinnipiac.edu::17f6105e-8432-4431-969a-4424c976ccf7" providerId="AD" clId="Web-{776A4B80-52B9-90C4-FA22-1B0898C37FBA}" dt="2019-09-12T15:18:25.184" v="826"/>
        <pc:sldMkLst>
          <pc:docMk/>
          <pc:sldMk cId="1899589041" sldId="301"/>
        </pc:sldMkLst>
      </pc:sldChg>
      <pc:sldChg chg="modNotes">
        <pc:chgData name="Rockfeld, Jennifer Prof." userId="S::jrockfeld@quinnipiac.edu::17f6105e-8432-4431-969a-4424c976ccf7" providerId="AD" clId="Web-{776A4B80-52B9-90C4-FA22-1B0898C37FBA}" dt="2019-09-12T14:57:23.390" v="46"/>
        <pc:sldMkLst>
          <pc:docMk/>
          <pc:sldMk cId="432940344" sldId="314"/>
        </pc:sldMkLst>
      </pc:sldChg>
      <pc:sldChg chg="addSp delSp modSp add del mod ord setBg modNotes">
        <pc:chgData name="Rockfeld, Jennifer Prof." userId="S::jrockfeld@quinnipiac.edu::17f6105e-8432-4431-969a-4424c976ccf7" providerId="AD" clId="Web-{776A4B80-52B9-90C4-FA22-1B0898C37FBA}" dt="2019-09-12T15:17:32.338" v="758"/>
        <pc:sldMkLst>
          <pc:docMk/>
          <pc:sldMk cId="1214623804" sldId="315"/>
        </pc:sldMkLst>
        <pc:spChg chg="mod ord">
          <ac:chgData name="Rockfeld, Jennifer Prof." userId="S::jrockfeld@quinnipiac.edu::17f6105e-8432-4431-969a-4424c976ccf7" providerId="AD" clId="Web-{776A4B80-52B9-90C4-FA22-1B0898C37FBA}" dt="2019-09-12T15:16:56.509" v="753" actId="1076"/>
          <ac:spMkLst>
            <pc:docMk/>
            <pc:sldMk cId="1214623804" sldId="315"/>
            <ac:spMk id="3" creationId="{00000000-0000-0000-0000-000000000000}"/>
          </ac:spMkLst>
        </pc:spChg>
        <pc:spChg chg="mod">
          <ac:chgData name="Rockfeld, Jennifer Prof." userId="S::jrockfeld@quinnipiac.edu::17f6105e-8432-4431-969a-4424c976ccf7" providerId="AD" clId="Web-{776A4B80-52B9-90C4-FA22-1B0898C37FBA}" dt="2019-09-12T15:16:25.930" v="745"/>
          <ac:spMkLst>
            <pc:docMk/>
            <pc:sldMk cId="1214623804" sldId="315"/>
            <ac:spMk id="5" creationId="{67A79728-E9F3-0F41-8613-996507D1D96A}"/>
          </ac:spMkLst>
        </pc:spChg>
        <pc:spChg chg="add">
          <ac:chgData name="Rockfeld, Jennifer Prof." userId="S::jrockfeld@quinnipiac.edu::17f6105e-8432-4431-969a-4424c976ccf7" providerId="AD" clId="Web-{776A4B80-52B9-90C4-FA22-1B0898C37FBA}" dt="2019-09-12T15:17:32.338" v="758"/>
          <ac:spMkLst>
            <pc:docMk/>
            <pc:sldMk cId="1214623804" sldId="315"/>
            <ac:spMk id="7" creationId="{63DD1EA6-777D-4553-8F90-B65D976E819D}"/>
          </ac:spMkLst>
        </pc:spChg>
        <pc:spChg chg="add del">
          <ac:chgData name="Rockfeld, Jennifer Prof." userId="S::jrockfeld@quinnipiac.edu::17f6105e-8432-4431-969a-4424c976ccf7" providerId="AD" clId="Web-{776A4B80-52B9-90C4-FA22-1B0898C37FBA}" dt="2019-09-12T15:16:25.930" v="745"/>
          <ac:spMkLst>
            <pc:docMk/>
            <pc:sldMk cId="1214623804" sldId="315"/>
            <ac:spMk id="10" creationId="{15045B1D-AED4-407C-BC82-BF20E4E4FF38}"/>
          </ac:spMkLst>
        </pc:spChg>
        <pc:picChg chg="add mod">
          <ac:chgData name="Rockfeld, Jennifer Prof." userId="S::jrockfeld@quinnipiac.edu::17f6105e-8432-4431-969a-4424c976ccf7" providerId="AD" clId="Web-{776A4B80-52B9-90C4-FA22-1B0898C37FBA}" dt="2019-09-12T15:16:52.212" v="752" actId="1076"/>
          <ac:picMkLst>
            <pc:docMk/>
            <pc:sldMk cId="1214623804" sldId="315"/>
            <ac:picMk id="2" creationId="{21AFA314-7E12-40B3-8A49-A9338E963A88}"/>
          </ac:picMkLst>
        </pc:picChg>
        <pc:picChg chg="add del">
          <ac:chgData name="Rockfeld, Jennifer Prof." userId="S::jrockfeld@quinnipiac.edu::17f6105e-8432-4431-969a-4424c976ccf7" providerId="AD" clId="Web-{776A4B80-52B9-90C4-FA22-1B0898C37FBA}" dt="2019-09-12T15:17:24.416" v="757"/>
          <ac:picMkLst>
            <pc:docMk/>
            <pc:sldMk cId="1214623804" sldId="315"/>
            <ac:picMk id="4" creationId="{C7AB5A2B-C64A-435B-8F8A-B89EA2388445}"/>
          </ac:picMkLst>
        </pc:picChg>
        <pc:picChg chg="add del">
          <ac:chgData name="Rockfeld, Jennifer Prof." userId="S::jrockfeld@quinnipiac.edu::17f6105e-8432-4431-969a-4424c976ccf7" providerId="AD" clId="Web-{776A4B80-52B9-90C4-FA22-1B0898C37FBA}" dt="2019-09-12T15:15:32.162" v="739"/>
          <ac:picMkLst>
            <pc:docMk/>
            <pc:sldMk cId="1214623804" sldId="315"/>
            <ac:picMk id="7170" creationId="{00000000-0000-0000-0000-000000000000}"/>
          </ac:picMkLst>
        </pc:picChg>
      </pc:sldChg>
      <pc:sldChg chg="modNotes">
        <pc:chgData name="Rockfeld, Jennifer Prof." userId="S::jrockfeld@quinnipiac.edu::17f6105e-8432-4431-969a-4424c976ccf7" providerId="AD" clId="Web-{776A4B80-52B9-90C4-FA22-1B0898C37FBA}" dt="2019-09-12T15:32:32.745" v="960"/>
        <pc:sldMkLst>
          <pc:docMk/>
          <pc:sldMk cId="3268405574" sldId="337"/>
        </pc:sldMkLst>
      </pc:sldChg>
      <pc:sldChg chg="addSp delSp modSp ord modNotes">
        <pc:chgData name="Rockfeld, Jennifer Prof." userId="S::jrockfeld@quinnipiac.edu::17f6105e-8432-4431-969a-4424c976ccf7" providerId="AD" clId="Web-{776A4B80-52B9-90C4-FA22-1B0898C37FBA}" dt="2019-09-12T14:58:51.237" v="66"/>
        <pc:sldMkLst>
          <pc:docMk/>
          <pc:sldMk cId="206664175" sldId="355"/>
        </pc:sldMkLst>
        <pc:spChg chg="mod">
          <ac:chgData name="Rockfeld, Jennifer Prof." userId="S::jrockfeld@quinnipiac.edu::17f6105e-8432-4431-969a-4424c976ccf7" providerId="AD" clId="Web-{776A4B80-52B9-90C4-FA22-1B0898C37FBA}" dt="2019-09-12T14:55:52.121" v="20" actId="20577"/>
          <ac:spMkLst>
            <pc:docMk/>
            <pc:sldMk cId="206664175" sldId="355"/>
            <ac:spMk id="3" creationId="{00000000-0000-0000-0000-000000000000}"/>
          </ac:spMkLst>
        </pc:spChg>
        <pc:spChg chg="del">
          <ac:chgData name="Rockfeld, Jennifer Prof." userId="S::jrockfeld@quinnipiac.edu::17f6105e-8432-4431-969a-4424c976ccf7" providerId="AD" clId="Web-{776A4B80-52B9-90C4-FA22-1B0898C37FBA}" dt="2019-09-12T14:54:37.071" v="0"/>
          <ac:spMkLst>
            <pc:docMk/>
            <pc:sldMk cId="206664175" sldId="355"/>
            <ac:spMk id="7" creationId="{4AE4C641-27A2-9A45-9C36-38F0636A284C}"/>
          </ac:spMkLst>
        </pc:spChg>
        <pc:picChg chg="add del">
          <ac:chgData name="Rockfeld, Jennifer Prof." userId="S::jrockfeld@quinnipiac.edu::17f6105e-8432-4431-969a-4424c976ccf7" providerId="AD" clId="Web-{776A4B80-52B9-90C4-FA22-1B0898C37FBA}" dt="2019-09-12T14:56:41.591" v="36"/>
          <ac:picMkLst>
            <pc:docMk/>
            <pc:sldMk cId="206664175" sldId="355"/>
            <ac:picMk id="4" creationId="{36080850-4831-47C0-80B8-555D5D0963C6}"/>
          </ac:picMkLst>
        </pc:picChg>
        <pc:picChg chg="del">
          <ac:chgData name="Rockfeld, Jennifer Prof." userId="S::jrockfeld@quinnipiac.edu::17f6105e-8432-4431-969a-4424c976ccf7" providerId="AD" clId="Web-{776A4B80-52B9-90C4-FA22-1B0898C37FBA}" dt="2019-09-12T14:55:54.527" v="22"/>
          <ac:picMkLst>
            <pc:docMk/>
            <pc:sldMk cId="206664175" sldId="355"/>
            <ac:picMk id="5" creationId="{00000000-0000-0000-0000-000000000000}"/>
          </ac:picMkLst>
        </pc:picChg>
        <pc:picChg chg="del">
          <ac:chgData name="Rockfeld, Jennifer Prof." userId="S::jrockfeld@quinnipiac.edu::17f6105e-8432-4431-969a-4424c976ccf7" providerId="AD" clId="Web-{776A4B80-52B9-90C4-FA22-1B0898C37FBA}" dt="2019-09-12T14:55:55.325" v="23"/>
          <ac:picMkLst>
            <pc:docMk/>
            <pc:sldMk cId="206664175" sldId="355"/>
            <ac:picMk id="9" creationId="{00000000-0000-0000-0000-000000000000}"/>
          </ac:picMkLst>
        </pc:picChg>
      </pc:sldChg>
      <pc:sldChg chg="modNotes">
        <pc:chgData name="Rockfeld, Jennifer Prof." userId="S::jrockfeld@quinnipiac.edu::17f6105e-8432-4431-969a-4424c976ccf7" providerId="AD" clId="Web-{776A4B80-52B9-90C4-FA22-1B0898C37FBA}" dt="2019-09-12T15:06:31.596" v="448"/>
        <pc:sldMkLst>
          <pc:docMk/>
          <pc:sldMk cId="76843926" sldId="360"/>
        </pc:sldMkLst>
      </pc:sldChg>
      <pc:sldChg chg="add ord replId modNotes">
        <pc:chgData name="Rockfeld, Jennifer Prof." userId="S::jrockfeld@quinnipiac.edu::17f6105e-8432-4431-969a-4424c976ccf7" providerId="AD" clId="Web-{776A4B80-52B9-90C4-FA22-1B0898C37FBA}" dt="2019-09-12T15:00:04.489" v="187"/>
        <pc:sldMkLst>
          <pc:docMk/>
          <pc:sldMk cId="3783050495" sldId="365"/>
        </pc:sldMkLst>
      </pc:sldChg>
      <pc:sldChg chg="addSp modSp add replId modNotes">
        <pc:chgData name="Rockfeld, Jennifer Prof." userId="S::jrockfeld@quinnipiac.edu::17f6105e-8432-4431-969a-4424c976ccf7" providerId="AD" clId="Web-{776A4B80-52B9-90C4-FA22-1B0898C37FBA}" dt="2019-09-12T14:57:15.624" v="44"/>
        <pc:sldMkLst>
          <pc:docMk/>
          <pc:sldMk cId="3796121160" sldId="366"/>
        </pc:sldMkLst>
        <pc:spChg chg="mod">
          <ac:chgData name="Rockfeld, Jennifer Prof." userId="S::jrockfeld@quinnipiac.edu::17f6105e-8432-4431-969a-4424c976ccf7" providerId="AD" clId="Web-{776A4B80-52B9-90C4-FA22-1B0898C37FBA}" dt="2019-09-12T14:56:52.123" v="38" actId="20577"/>
          <ac:spMkLst>
            <pc:docMk/>
            <pc:sldMk cId="3796121160" sldId="366"/>
            <ac:spMk id="3" creationId="{00000000-0000-0000-0000-000000000000}"/>
          </ac:spMkLst>
        </pc:spChg>
        <pc:picChg chg="add">
          <ac:chgData name="Rockfeld, Jennifer Prof." userId="S::jrockfeld@quinnipiac.edu::17f6105e-8432-4431-969a-4424c976ccf7" providerId="AD" clId="Web-{776A4B80-52B9-90C4-FA22-1B0898C37FBA}" dt="2019-09-12T14:56:47.451" v="37"/>
          <ac:picMkLst>
            <pc:docMk/>
            <pc:sldMk cId="3796121160" sldId="366"/>
            <ac:picMk id="4" creationId="{4CFA2FEA-064F-450B-AA0C-2B79C06865EE}"/>
          </ac:picMkLst>
        </pc:picChg>
      </pc:sldChg>
      <pc:sldChg chg="add ord">
        <pc:chgData name="Rockfeld, Jennifer Prof." userId="S::jrockfeld@quinnipiac.edu::17f6105e-8432-4431-969a-4424c976ccf7" providerId="AD" clId="Web-{776A4B80-52B9-90C4-FA22-1B0898C37FBA}" dt="2019-09-12T15:12:30.546" v="718"/>
        <pc:sldMkLst>
          <pc:docMk/>
          <pc:sldMk cId="3869180342" sldId="369"/>
        </pc:sldMkLst>
      </pc:sldChg>
    </pc:docChg>
  </pc:docChgLst>
  <pc:docChgLst>
    <pc:chgData name="Zucconi, Rebecca Prof." userId="10033FFF99E82C13@LIVE.COM" providerId="AD" clId="Web-{A9DE3F31-8218-4C3D-B4A6-F8013528858D}"/>
  </pc:docChgLst>
  <pc:docChgLst>
    <pc:chgData name="Zucconi, Rebecca Prof." userId="S::rzucconi@quinnipiac.edu::765a1284-d6e0-43b3-8745-3b830b318731" providerId="AD" clId="Web-{84BFF494-ECFE-3071-8484-1277BDE32BDC}"/>
    <pc:docChg chg="modSld">
      <pc:chgData name="Zucconi, Rebecca Prof." userId="S::rzucconi@quinnipiac.edu::765a1284-d6e0-43b3-8745-3b830b318731" providerId="AD" clId="Web-{84BFF494-ECFE-3071-8484-1277BDE32BDC}" dt="2020-03-03T20:20:16.714" v="14"/>
      <pc:docMkLst>
        <pc:docMk/>
      </pc:docMkLst>
      <pc:sldChg chg="addSp modSp modNotes">
        <pc:chgData name="Zucconi, Rebecca Prof." userId="S::rzucconi@quinnipiac.edu::765a1284-d6e0-43b3-8745-3b830b318731" providerId="AD" clId="Web-{84BFF494-ECFE-3071-8484-1277BDE32BDC}" dt="2020-03-03T20:20:16.714" v="14"/>
        <pc:sldMkLst>
          <pc:docMk/>
          <pc:sldMk cId="76843926" sldId="360"/>
        </pc:sldMkLst>
        <pc:picChg chg="add mod">
          <ac:chgData name="Zucconi, Rebecca Prof." userId="S::rzucconi@quinnipiac.edu::765a1284-d6e0-43b3-8745-3b830b318731" providerId="AD" clId="Web-{84BFF494-ECFE-3071-8484-1277BDE32BDC}" dt="2020-03-03T17:41:03.079" v="3" actId="14100"/>
          <ac:picMkLst>
            <pc:docMk/>
            <pc:sldMk cId="76843926" sldId="360"/>
            <ac:picMk id="4" creationId="{15243F29-0C6B-4B17-9003-6609027B98A7}"/>
          </ac:picMkLst>
        </pc:picChg>
      </pc:sldChg>
    </pc:docChg>
  </pc:docChgLst>
  <pc:docChgLst>
    <pc:chgData name="Rockfeld, Jennifer Prof." userId="S::jrockfeld@quinnipiac.edu::17f6105e-8432-4431-969a-4424c976ccf7" providerId="AD" clId="Web-{04295B96-1CD6-9D46-3789-25F2A26EDD01}"/>
    <pc:docChg chg="modSld sldOrd">
      <pc:chgData name="Rockfeld, Jennifer Prof." userId="S::jrockfeld@quinnipiac.edu::17f6105e-8432-4431-969a-4424c976ccf7" providerId="AD" clId="Web-{04295B96-1CD6-9D46-3789-25F2A26EDD01}" dt="2019-09-02T18:25:59.026" v="2"/>
      <pc:docMkLst>
        <pc:docMk/>
      </pc:docMkLst>
      <pc:sldChg chg="delSp">
        <pc:chgData name="Rockfeld, Jennifer Prof." userId="S::jrockfeld@quinnipiac.edu::17f6105e-8432-4431-969a-4424c976ccf7" providerId="AD" clId="Web-{04295B96-1CD6-9D46-3789-25F2A26EDD01}" dt="2019-09-02T18:25:45.729" v="1"/>
        <pc:sldMkLst>
          <pc:docMk/>
          <pc:sldMk cId="4088866050" sldId="290"/>
        </pc:sldMkLst>
        <pc:spChg chg="del">
          <ac:chgData name="Rockfeld, Jennifer Prof." userId="S::jrockfeld@quinnipiac.edu::17f6105e-8432-4431-969a-4424c976ccf7" providerId="AD" clId="Web-{04295B96-1CD6-9D46-3789-25F2A26EDD01}" dt="2019-09-02T18:25:45.729" v="1"/>
          <ac:spMkLst>
            <pc:docMk/>
            <pc:sldMk cId="4088866050" sldId="290"/>
            <ac:spMk id="2" creationId="{00000000-0000-0000-0000-000000000000}"/>
          </ac:spMkLst>
        </pc:spChg>
      </pc:sldChg>
      <pc:sldChg chg="ord">
        <pc:chgData name="Rockfeld, Jennifer Prof." userId="S::jrockfeld@quinnipiac.edu::17f6105e-8432-4431-969a-4424c976ccf7" providerId="AD" clId="Web-{04295B96-1CD6-9D46-3789-25F2A26EDD01}" dt="2019-09-02T18:25:17.650" v="0"/>
        <pc:sldMkLst>
          <pc:docMk/>
          <pc:sldMk cId="593161502" sldId="357"/>
        </pc:sldMkLst>
      </pc:sldChg>
    </pc:docChg>
  </pc:docChgLst>
  <pc:docChgLst>
    <pc:chgData name="Zucconi, Rebecca Prof." userId="S::rzucconi@quinnipiac.edu::765a1284-d6e0-43b3-8745-3b830b318731" providerId="AD" clId="Web-{5B156C30-39AC-5ACD-FA8B-BB1B009F2068}"/>
    <pc:docChg chg="modSld">
      <pc:chgData name="Zucconi, Rebecca Prof." userId="S::rzucconi@quinnipiac.edu::765a1284-d6e0-43b3-8745-3b830b318731" providerId="AD" clId="Web-{5B156C30-39AC-5ACD-FA8B-BB1B009F2068}" dt="2019-09-26T16:52:30.007" v="29"/>
      <pc:docMkLst>
        <pc:docMk/>
      </pc:docMkLst>
      <pc:sldChg chg="addSp delSp modSp">
        <pc:chgData name="Zucconi, Rebecca Prof." userId="S::rzucconi@quinnipiac.edu::765a1284-d6e0-43b3-8745-3b830b318731" providerId="AD" clId="Web-{5B156C30-39AC-5ACD-FA8B-BB1B009F2068}" dt="2019-09-26T16:52:30.007" v="29"/>
        <pc:sldMkLst>
          <pc:docMk/>
          <pc:sldMk cId="1599298893" sldId="339"/>
        </pc:sldMkLst>
        <pc:spChg chg="add del mod">
          <ac:chgData name="Zucconi, Rebecca Prof." userId="S::rzucconi@quinnipiac.edu::765a1284-d6e0-43b3-8745-3b830b318731" providerId="AD" clId="Web-{5B156C30-39AC-5ACD-FA8B-BB1B009F2068}" dt="2019-09-26T16:52:30.007" v="29"/>
          <ac:spMkLst>
            <pc:docMk/>
            <pc:sldMk cId="1599298893" sldId="339"/>
            <ac:spMk id="2" creationId="{3FB85564-30E7-42E7-BBF9-C16B997045A8}"/>
          </ac:spMkLst>
        </pc:spChg>
        <pc:picChg chg="mod">
          <ac:chgData name="Zucconi, Rebecca Prof." userId="S::rzucconi@quinnipiac.edu::765a1284-d6e0-43b3-8745-3b830b318731" providerId="AD" clId="Web-{5B156C30-39AC-5ACD-FA8B-BB1B009F2068}" dt="2019-09-26T16:50:10.472" v="1" actId="14100"/>
          <ac:picMkLst>
            <pc:docMk/>
            <pc:sldMk cId="1599298893" sldId="339"/>
            <ac:picMk id="2050" creationId="{00000000-0000-0000-0000-000000000000}"/>
          </ac:picMkLst>
        </pc:picChg>
      </pc:sldChg>
    </pc:docChg>
  </pc:docChgLst>
  <pc:docChgLst>
    <pc:chgData name="Rockfeld, Jennifer Prof." userId="S::jrockfeld@quinnipiac.edu::17f6105e-8432-4431-969a-4424c976ccf7" providerId="AD" clId="Web-{31E8DFCD-9753-6281-E3E2-30BA04889101}"/>
    <pc:docChg chg="delSld modSld modSection">
      <pc:chgData name="Rockfeld, Jennifer Prof." userId="S::jrockfeld@quinnipiac.edu::17f6105e-8432-4431-969a-4424c976ccf7" providerId="AD" clId="Web-{31E8DFCD-9753-6281-E3E2-30BA04889101}" dt="2019-09-12T19:21:39.240" v="32" actId="20577"/>
      <pc:docMkLst>
        <pc:docMk/>
      </pc:docMkLst>
      <pc:sldChg chg="modSp">
        <pc:chgData name="Rockfeld, Jennifer Prof." userId="S::jrockfeld@quinnipiac.edu::17f6105e-8432-4431-969a-4424c976ccf7" providerId="AD" clId="Web-{31E8DFCD-9753-6281-E3E2-30BA04889101}" dt="2019-09-12T19:21:38.724" v="30" actId="20577"/>
        <pc:sldMkLst>
          <pc:docMk/>
          <pc:sldMk cId="3268405574" sldId="337"/>
        </pc:sldMkLst>
        <pc:spChg chg="mod">
          <ac:chgData name="Rockfeld, Jennifer Prof." userId="S::jrockfeld@quinnipiac.edu::17f6105e-8432-4431-969a-4424c976ccf7" providerId="AD" clId="Web-{31E8DFCD-9753-6281-E3E2-30BA04889101}" dt="2019-09-12T19:21:38.724" v="30" actId="20577"/>
          <ac:spMkLst>
            <pc:docMk/>
            <pc:sldMk cId="3268405574" sldId="337"/>
            <ac:spMk id="2" creationId="{F19057A2-1F55-4A58-B417-14A7593970EB}"/>
          </ac:spMkLst>
        </pc:spChg>
      </pc:sldChg>
    </pc:docChg>
  </pc:docChgLst>
  <pc:docChgLst>
    <pc:chgData name="Rockfeld, Jennifer Prof." userId="S::jrockfeld@quinnipiac.edu::17f6105e-8432-4431-969a-4424c976ccf7" providerId="AD" clId="Web-{1FCAB203-AA4A-4DB8-2032-F4CC8C37B3F4}"/>
    <pc:docChg chg="addSld delSld modSld modSection">
      <pc:chgData name="Rockfeld, Jennifer Prof." userId="S::jrockfeld@quinnipiac.edu::17f6105e-8432-4431-969a-4424c976ccf7" providerId="AD" clId="Web-{1FCAB203-AA4A-4DB8-2032-F4CC8C37B3F4}" dt="2019-11-25T03:01:24.317" v="899" actId="20577"/>
      <pc:docMkLst>
        <pc:docMk/>
      </pc:docMkLst>
      <pc:sldChg chg="modNotes">
        <pc:chgData name="Rockfeld, Jennifer Prof." userId="S::jrockfeld@quinnipiac.edu::17f6105e-8432-4431-969a-4424c976ccf7" providerId="AD" clId="Web-{1FCAB203-AA4A-4DB8-2032-F4CC8C37B3F4}" dt="2019-11-25T02:48:54.597" v="286"/>
        <pc:sldMkLst>
          <pc:docMk/>
          <pc:sldMk cId="2602544536" sldId="289"/>
        </pc:sldMkLst>
      </pc:sldChg>
      <pc:sldChg chg="modNotes">
        <pc:chgData name="Rockfeld, Jennifer Prof." userId="S::jrockfeld@quinnipiac.edu::17f6105e-8432-4431-969a-4424c976ccf7" providerId="AD" clId="Web-{1FCAB203-AA4A-4DB8-2032-F4CC8C37B3F4}" dt="2019-11-25T02:51:46.911" v="358"/>
        <pc:sldMkLst>
          <pc:docMk/>
          <pc:sldMk cId="4088866050" sldId="290"/>
        </pc:sldMkLst>
      </pc:sldChg>
      <pc:sldChg chg="addSp delSp modSp">
        <pc:chgData name="Rockfeld, Jennifer Prof." userId="S::jrockfeld@quinnipiac.edu::17f6105e-8432-4431-969a-4424c976ccf7" providerId="AD" clId="Web-{1FCAB203-AA4A-4DB8-2032-F4CC8C37B3F4}" dt="2019-11-25T02:38:02.737" v="132"/>
        <pc:sldMkLst>
          <pc:docMk/>
          <pc:sldMk cId="23615817" sldId="309"/>
        </pc:sldMkLst>
        <pc:spChg chg="add del mod">
          <ac:chgData name="Rockfeld, Jennifer Prof." userId="S::jrockfeld@quinnipiac.edu::17f6105e-8432-4431-969a-4424c976ccf7" providerId="AD" clId="Web-{1FCAB203-AA4A-4DB8-2032-F4CC8C37B3F4}" dt="2019-11-25T02:37:26.487" v="129"/>
          <ac:spMkLst>
            <pc:docMk/>
            <pc:sldMk cId="23615817" sldId="309"/>
            <ac:spMk id="3" creationId="{C151D6E4-9D79-4878-9B1E-776B129E68CC}"/>
          </ac:spMkLst>
        </pc:spChg>
        <pc:spChg chg="add">
          <ac:chgData name="Rockfeld, Jennifer Prof." userId="S::jrockfeld@quinnipiac.edu::17f6105e-8432-4431-969a-4424c976ccf7" providerId="AD" clId="Web-{1FCAB203-AA4A-4DB8-2032-F4CC8C37B3F4}" dt="2019-11-25T02:37:43.315" v="130"/>
          <ac:spMkLst>
            <pc:docMk/>
            <pc:sldMk cId="23615817" sldId="309"/>
            <ac:spMk id="5" creationId="{D6E83029-1FC6-476D-BE34-70143F8DC552}"/>
          </ac:spMkLst>
        </pc:spChg>
        <pc:spChg chg="del">
          <ac:chgData name="Rockfeld, Jennifer Prof." userId="S::jrockfeld@quinnipiac.edu::17f6105e-8432-4431-969a-4424c976ccf7" providerId="AD" clId="Web-{1FCAB203-AA4A-4DB8-2032-F4CC8C37B3F4}" dt="2019-11-25T02:37:18.737" v="125"/>
          <ac:spMkLst>
            <pc:docMk/>
            <pc:sldMk cId="23615817" sldId="309"/>
            <ac:spMk id="6" creationId="{00000000-0000-0000-0000-000000000000}"/>
          </ac:spMkLst>
        </pc:spChg>
        <pc:spChg chg="add">
          <ac:chgData name="Rockfeld, Jennifer Prof." userId="S::jrockfeld@quinnipiac.edu::17f6105e-8432-4431-969a-4424c976ccf7" providerId="AD" clId="Web-{1FCAB203-AA4A-4DB8-2032-F4CC8C37B3F4}" dt="2019-11-25T02:38:02.737" v="132"/>
          <ac:spMkLst>
            <pc:docMk/>
            <pc:sldMk cId="23615817" sldId="309"/>
            <ac:spMk id="9" creationId="{6FC60F52-312A-4506-9BAC-178F285F4FEB}"/>
          </ac:spMkLst>
        </pc:spChg>
      </pc:sldChg>
      <pc:sldChg chg="modSp">
        <pc:chgData name="Rockfeld, Jennifer Prof." userId="S::jrockfeld@quinnipiac.edu::17f6105e-8432-4431-969a-4424c976ccf7" providerId="AD" clId="Web-{1FCAB203-AA4A-4DB8-2032-F4CC8C37B3F4}" dt="2019-11-25T02:36:45.456" v="122" actId="20577"/>
        <pc:sldMkLst>
          <pc:docMk/>
          <pc:sldMk cId="3008616477" sldId="310"/>
        </pc:sldMkLst>
        <pc:spChg chg="mod">
          <ac:chgData name="Rockfeld, Jennifer Prof." userId="S::jrockfeld@quinnipiac.edu::17f6105e-8432-4431-969a-4424c976ccf7" providerId="AD" clId="Web-{1FCAB203-AA4A-4DB8-2032-F4CC8C37B3F4}" dt="2019-11-25T02:36:45.456" v="122" actId="20577"/>
          <ac:spMkLst>
            <pc:docMk/>
            <pc:sldMk cId="3008616477" sldId="310"/>
            <ac:spMk id="5" creationId="{00000000-0000-0000-0000-000000000000}"/>
          </ac:spMkLst>
        </pc:spChg>
      </pc:sldChg>
      <pc:sldChg chg="addSp delSp modSp">
        <pc:chgData name="Rockfeld, Jennifer Prof." userId="S::jrockfeld@quinnipiac.edu::17f6105e-8432-4431-969a-4424c976ccf7" providerId="AD" clId="Web-{1FCAB203-AA4A-4DB8-2032-F4CC8C37B3F4}" dt="2019-11-25T03:01:24.317" v="898" actId="20577"/>
        <pc:sldMkLst>
          <pc:docMk/>
          <pc:sldMk cId="954280296" sldId="311"/>
        </pc:sldMkLst>
        <pc:spChg chg="add mod">
          <ac:chgData name="Rockfeld, Jennifer Prof." userId="S::jrockfeld@quinnipiac.edu::17f6105e-8432-4431-969a-4424c976ccf7" providerId="AD" clId="Web-{1FCAB203-AA4A-4DB8-2032-F4CC8C37B3F4}" dt="2019-11-25T03:01:24.317" v="898" actId="20577"/>
          <ac:spMkLst>
            <pc:docMk/>
            <pc:sldMk cId="954280296" sldId="311"/>
            <ac:spMk id="2" creationId="{B5692F45-49DA-4C23-A130-DC47F5B4357E}"/>
          </ac:spMkLst>
        </pc:spChg>
        <pc:spChg chg="del mod">
          <ac:chgData name="Rockfeld, Jennifer Prof." userId="S::jrockfeld@quinnipiac.edu::17f6105e-8432-4431-969a-4424c976ccf7" providerId="AD" clId="Web-{1FCAB203-AA4A-4DB8-2032-F4CC8C37B3F4}" dt="2019-11-25T02:38:13.815" v="138"/>
          <ac:spMkLst>
            <pc:docMk/>
            <pc:sldMk cId="954280296" sldId="311"/>
            <ac:spMk id="8" creationId="{00000000-0000-0000-0000-000000000000}"/>
          </ac:spMkLst>
        </pc:spChg>
      </pc:sldChg>
      <pc:sldChg chg="addSp delSp modSp modNotes">
        <pc:chgData name="Rockfeld, Jennifer Prof." userId="S::jrockfeld@quinnipiac.edu::17f6105e-8432-4431-969a-4424c976ccf7" providerId="AD" clId="Web-{1FCAB203-AA4A-4DB8-2032-F4CC8C37B3F4}" dt="2019-11-25T02:48:27.394" v="284"/>
        <pc:sldMkLst>
          <pc:docMk/>
          <pc:sldMk cId="432940344" sldId="314"/>
        </pc:sldMkLst>
        <pc:spChg chg="add del mod">
          <ac:chgData name="Rockfeld, Jennifer Prof." userId="S::jrockfeld@quinnipiac.edu::17f6105e-8432-4431-969a-4424c976ccf7" providerId="AD" clId="Web-{1FCAB203-AA4A-4DB8-2032-F4CC8C37B3F4}" dt="2019-11-25T02:42:26.269" v="175"/>
          <ac:spMkLst>
            <pc:docMk/>
            <pc:sldMk cId="432940344" sldId="314"/>
            <ac:spMk id="4" creationId="{4C9FF564-1D71-4B15-889E-D2982D78E61A}"/>
          </ac:spMkLst>
        </pc:spChg>
        <pc:spChg chg="add del mod">
          <ac:chgData name="Rockfeld, Jennifer Prof." userId="S::jrockfeld@quinnipiac.edu::17f6105e-8432-4431-969a-4424c976ccf7" providerId="AD" clId="Web-{1FCAB203-AA4A-4DB8-2032-F4CC8C37B3F4}" dt="2019-11-25T02:44:19.956" v="186"/>
          <ac:spMkLst>
            <pc:docMk/>
            <pc:sldMk cId="432940344" sldId="314"/>
            <ac:spMk id="5" creationId="{00000000-0000-0000-0000-000000000000}"/>
          </ac:spMkLst>
        </pc:spChg>
      </pc:sldChg>
      <pc:sldChg chg="modNotes">
        <pc:chgData name="Rockfeld, Jennifer Prof." userId="S::jrockfeld@quinnipiac.edu::17f6105e-8432-4431-969a-4424c976ccf7" providerId="AD" clId="Web-{1FCAB203-AA4A-4DB8-2032-F4CC8C37B3F4}" dt="2019-11-25T02:34:24.378" v="111"/>
        <pc:sldMkLst>
          <pc:docMk/>
          <pc:sldMk cId="1648010966" sldId="338"/>
        </pc:sldMkLst>
      </pc:sldChg>
      <pc:sldChg chg="modSp">
        <pc:chgData name="Rockfeld, Jennifer Prof." userId="S::jrockfeld@quinnipiac.edu::17f6105e-8432-4431-969a-4424c976ccf7" providerId="AD" clId="Web-{1FCAB203-AA4A-4DB8-2032-F4CC8C37B3F4}" dt="2019-11-25T02:27:01.997" v="27" actId="20577"/>
        <pc:sldMkLst>
          <pc:docMk/>
          <pc:sldMk cId="1599298893" sldId="339"/>
        </pc:sldMkLst>
        <pc:spChg chg="mod">
          <ac:chgData name="Rockfeld, Jennifer Prof." userId="S::jrockfeld@quinnipiac.edu::17f6105e-8432-4431-969a-4424c976ccf7" providerId="AD" clId="Web-{1FCAB203-AA4A-4DB8-2032-F4CC8C37B3F4}" dt="2019-11-25T02:27:01.997" v="27" actId="20577"/>
          <ac:spMkLst>
            <pc:docMk/>
            <pc:sldMk cId="1599298893" sldId="339"/>
            <ac:spMk id="2" creationId="{E9E62D93-103E-7C4F-9BE0-BEE05DB7D845}"/>
          </ac:spMkLst>
        </pc:spChg>
      </pc:sldChg>
      <pc:sldChg chg="modSp">
        <pc:chgData name="Rockfeld, Jennifer Prof." userId="S::jrockfeld@quinnipiac.edu::17f6105e-8432-4431-969a-4424c976ccf7" providerId="AD" clId="Web-{1FCAB203-AA4A-4DB8-2032-F4CC8C37B3F4}" dt="2019-11-25T02:42:06.472" v="169" actId="20577"/>
        <pc:sldMkLst>
          <pc:docMk/>
          <pc:sldMk cId="1421912527" sldId="353"/>
        </pc:sldMkLst>
        <pc:spChg chg="mod">
          <ac:chgData name="Rockfeld, Jennifer Prof." userId="S::jrockfeld@quinnipiac.edu::17f6105e-8432-4431-969a-4424c976ccf7" providerId="AD" clId="Web-{1FCAB203-AA4A-4DB8-2032-F4CC8C37B3F4}" dt="2019-11-25T02:42:06.472" v="169" actId="20577"/>
          <ac:spMkLst>
            <pc:docMk/>
            <pc:sldMk cId="1421912527" sldId="353"/>
            <ac:spMk id="3" creationId="{00000000-0000-0000-0000-000000000000}"/>
          </ac:spMkLst>
        </pc:spChg>
      </pc:sldChg>
      <pc:sldChg chg="modNotes">
        <pc:chgData name="Rockfeld, Jennifer Prof." userId="S::jrockfeld@quinnipiac.edu::17f6105e-8432-4431-969a-4424c976ccf7" providerId="AD" clId="Web-{1FCAB203-AA4A-4DB8-2032-F4CC8C37B3F4}" dt="2019-11-25T02:48:31.534" v="285"/>
        <pc:sldMkLst>
          <pc:docMk/>
          <pc:sldMk cId="206664175" sldId="355"/>
        </pc:sldMkLst>
      </pc:sldChg>
      <pc:sldChg chg="modNotes">
        <pc:chgData name="Rockfeld, Jennifer Prof." userId="S::jrockfeld@quinnipiac.edu::17f6105e-8432-4431-969a-4424c976ccf7" providerId="AD" clId="Web-{1FCAB203-AA4A-4DB8-2032-F4CC8C37B3F4}" dt="2019-11-25T02:48:59.347" v="287"/>
        <pc:sldMkLst>
          <pc:docMk/>
          <pc:sldMk cId="755402285" sldId="358"/>
        </pc:sldMkLst>
      </pc:sldChg>
      <pc:sldChg chg="modNotes">
        <pc:chgData name="Rockfeld, Jennifer Prof." userId="S::jrockfeld@quinnipiac.edu::17f6105e-8432-4431-969a-4424c976ccf7" providerId="AD" clId="Web-{1FCAB203-AA4A-4DB8-2032-F4CC8C37B3F4}" dt="2019-11-25T02:51:50.802" v="359"/>
        <pc:sldMkLst>
          <pc:docMk/>
          <pc:sldMk cId="781704880" sldId="359"/>
        </pc:sldMkLst>
      </pc:sldChg>
      <pc:sldChg chg="addSp delSp modSp modNotes">
        <pc:chgData name="Rockfeld, Jennifer Prof." userId="S::jrockfeld@quinnipiac.edu::17f6105e-8432-4431-969a-4424c976ccf7" providerId="AD" clId="Web-{1FCAB203-AA4A-4DB8-2032-F4CC8C37B3F4}" dt="2019-11-25T02:59:22.880" v="838" actId="20577"/>
        <pc:sldMkLst>
          <pc:docMk/>
          <pc:sldMk cId="76843926" sldId="360"/>
        </pc:sldMkLst>
        <pc:spChg chg="add mod">
          <ac:chgData name="Rockfeld, Jennifer Prof." userId="S::jrockfeld@quinnipiac.edu::17f6105e-8432-4431-969a-4424c976ccf7" providerId="AD" clId="Web-{1FCAB203-AA4A-4DB8-2032-F4CC8C37B3F4}" dt="2019-11-25T02:59:22.880" v="838" actId="20577"/>
          <ac:spMkLst>
            <pc:docMk/>
            <pc:sldMk cId="76843926" sldId="360"/>
            <ac:spMk id="3" creationId="{60549520-1119-4687-8F89-050540538F38}"/>
          </ac:spMkLst>
        </pc:spChg>
        <pc:picChg chg="del">
          <ac:chgData name="Rockfeld, Jennifer Prof." userId="S::jrockfeld@quinnipiac.edu::17f6105e-8432-4431-969a-4424c976ccf7" providerId="AD" clId="Web-{1FCAB203-AA4A-4DB8-2032-F4CC8C37B3F4}" dt="2019-11-25T02:54:35.927" v="362"/>
          <ac:picMkLst>
            <pc:docMk/>
            <pc:sldMk cId="76843926" sldId="360"/>
            <ac:picMk id="4" creationId="{125A6823-7F30-4643-868D-E3048375E369}"/>
          </ac:picMkLst>
        </pc:picChg>
        <pc:picChg chg="del">
          <ac:chgData name="Rockfeld, Jennifer Prof." userId="S::jrockfeld@quinnipiac.edu::17f6105e-8432-4431-969a-4424c976ccf7" providerId="AD" clId="Web-{1FCAB203-AA4A-4DB8-2032-F4CC8C37B3F4}" dt="2019-11-25T02:52:21.348" v="360"/>
          <ac:picMkLst>
            <pc:docMk/>
            <pc:sldMk cId="76843926" sldId="360"/>
            <ac:picMk id="4098" creationId="{00000000-0000-0000-0000-000000000000}"/>
          </ac:picMkLst>
        </pc:picChg>
      </pc:sldChg>
      <pc:sldChg chg="modNotes">
        <pc:chgData name="Rockfeld, Jennifer Prof." userId="S::jrockfeld@quinnipiac.edu::17f6105e-8432-4431-969a-4424c976ccf7" providerId="AD" clId="Web-{1FCAB203-AA4A-4DB8-2032-F4CC8C37B3F4}" dt="2019-11-25T03:00:03.958" v="841"/>
        <pc:sldMkLst>
          <pc:docMk/>
          <pc:sldMk cId="759538250" sldId="363"/>
        </pc:sldMkLst>
      </pc:sldChg>
      <pc:sldChg chg="delSp modNotes">
        <pc:chgData name="Rockfeld, Jennifer Prof." userId="S::jrockfeld@quinnipiac.edu::17f6105e-8432-4431-969a-4424c976ccf7" providerId="AD" clId="Web-{1FCAB203-AA4A-4DB8-2032-F4CC8C37B3F4}" dt="2019-11-25T03:00:14.864" v="843"/>
        <pc:sldMkLst>
          <pc:docMk/>
          <pc:sldMk cId="461136317" sldId="364"/>
        </pc:sldMkLst>
        <pc:picChg chg="del">
          <ac:chgData name="Rockfeld, Jennifer Prof." userId="S::jrockfeld@quinnipiac.edu::17f6105e-8432-4431-969a-4424c976ccf7" providerId="AD" clId="Web-{1FCAB203-AA4A-4DB8-2032-F4CC8C37B3F4}" dt="2019-11-25T03:00:12.770" v="842"/>
          <ac:picMkLst>
            <pc:docMk/>
            <pc:sldMk cId="461136317" sldId="364"/>
            <ac:picMk id="1026" creationId="{00000000-0000-0000-0000-000000000000}"/>
          </ac:picMkLst>
        </pc:picChg>
      </pc:sldChg>
      <pc:sldChg chg="addSp add replId">
        <pc:chgData name="Rockfeld, Jennifer Prof." userId="S::jrockfeld@quinnipiac.edu::17f6105e-8432-4431-969a-4424c976ccf7" providerId="AD" clId="Web-{1FCAB203-AA4A-4DB8-2032-F4CC8C37B3F4}" dt="2019-11-25T02:38:06.300" v="133"/>
        <pc:sldMkLst>
          <pc:docMk/>
          <pc:sldMk cId="3116183296" sldId="370"/>
        </pc:sldMkLst>
        <pc:spChg chg="add">
          <ac:chgData name="Rockfeld, Jennifer Prof." userId="S::jrockfeld@quinnipiac.edu::17f6105e-8432-4431-969a-4424c976ccf7" providerId="AD" clId="Web-{1FCAB203-AA4A-4DB8-2032-F4CC8C37B3F4}" dt="2019-11-25T02:38:06.300" v="133"/>
          <ac:spMkLst>
            <pc:docMk/>
            <pc:sldMk cId="3116183296" sldId="370"/>
            <ac:spMk id="3" creationId="{C815C8FE-447B-4A31-ACB3-C25D905AA430}"/>
          </ac:spMkLst>
        </pc:spChg>
      </pc:sldChg>
      <pc:sldChg chg="add del replId">
        <pc:chgData name="Rockfeld, Jennifer Prof." userId="S::jrockfeld@quinnipiac.edu::17f6105e-8432-4431-969a-4424c976ccf7" providerId="AD" clId="Web-{1FCAB203-AA4A-4DB8-2032-F4CC8C37B3F4}" dt="2019-11-25T02:55:26.770" v="364"/>
        <pc:sldMkLst>
          <pc:docMk/>
          <pc:sldMk cId="3630571897" sldId="371"/>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D0A1D60-E0CA-BD4C-AE6B-411F5F382D1B}" type="datetimeFigureOut">
              <a:rPr lang="en-US" smtClean="0"/>
              <a:t>6/19/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7FD3922-A580-0840-94D5-C5F132B230D2}" type="slidenum">
              <a:rPr lang="en-US" smtClean="0"/>
              <a:t>‹#›</a:t>
            </a:fld>
            <a:endParaRPr lang="en-US"/>
          </a:p>
        </p:txBody>
      </p:sp>
    </p:spTree>
    <p:extLst>
      <p:ext uri="{BB962C8B-B14F-4D97-AF65-F5344CB8AC3E}">
        <p14:creationId xmlns:p14="http://schemas.microsoft.com/office/powerpoint/2010/main" val="37275298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www.cdc.gov/nccdphp/dnpao/data-trends-maps/index.html"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cdc.gov/nccdphp/dnpao/data-trends-maps/index.html"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www.cdc.gov/nccdphp/dnpao/data-trends-maps/index.html"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cdc.gov/nccdphp/dnpao/data-trends-maps/index.html"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health.gov/paguidelines/moveyourway/" TargetMode="External"/><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healthypeople.gov/2020/topics-objectives/topic/physical-activity"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ncbi.nlm.nih.gov/pubmed/29288783"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ncbi.nlm.nih.gov/pubmed/25918126"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www.ncbi.nlm.nih.gov/pubmed/18379201"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www.hhs.gov/fitness/be-active/physical-activity-guidelines-for-americans/index.html" TargetMode="External"/><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health.gov/paguidelines/2008/report/pdf/G1_allcause.pdf"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a:solidFill>
                  <a:schemeClr val="tx1"/>
                </a:solidFill>
                <a:effectLst/>
                <a:latin typeface="+mn-lt"/>
                <a:ea typeface="+mn-ea"/>
                <a:cs typeface="+mn-cs"/>
              </a:rPr>
              <a:t>Health experts often remark that if exercise came in pill form it would be the most sought-after drug on the marke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a:solidFill>
                  <a:schemeClr val="tx1"/>
                </a:solidFill>
                <a:effectLst/>
                <a:latin typeface="+mn-lt"/>
                <a:ea typeface="+mn-ea"/>
                <a:cs typeface="+mn-cs"/>
              </a:rPr>
              <a:t>We</a:t>
            </a:r>
            <a:r>
              <a:rPr lang="en-US" sz="1200" b="0" i="0" kern="1200" baseline="0">
                <a:solidFill>
                  <a:schemeClr val="tx1"/>
                </a:solidFill>
                <a:effectLst/>
                <a:latin typeface="+mn-lt"/>
                <a:ea typeface="+mn-ea"/>
                <a:cs typeface="+mn-cs"/>
              </a:rPr>
              <a:t> want to show you how you </a:t>
            </a:r>
            <a:r>
              <a:rPr lang="en-US" sz="1200" b="0" i="0" kern="1200">
                <a:solidFill>
                  <a:schemeClr val="tx1"/>
                </a:solidFill>
                <a:effectLst/>
                <a:latin typeface="+mn-lt"/>
                <a:ea typeface="+mn-ea"/>
                <a:cs typeface="+mn-cs"/>
              </a:rPr>
              <a:t>can use exercise as a first line of prevention and treatment for your</a:t>
            </a:r>
            <a:r>
              <a:rPr lang="en-US" sz="1200" b="0" i="0" kern="1200" baseline="0">
                <a:solidFill>
                  <a:schemeClr val="tx1"/>
                </a:solidFill>
                <a:effectLst/>
                <a:latin typeface="+mn-lt"/>
                <a:ea typeface="+mn-ea"/>
                <a:cs typeface="+mn-cs"/>
              </a:rPr>
              <a:t> </a:t>
            </a:r>
            <a:r>
              <a:rPr lang="en-US" sz="1200" b="0" i="0" kern="1200">
                <a:solidFill>
                  <a:schemeClr val="tx1"/>
                </a:solidFill>
                <a:effectLst/>
                <a:latin typeface="+mn-lt"/>
                <a:ea typeface="+mn-ea"/>
                <a:cs typeface="+mn-cs"/>
              </a:rPr>
              <a:t>patients’ fitness and health.</a:t>
            </a:r>
            <a:endParaRPr lang="en-US" b="0"/>
          </a:p>
          <a:p>
            <a:endParaRPr lang="en-US"/>
          </a:p>
        </p:txBody>
      </p:sp>
      <p:sp>
        <p:nvSpPr>
          <p:cNvPr id="4" name="Slide Number Placeholder 3"/>
          <p:cNvSpPr>
            <a:spLocks noGrp="1"/>
          </p:cNvSpPr>
          <p:nvPr>
            <p:ph type="sldNum" sz="quarter" idx="10"/>
          </p:nvPr>
        </p:nvSpPr>
        <p:spPr/>
        <p:txBody>
          <a:bodyPr/>
          <a:lstStyle/>
          <a:p>
            <a:fld id="{67FD3922-A580-0840-94D5-C5F132B230D2}" type="slidenum">
              <a:rPr lang="en-US" smtClean="0"/>
              <a:t>1</a:t>
            </a:fld>
            <a:endParaRPr lang="en-US"/>
          </a:p>
        </p:txBody>
      </p:sp>
    </p:spTree>
    <p:extLst>
      <p:ext uri="{BB962C8B-B14F-4D97-AF65-F5344CB8AC3E}">
        <p14:creationId xmlns:p14="http://schemas.microsoft.com/office/powerpoint/2010/main" val="177746147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Or a combination,</a:t>
            </a:r>
            <a:r>
              <a:rPr lang="en-US" baseline="0"/>
              <a:t> preferably spread out.</a:t>
            </a:r>
          </a:p>
          <a:p>
            <a:pPr marL="0" marR="0" indent="0" algn="l" defTabSz="914400" rtl="0" eaLnBrk="1" fontAlgn="auto" latinLnBrk="0" hangingPunct="1">
              <a:lnSpc>
                <a:spcPct val="100000"/>
              </a:lnSpc>
              <a:spcBef>
                <a:spcPts val="0"/>
              </a:spcBef>
              <a:spcAft>
                <a:spcPts val="0"/>
              </a:spcAft>
              <a:buClrTx/>
              <a:buSzTx/>
              <a:buFontTx/>
              <a:buNone/>
              <a:tabLst/>
              <a:defRPr/>
            </a:pPr>
            <a:r>
              <a:rPr lang="en-US">
                <a:solidFill>
                  <a:schemeClr val="tx2">
                    <a:lumMod val="40000"/>
                    <a:lumOff val="60000"/>
                  </a:schemeClr>
                </a:solidFill>
              </a:rPr>
              <a:t>Recommendations are similar for adults of all races &amp; ethnicities</a:t>
            </a:r>
            <a:r>
              <a:rPr lang="en-US"/>
              <a:t>.</a:t>
            </a:r>
          </a:p>
          <a:p>
            <a:endParaRPr lang="en-US"/>
          </a:p>
        </p:txBody>
      </p:sp>
      <p:sp>
        <p:nvSpPr>
          <p:cNvPr id="4" name="Slide Number Placeholder 3"/>
          <p:cNvSpPr>
            <a:spLocks noGrp="1"/>
          </p:cNvSpPr>
          <p:nvPr>
            <p:ph type="sldNum" sz="quarter" idx="10"/>
          </p:nvPr>
        </p:nvSpPr>
        <p:spPr/>
        <p:txBody>
          <a:bodyPr/>
          <a:lstStyle/>
          <a:p>
            <a:fld id="{E4D628F0-417F-EA4F-9DBC-294432F3D5CD}" type="slidenum">
              <a:rPr lang="en-US" smtClean="0"/>
              <a:t>10</a:t>
            </a:fld>
            <a:endParaRPr lang="en-US"/>
          </a:p>
        </p:txBody>
      </p:sp>
    </p:spTree>
    <p:extLst>
      <p:ext uri="{BB962C8B-B14F-4D97-AF65-F5344CB8AC3E}">
        <p14:creationId xmlns:p14="http://schemas.microsoft.com/office/powerpoint/2010/main" val="29402753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 guidelines also include specific recommendations for certain populations, including older adults, pregnant women, and adults with health conditions and disabilities.  All of them recommend different ways to get enough movement into one's daily activity.  </a:t>
            </a:r>
            <a:endParaRPr lang="en-US" err="1"/>
          </a:p>
        </p:txBody>
      </p:sp>
      <p:sp>
        <p:nvSpPr>
          <p:cNvPr id="4" name="Slide Number Placeholder 3"/>
          <p:cNvSpPr>
            <a:spLocks noGrp="1"/>
          </p:cNvSpPr>
          <p:nvPr>
            <p:ph type="sldNum" sz="quarter" idx="10"/>
          </p:nvPr>
        </p:nvSpPr>
        <p:spPr/>
        <p:txBody>
          <a:bodyPr/>
          <a:lstStyle/>
          <a:p>
            <a:fld id="{E4D628F0-417F-EA4F-9DBC-294432F3D5CD}" type="slidenum">
              <a:rPr lang="en-US" smtClean="0"/>
              <a:t>11</a:t>
            </a:fld>
            <a:endParaRPr lang="en-US"/>
          </a:p>
        </p:txBody>
      </p:sp>
    </p:spTree>
    <p:extLst>
      <p:ext uri="{BB962C8B-B14F-4D97-AF65-F5344CB8AC3E}">
        <p14:creationId xmlns:p14="http://schemas.microsoft.com/office/powerpoint/2010/main" val="12504946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a:t>National average </a:t>
            </a:r>
            <a:r>
              <a:rPr lang="en-US" b="1"/>
              <a:t>50.3% </a:t>
            </a:r>
            <a:r>
              <a:rPr lang="en-US"/>
              <a:t>for adults getting enough aerobic physical activity. </a:t>
            </a:r>
          </a:p>
          <a:p>
            <a:endParaRPr lang="en-US" b="1"/>
          </a:p>
          <a:p>
            <a:r>
              <a:rPr lang="en-US" sz="1200" b="0" i="0" kern="1200">
                <a:solidFill>
                  <a:schemeClr val="tx1"/>
                </a:solidFill>
                <a:effectLst/>
                <a:latin typeface="+mn-lt"/>
                <a:ea typeface="+mn-ea"/>
                <a:cs typeface="+mn-cs"/>
              </a:rPr>
              <a:t>Centers for Disease Control and Prevention. National Center for Chronic Disease Prevention and Health Promotion, Division of Nutrition, Physical Activity, and Obesity. Data, Trend and Maps [online]. [accessed Nov 26, 2019]. URL: </a:t>
            </a:r>
            <a:r>
              <a:rPr lang="en-US" sz="1200" b="0" i="0" u="none" strike="noStrike" kern="1200">
                <a:solidFill>
                  <a:schemeClr val="tx1"/>
                </a:solidFill>
                <a:effectLst/>
                <a:latin typeface="+mn-lt"/>
                <a:ea typeface="+mn-ea"/>
                <a:cs typeface="+mn-cs"/>
                <a:hlinkClick r:id="rId3"/>
              </a:rPr>
              <a:t>https://www.cdc.gov/nccdphp/dnpao/data-trends-maps/index.html</a:t>
            </a:r>
            <a:r>
              <a:rPr lang="en-US" sz="1200" b="0" i="0" kern="1200">
                <a:solidFill>
                  <a:schemeClr val="tx1"/>
                </a:solidFill>
                <a:effectLst/>
                <a:latin typeface="+mn-lt"/>
                <a:ea typeface="+mn-ea"/>
                <a:cs typeface="+mn-cs"/>
              </a:rPr>
              <a:t>.</a:t>
            </a:r>
            <a:endParaRPr lang="en-US" b="1"/>
          </a:p>
        </p:txBody>
      </p:sp>
      <p:sp>
        <p:nvSpPr>
          <p:cNvPr id="4" name="Slide Number Placeholder 3"/>
          <p:cNvSpPr>
            <a:spLocks noGrp="1"/>
          </p:cNvSpPr>
          <p:nvPr>
            <p:ph type="sldNum" sz="quarter" idx="10"/>
          </p:nvPr>
        </p:nvSpPr>
        <p:spPr/>
        <p:txBody>
          <a:bodyPr/>
          <a:lstStyle/>
          <a:p>
            <a:fld id="{E4D628F0-417F-EA4F-9DBC-294432F3D5CD}" type="slidenum">
              <a:rPr lang="en-US" smtClean="0"/>
              <a:t>12</a:t>
            </a:fld>
            <a:endParaRPr lang="en-US"/>
          </a:p>
        </p:txBody>
      </p:sp>
    </p:spTree>
    <p:extLst>
      <p:ext uri="{BB962C8B-B14F-4D97-AF65-F5344CB8AC3E}">
        <p14:creationId xmlns:p14="http://schemas.microsoft.com/office/powerpoint/2010/main" val="217415693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a:t>National average </a:t>
            </a:r>
            <a:r>
              <a:rPr lang="en-US" b="1"/>
              <a:t>20.3% </a:t>
            </a:r>
            <a:r>
              <a:rPr lang="en-US"/>
              <a:t>for those getting aerobic activity and muscle strengthening activities.  </a:t>
            </a:r>
            <a:endParaRPr lang="en-US" b="1"/>
          </a:p>
          <a:p>
            <a:endParaRPr lang="en-US"/>
          </a:p>
          <a:p>
            <a:r>
              <a:rPr lang="en-US" sz="1200" b="0" i="0" kern="1200">
                <a:solidFill>
                  <a:schemeClr val="tx1"/>
                </a:solidFill>
                <a:effectLst/>
                <a:latin typeface="+mn-lt"/>
                <a:ea typeface="+mn-ea"/>
                <a:cs typeface="+mn-cs"/>
              </a:rPr>
              <a:t>Centers for Disease Control and Prevention. National Center for Chronic Disease Prevention and Health Promotion, Division of Nutrition, Physical Activity, and Obesity. Data, Trend and Maps [online]. [accessed Nov 26, 2019]. URL: </a:t>
            </a:r>
            <a:r>
              <a:rPr lang="en-US" sz="1200" b="0" i="0" u="none" strike="noStrike" kern="1200">
                <a:solidFill>
                  <a:schemeClr val="tx1"/>
                </a:solidFill>
                <a:effectLst/>
                <a:latin typeface="+mn-lt"/>
                <a:ea typeface="+mn-ea"/>
                <a:cs typeface="+mn-cs"/>
                <a:hlinkClick r:id="rId3"/>
              </a:rPr>
              <a:t>https://www.cdc.gov/nccdphp/dnpao/data-trends-maps/index.html</a:t>
            </a:r>
            <a:r>
              <a:rPr lang="en-US" sz="1200" b="0" i="0" kern="1200">
                <a:solidFill>
                  <a:schemeClr val="tx1"/>
                </a:solidFill>
                <a:effectLst/>
                <a:latin typeface="+mn-lt"/>
                <a:ea typeface="+mn-ea"/>
                <a:cs typeface="+mn-cs"/>
              </a:rPr>
              <a:t>.</a:t>
            </a:r>
            <a:endParaRPr lang="en-US"/>
          </a:p>
        </p:txBody>
      </p:sp>
      <p:sp>
        <p:nvSpPr>
          <p:cNvPr id="4" name="Slide Number Placeholder 3"/>
          <p:cNvSpPr>
            <a:spLocks noGrp="1"/>
          </p:cNvSpPr>
          <p:nvPr>
            <p:ph type="sldNum" sz="quarter" idx="10"/>
          </p:nvPr>
        </p:nvSpPr>
        <p:spPr/>
        <p:txBody>
          <a:bodyPr/>
          <a:lstStyle/>
          <a:p>
            <a:fld id="{67FD3922-A580-0840-94D5-C5F132B230D2}" type="slidenum">
              <a:rPr lang="en-US" smtClean="0"/>
              <a:t>13</a:t>
            </a:fld>
            <a:endParaRPr lang="en-US"/>
          </a:p>
        </p:txBody>
      </p:sp>
    </p:spTree>
    <p:extLst>
      <p:ext uri="{BB962C8B-B14F-4D97-AF65-F5344CB8AC3E}">
        <p14:creationId xmlns:p14="http://schemas.microsoft.com/office/powerpoint/2010/main" val="201002738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a:t>National average </a:t>
            </a:r>
            <a:r>
              <a:rPr lang="en-US" b="1"/>
              <a:t>20.3% </a:t>
            </a:r>
            <a:r>
              <a:rPr lang="en-US"/>
              <a:t>for those getting aerobic activity and muscle strengthening activities.  </a:t>
            </a:r>
          </a:p>
          <a:p>
            <a:endParaRPr lang="en-US" b="1"/>
          </a:p>
          <a:p>
            <a:r>
              <a:rPr lang="en-US" sz="1200" b="0" i="0" kern="1200">
                <a:solidFill>
                  <a:schemeClr val="tx1"/>
                </a:solidFill>
                <a:effectLst/>
                <a:latin typeface="+mn-lt"/>
                <a:ea typeface="+mn-ea"/>
                <a:cs typeface="+mn-cs"/>
              </a:rPr>
              <a:t>Centers for Disease Control and Prevention. National Center for Chronic Disease Prevention and Health Promotion, Division of Nutrition, Physical Activity, and Obesity. Data, Trend and Maps [online]. [accessed Nov 26, 2019]. URL: </a:t>
            </a:r>
            <a:r>
              <a:rPr lang="en-US" sz="1200" b="0" i="0" u="none" strike="noStrike" kern="1200">
                <a:solidFill>
                  <a:schemeClr val="tx1"/>
                </a:solidFill>
                <a:effectLst/>
                <a:latin typeface="+mn-lt"/>
                <a:ea typeface="+mn-ea"/>
                <a:cs typeface="+mn-cs"/>
                <a:hlinkClick r:id="rId3"/>
              </a:rPr>
              <a:t>https://www.cdc.gov/nccdphp/dnpao/data-trends-maps/index.html</a:t>
            </a:r>
            <a:r>
              <a:rPr lang="en-US" sz="1200" b="0" i="0" kern="1200">
                <a:solidFill>
                  <a:schemeClr val="tx1"/>
                </a:solidFill>
                <a:effectLst/>
                <a:latin typeface="+mn-lt"/>
                <a:ea typeface="+mn-ea"/>
                <a:cs typeface="+mn-cs"/>
              </a:rPr>
              <a:t>.</a:t>
            </a:r>
            <a:endParaRPr lang="en-US" b="1"/>
          </a:p>
          <a:p>
            <a:endParaRPr lang="en-US"/>
          </a:p>
        </p:txBody>
      </p:sp>
      <p:sp>
        <p:nvSpPr>
          <p:cNvPr id="4" name="Slide Number Placeholder 3"/>
          <p:cNvSpPr>
            <a:spLocks noGrp="1"/>
          </p:cNvSpPr>
          <p:nvPr>
            <p:ph type="sldNum" sz="quarter" idx="10"/>
          </p:nvPr>
        </p:nvSpPr>
        <p:spPr/>
        <p:txBody>
          <a:bodyPr/>
          <a:lstStyle/>
          <a:p>
            <a:fld id="{67FD3922-A580-0840-94D5-C5F132B230D2}" type="slidenum">
              <a:rPr lang="en-US" smtClean="0"/>
              <a:t>14</a:t>
            </a:fld>
            <a:endParaRPr lang="en-US"/>
          </a:p>
        </p:txBody>
      </p:sp>
    </p:spTree>
    <p:extLst>
      <p:ext uri="{BB962C8B-B14F-4D97-AF65-F5344CB8AC3E}">
        <p14:creationId xmlns:p14="http://schemas.microsoft.com/office/powerpoint/2010/main" val="319909400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a:t>National average </a:t>
            </a:r>
            <a:r>
              <a:rPr lang="en-US" b="1"/>
              <a:t>26.6%</a:t>
            </a:r>
            <a:r>
              <a:rPr lang="en-US"/>
              <a:t> for adults who in engage in NO physical activity.  </a:t>
            </a:r>
            <a:endParaRPr lang="en-US" b="1"/>
          </a:p>
          <a:p>
            <a:endParaRPr lang="en-US" b="0"/>
          </a:p>
          <a:p>
            <a:r>
              <a:rPr lang="en-US" b="0"/>
              <a:t>The</a:t>
            </a:r>
            <a:r>
              <a:rPr lang="en-US" b="0" baseline="0"/>
              <a:t> data on these maps illustrate an opportunity for physicians to positively affect the attitudes and behaviors of many patients.</a:t>
            </a:r>
            <a:endParaRPr lang="en-US" b="0"/>
          </a:p>
          <a:p>
            <a:endParaRPr lang="en-US"/>
          </a:p>
          <a:p>
            <a:r>
              <a:rPr lang="en-US" sz="1200" b="0" i="0" kern="1200">
                <a:solidFill>
                  <a:schemeClr val="tx1"/>
                </a:solidFill>
                <a:effectLst/>
                <a:latin typeface="+mn-lt"/>
                <a:ea typeface="+mn-ea"/>
                <a:cs typeface="+mn-cs"/>
              </a:rPr>
              <a:t>Centers for Disease Control and Prevention. National Center for Chronic Disease Prevention and Health Promotion, Division of Nutrition, Physical Activity, and Obesity. Data, Trend and Maps [online]. [accessed Nov 26, 2019]. URL: </a:t>
            </a:r>
            <a:r>
              <a:rPr lang="en-US" sz="1200" b="0" i="0" u="none" strike="noStrike" kern="1200">
                <a:solidFill>
                  <a:schemeClr val="tx1"/>
                </a:solidFill>
                <a:effectLst/>
                <a:latin typeface="+mn-lt"/>
                <a:ea typeface="+mn-ea"/>
                <a:cs typeface="+mn-cs"/>
                <a:hlinkClick r:id="rId3"/>
              </a:rPr>
              <a:t>https://www.cdc.gov/nccdphp/dnpao/data-trends-maps/index.html</a:t>
            </a:r>
            <a:r>
              <a:rPr lang="en-US" sz="1200" b="0" i="0" kern="1200">
                <a:solidFill>
                  <a:schemeClr val="tx1"/>
                </a:solidFill>
                <a:effectLst/>
                <a:latin typeface="+mn-lt"/>
                <a:ea typeface="+mn-ea"/>
                <a:cs typeface="+mn-cs"/>
              </a:rPr>
              <a:t>.</a:t>
            </a:r>
            <a:endParaRPr lang="en-US"/>
          </a:p>
        </p:txBody>
      </p:sp>
      <p:sp>
        <p:nvSpPr>
          <p:cNvPr id="4" name="Slide Number Placeholder 3"/>
          <p:cNvSpPr>
            <a:spLocks noGrp="1"/>
          </p:cNvSpPr>
          <p:nvPr>
            <p:ph type="sldNum" sz="quarter" idx="10"/>
          </p:nvPr>
        </p:nvSpPr>
        <p:spPr/>
        <p:txBody>
          <a:bodyPr/>
          <a:lstStyle/>
          <a:p>
            <a:fld id="{67FD3922-A580-0840-94D5-C5F132B230D2}" type="slidenum">
              <a:rPr lang="en-US" smtClean="0"/>
              <a:t>15</a:t>
            </a:fld>
            <a:endParaRPr lang="en-US"/>
          </a:p>
        </p:txBody>
      </p:sp>
    </p:spTree>
    <p:extLst>
      <p:ext uri="{BB962C8B-B14F-4D97-AF65-F5344CB8AC3E}">
        <p14:creationId xmlns:p14="http://schemas.microsoft.com/office/powerpoint/2010/main" val="908970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a:t>
            </a:r>
            <a:r>
              <a:rPr lang="en-US" b="1"/>
              <a:t>Move Your Way </a:t>
            </a:r>
            <a:r>
              <a:rPr lang="en-US"/>
              <a:t>campaign was created by the Office of Disease Prevention and Health Promotion within the U.S. Department of Health and Human Services to be used by communities, health professionals, educators, and others to communicate to consumers in plain language about the recommendations from the Guidelines, promote the health benefits of meeting the recommendations, and provide tips for how consumers can meet the recommendations. </a:t>
            </a:r>
          </a:p>
          <a:p>
            <a:endParaRPr lang="en-US"/>
          </a:p>
          <a:p>
            <a:r>
              <a:rPr lang="en-US"/>
              <a:t>The</a:t>
            </a:r>
            <a:r>
              <a:rPr lang="en-US" baseline="0"/>
              <a:t> main message: </a:t>
            </a:r>
            <a:r>
              <a:rPr lang="en-US" b="1" baseline="0"/>
              <a:t>Do what you can</a:t>
            </a:r>
          </a:p>
          <a:p>
            <a:endParaRPr lang="en-US" sz="1200" b="1" baseline="0">
              <a:ea typeface="+mn-lt"/>
              <a:cs typeface="+mn-lt"/>
            </a:endParaRPr>
          </a:p>
          <a:p>
            <a:r>
              <a:rPr lang="en-US" sz="1200">
                <a:ea typeface="+mn-lt"/>
                <a:cs typeface="+mn-lt"/>
              </a:rPr>
              <a:t>Move Your Way Campaign Materials. U.S. Department of Health and Human Services website. </a:t>
            </a:r>
            <a:r>
              <a:rPr lang="en-US" sz="1200">
                <a:hlinkClick r:id="rId3"/>
              </a:rPr>
              <a:t>https://health.gov/paguidelines/moveyourway/</a:t>
            </a:r>
            <a:r>
              <a:rPr lang="en-US" sz="1200">
                <a:ea typeface="+mn-lt"/>
                <a:cs typeface="+mn-lt"/>
              </a:rPr>
              <a:t>. Updated November 26, 2019. Accessed November 26, 2019.</a:t>
            </a:r>
            <a:endParaRPr lang="en-US">
              <a:ea typeface="+mn-lt"/>
              <a:cs typeface="+mn-lt"/>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16</a:t>
            </a:fld>
            <a:endParaRPr lang="en-US"/>
          </a:p>
        </p:txBody>
      </p:sp>
    </p:spTree>
    <p:extLst>
      <p:ext uri="{BB962C8B-B14F-4D97-AF65-F5344CB8AC3E}">
        <p14:creationId xmlns:p14="http://schemas.microsoft.com/office/powerpoint/2010/main" val="88581747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a:t>Physicians have been identified</a:t>
            </a:r>
            <a:r>
              <a:rPr lang="en-US" sz="1200" b="1" baseline="0"/>
              <a:t> as having </a:t>
            </a:r>
            <a:r>
              <a:rPr lang="en-US" sz="1200" b="1"/>
              <a:t>a major role in addressing the prevalence of inactivity and its impact on chronic disease.</a:t>
            </a:r>
          </a:p>
          <a:p>
            <a:pPr marL="0" marR="0" indent="0" algn="l" defTabSz="914400" rtl="0" eaLnBrk="1" fontAlgn="auto" latinLnBrk="0" hangingPunct="1">
              <a:lnSpc>
                <a:spcPct val="100000"/>
              </a:lnSpc>
              <a:spcBef>
                <a:spcPts val="0"/>
              </a:spcBef>
              <a:spcAft>
                <a:spcPts val="0"/>
              </a:spcAft>
              <a:buClrTx/>
              <a:buSzTx/>
              <a:buFontTx/>
              <a:buNone/>
              <a:tabLst/>
              <a:defRPr/>
            </a:pPr>
            <a:r>
              <a:rPr lang="en-US"/>
              <a:t>Physicians</a:t>
            </a:r>
            <a:r>
              <a:rPr lang="en-US" baseline="0"/>
              <a:t> see their patients on average 3x/year and should be in a good position to provide continued preventive counseling and feedback.</a:t>
            </a:r>
            <a:endParaRPr lang="en-US" sz="1200">
              <a:cs typeface="Calibri"/>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1"/>
              <a:t>But</a:t>
            </a:r>
            <a:r>
              <a:rPr lang="en-US" sz="1200" b="1" baseline="0"/>
              <a:t> o</a:t>
            </a:r>
            <a:r>
              <a:rPr lang="en-US" sz="1200" b="1"/>
              <a:t>nly 32% of patients report having received physical activity counseling at an office visit in the past year.</a:t>
            </a:r>
            <a:endParaRPr lang="en-US" sz="1200" b="1">
              <a:cs typeface="Calibri"/>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a:cs typeface="Calibri"/>
            </a:endParaRPr>
          </a:p>
          <a:p>
            <a:r>
              <a:rPr lang="en-US"/>
              <a:t>2020 Topics and Objectives: Physical Activity. Office of Disease Prevention and Health Promotion website </a:t>
            </a:r>
            <a:r>
              <a:rPr lang="en-US">
                <a:hlinkClick r:id="rId3"/>
              </a:rPr>
              <a:t>https://www.healthypeople.gov/2020/topics-objectives/topic/physical-activity</a:t>
            </a:r>
            <a:r>
              <a:rPr lang="en-US"/>
              <a:t>.  Updated November 21, 2019.  Accessed November 25, 2019.</a:t>
            </a:r>
            <a:endParaRPr lang="en-US">
              <a:cs typeface="Calibri"/>
            </a:endParaRPr>
          </a:p>
          <a:p>
            <a:endParaRPr lang="en-US"/>
          </a:p>
          <a:p>
            <a:endParaRPr lang="en-US">
              <a:cs typeface="Calibri"/>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17</a:t>
            </a:fld>
            <a:endParaRPr lang="en-US"/>
          </a:p>
        </p:txBody>
      </p:sp>
    </p:spTree>
    <p:extLst>
      <p:ext uri="{BB962C8B-B14F-4D97-AF65-F5344CB8AC3E}">
        <p14:creationId xmlns:p14="http://schemas.microsoft.com/office/powerpoint/2010/main" val="309943851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Only a little more than half of primary care physicians state that they counsel their patients about physical activity.  We are hoping to improve upon that number.  </a:t>
            </a:r>
          </a:p>
          <a:p>
            <a:endParaRPr lang="en-US">
              <a:cs typeface="Calibri"/>
            </a:endParaRPr>
          </a:p>
          <a:p>
            <a:r>
              <a:rPr lang="en-US">
                <a:cs typeface="Calibri"/>
              </a:rPr>
              <a:t>Omura, JD et al.  </a:t>
            </a:r>
            <a:r>
              <a:rPr lang="en-US"/>
              <a:t>Primary care providers' physical activity counseling and referral practices and barriers for cardiovascular disease prevention. </a:t>
            </a:r>
            <a:r>
              <a:rPr lang="en-US" sz="1200" b="0" i="0" u="sng" kern="1200">
                <a:solidFill>
                  <a:schemeClr val="tx1"/>
                </a:solidFill>
                <a:effectLst/>
                <a:latin typeface="+mn-lt"/>
                <a:ea typeface="+mn-ea"/>
                <a:cs typeface="+mn-cs"/>
                <a:hlinkClick r:id="rId3" tooltip="Preventive medicine."/>
              </a:rPr>
              <a:t>Prev Med.</a:t>
            </a:r>
            <a:r>
              <a:rPr lang="en-US" sz="1200" b="0" i="0" kern="1200">
                <a:solidFill>
                  <a:schemeClr val="tx1"/>
                </a:solidFill>
                <a:effectLst/>
                <a:latin typeface="+mn-lt"/>
                <a:ea typeface="+mn-ea"/>
                <a:cs typeface="+mn-cs"/>
              </a:rPr>
              <a:t> 2018 Mar;108:115-122.</a:t>
            </a:r>
            <a:endParaRPr lang="en-US">
              <a:cs typeface="Calibri"/>
            </a:endParaRPr>
          </a:p>
          <a:p>
            <a:endParaRPr lang="en-US">
              <a:cs typeface="Calibri"/>
            </a:endParaRPr>
          </a:p>
          <a:p>
            <a:endParaRPr lang="en-US"/>
          </a:p>
          <a:p>
            <a:endParaRPr lang="en-US">
              <a:cs typeface="Calibri"/>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18</a:t>
            </a:fld>
            <a:endParaRPr lang="en-US"/>
          </a:p>
        </p:txBody>
      </p:sp>
    </p:spTree>
    <p:extLst>
      <p:ext uri="{BB962C8B-B14F-4D97-AF65-F5344CB8AC3E}">
        <p14:creationId xmlns:p14="http://schemas.microsoft.com/office/powerpoint/2010/main" val="92373202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a:t>
            </a:r>
            <a:r>
              <a:rPr lang="en-US" b="1"/>
              <a:t>Plan</a:t>
            </a:r>
            <a:r>
              <a:rPr lang="en-US"/>
              <a:t> is a comprehensive set of </a:t>
            </a:r>
            <a:r>
              <a:rPr lang="en-US" b="1"/>
              <a:t>policies, programs, and initiatives </a:t>
            </a:r>
            <a:r>
              <a:rPr lang="en-US"/>
              <a:t>designed to increase physical activity in all segments of the U.S. population. </a:t>
            </a:r>
          </a:p>
          <a:p>
            <a:endParaRPr lang="en-US"/>
          </a:p>
          <a:p>
            <a:pPr algn="l"/>
            <a:r>
              <a:rPr lang="en-US" b="0" i="0">
                <a:solidFill>
                  <a:srgbClr val="000000"/>
                </a:solidFill>
                <a:effectLst/>
                <a:latin typeface="arial" panose="020B0604020202020204" pitchFamily="34" charset="0"/>
              </a:rPr>
              <a:t>Kraus WE et al.  The National Physical Activity Plan: a call to action from the American Heart Association: a science advisory from the American Heart Associa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sng" kern="1200">
                <a:solidFill>
                  <a:schemeClr val="tx1"/>
                </a:solidFill>
                <a:effectLst/>
                <a:latin typeface="+mn-lt"/>
                <a:ea typeface="+mn-ea"/>
                <a:cs typeface="+mn-cs"/>
                <a:hlinkClick r:id="rId3" tooltip="Circulation."/>
              </a:rPr>
              <a:t>Circulation.</a:t>
            </a:r>
            <a:r>
              <a:rPr lang="en-US" sz="1200" b="0" i="0" kern="1200">
                <a:solidFill>
                  <a:schemeClr val="tx1"/>
                </a:solidFill>
                <a:effectLst/>
                <a:latin typeface="+mn-lt"/>
                <a:ea typeface="+mn-ea"/>
                <a:cs typeface="+mn-cs"/>
              </a:rPr>
              <a:t> 2015 May 26;131(21):1932-40.</a:t>
            </a:r>
            <a:endParaRPr lang="en-US">
              <a:cs typeface="Calibri"/>
            </a:endParaRPr>
          </a:p>
          <a:p>
            <a:endParaRPr lang="en-US"/>
          </a:p>
          <a:p>
            <a:endParaRPr lang="en-US">
              <a:cs typeface="Calibri"/>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19</a:t>
            </a:fld>
            <a:endParaRPr lang="en-US"/>
          </a:p>
        </p:txBody>
      </p:sp>
    </p:spTree>
    <p:extLst>
      <p:ext uri="{BB962C8B-B14F-4D97-AF65-F5344CB8AC3E}">
        <p14:creationId xmlns:p14="http://schemas.microsoft.com/office/powerpoint/2010/main" val="23805494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4D628F0-417F-EA4F-9DBC-294432F3D5CD}" type="slidenum">
              <a:rPr lang="en-US" smtClean="0"/>
              <a:t>2</a:t>
            </a:fld>
            <a:endParaRPr lang="en-US"/>
          </a:p>
        </p:txBody>
      </p:sp>
    </p:spTree>
    <p:extLst>
      <p:ext uri="{BB962C8B-B14F-4D97-AF65-F5344CB8AC3E}">
        <p14:creationId xmlns:p14="http://schemas.microsoft.com/office/powerpoint/2010/main" val="360034588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As with much counseling around behavior change, your level of physical activity informs how much you counsel your patients in this area.   </a:t>
            </a:r>
          </a:p>
          <a:p>
            <a:endParaRPr lang="en-US"/>
          </a:p>
          <a:p>
            <a:r>
              <a:rPr lang="en-US"/>
              <a:t>Frank, E et al.  Physical activity levels and counseling practices of U.S. medical students.  </a:t>
            </a:r>
            <a:r>
              <a:rPr lang="en-US" sz="1200" b="0" i="0" u="sng" kern="1200">
                <a:solidFill>
                  <a:schemeClr val="tx1"/>
                </a:solidFill>
                <a:effectLst/>
                <a:latin typeface="+mn-lt"/>
                <a:ea typeface="+mn-ea"/>
                <a:cs typeface="+mn-cs"/>
                <a:hlinkClick r:id="rId3" tooltip="Medicine and science in sports and exercise."/>
              </a:rPr>
              <a:t>Med Sci Sports Exerc.</a:t>
            </a:r>
            <a:r>
              <a:rPr lang="en-US" sz="1200" b="0" i="0" kern="1200">
                <a:solidFill>
                  <a:schemeClr val="tx1"/>
                </a:solidFill>
                <a:effectLst/>
                <a:latin typeface="+mn-lt"/>
                <a:ea typeface="+mn-ea"/>
                <a:cs typeface="+mn-cs"/>
              </a:rPr>
              <a:t> 2008 Mar;40(3):413-21.</a:t>
            </a:r>
            <a:endParaRPr lang="en-US"/>
          </a:p>
          <a:p>
            <a:endParaRPr lang="en-US">
              <a:cs typeface="Calibri"/>
            </a:endParaRPr>
          </a:p>
          <a:p>
            <a:endParaRPr lang="en-US">
              <a:cs typeface="Calibri"/>
            </a:endParaRPr>
          </a:p>
          <a:p>
            <a:endParaRPr lang="en-US">
              <a:cs typeface="Calibri"/>
            </a:endParaRPr>
          </a:p>
          <a:p>
            <a:endParaRPr lang="en-US"/>
          </a:p>
          <a:p>
            <a:endParaRPr lang="en-US">
              <a:cs typeface="Calibri"/>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20</a:t>
            </a:fld>
            <a:endParaRPr lang="en-US"/>
          </a:p>
        </p:txBody>
      </p:sp>
    </p:spTree>
    <p:extLst>
      <p:ext uri="{BB962C8B-B14F-4D97-AF65-F5344CB8AC3E}">
        <p14:creationId xmlns:p14="http://schemas.microsoft.com/office/powerpoint/2010/main" val="323080917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cs typeface="Calibri"/>
            </a:endParaRPr>
          </a:p>
        </p:txBody>
      </p:sp>
      <p:sp>
        <p:nvSpPr>
          <p:cNvPr id="4" name="Slide Number Placeholder 3"/>
          <p:cNvSpPr>
            <a:spLocks noGrp="1"/>
          </p:cNvSpPr>
          <p:nvPr>
            <p:ph type="sldNum" sz="quarter" idx="10"/>
          </p:nvPr>
        </p:nvSpPr>
        <p:spPr/>
        <p:txBody>
          <a:bodyPr/>
          <a:lstStyle/>
          <a:p>
            <a:fld id="{B832F658-E19B-EB4A-A2B9-AFCA183D6E3B}" type="slidenum">
              <a:rPr lang="en-US" smtClean="0"/>
              <a:t>21</a:t>
            </a:fld>
            <a:endParaRPr lang="en-US"/>
          </a:p>
        </p:txBody>
      </p:sp>
    </p:spTree>
    <p:extLst>
      <p:ext uri="{BB962C8B-B14F-4D97-AF65-F5344CB8AC3E}">
        <p14:creationId xmlns:p14="http://schemas.microsoft.com/office/powerpoint/2010/main" val="49541540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cs typeface="Calibri"/>
            </a:endParaRPr>
          </a:p>
        </p:txBody>
      </p:sp>
      <p:sp>
        <p:nvSpPr>
          <p:cNvPr id="4" name="Slide Number Placeholder 3"/>
          <p:cNvSpPr>
            <a:spLocks noGrp="1"/>
          </p:cNvSpPr>
          <p:nvPr>
            <p:ph type="sldNum" sz="quarter" idx="10"/>
          </p:nvPr>
        </p:nvSpPr>
        <p:spPr/>
        <p:txBody>
          <a:bodyPr/>
          <a:lstStyle/>
          <a:p>
            <a:fld id="{B832F658-E19B-EB4A-A2B9-AFCA183D6E3B}" type="slidenum">
              <a:rPr lang="en-US" smtClean="0"/>
              <a:t>22</a:t>
            </a:fld>
            <a:endParaRPr lang="en-US"/>
          </a:p>
        </p:txBody>
      </p:sp>
    </p:spTree>
    <p:extLst>
      <p:ext uri="{BB962C8B-B14F-4D97-AF65-F5344CB8AC3E}">
        <p14:creationId xmlns:p14="http://schemas.microsoft.com/office/powerpoint/2010/main" val="12288293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cs typeface="Calibri"/>
              <a:hlinkClick r:id="" action="ppaction://noaction"/>
            </a:endParaRPr>
          </a:p>
        </p:txBody>
      </p:sp>
      <p:sp>
        <p:nvSpPr>
          <p:cNvPr id="4" name="Slide Number Placeholder 3"/>
          <p:cNvSpPr>
            <a:spLocks noGrp="1"/>
          </p:cNvSpPr>
          <p:nvPr>
            <p:ph type="sldNum" sz="quarter" idx="10"/>
          </p:nvPr>
        </p:nvSpPr>
        <p:spPr/>
        <p:txBody>
          <a:bodyPr/>
          <a:lstStyle/>
          <a:p>
            <a:fld id="{B832F658-E19B-EB4A-A2B9-AFCA183D6E3B}" type="slidenum">
              <a:rPr lang="en-US" smtClean="0"/>
              <a:t>23</a:t>
            </a:fld>
            <a:endParaRPr lang="en-US"/>
          </a:p>
        </p:txBody>
      </p:sp>
    </p:spTree>
    <p:extLst>
      <p:ext uri="{BB962C8B-B14F-4D97-AF65-F5344CB8AC3E}">
        <p14:creationId xmlns:p14="http://schemas.microsoft.com/office/powerpoint/2010/main" val="414874930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832F658-E19B-EB4A-A2B9-AFCA183D6E3B}" type="slidenum">
              <a:rPr lang="en-US" smtClean="0"/>
              <a:t>24</a:t>
            </a:fld>
            <a:endParaRPr lang="en-US"/>
          </a:p>
        </p:txBody>
      </p:sp>
    </p:spTree>
    <p:extLst>
      <p:ext uri="{BB962C8B-B14F-4D97-AF65-F5344CB8AC3E}">
        <p14:creationId xmlns:p14="http://schemas.microsoft.com/office/powerpoint/2010/main" val="133420339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 A questionnaire such as this one can assess the patient's readiness for change.    Once you determine where the patient is, you can try to move them forward.  </a:t>
            </a:r>
            <a:endParaRPr lang="en-US">
              <a:cs typeface="Calibri"/>
            </a:endParaRPr>
          </a:p>
          <a:p>
            <a:r>
              <a:rPr lang="en-US">
                <a:cs typeface="Calibri"/>
              </a:rPr>
              <a:t>'No' to all of the questions indicates pre-contemplative stage.  A 'yes' to question two, but 'no' to the others, indicates contemplative stage.  A 'yes' to questions one and two is preparation stage, and a 'yes' to questions one and three is action stage.  A 'yes' to question 4 indicates maintenance stage.  </a:t>
            </a:r>
          </a:p>
        </p:txBody>
      </p:sp>
      <p:sp>
        <p:nvSpPr>
          <p:cNvPr id="4" name="Slide Number Placeholder 3"/>
          <p:cNvSpPr>
            <a:spLocks noGrp="1"/>
          </p:cNvSpPr>
          <p:nvPr>
            <p:ph type="sldNum" sz="quarter" idx="5"/>
          </p:nvPr>
        </p:nvSpPr>
        <p:spPr/>
        <p:txBody>
          <a:bodyPr/>
          <a:lstStyle/>
          <a:p>
            <a:fld id="{67FD3922-A580-0840-94D5-C5F132B230D2}" type="slidenum">
              <a:rPr lang="en-US" smtClean="0"/>
              <a:t>25</a:t>
            </a:fld>
            <a:endParaRPr lang="en-US"/>
          </a:p>
        </p:txBody>
      </p:sp>
    </p:spTree>
    <p:extLst>
      <p:ext uri="{BB962C8B-B14F-4D97-AF65-F5344CB8AC3E}">
        <p14:creationId xmlns:p14="http://schemas.microsoft.com/office/powerpoint/2010/main" val="26614383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7FD3922-A580-0840-94D5-C5F132B230D2}" type="slidenum">
              <a:rPr lang="en-US" smtClean="0"/>
              <a:t>26</a:t>
            </a:fld>
            <a:endParaRPr lang="en-US"/>
          </a:p>
        </p:txBody>
      </p:sp>
    </p:spTree>
    <p:extLst>
      <p:ext uri="{BB962C8B-B14F-4D97-AF65-F5344CB8AC3E}">
        <p14:creationId xmlns:p14="http://schemas.microsoft.com/office/powerpoint/2010/main" val="118297180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7FD3922-A580-0840-94D5-C5F132B230D2}" type="slidenum">
              <a:rPr lang="en-US" smtClean="0"/>
              <a:t>27</a:t>
            </a:fld>
            <a:endParaRPr lang="en-US"/>
          </a:p>
        </p:txBody>
      </p:sp>
    </p:spTree>
    <p:extLst>
      <p:ext uri="{BB962C8B-B14F-4D97-AF65-F5344CB8AC3E}">
        <p14:creationId xmlns:p14="http://schemas.microsoft.com/office/powerpoint/2010/main" val="119630257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cs typeface="Calibri"/>
            </a:endParaRPr>
          </a:p>
        </p:txBody>
      </p:sp>
      <p:sp>
        <p:nvSpPr>
          <p:cNvPr id="4" name="Slide Number Placeholder 3"/>
          <p:cNvSpPr>
            <a:spLocks noGrp="1"/>
          </p:cNvSpPr>
          <p:nvPr>
            <p:ph type="sldNum" sz="quarter" idx="10"/>
          </p:nvPr>
        </p:nvSpPr>
        <p:spPr/>
        <p:txBody>
          <a:bodyPr/>
          <a:lstStyle/>
          <a:p>
            <a:fld id="{B832F658-E19B-EB4A-A2B9-AFCA183D6E3B}" type="slidenum">
              <a:rPr lang="en-US" smtClean="0"/>
              <a:t>28</a:t>
            </a:fld>
            <a:endParaRPr lang="en-US"/>
          </a:p>
        </p:txBody>
      </p:sp>
    </p:spTree>
    <p:extLst>
      <p:ext uri="{BB962C8B-B14F-4D97-AF65-F5344CB8AC3E}">
        <p14:creationId xmlns:p14="http://schemas.microsoft.com/office/powerpoint/2010/main" val="195644946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a:cs typeface="Calibri"/>
              </a:rPr>
              <a:t>There are algorithms available to screen patients to determine whether it is safe for them to start an exercise program. If there is known pre-existing disease or signs/symptoms of disease, the patient may need a cardiac evaluation (</a:t>
            </a:r>
            <a:r>
              <a:rPr lang="en-US" err="1">
                <a:cs typeface="Calibri"/>
              </a:rPr>
              <a:t>eg</a:t>
            </a:r>
            <a:r>
              <a:rPr lang="en-US">
                <a:cs typeface="Calibri"/>
              </a:rPr>
              <a:t> exercise stress test) prior to participating in more rigorous activity.  </a:t>
            </a:r>
            <a:endParaRPr lang="en-US"/>
          </a:p>
          <a:p>
            <a:pPr>
              <a:defRPr/>
            </a:pPr>
            <a:r>
              <a:rPr lang="en-US"/>
              <a:t>Riebe D et al. Updating ACSM’s Recommendations for Exercise Preparticipation Health Screening. Medicine &amp; Science in Sports &amp; Exercise. 2015; 47(11):2473–2479.</a:t>
            </a:r>
            <a:endParaRPr lang="en-US">
              <a:hlinkClick r:id="" action="ppaction://noaction"/>
            </a:endParaRPr>
          </a:p>
          <a:p>
            <a:pPr>
              <a:defRPr/>
            </a:pPr>
            <a:endParaRPr lang="en-US">
              <a:hlinkClick r:id="" action="ppaction://noaction"/>
            </a:endParaRPr>
          </a:p>
          <a:p>
            <a:r>
              <a:rPr lang="en-US">
                <a:hlinkClick r:id="" action="ppaction://noaction"/>
              </a:rPr>
              <a:t>The Department of Health and Human Services issued the federal government's first-ever </a:t>
            </a:r>
            <a:r>
              <a:rPr lang="en-US" i="1">
                <a:hlinkClick r:id="" action="ppaction://noaction"/>
              </a:rPr>
              <a:t>Physical Activity Guidelines for Americans</a:t>
            </a:r>
            <a:r>
              <a:rPr lang="en-US">
                <a:hlinkClick r:id="" action="ppaction://noaction"/>
              </a:rPr>
              <a:t> in 2008 to help Americans understand the types and amounts of physical activity that offer important health benefits.  This edition of the Guidelines discusses the proven benefits of physical activity and outlines the amounts and types of physical activity recommended for different ages and populations.</a:t>
            </a:r>
          </a:p>
          <a:p>
            <a:r>
              <a:rPr lang="en-US">
                <a:hlinkClick r:id="" action="ppaction://noaction"/>
              </a:rPr>
              <a:t>U.S. Department of Health and Human Services President's Council on Sports, Fitness &amp; Nutrition website.</a:t>
            </a:r>
            <a:r>
              <a:rPr lang="en-US"/>
              <a:t> </a:t>
            </a:r>
            <a:r>
              <a:rPr lang="en-US">
                <a:hlinkClick r:id="rId3"/>
              </a:rPr>
              <a:t>https://www.hhs.gov/fitness/be-active/physical-activity-guidelines-for-americans/index.html</a:t>
            </a:r>
            <a:r>
              <a:rPr lang="en-US" b="1"/>
              <a:t>  </a:t>
            </a:r>
            <a:r>
              <a:rPr lang="en-US"/>
              <a:t>Accessed March 3rd, 2020.</a:t>
            </a:r>
            <a:endParaRPr lang="en-US">
              <a:cs typeface="Calibri"/>
            </a:endParaRPr>
          </a:p>
          <a:p>
            <a:endParaRPr lang="en-US">
              <a:cs typeface="Calibri"/>
            </a:endParaRPr>
          </a:p>
        </p:txBody>
      </p:sp>
      <p:sp>
        <p:nvSpPr>
          <p:cNvPr id="4" name="Slide Number Placeholder 3"/>
          <p:cNvSpPr>
            <a:spLocks noGrp="1"/>
          </p:cNvSpPr>
          <p:nvPr>
            <p:ph type="sldNum" sz="quarter" idx="10"/>
          </p:nvPr>
        </p:nvSpPr>
        <p:spPr/>
        <p:txBody>
          <a:bodyPr/>
          <a:lstStyle/>
          <a:p>
            <a:fld id="{67FD3922-A580-0840-94D5-C5F132B230D2}" type="slidenum">
              <a:rPr lang="en-US" smtClean="0"/>
              <a:t>29</a:t>
            </a:fld>
            <a:endParaRPr lang="en-US"/>
          </a:p>
        </p:txBody>
      </p:sp>
    </p:spTree>
    <p:extLst>
      <p:ext uri="{BB962C8B-B14F-4D97-AF65-F5344CB8AC3E}">
        <p14:creationId xmlns:p14="http://schemas.microsoft.com/office/powerpoint/2010/main" val="11107038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0"/>
              <a:t>2008 Physical Activity Guidelines for Americans</a:t>
            </a:r>
          </a:p>
          <a:p>
            <a:pPr marL="171450" indent="-171450">
              <a:buFont typeface="Arial" panose="020B0604020202020204" pitchFamily="34" charset="0"/>
              <a:buChar char="•"/>
            </a:pPr>
            <a:r>
              <a:rPr lang="en-US" i="0"/>
              <a:t>1</a:t>
            </a:r>
            <a:r>
              <a:rPr lang="en-US" i="0" baseline="30000"/>
              <a:t>st</a:t>
            </a:r>
            <a:r>
              <a:rPr lang="en-US" i="0"/>
              <a:t> comprehensive guidelines on physical activity ever to be issued by the federal government. </a:t>
            </a:r>
          </a:p>
          <a:p>
            <a:pPr marL="171450" indent="-171450">
              <a:buFont typeface="Arial" panose="020B0604020202020204" pitchFamily="34" charset="0"/>
              <a:buChar char="•"/>
            </a:pPr>
            <a:r>
              <a:rPr lang="en-US" i="0"/>
              <a:t>Intended as a primary source of information for policy makers, physical educators, health providers, and the public </a:t>
            </a:r>
          </a:p>
          <a:p>
            <a:pPr marL="171450" indent="-171450">
              <a:buFont typeface="Arial" panose="020B0604020202020204" pitchFamily="34" charset="0"/>
              <a:buChar char="•"/>
            </a:pPr>
            <a:r>
              <a:rPr lang="en-US" i="0"/>
              <a:t>Describes amount, types, and intensity of physical activity needed to achieve many health benefits for Americans across their life span.</a:t>
            </a:r>
            <a:r>
              <a:rPr lang="en-US"/>
              <a:t> </a:t>
            </a:r>
            <a:endParaRPr lang="en-US">
              <a:cs typeface="Calibri"/>
            </a:endParaRPr>
          </a:p>
          <a:p>
            <a:endParaRPr lang="en-US">
              <a:cs typeface="Calibri"/>
              <a:hlinkClick r:id="rId3"/>
            </a:endParaRPr>
          </a:p>
          <a:p>
            <a:r>
              <a:rPr lang="en-US" sz="1200"/>
              <a:t>The</a:t>
            </a:r>
            <a:r>
              <a:rPr lang="en-US" sz="1200" baseline="0"/>
              <a:t> original 2008 was </a:t>
            </a:r>
            <a:r>
              <a:rPr lang="en-US"/>
              <a:t>updated</a:t>
            </a:r>
            <a:r>
              <a:rPr lang="en-US" sz="1200" baseline="0"/>
              <a:t> in 2018.</a:t>
            </a:r>
            <a:endParaRPr lang="en-US" sz="1200"/>
          </a:p>
          <a:p>
            <a:r>
              <a:rPr lang="en-US"/>
              <a:t>The primary audience for the Physical Activity Guidelines for Americans is </a:t>
            </a:r>
            <a:r>
              <a:rPr lang="en-US" b="1"/>
              <a:t>policy makers </a:t>
            </a:r>
            <a:r>
              <a:rPr lang="en-US"/>
              <a:t>and </a:t>
            </a:r>
            <a:r>
              <a:rPr lang="en-US" b="1"/>
              <a:t>health professionals</a:t>
            </a:r>
            <a:r>
              <a:rPr lang="en-US" b="0"/>
              <a:t>.</a:t>
            </a:r>
          </a:p>
          <a:p>
            <a:r>
              <a:rPr lang="en-US"/>
              <a:t>The main idea behind the Guidelines is that regular physical activity over months and years can produce long-term health benefits. </a:t>
            </a:r>
          </a:p>
          <a:p>
            <a:endParaRPr lang="en-US"/>
          </a:p>
          <a:p>
            <a:r>
              <a:rPr lang="en-US"/>
              <a:t>U.S. Department of Health and Human Services. Physical Activity Guidelines for Americans, 2nd edition. Washington, DC: U.S. Department of Health and Human Services; 2018. </a:t>
            </a:r>
            <a:endParaRPr lang="en-US">
              <a:cs typeface="Calibri"/>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3</a:t>
            </a:fld>
            <a:endParaRPr lang="en-US"/>
          </a:p>
        </p:txBody>
      </p:sp>
    </p:spTree>
    <p:extLst>
      <p:ext uri="{BB962C8B-B14F-4D97-AF65-F5344CB8AC3E}">
        <p14:creationId xmlns:p14="http://schemas.microsoft.com/office/powerpoint/2010/main" val="151116879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cs typeface="Calibri"/>
            </a:endParaRPr>
          </a:p>
        </p:txBody>
      </p:sp>
      <p:sp>
        <p:nvSpPr>
          <p:cNvPr id="4" name="Slide Number Placeholder 3"/>
          <p:cNvSpPr>
            <a:spLocks noGrp="1"/>
          </p:cNvSpPr>
          <p:nvPr>
            <p:ph type="sldNum" sz="quarter" idx="10"/>
          </p:nvPr>
        </p:nvSpPr>
        <p:spPr/>
        <p:txBody>
          <a:bodyPr/>
          <a:lstStyle/>
          <a:p>
            <a:fld id="{B832F658-E19B-EB4A-A2B9-AFCA183D6E3B}" type="slidenum">
              <a:rPr lang="en-US" smtClean="0"/>
              <a:t>30</a:t>
            </a:fld>
            <a:endParaRPr lang="en-US"/>
          </a:p>
        </p:txBody>
      </p:sp>
    </p:spTree>
    <p:extLst>
      <p:ext uri="{BB962C8B-B14F-4D97-AF65-F5344CB8AC3E}">
        <p14:creationId xmlns:p14="http://schemas.microsoft.com/office/powerpoint/2010/main" val="91656998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If a patient is ready to start making changes, you can help by outlining specific ways s/he can increase his/her physical activity.  It is also helpful to refer to local resources in the community.</a:t>
            </a:r>
            <a:endParaRPr lang="en-US"/>
          </a:p>
          <a:p>
            <a:endParaRPr lang="en-US">
              <a:cs typeface="Calibri"/>
            </a:endParaRPr>
          </a:p>
        </p:txBody>
      </p:sp>
      <p:sp>
        <p:nvSpPr>
          <p:cNvPr id="4" name="Slide Number Placeholder 3"/>
          <p:cNvSpPr>
            <a:spLocks noGrp="1"/>
          </p:cNvSpPr>
          <p:nvPr>
            <p:ph type="sldNum" sz="quarter" idx="10"/>
          </p:nvPr>
        </p:nvSpPr>
        <p:spPr/>
        <p:txBody>
          <a:bodyPr/>
          <a:lstStyle/>
          <a:p>
            <a:fld id="{67FD3922-A580-0840-94D5-C5F132B230D2}" type="slidenum">
              <a:rPr lang="en-US" smtClean="0"/>
              <a:t>31</a:t>
            </a:fld>
            <a:endParaRPr lang="en-US"/>
          </a:p>
        </p:txBody>
      </p:sp>
    </p:spTree>
    <p:extLst>
      <p:ext uri="{BB962C8B-B14F-4D97-AF65-F5344CB8AC3E}">
        <p14:creationId xmlns:p14="http://schemas.microsoft.com/office/powerpoint/2010/main" val="269764357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832F658-E19B-EB4A-A2B9-AFCA183D6E3B}" type="slidenum">
              <a:rPr lang="en-US" smtClean="0"/>
              <a:t>32</a:t>
            </a:fld>
            <a:endParaRPr lang="en-US"/>
          </a:p>
        </p:txBody>
      </p:sp>
    </p:spTree>
    <p:extLst>
      <p:ext uri="{BB962C8B-B14F-4D97-AF65-F5344CB8AC3E}">
        <p14:creationId xmlns:p14="http://schemas.microsoft.com/office/powerpoint/2010/main" val="267107509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Patient's self-efficacy, motivation, and provider's competence are key components that predict success.  </a:t>
            </a:r>
          </a:p>
        </p:txBody>
      </p:sp>
      <p:sp>
        <p:nvSpPr>
          <p:cNvPr id="4" name="Slide Number Placeholder 3"/>
          <p:cNvSpPr>
            <a:spLocks noGrp="1"/>
          </p:cNvSpPr>
          <p:nvPr>
            <p:ph type="sldNum" sz="quarter" idx="5"/>
          </p:nvPr>
        </p:nvSpPr>
        <p:spPr/>
        <p:txBody>
          <a:bodyPr/>
          <a:lstStyle/>
          <a:p>
            <a:fld id="{67FD3922-A580-0840-94D5-C5F132B230D2}" type="slidenum">
              <a:rPr lang="en-US" smtClean="0"/>
              <a:t>33</a:t>
            </a:fld>
            <a:endParaRPr lang="en-US"/>
          </a:p>
        </p:txBody>
      </p:sp>
    </p:spTree>
    <p:extLst>
      <p:ext uri="{BB962C8B-B14F-4D97-AF65-F5344CB8AC3E}">
        <p14:creationId xmlns:p14="http://schemas.microsoft.com/office/powerpoint/2010/main" val="27493271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is-IS"/>
              <a:t>Specific</a:t>
            </a:r>
            <a:r>
              <a:rPr lang="is-IS" baseline="0"/>
              <a:t>ally for </a:t>
            </a:r>
            <a:r>
              <a:rPr lang="is-IS" baseline="0" err="1"/>
              <a:t>medical</a:t>
            </a:r>
            <a:r>
              <a:rPr lang="is-IS" baseline="0"/>
              <a:t> </a:t>
            </a:r>
            <a:r>
              <a:rPr lang="is-IS" baseline="0" err="1"/>
              <a:t>students</a:t>
            </a:r>
            <a:r>
              <a:rPr lang="is-IS" baseline="0"/>
              <a:t>, PA </a:t>
            </a:r>
            <a:r>
              <a:rPr lang="is-IS" baseline="0" err="1"/>
              <a:t>has</a:t>
            </a:r>
            <a:r>
              <a:rPr lang="is-IS" baseline="0"/>
              <a:t> a </a:t>
            </a:r>
            <a:r>
              <a:rPr lang="is-IS" baseline="0" err="1"/>
              <a:t>host</a:t>
            </a:r>
            <a:r>
              <a:rPr lang="is-IS" baseline="0"/>
              <a:t> of </a:t>
            </a:r>
            <a:r>
              <a:rPr lang="is-IS" baseline="0" err="1"/>
              <a:t>positive</a:t>
            </a:r>
            <a:r>
              <a:rPr lang="is-IS" baseline="0"/>
              <a:t> </a:t>
            </a:r>
            <a:r>
              <a:rPr lang="is-IS" baseline="0" err="1"/>
              <a:t>effects</a:t>
            </a:r>
            <a:r>
              <a:rPr lang="is-IS" baseline="0"/>
              <a:t> on </a:t>
            </a:r>
            <a:r>
              <a:rPr lang="is-IS" baseline="0" err="1"/>
              <a:t>cognitive</a:t>
            </a:r>
            <a:r>
              <a:rPr lang="is-IS" baseline="0"/>
              <a:t> function.</a:t>
            </a:r>
            <a:endParaRPr lang="is-IS">
              <a:cs typeface="Calibri"/>
            </a:endParaRPr>
          </a:p>
          <a:p>
            <a:endParaRPr lang="en-US" baseline="0">
              <a:cs typeface="Calibri"/>
            </a:endParaRPr>
          </a:p>
          <a:p>
            <a:r>
              <a:rPr lang="is-IS">
                <a:cs typeface="Calibri"/>
              </a:rPr>
              <a:t>A recent study was done in</a:t>
            </a:r>
            <a:r>
              <a:rPr lang="en-US">
                <a:cs typeface="Calibri"/>
              </a:rPr>
              <a:t> </a:t>
            </a:r>
            <a:r>
              <a:rPr lang="en-US" err="1">
                <a:cs typeface="Calibri"/>
              </a:rPr>
              <a:t>Saudia</a:t>
            </a:r>
            <a:r>
              <a:rPr lang="en-US">
                <a:cs typeface="Calibri"/>
              </a:rPr>
              <a:t> Arabia where they found that 47% of medical students were physically active.  Those students who exercised had higher GPAs.</a:t>
            </a:r>
          </a:p>
          <a:p>
            <a:endParaRPr lang="is-IS"/>
          </a:p>
          <a:p>
            <a:r>
              <a:rPr lang="is-IS">
                <a:cs typeface="Calibri"/>
              </a:rPr>
              <a:t>In 2008, a study in 16 US schools found that 61% of students met the recommended amount of PA, and those that did had lower levels of stress and were more likely to recommend PA to their patients.  </a:t>
            </a:r>
          </a:p>
          <a:p>
            <a:endParaRPr lang="is-IS">
              <a:cs typeface="Calibri"/>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34</a:t>
            </a:fld>
            <a:endParaRPr lang="en-US"/>
          </a:p>
        </p:txBody>
      </p:sp>
    </p:spTree>
    <p:extLst>
      <p:ext uri="{BB962C8B-B14F-4D97-AF65-F5344CB8AC3E}">
        <p14:creationId xmlns:p14="http://schemas.microsoft.com/office/powerpoint/2010/main" val="2748518736"/>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We would love to solicit your ideas about how to make our campus support more physical activity.   Today, we will be taking a brisk walk around campus to start our journey!  </a:t>
            </a:r>
            <a:endParaRPr lang="en-US"/>
          </a:p>
        </p:txBody>
      </p:sp>
      <p:sp>
        <p:nvSpPr>
          <p:cNvPr id="4" name="Slide Number Placeholder 3"/>
          <p:cNvSpPr>
            <a:spLocks noGrp="1"/>
          </p:cNvSpPr>
          <p:nvPr>
            <p:ph type="sldNum" sz="quarter" idx="10"/>
          </p:nvPr>
        </p:nvSpPr>
        <p:spPr/>
        <p:txBody>
          <a:bodyPr/>
          <a:lstStyle/>
          <a:p>
            <a:fld id="{67FD3922-A580-0840-94D5-C5F132B230D2}" type="slidenum">
              <a:rPr lang="en-US" smtClean="0"/>
              <a:t>35</a:t>
            </a:fld>
            <a:endParaRPr lang="en-US"/>
          </a:p>
        </p:txBody>
      </p:sp>
    </p:spTree>
    <p:extLst>
      <p:ext uri="{BB962C8B-B14F-4D97-AF65-F5344CB8AC3E}">
        <p14:creationId xmlns:p14="http://schemas.microsoft.com/office/powerpoint/2010/main" val="9879106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ts val="0"/>
              </a:spcBef>
              <a:spcAft>
                <a:spcPts val="0"/>
              </a:spcAft>
              <a:buClrTx/>
              <a:buSzTx/>
              <a:buFontTx/>
              <a:buNone/>
              <a:tabLst/>
              <a:defRPr/>
            </a:pPr>
            <a:r>
              <a:rPr lang="en-US" b="1"/>
              <a:t>WHO: </a:t>
            </a:r>
            <a:r>
              <a:rPr lang="en-US" sz="1200" b="0" i="0" kern="1200">
                <a:solidFill>
                  <a:schemeClr val="tx1"/>
                </a:solidFill>
                <a:effectLst/>
                <a:latin typeface="+mn-lt"/>
                <a:ea typeface="+mn-ea"/>
                <a:cs typeface="+mn-cs"/>
              </a:rPr>
              <a:t>Physical inactivity (insufficient physical activity) is one of the leading risk factor for noncommunicable diseases (NCD) and death worldwide.</a:t>
            </a:r>
            <a:endParaRPr lang="en-US" b="1">
              <a:cs typeface="Calibri"/>
            </a:endParaRPr>
          </a:p>
          <a:p>
            <a:pPr fontAlgn="base"/>
            <a:r>
              <a:rPr lang="en-US" sz="1200" b="0" i="0" kern="1200">
                <a:solidFill>
                  <a:schemeClr val="tx1"/>
                </a:solidFill>
                <a:effectLst/>
                <a:latin typeface="+mn-lt"/>
                <a:ea typeface="+mn-ea"/>
                <a:cs typeface="+mn-cs"/>
              </a:rPr>
              <a:t>Physical inactivity has been identified as the fourth leading risk factor for global mortality causing an estimated 3.2 million deaths globally.</a:t>
            </a:r>
          </a:p>
          <a:p>
            <a:pPr fontAlgn="base"/>
            <a:endParaRPr lang="en-US"/>
          </a:p>
          <a:p>
            <a:pPr marL="0" marR="0" indent="0" algn="l" defTabSz="914400" rtl="0" eaLnBrk="1" fontAlgn="base" latinLnBrk="0" hangingPunct="1">
              <a:lnSpc>
                <a:spcPct val="100000"/>
              </a:lnSpc>
              <a:spcBef>
                <a:spcPts val="0"/>
              </a:spcBef>
              <a:spcAft>
                <a:spcPts val="0"/>
              </a:spcAft>
              <a:buClrTx/>
              <a:buSzTx/>
              <a:buFontTx/>
              <a:buNone/>
              <a:tabLst/>
              <a:defRPr/>
            </a:pPr>
            <a:r>
              <a:rPr lang="en-US" sz="1200" b="0" i="0" kern="1200">
                <a:solidFill>
                  <a:schemeClr val="tx1"/>
                </a:solidFill>
                <a:effectLst/>
                <a:latin typeface="+mn-lt"/>
                <a:ea typeface="+mn-ea"/>
                <a:cs typeface="+mn-cs"/>
              </a:rPr>
              <a:t>“</a:t>
            </a:r>
            <a:r>
              <a:rPr lang="en-US" sz="1200" b="1" i="0" kern="1200">
                <a:solidFill>
                  <a:schemeClr val="tx1"/>
                </a:solidFill>
                <a:effectLst/>
                <a:latin typeface="+mn-lt"/>
                <a:ea typeface="+mn-ea"/>
                <a:cs typeface="+mn-cs"/>
              </a:rPr>
              <a:t>MET</a:t>
            </a:r>
            <a:r>
              <a:rPr lang="en-US" sz="1200" b="0" i="0" kern="1200">
                <a:solidFill>
                  <a:schemeClr val="tx1"/>
                </a:solidFill>
                <a:effectLst/>
                <a:latin typeface="+mn-lt"/>
                <a:ea typeface="+mn-ea"/>
                <a:cs typeface="+mn-cs"/>
              </a:rPr>
              <a:t>” is another name for metabolic equivalent; a measure of </a:t>
            </a:r>
            <a:r>
              <a:rPr lang="en-US" sz="1200" b="1" i="0" kern="1200">
                <a:solidFill>
                  <a:schemeClr val="tx1"/>
                </a:solidFill>
                <a:effectLst/>
                <a:latin typeface="+mn-lt"/>
                <a:ea typeface="+mn-ea"/>
                <a:cs typeface="+mn-cs"/>
              </a:rPr>
              <a:t>exercise</a:t>
            </a:r>
            <a:r>
              <a:rPr lang="en-US" sz="1200" b="0" i="0" kern="1200">
                <a:solidFill>
                  <a:schemeClr val="tx1"/>
                </a:solidFill>
                <a:effectLst/>
                <a:latin typeface="+mn-lt"/>
                <a:ea typeface="+mn-ea"/>
                <a:cs typeface="+mn-cs"/>
              </a:rPr>
              <a:t> intensity based on oxygen consumption. More specifically, a single </a:t>
            </a:r>
            <a:r>
              <a:rPr lang="en-US" sz="1200" b="1" i="0" kern="1200">
                <a:solidFill>
                  <a:schemeClr val="tx1"/>
                </a:solidFill>
                <a:effectLst/>
                <a:latin typeface="+mn-lt"/>
                <a:ea typeface="+mn-ea"/>
                <a:cs typeface="+mn-cs"/>
              </a:rPr>
              <a:t>MET</a:t>
            </a:r>
            <a:r>
              <a:rPr lang="en-US" sz="1200" b="0" i="0" kern="1200">
                <a:solidFill>
                  <a:schemeClr val="tx1"/>
                </a:solidFill>
                <a:effectLst/>
                <a:latin typeface="+mn-lt"/>
                <a:ea typeface="+mn-ea"/>
                <a:cs typeface="+mn-cs"/>
              </a:rPr>
              <a:t> is defined as the amount of oxygen a person consumes (or the energy expended) per unit of body weight during 1 minute of rest.</a:t>
            </a:r>
            <a:endParaRPr lang="en-US"/>
          </a:p>
          <a:p>
            <a:pPr fontAlgn="base"/>
            <a:endParaRPr lang="en-US" sz="1200">
              <a:cs typeface="Calibri"/>
            </a:endParaRPr>
          </a:p>
          <a:p>
            <a:pPr fontAlgn="base"/>
            <a:r>
              <a:rPr lang="en-US"/>
              <a:t>Physical Activity Guidelines Advisory Committee Report.</a:t>
            </a:r>
            <a:r>
              <a:rPr lang="en-US" sz="1200">
                <a:ea typeface="+mn-lt"/>
                <a:cs typeface="+mn-lt"/>
              </a:rPr>
              <a:t> U.S. Department of Health and Human Services website. </a:t>
            </a:r>
            <a:r>
              <a:rPr lang="en-US" sz="1200">
                <a:solidFill>
                  <a:srgbClr val="F49100"/>
                </a:solidFill>
                <a:latin typeface="+mn-lt"/>
                <a:cs typeface="Calibri"/>
                <a:hlinkClick r:id="rId3"/>
              </a:rPr>
              <a:t>https://health.gov/paguidelines/2008/report/pdf/G1_allcause.pdf</a:t>
            </a:r>
            <a:r>
              <a:rPr lang="en-US" sz="1200">
                <a:solidFill>
                  <a:srgbClr val="F49100"/>
                </a:solidFill>
                <a:latin typeface="+mn-lt"/>
                <a:cs typeface="Calibri"/>
              </a:rPr>
              <a:t>. </a:t>
            </a:r>
            <a:r>
              <a:rPr lang="en-US" sz="1200">
                <a:ea typeface="+mn-lt"/>
                <a:cs typeface="+mn-lt"/>
              </a:rPr>
              <a:t>Updated October 2018. Accessed November 25, 2019.</a:t>
            </a:r>
            <a:endParaRPr lang="en-US">
              <a:cs typeface="Calibri"/>
            </a:endParaRPr>
          </a:p>
          <a:p>
            <a:endParaRPr lang="en-US">
              <a:cs typeface="Calibri"/>
            </a:endParaRPr>
          </a:p>
        </p:txBody>
      </p:sp>
      <p:sp>
        <p:nvSpPr>
          <p:cNvPr id="4" name="Slide Number Placeholder 3"/>
          <p:cNvSpPr>
            <a:spLocks noGrp="1"/>
          </p:cNvSpPr>
          <p:nvPr>
            <p:ph type="sldNum" sz="quarter" idx="10"/>
          </p:nvPr>
        </p:nvSpPr>
        <p:spPr/>
        <p:txBody>
          <a:bodyPr/>
          <a:lstStyle/>
          <a:p>
            <a:fld id="{E4D628F0-417F-EA4F-9DBC-294432F3D5CD}" type="slidenum">
              <a:rPr lang="en-US" smtClean="0"/>
              <a:t>4</a:t>
            </a:fld>
            <a:endParaRPr lang="en-US"/>
          </a:p>
        </p:txBody>
      </p:sp>
    </p:spTree>
    <p:extLst>
      <p:ext uri="{BB962C8B-B14F-4D97-AF65-F5344CB8AC3E}">
        <p14:creationId xmlns:p14="http://schemas.microsoft.com/office/powerpoint/2010/main" val="416407071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endParaRPr lang="en-US" sz="1200" b="0" i="0" kern="1200">
              <a:solidFill>
                <a:schemeClr val="tx1"/>
              </a:solidFill>
              <a:effectLst/>
              <a:latin typeface="+mn-lt"/>
              <a:ea typeface="+mn-ea"/>
              <a:cs typeface="+mn-cs"/>
            </a:endParaRPr>
          </a:p>
          <a:p>
            <a:endParaRPr lang="en-US" sz="1200"/>
          </a:p>
        </p:txBody>
      </p:sp>
      <p:sp>
        <p:nvSpPr>
          <p:cNvPr id="4" name="Slide Number Placeholder 3"/>
          <p:cNvSpPr>
            <a:spLocks noGrp="1"/>
          </p:cNvSpPr>
          <p:nvPr>
            <p:ph type="sldNum" sz="quarter" idx="10"/>
          </p:nvPr>
        </p:nvSpPr>
        <p:spPr/>
        <p:txBody>
          <a:bodyPr/>
          <a:lstStyle/>
          <a:p>
            <a:fld id="{E4D628F0-417F-EA4F-9DBC-294432F3D5CD}" type="slidenum">
              <a:rPr lang="en-US" smtClean="0"/>
              <a:t>5</a:t>
            </a:fld>
            <a:endParaRPr lang="en-US"/>
          </a:p>
        </p:txBody>
      </p:sp>
    </p:spTree>
    <p:extLst>
      <p:ext uri="{BB962C8B-B14F-4D97-AF65-F5344CB8AC3E}">
        <p14:creationId xmlns:p14="http://schemas.microsoft.com/office/powerpoint/2010/main" val="397220831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Cancer Risk</a:t>
            </a:r>
            <a:r>
              <a:rPr lang="en-US"/>
              <a:t>:</a:t>
            </a:r>
            <a:r>
              <a:rPr lang="en-US" baseline="0"/>
              <a:t> </a:t>
            </a:r>
            <a:r>
              <a:rPr lang="en-US"/>
              <a:t>Bladder, breast,</a:t>
            </a:r>
            <a:r>
              <a:rPr lang="en-US" baseline="0"/>
              <a:t> colon, endometrium, esophagus, kidney, lung, stomach</a:t>
            </a:r>
            <a:endParaRPr lang="en-US"/>
          </a:p>
        </p:txBody>
      </p:sp>
      <p:sp>
        <p:nvSpPr>
          <p:cNvPr id="4" name="Slide Number Placeholder 3"/>
          <p:cNvSpPr>
            <a:spLocks noGrp="1"/>
          </p:cNvSpPr>
          <p:nvPr>
            <p:ph type="sldNum" sz="quarter" idx="10"/>
          </p:nvPr>
        </p:nvSpPr>
        <p:spPr/>
        <p:txBody>
          <a:bodyPr/>
          <a:lstStyle/>
          <a:p>
            <a:fld id="{67FD3922-A580-0840-94D5-C5F132B230D2}" type="slidenum">
              <a:rPr lang="en-US" smtClean="0"/>
              <a:t>6</a:t>
            </a:fld>
            <a:endParaRPr lang="en-US"/>
          </a:p>
        </p:txBody>
      </p:sp>
    </p:spTree>
    <p:extLst>
      <p:ext uri="{BB962C8B-B14F-4D97-AF65-F5344CB8AC3E}">
        <p14:creationId xmlns:p14="http://schemas.microsoft.com/office/powerpoint/2010/main" val="141402159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Everyone benefits from Physical Activity.</a:t>
            </a:r>
          </a:p>
          <a:p>
            <a:pPr marL="0" marR="0" indent="0" algn="l" defTabSz="914400" rtl="0" eaLnBrk="1" fontAlgn="auto" latinLnBrk="0" hangingPunct="1">
              <a:lnSpc>
                <a:spcPct val="100000"/>
              </a:lnSpc>
              <a:spcBef>
                <a:spcPts val="0"/>
              </a:spcBef>
              <a:spcAft>
                <a:spcPts val="0"/>
              </a:spcAft>
              <a:buClrTx/>
              <a:buSzTx/>
              <a:buFontTx/>
              <a:buNone/>
              <a:tabLst/>
              <a:defRPr/>
            </a:pPr>
            <a:r>
              <a:rPr lang="en-US"/>
              <a:t>Achieving the benefits of physical activity depends on our personal efforts to increase activity in </a:t>
            </a:r>
            <a:r>
              <a:rPr lang="en-US" b="1"/>
              <a:t>ourselves, family, friends, patients, and colleagues</a:t>
            </a:r>
            <a:r>
              <a:rPr lang="en-US"/>
              <a:t>. Action is also required at the </a:t>
            </a:r>
            <a:r>
              <a:rPr lang="en-US" b="1"/>
              <a:t>school, workplace</a:t>
            </a:r>
            <a:r>
              <a:rPr lang="en-US"/>
              <a:t>, and </a:t>
            </a:r>
            <a:r>
              <a:rPr lang="en-US" b="1"/>
              <a:t>community levels. </a:t>
            </a:r>
            <a:endParaRPr lang="en-US" sz="1200" b="1"/>
          </a:p>
          <a:p>
            <a:endParaRPr lang="en-US"/>
          </a:p>
        </p:txBody>
      </p:sp>
      <p:sp>
        <p:nvSpPr>
          <p:cNvPr id="4" name="Slide Number Placeholder 3"/>
          <p:cNvSpPr>
            <a:spLocks noGrp="1"/>
          </p:cNvSpPr>
          <p:nvPr>
            <p:ph type="sldNum" sz="quarter" idx="10"/>
          </p:nvPr>
        </p:nvSpPr>
        <p:spPr/>
        <p:txBody>
          <a:bodyPr/>
          <a:lstStyle/>
          <a:p>
            <a:fld id="{67FD3922-A580-0840-94D5-C5F132B230D2}" type="slidenum">
              <a:rPr lang="en-US" smtClean="0"/>
              <a:t>7</a:t>
            </a:fld>
            <a:endParaRPr lang="en-US"/>
          </a:p>
        </p:txBody>
      </p:sp>
    </p:spTree>
    <p:extLst>
      <p:ext uri="{BB962C8B-B14F-4D97-AF65-F5344CB8AC3E}">
        <p14:creationId xmlns:p14="http://schemas.microsoft.com/office/powerpoint/2010/main" val="60918073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4D628F0-417F-EA4F-9DBC-294432F3D5CD}" type="slidenum">
              <a:rPr lang="en-US" smtClean="0"/>
              <a:t>8</a:t>
            </a:fld>
            <a:endParaRPr lang="en-US"/>
          </a:p>
        </p:txBody>
      </p:sp>
    </p:spTree>
    <p:extLst>
      <p:ext uri="{BB962C8B-B14F-4D97-AF65-F5344CB8AC3E}">
        <p14:creationId xmlns:p14="http://schemas.microsoft.com/office/powerpoint/2010/main" val="58744684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4D628F0-417F-EA4F-9DBC-294432F3D5CD}" type="slidenum">
              <a:rPr lang="en-US" smtClean="0"/>
              <a:t>9</a:t>
            </a:fld>
            <a:endParaRPr lang="en-US"/>
          </a:p>
        </p:txBody>
      </p:sp>
    </p:spTree>
    <p:extLst>
      <p:ext uri="{BB962C8B-B14F-4D97-AF65-F5344CB8AC3E}">
        <p14:creationId xmlns:p14="http://schemas.microsoft.com/office/powerpoint/2010/main" val="2475303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3" name="Subtitle 2"/>
          <p:cNvSpPr>
            <a:spLocks noGrp="1"/>
          </p:cNvSpPr>
          <p:nvPr>
            <p:ph type="subTitle" idx="1"/>
          </p:nvPr>
        </p:nvSpPr>
        <p:spPr>
          <a:xfrm>
            <a:off x="2209799" y="3694375"/>
            <a:ext cx="9144000" cy="754025"/>
          </a:xfrm>
        </p:spPr>
        <p:txBody>
          <a:bodyPr anchor="b">
            <a:normAutofit/>
          </a:bodyPr>
          <a:lstStyle>
            <a:lvl1pPr marL="0" indent="0" algn="r">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Title 3"/>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367160"/>
            <a:ext cx="10515600" cy="819355"/>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839788" y="987425"/>
            <a:ext cx="10515600" cy="337973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839788" y="5186516"/>
            <a:ext cx="10514012" cy="682472"/>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6/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3534344"/>
          </a:xfrm>
        </p:spPr>
        <p:txBody>
          <a:bodyPr anchor="ctr"/>
          <a:lstStyle>
            <a:lvl1pPr>
              <a:defRPr sz="3200"/>
            </a:lvl1pPr>
          </a:lstStyle>
          <a:p>
            <a:r>
              <a:rPr lang="en-US"/>
              <a:t>Click to edit Master title style</a:t>
            </a:r>
          </a:p>
        </p:txBody>
      </p:sp>
      <p:sp>
        <p:nvSpPr>
          <p:cNvPr id="4" name="Text Placeholder 3"/>
          <p:cNvSpPr>
            <a:spLocks noGrp="1"/>
          </p:cNvSpPr>
          <p:nvPr>
            <p:ph type="body" sz="half" idx="2"/>
          </p:nvPr>
        </p:nvSpPr>
        <p:spPr>
          <a:xfrm>
            <a:off x="839788" y="4489399"/>
            <a:ext cx="10514012" cy="1501826"/>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6/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2" y="365125"/>
            <a:ext cx="9302752" cy="2992904"/>
          </a:xfrm>
        </p:spPr>
        <p:txBody>
          <a:bodyPr anchor="ctr"/>
          <a:lstStyle>
            <a:lvl1pPr>
              <a:defRPr sz="4400"/>
            </a:lvl1pPr>
          </a:lstStyle>
          <a:p>
            <a:r>
              <a:rPr lang="en-US"/>
              <a:t>Click to edit Master title style</a:t>
            </a:r>
          </a:p>
        </p:txBody>
      </p:sp>
      <p:sp>
        <p:nvSpPr>
          <p:cNvPr id="12" name="Text Placeholder 3"/>
          <p:cNvSpPr>
            <a:spLocks noGrp="1"/>
          </p:cNvSpPr>
          <p:nvPr>
            <p:ph type="body" sz="half" idx="13"/>
          </p:nvPr>
        </p:nvSpPr>
        <p:spPr>
          <a:xfrm>
            <a:off x="1720644" y="3365557"/>
            <a:ext cx="8752299" cy="548968"/>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4" name="Text Placeholder 3"/>
          <p:cNvSpPr>
            <a:spLocks noGrp="1"/>
          </p:cNvSpPr>
          <p:nvPr>
            <p:ph type="body" sz="half" idx="2"/>
          </p:nvPr>
        </p:nvSpPr>
        <p:spPr>
          <a:xfrm>
            <a:off x="838200" y="4501729"/>
            <a:ext cx="10512424" cy="1489496"/>
          </a:xfrm>
        </p:spPr>
        <p:txBody>
          <a:bodyPr anchor="ctr">
            <a:normAutofit/>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6/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
        <p:nvSpPr>
          <p:cNvPr id="9" name="TextBox 8"/>
          <p:cNvSpPr txBox="1"/>
          <p:nvPr/>
        </p:nvSpPr>
        <p:spPr>
          <a:xfrm>
            <a:off x="1111044" y="786824"/>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a:solidFill>
                  <a:schemeClr val="tx1"/>
                </a:solidFill>
                <a:effectLst/>
              </a:rPr>
              <a:t>“</a:t>
            </a:r>
          </a:p>
        </p:txBody>
      </p:sp>
      <p:sp>
        <p:nvSpPr>
          <p:cNvPr id="10" name="TextBox 9"/>
          <p:cNvSpPr txBox="1"/>
          <p:nvPr/>
        </p:nvSpPr>
        <p:spPr>
          <a:xfrm>
            <a:off x="10437812" y="2743200"/>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a:solidFill>
                  <a:schemeClr val="tx1"/>
                </a:solidFill>
                <a:effectLst/>
              </a:rPr>
              <a:t>”</a:t>
            </a: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39788" y="2326967"/>
            <a:ext cx="10515600" cy="2511835"/>
          </a:xfrm>
        </p:spPr>
        <p:txBody>
          <a:bodyPr anchor="b">
            <a:normAutofit/>
          </a:bodyPr>
          <a:lstStyle>
            <a:lvl1pPr>
              <a:defRPr sz="5400"/>
            </a:lvl1pPr>
          </a:lstStyle>
          <a:p>
            <a:r>
              <a:rPr lang="en-US"/>
              <a:t>Click to edit Master title style</a:t>
            </a:r>
          </a:p>
        </p:txBody>
      </p:sp>
      <p:sp>
        <p:nvSpPr>
          <p:cNvPr id="4" name="Text Placeholder 3"/>
          <p:cNvSpPr>
            <a:spLocks noGrp="1"/>
          </p:cNvSpPr>
          <p:nvPr>
            <p:ph type="body" sz="half" idx="2"/>
          </p:nvPr>
        </p:nvSpPr>
        <p:spPr>
          <a:xfrm>
            <a:off x="839788" y="4850581"/>
            <a:ext cx="10514012" cy="1140644"/>
          </a:xfrm>
        </p:spPr>
        <p:txBody>
          <a:bodyPr anchor="t"/>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6/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15" name="Title 1"/>
          <p:cNvSpPr>
            <a:spLocks noGrp="1"/>
          </p:cNvSpPr>
          <p:nvPr>
            <p:ph type="title"/>
          </p:nvPr>
        </p:nvSpPr>
        <p:spPr>
          <a:xfrm>
            <a:off x="838200" y="365125"/>
            <a:ext cx="10515600" cy="1325563"/>
          </a:xfrm>
        </p:spPr>
        <p:txBody>
          <a:bodyPr/>
          <a:lstStyle/>
          <a:p>
            <a:r>
              <a:rPr lang="en-US"/>
              <a:t>Click to edit Master title style</a:t>
            </a:r>
          </a:p>
        </p:txBody>
      </p:sp>
      <p:sp>
        <p:nvSpPr>
          <p:cNvPr id="7" name="Text Placeholder 2"/>
          <p:cNvSpPr>
            <a:spLocks noGrp="1"/>
          </p:cNvSpPr>
          <p:nvPr>
            <p:ph type="body" idx="1"/>
          </p:nvPr>
        </p:nvSpPr>
        <p:spPr>
          <a:xfrm>
            <a:off x="1337282" y="1885950"/>
            <a:ext cx="2946866" cy="576262"/>
          </a:xfrm>
        </p:spPr>
        <p:txBody>
          <a:bodyPr anchor="b">
            <a:noAutofit/>
          </a:bodyPr>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8" name="Text Placeholder 3"/>
          <p:cNvSpPr>
            <a:spLocks noGrp="1"/>
          </p:cNvSpPr>
          <p:nvPr>
            <p:ph type="body" sz="half" idx="15"/>
          </p:nvPr>
        </p:nvSpPr>
        <p:spPr>
          <a:xfrm>
            <a:off x="1356798" y="257175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9" name="Text Placeholder 4"/>
          <p:cNvSpPr>
            <a:spLocks noGrp="1"/>
          </p:cNvSpPr>
          <p:nvPr>
            <p:ph type="body" sz="quarter" idx="3"/>
          </p:nvPr>
        </p:nvSpPr>
        <p:spPr>
          <a:xfrm>
            <a:off x="4587994" y="1885950"/>
            <a:ext cx="2936241" cy="576262"/>
          </a:xfrm>
        </p:spPr>
        <p:txBody>
          <a:bodyPr vert="horz" lIns="91440" tIns="45720" rIns="91440" bIns="45720" rtlCol="0" anchor="b">
            <a:no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0" name="Text Placeholder 3"/>
          <p:cNvSpPr>
            <a:spLocks noGrp="1"/>
          </p:cNvSpPr>
          <p:nvPr>
            <p:ph type="body" sz="half" idx="16"/>
          </p:nvPr>
        </p:nvSpPr>
        <p:spPr>
          <a:xfrm>
            <a:off x="4577441" y="257175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1" name="Text Placeholder 4"/>
          <p:cNvSpPr>
            <a:spLocks noGrp="1"/>
          </p:cNvSpPr>
          <p:nvPr>
            <p:ph type="body" sz="quarter" idx="13"/>
          </p:nvPr>
        </p:nvSpPr>
        <p:spPr>
          <a:xfrm>
            <a:off x="7829035" y="1885950"/>
            <a:ext cx="2932113" cy="576262"/>
          </a:xfrm>
        </p:spPr>
        <p:txBody>
          <a:bodyPr vert="horz" lIns="91440" tIns="45720" rIns="91440" bIns="45720" rtlCol="0" anchor="b">
            <a:noAutofit/>
          </a:bodyPr>
          <a:lstStyle>
            <a:lvl1pPr>
              <a:buNone/>
              <a:defRPr lang="en-US" sz="2400" b="0" dirty="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2" name="Text Placeholder 3"/>
          <p:cNvSpPr>
            <a:spLocks noGrp="1"/>
          </p:cNvSpPr>
          <p:nvPr>
            <p:ph type="body" sz="half" idx="17"/>
          </p:nvPr>
        </p:nvSpPr>
        <p:spPr>
          <a:xfrm>
            <a:off x="7829035" y="257175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AEA36FFC-FEDD-144E-8B9C-C5031E00FB00}" type="datetimeFigureOut">
              <a:rPr lang="en-US" smtClean="0"/>
              <a:t>6/1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30" name="Title 1"/>
          <p:cNvSpPr>
            <a:spLocks noGrp="1"/>
          </p:cNvSpPr>
          <p:nvPr>
            <p:ph type="title"/>
          </p:nvPr>
        </p:nvSpPr>
        <p:spPr>
          <a:xfrm>
            <a:off x="838200" y="365125"/>
            <a:ext cx="10515600" cy="1325563"/>
          </a:xfrm>
        </p:spPr>
        <p:txBody>
          <a:bodyPr/>
          <a:lstStyle/>
          <a:p>
            <a:r>
              <a:rPr lang="en-US"/>
              <a:t>Click to edit Master title style</a:t>
            </a:r>
          </a:p>
        </p:txBody>
      </p:sp>
      <p:sp>
        <p:nvSpPr>
          <p:cNvPr id="19" name="Text Placeholder 2"/>
          <p:cNvSpPr>
            <a:spLocks noGrp="1"/>
          </p:cNvSpPr>
          <p:nvPr>
            <p:ph type="body" idx="1"/>
          </p:nvPr>
        </p:nvSpPr>
        <p:spPr>
          <a:xfrm>
            <a:off x="1332085" y="4297503"/>
            <a:ext cx="2940050"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Picture Placeholder 2"/>
          <p:cNvSpPr>
            <a:spLocks noGrp="1" noChangeAspect="1"/>
          </p:cNvSpPr>
          <p:nvPr>
            <p:ph type="pic" idx="15"/>
          </p:nvPr>
        </p:nvSpPr>
        <p:spPr>
          <a:xfrm>
            <a:off x="1332085" y="2256354"/>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1" name="Text Placeholder 3"/>
          <p:cNvSpPr>
            <a:spLocks noGrp="1"/>
          </p:cNvSpPr>
          <p:nvPr>
            <p:ph type="body" sz="half" idx="18"/>
          </p:nvPr>
        </p:nvSpPr>
        <p:spPr>
          <a:xfrm>
            <a:off x="1332085" y="4873765"/>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2" name="Text Placeholder 4"/>
          <p:cNvSpPr>
            <a:spLocks noGrp="1"/>
          </p:cNvSpPr>
          <p:nvPr>
            <p:ph type="body" sz="quarter" idx="3"/>
          </p:nvPr>
        </p:nvSpPr>
        <p:spPr>
          <a:xfrm>
            <a:off x="4568997" y="4297503"/>
            <a:ext cx="2930525"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3" name="Picture Placeholder 2"/>
          <p:cNvSpPr>
            <a:spLocks noGrp="1" noChangeAspect="1"/>
          </p:cNvSpPr>
          <p:nvPr>
            <p:ph type="pic" idx="21"/>
          </p:nvPr>
        </p:nvSpPr>
        <p:spPr>
          <a:xfrm>
            <a:off x="4568996" y="2256354"/>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4" name="Text Placeholder 3"/>
          <p:cNvSpPr>
            <a:spLocks noGrp="1"/>
          </p:cNvSpPr>
          <p:nvPr>
            <p:ph type="body" sz="half" idx="19"/>
          </p:nvPr>
        </p:nvSpPr>
        <p:spPr>
          <a:xfrm>
            <a:off x="4567644" y="4873764"/>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5" name="Text Placeholder 4"/>
          <p:cNvSpPr>
            <a:spLocks noGrp="1"/>
          </p:cNvSpPr>
          <p:nvPr>
            <p:ph type="body" sz="quarter" idx="13"/>
          </p:nvPr>
        </p:nvSpPr>
        <p:spPr>
          <a:xfrm>
            <a:off x="7804322" y="4297503"/>
            <a:ext cx="2932113"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6" name="Picture Placeholder 2"/>
          <p:cNvSpPr>
            <a:spLocks noGrp="1" noChangeAspect="1"/>
          </p:cNvSpPr>
          <p:nvPr>
            <p:ph type="pic" idx="22"/>
          </p:nvPr>
        </p:nvSpPr>
        <p:spPr>
          <a:xfrm>
            <a:off x="7804321" y="2256354"/>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7" name="Text Placeholder 3"/>
          <p:cNvSpPr>
            <a:spLocks noGrp="1"/>
          </p:cNvSpPr>
          <p:nvPr>
            <p:ph type="body" sz="half" idx="20"/>
          </p:nvPr>
        </p:nvSpPr>
        <p:spPr>
          <a:xfrm>
            <a:off x="7804197" y="4873762"/>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AEA36FFC-FEDD-144E-8B9C-C5031E00FB00}" type="datetimeFigureOut">
              <a:rPr lang="en-US" smtClean="0"/>
              <a:t>6/1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6/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6/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8"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6/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Title 1"/>
          <p:cNvSpPr>
            <a:spLocks noGrp="1"/>
          </p:cNvSpPr>
          <p:nvPr>
            <p:ph type="ctrTitle"/>
          </p:nvPr>
        </p:nvSpPr>
        <p:spPr>
          <a:xfrm>
            <a:off x="854532" y="4464028"/>
            <a:ext cx="9144000" cy="1641490"/>
          </a:xfrm>
        </p:spPr>
        <p:txBody>
          <a:bodyPr wrap="none" anchor="t">
            <a:normAutofit/>
          </a:bodyPr>
          <a:lstStyle>
            <a:lvl1pPr algn="l">
              <a:defRPr sz="9600" b="0" spc="-300">
                <a:gradFill flip="none" rotWithShape="1">
                  <a:gsLst>
                    <a:gs pos="32000">
                      <a:schemeClr val="tx1">
                        <a:lumMod val="89000"/>
                      </a:schemeClr>
                    </a:gs>
                    <a:gs pos="0">
                      <a:schemeClr val="bg1">
                        <a:lumMod val="47000"/>
                        <a:lumOff val="53000"/>
                      </a:schemeClr>
                    </a:gs>
                    <a:gs pos="100000">
                      <a:schemeClr val="tx2">
                        <a:lumMod val="0"/>
                        <a:lumOff val="100000"/>
                      </a:schemeClr>
                    </a:gs>
                  </a:gsLst>
                  <a:lin ang="8100000" scaled="1"/>
                  <a:tileRect/>
                </a:gradFill>
                <a:effectLst>
                  <a:outerShdw blurRad="469900" dist="342900" dir="5400000" sy="-20000" rotWithShape="0">
                    <a:prstClr val="black">
                      <a:alpha val="66000"/>
                    </a:prstClr>
                  </a:outerShdw>
                </a:effectLst>
                <a:latin typeface="+mj-lt"/>
              </a:defRPr>
            </a:lvl1pPr>
          </a:lstStyle>
          <a:p>
            <a:r>
              <a:rPr lang="en-US"/>
              <a:t>Click to edit Master title style</a:t>
            </a:r>
          </a:p>
        </p:txBody>
      </p:sp>
      <p:sp>
        <p:nvSpPr>
          <p:cNvPr id="8" name="Subtitle 2"/>
          <p:cNvSpPr>
            <a:spLocks noGrp="1"/>
          </p:cNvSpPr>
          <p:nvPr>
            <p:ph type="subTitle" idx="1"/>
          </p:nvPr>
        </p:nvSpPr>
        <p:spPr>
          <a:xfrm>
            <a:off x="854532" y="3693674"/>
            <a:ext cx="9144000" cy="754025"/>
          </a:xfrm>
        </p:spPr>
        <p:txBody>
          <a:bodyPr anchor="b">
            <a:normAutofit/>
          </a:bodyPr>
          <a:lstStyle>
            <a:lvl1pPr marL="0" indent="0" algn="l">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AEA36FFC-FEDD-144E-8B9C-C5031E00FB00}" type="datetimeFigureOut">
              <a:rPr lang="en-US" smtClean="0"/>
              <a:t>6/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120000" y="1825625"/>
            <a:ext cx="5025216"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319840" y="1825625"/>
            <a:ext cx="503396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EA36FFC-FEDD-144E-8B9C-C5031E00FB00}" type="datetimeFigureOut">
              <a:rPr lang="en-US" smtClean="0"/>
              <a:t>6/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1120000" y="1681163"/>
            <a:ext cx="5025216" cy="823912"/>
          </a:xfrm>
        </p:spPr>
        <p:txBody>
          <a:bodyPr anchor="b"/>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20000" y="2505075"/>
            <a:ext cx="5025216"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319840" y="1681163"/>
            <a:ext cx="5035548" cy="823912"/>
          </a:xfrm>
        </p:spPr>
        <p:txBody>
          <a:bodyPr vert="horz" lIns="91440" tIns="45720" rIns="91440" bIns="45720" rtlCol="0" anchor="b">
            <a:norm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6" name="Content Placeholder 5"/>
          <p:cNvSpPr>
            <a:spLocks noGrp="1"/>
          </p:cNvSpPr>
          <p:nvPr>
            <p:ph sz="quarter" idx="4"/>
          </p:nvPr>
        </p:nvSpPr>
        <p:spPr>
          <a:xfrm>
            <a:off x="6319840" y="2505075"/>
            <a:ext cx="503554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EA36FFC-FEDD-144E-8B9C-C5031E00FB00}" type="datetimeFigureOut">
              <a:rPr lang="en-US" smtClean="0"/>
              <a:t>6/19/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EA36FFC-FEDD-144E-8B9C-C5031E00FB00}" type="datetimeFigureOut">
              <a:rPr lang="en-US" smtClean="0"/>
              <a:t>6/1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A36FFC-FEDD-144E-8B9C-C5031E00FB00}" type="datetimeFigureOut">
              <a:rPr lang="en-US" smtClean="0"/>
              <a:t>6/19/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6/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6/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1120000" y="1825625"/>
            <a:ext cx="102338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AEA36FFC-FEDD-144E-8B9C-C5031E00FB00}" type="datetimeFigureOut">
              <a:rPr lang="en-US" smtClean="0"/>
              <a:t>6/19/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03FFA660-A063-C447-9732-548DA7F7F21C}" type="slidenum">
              <a:rPr lang="en-US" smtClean="0"/>
              <a:t>‹#›</a:t>
            </a:fld>
            <a:endParaRPr lang="en-US"/>
          </a:p>
        </p:txBody>
      </p:sp>
    </p:spTree>
    <p:extLst>
      <p:ext uri="{BB962C8B-B14F-4D97-AF65-F5344CB8AC3E}">
        <p14:creationId xmlns:p14="http://schemas.microsoft.com/office/powerpoint/2010/main" val="941317310"/>
      </p:ext>
    </p:extLst>
  </p:cSld>
  <p:clrMap bg1="dk1" tx1="lt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 id="2147483699" r:id="rId15"/>
    <p:sldLayoutId id="2147483700" r:id="rId16"/>
    <p:sldLayoutId id="2147483701" r:id="rId17"/>
  </p:sldLayoutIdLst>
  <p:txStyles>
    <p:title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hyperlink" Target="https://health.gov/paguidelines/moveyourway/" TargetMode="Externa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29.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hyperlink" Target="https://health.gov/paguidelines/second-edition/pdf/PAG_ExecutiveSummary.pdf" TargetMode="External"/></Relationships>
</file>

<file path=ppt/slides/_rels/slide30.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hyperlink" Target="https://www.exerciseismedicine.org/assets/page_documents/EIM%20Health%20Care%20Providers%20Action%20Guide%20clickable%20links.pdf" TargetMode="External"/><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hyperlink" Target="https://health.gov/paguidelines/2008/report/pdf/G1_allcause.pdf" TargetMode="External"/><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health.gov/paguidelines/second-edition/pdf/PAG_ExecutiveSummary.pdf"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p:txBody>
          <a:bodyPr>
            <a:noAutofit/>
          </a:bodyPr>
          <a:lstStyle/>
          <a:p>
            <a:r>
              <a:rPr lang="en-US" sz="5400"/>
              <a:t>Lifestyle Medicine &amp; Medical Student Wellness: </a:t>
            </a:r>
          </a:p>
          <a:p>
            <a:r>
              <a:rPr lang="en-US" sz="5400">
                <a:solidFill>
                  <a:schemeClr val="accent3"/>
                </a:solidFill>
              </a:rPr>
              <a:t>Physical Activity</a:t>
            </a:r>
            <a:endParaRPr lang="en-US" sz="5400"/>
          </a:p>
        </p:txBody>
      </p:sp>
    </p:spTree>
    <p:extLst>
      <p:ext uri="{BB962C8B-B14F-4D97-AF65-F5344CB8AC3E}">
        <p14:creationId xmlns:p14="http://schemas.microsoft.com/office/powerpoint/2010/main" val="59316150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Key Guidelines: </a:t>
            </a:r>
            <a:r>
              <a:rPr lang="en-US" sz="3600">
                <a:solidFill>
                  <a:srgbClr val="F6D332"/>
                </a:solidFill>
              </a:rPr>
              <a:t>Adults</a:t>
            </a:r>
          </a:p>
        </p:txBody>
      </p:sp>
      <p:sp>
        <p:nvSpPr>
          <p:cNvPr id="5" name="Content Placeholder 4"/>
          <p:cNvSpPr>
            <a:spLocks noGrp="1"/>
          </p:cNvSpPr>
          <p:nvPr>
            <p:ph idx="1"/>
          </p:nvPr>
        </p:nvSpPr>
        <p:spPr/>
        <p:txBody>
          <a:bodyPr>
            <a:normAutofit fontScale="92500" lnSpcReduction="20000"/>
          </a:bodyPr>
          <a:lstStyle/>
          <a:p>
            <a:r>
              <a:rPr lang="en-US"/>
              <a:t>Adults should move more &amp; sit less throughout the day </a:t>
            </a:r>
          </a:p>
          <a:p>
            <a:endParaRPr lang="en-US"/>
          </a:p>
          <a:p>
            <a:r>
              <a:rPr lang="en-US"/>
              <a:t>&gt;150-300 minutes/week moderate-intensity </a:t>
            </a:r>
            <a:r>
              <a:rPr lang="en-US" i="1"/>
              <a:t>OR</a:t>
            </a:r>
            <a:r>
              <a:rPr lang="en-US"/>
              <a:t> 75-150 minutes/week vigorous-intensity aerobic physical activity</a:t>
            </a:r>
          </a:p>
          <a:p>
            <a:endParaRPr lang="en-US"/>
          </a:p>
          <a:p>
            <a:r>
              <a:rPr lang="en-US"/>
              <a:t>Additional health benefits are gained by engaging in physical activity &gt;300 minutes/week</a:t>
            </a:r>
          </a:p>
          <a:p>
            <a:endParaRPr lang="en-US"/>
          </a:p>
          <a:p>
            <a:r>
              <a:rPr lang="en-US"/>
              <a:t>Muscle-strengthening activities on 2 or more days a week</a:t>
            </a:r>
          </a:p>
          <a:p>
            <a:pPr marL="0" indent="0">
              <a:buNone/>
            </a:pPr>
            <a:br>
              <a:rPr lang="en-US"/>
            </a:br>
            <a:endParaRPr lang="en-US"/>
          </a:p>
        </p:txBody>
      </p:sp>
      <p:sp>
        <p:nvSpPr>
          <p:cNvPr id="6" name="TextBox 5">
            <a:extLst>
              <a:ext uri="{FF2B5EF4-FFF2-40B4-BE49-F238E27FC236}">
                <a16:creationId xmlns:a16="http://schemas.microsoft.com/office/drawing/2014/main" id="{B0475463-0D14-9548-A243-1FF95889E6AC}"/>
              </a:ext>
            </a:extLst>
          </p:cNvPr>
          <p:cNvSpPr txBox="1"/>
          <p:nvPr/>
        </p:nvSpPr>
        <p:spPr>
          <a:xfrm>
            <a:off x="85725" y="6335056"/>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3"/>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21464789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Key Guidelines</a:t>
            </a:r>
            <a:r>
              <a:rPr lang="en-US" sz="4800">
                <a:solidFill>
                  <a:schemeClr val="tx2"/>
                </a:solidFill>
              </a:rPr>
              <a:t>: </a:t>
            </a:r>
            <a:r>
              <a:rPr lang="en-US" sz="3600">
                <a:solidFill>
                  <a:srgbClr val="F6D332"/>
                </a:solidFill>
              </a:rPr>
              <a:t>Specific Recommendations</a:t>
            </a:r>
          </a:p>
        </p:txBody>
      </p:sp>
      <p:sp>
        <p:nvSpPr>
          <p:cNvPr id="5" name="Content Placeholder 4"/>
          <p:cNvSpPr>
            <a:spLocks noGrp="1"/>
          </p:cNvSpPr>
          <p:nvPr>
            <p:ph idx="1"/>
          </p:nvPr>
        </p:nvSpPr>
        <p:spPr>
          <a:xfrm>
            <a:off x="1120000" y="1825625"/>
            <a:ext cx="10233800" cy="3525864"/>
          </a:xfrm>
        </p:spPr>
        <p:txBody>
          <a:bodyPr>
            <a:normAutofit fontScale="92500" lnSpcReduction="10000"/>
          </a:bodyPr>
          <a:lstStyle/>
          <a:p>
            <a:r>
              <a:rPr lang="en-US"/>
              <a:t>Older Adults</a:t>
            </a:r>
          </a:p>
          <a:p>
            <a:endParaRPr lang="en-US"/>
          </a:p>
          <a:p>
            <a:r>
              <a:rPr lang="en-US"/>
              <a:t>Women during Pregnancy &amp; the Postpartum Period</a:t>
            </a:r>
          </a:p>
          <a:p>
            <a:endParaRPr lang="en-US"/>
          </a:p>
          <a:p>
            <a:r>
              <a:rPr lang="en-US"/>
              <a:t>Adults with Chronic Health Conditions</a:t>
            </a:r>
          </a:p>
          <a:p>
            <a:endParaRPr lang="en-US"/>
          </a:p>
          <a:p>
            <a:r>
              <a:rPr lang="en-US"/>
              <a:t>Adults with Disabilities</a:t>
            </a:r>
            <a:br>
              <a:rPr lang="en-US"/>
            </a:br>
            <a:endParaRPr lang="en-US"/>
          </a:p>
        </p:txBody>
      </p:sp>
      <p:sp>
        <p:nvSpPr>
          <p:cNvPr id="6" name="TextBox 5">
            <a:extLst>
              <a:ext uri="{FF2B5EF4-FFF2-40B4-BE49-F238E27FC236}">
                <a16:creationId xmlns:a16="http://schemas.microsoft.com/office/drawing/2014/main" id="{8549EB7F-27D1-CB4B-BBA5-E16CEAA1B051}"/>
              </a:ext>
            </a:extLst>
          </p:cNvPr>
          <p:cNvSpPr txBox="1"/>
          <p:nvPr/>
        </p:nvSpPr>
        <p:spPr>
          <a:xfrm>
            <a:off x="85725" y="6335056"/>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3"/>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187086217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Who is meeting the guidelines?</a:t>
            </a:r>
          </a:p>
        </p:txBody>
      </p:sp>
      <p:sp>
        <p:nvSpPr>
          <p:cNvPr id="5" name="TextBox 4"/>
          <p:cNvSpPr txBox="1"/>
          <p:nvPr/>
        </p:nvSpPr>
        <p:spPr>
          <a:xfrm>
            <a:off x="271462" y="6376738"/>
            <a:ext cx="11649075" cy="461665"/>
          </a:xfrm>
          <a:prstGeom prst="rect">
            <a:avLst/>
          </a:prstGeom>
          <a:noFill/>
        </p:spPr>
        <p:txBody>
          <a:bodyPr wrap="square" rtlCol="0" anchor="t">
            <a:spAutoFit/>
          </a:bodyPr>
          <a:lstStyle/>
          <a:p>
            <a:pPr algn="ctr"/>
            <a:r>
              <a:rPr lang="en-US" sz="1200"/>
              <a:t>Centers for Disease Control and Prevention. National Center for Chronic Disease Prevention and Health Promotion, Division of Nutrition, Physical Activity, and Obesity. Data, Trend and Maps [online]. [accessed Nov 26, 2019]. URL: https://</a:t>
            </a:r>
            <a:r>
              <a:rPr lang="en-US" sz="1200" err="1"/>
              <a:t>www.cdc.gov</a:t>
            </a:r>
            <a:r>
              <a:rPr lang="en-US" sz="1200"/>
              <a:t>/</a:t>
            </a:r>
            <a:r>
              <a:rPr lang="en-US" sz="1200" err="1"/>
              <a:t>nccdphp</a:t>
            </a:r>
            <a:r>
              <a:rPr lang="en-US" sz="1200"/>
              <a:t>/</a:t>
            </a:r>
            <a:r>
              <a:rPr lang="en-US" sz="1200" err="1"/>
              <a:t>dnpao</a:t>
            </a:r>
            <a:r>
              <a:rPr lang="en-US" sz="1200"/>
              <a:t>/data-trends-maps/</a:t>
            </a:r>
            <a:r>
              <a:rPr lang="en-US" sz="1200" err="1"/>
              <a:t>index.html</a:t>
            </a:r>
            <a:r>
              <a:rPr lang="en-US" sz="1200"/>
              <a:t>.</a:t>
            </a:r>
          </a:p>
        </p:txBody>
      </p:sp>
      <p:pic>
        <p:nvPicPr>
          <p:cNvPr id="3" name="Picture 2"/>
          <p:cNvPicPr>
            <a:picLocks noChangeAspect="1"/>
          </p:cNvPicPr>
          <p:nvPr/>
        </p:nvPicPr>
        <p:blipFill>
          <a:blip r:embed="rId3"/>
          <a:stretch>
            <a:fillRect/>
          </a:stretch>
        </p:blipFill>
        <p:spPr>
          <a:xfrm>
            <a:off x="1602828" y="1690688"/>
            <a:ext cx="9279940" cy="4031644"/>
          </a:xfrm>
          <a:prstGeom prst="rect">
            <a:avLst/>
          </a:prstGeom>
          <a:ln>
            <a:noFill/>
          </a:ln>
          <a:effectLst>
            <a:outerShdw blurRad="190500" algn="tl" rotWithShape="0">
              <a:srgbClr val="000000">
                <a:alpha val="70000"/>
              </a:srgbClr>
            </a:outerShdw>
          </a:effectLst>
        </p:spPr>
      </p:pic>
      <p:sp>
        <p:nvSpPr>
          <p:cNvPr id="8" name="Rectangle 7">
            <a:extLst>
              <a:ext uri="{FF2B5EF4-FFF2-40B4-BE49-F238E27FC236}">
                <a16:creationId xmlns:a16="http://schemas.microsoft.com/office/drawing/2014/main" id="{BC8201AD-AC3D-DF4B-A54D-8E8C9DEC638E}"/>
              </a:ext>
            </a:extLst>
          </p:cNvPr>
          <p:cNvSpPr/>
          <p:nvPr/>
        </p:nvSpPr>
        <p:spPr>
          <a:xfrm>
            <a:off x="1684332" y="2622093"/>
            <a:ext cx="563159" cy="127461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00861647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FB61BC91-38AF-1643-9650-B5DCD8C4D395}"/>
              </a:ext>
            </a:extLst>
          </p:cNvPr>
          <p:cNvSpPr>
            <a:spLocks noGrp="1"/>
          </p:cNvSpPr>
          <p:nvPr>
            <p:ph type="title"/>
          </p:nvPr>
        </p:nvSpPr>
        <p:spPr/>
        <p:txBody>
          <a:bodyPr>
            <a:normAutofit/>
          </a:bodyPr>
          <a:lstStyle/>
          <a:p>
            <a:r>
              <a:rPr lang="en-US" sz="4800">
                <a:solidFill>
                  <a:schemeClr val="tx1"/>
                </a:solidFill>
              </a:rPr>
              <a:t>Who is meeting the guidelines?</a:t>
            </a:r>
            <a:endParaRPr lang="en-US" sz="4800">
              <a:solidFill>
                <a:schemeClr val="tx2"/>
              </a:solidFill>
            </a:endParaRPr>
          </a:p>
        </p:txBody>
      </p:sp>
      <p:pic>
        <p:nvPicPr>
          <p:cNvPr id="2" name="Picture 1"/>
          <p:cNvPicPr>
            <a:picLocks noChangeAspect="1"/>
          </p:cNvPicPr>
          <p:nvPr/>
        </p:nvPicPr>
        <p:blipFill>
          <a:blip r:embed="rId3"/>
          <a:stretch>
            <a:fillRect/>
          </a:stretch>
        </p:blipFill>
        <p:spPr>
          <a:xfrm>
            <a:off x="1429406" y="1690688"/>
            <a:ext cx="9331641" cy="4099542"/>
          </a:xfrm>
          <a:prstGeom prst="rect">
            <a:avLst/>
          </a:prstGeom>
          <a:ln>
            <a:noFill/>
          </a:ln>
          <a:effectLst>
            <a:outerShdw blurRad="190500" algn="tl" rotWithShape="0">
              <a:srgbClr val="000000">
                <a:alpha val="70000"/>
              </a:srgbClr>
            </a:outerShdw>
          </a:effectLst>
        </p:spPr>
      </p:pic>
      <p:sp>
        <p:nvSpPr>
          <p:cNvPr id="7" name="Rectangle 6">
            <a:extLst>
              <a:ext uri="{FF2B5EF4-FFF2-40B4-BE49-F238E27FC236}">
                <a16:creationId xmlns:a16="http://schemas.microsoft.com/office/drawing/2014/main" id="{54638150-047D-134F-91A8-E2CF2CF6892A}"/>
              </a:ext>
            </a:extLst>
          </p:cNvPr>
          <p:cNvSpPr/>
          <p:nvPr/>
        </p:nvSpPr>
        <p:spPr>
          <a:xfrm>
            <a:off x="1502978" y="2687646"/>
            <a:ext cx="563159" cy="127461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D6E83029-1FC6-476D-BE34-70143F8DC552}"/>
              </a:ext>
            </a:extLst>
          </p:cNvPr>
          <p:cNvSpPr txBox="1"/>
          <p:nvPr/>
        </p:nvSpPr>
        <p:spPr>
          <a:xfrm>
            <a:off x="4724400" y="320040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t>Click to add text</a:t>
            </a:r>
          </a:p>
        </p:txBody>
      </p:sp>
      <p:sp>
        <p:nvSpPr>
          <p:cNvPr id="9" name="TextBox 8">
            <a:extLst>
              <a:ext uri="{FF2B5EF4-FFF2-40B4-BE49-F238E27FC236}">
                <a16:creationId xmlns:a16="http://schemas.microsoft.com/office/drawing/2014/main" id="{6FC60F52-312A-4506-9BAC-178F285F4FEB}"/>
              </a:ext>
            </a:extLst>
          </p:cNvPr>
          <p:cNvSpPr txBox="1"/>
          <p:nvPr/>
        </p:nvSpPr>
        <p:spPr>
          <a:xfrm>
            <a:off x="418260" y="6354375"/>
            <a:ext cx="11649075" cy="461665"/>
          </a:xfrm>
          <a:prstGeom prst="rect">
            <a:avLst/>
          </a:prstGeom>
          <a:noFill/>
        </p:spPr>
        <p:txBody>
          <a:bodyPr wrap="square" rtlCol="0" anchor="t">
            <a:spAutoFit/>
          </a:bodyPr>
          <a:lstStyle/>
          <a:p>
            <a:pPr algn="ctr"/>
            <a:r>
              <a:rPr lang="en-US" sz="1200"/>
              <a:t>Centers for Disease Control and Prevention. National Center for Chronic Disease Prevention and Health Promotion, Division of Nutrition, Physical Activity, and Obesity. Data, Trend and Maps [online]. [accessed Nov 26, 2019]. URL: https://</a:t>
            </a:r>
            <a:r>
              <a:rPr lang="en-US" sz="1200" err="1"/>
              <a:t>www.cdc.gov</a:t>
            </a:r>
            <a:r>
              <a:rPr lang="en-US" sz="1200"/>
              <a:t>/</a:t>
            </a:r>
            <a:r>
              <a:rPr lang="en-US" sz="1200" err="1"/>
              <a:t>nccdphp</a:t>
            </a:r>
            <a:r>
              <a:rPr lang="en-US" sz="1200"/>
              <a:t>/</a:t>
            </a:r>
            <a:r>
              <a:rPr lang="en-US" sz="1200" err="1"/>
              <a:t>dnpao</a:t>
            </a:r>
            <a:r>
              <a:rPr lang="en-US" sz="1200"/>
              <a:t>/data-trends-maps/</a:t>
            </a:r>
            <a:r>
              <a:rPr lang="en-US" sz="1200" err="1"/>
              <a:t>index.html</a:t>
            </a:r>
            <a:r>
              <a:rPr lang="en-US" sz="1200"/>
              <a:t>.</a:t>
            </a:r>
          </a:p>
        </p:txBody>
      </p:sp>
    </p:spTree>
    <p:extLst>
      <p:ext uri="{BB962C8B-B14F-4D97-AF65-F5344CB8AC3E}">
        <p14:creationId xmlns:p14="http://schemas.microsoft.com/office/powerpoint/2010/main" val="2361581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FB61BC91-38AF-1643-9650-B5DCD8C4D395}"/>
              </a:ext>
            </a:extLst>
          </p:cNvPr>
          <p:cNvSpPr>
            <a:spLocks noGrp="1"/>
          </p:cNvSpPr>
          <p:nvPr>
            <p:ph type="title"/>
          </p:nvPr>
        </p:nvSpPr>
        <p:spPr/>
        <p:txBody>
          <a:bodyPr>
            <a:normAutofit/>
          </a:bodyPr>
          <a:lstStyle/>
          <a:p>
            <a:r>
              <a:rPr lang="en-US" sz="4800">
                <a:solidFill>
                  <a:schemeClr val="tx1"/>
                </a:solidFill>
              </a:rPr>
              <a:t>Who is meeting the guidelines?</a:t>
            </a:r>
            <a:endParaRPr lang="en-US" sz="4800">
              <a:solidFill>
                <a:schemeClr val="tx2"/>
              </a:solidFill>
            </a:endParaRPr>
          </a:p>
        </p:txBody>
      </p:sp>
      <p:pic>
        <p:nvPicPr>
          <p:cNvPr id="2" name="Picture 1"/>
          <p:cNvPicPr>
            <a:picLocks noChangeAspect="1"/>
          </p:cNvPicPr>
          <p:nvPr/>
        </p:nvPicPr>
        <p:blipFill>
          <a:blip r:embed="rId3"/>
          <a:stretch>
            <a:fillRect/>
          </a:stretch>
        </p:blipFill>
        <p:spPr>
          <a:xfrm>
            <a:off x="1429406" y="1690688"/>
            <a:ext cx="9331641" cy="4099542"/>
          </a:xfrm>
          <a:prstGeom prst="rect">
            <a:avLst/>
          </a:prstGeom>
          <a:ln>
            <a:noFill/>
          </a:ln>
          <a:effectLst>
            <a:outerShdw blurRad="190500" algn="tl" rotWithShape="0">
              <a:srgbClr val="000000">
                <a:alpha val="70000"/>
              </a:srgbClr>
            </a:outerShdw>
          </a:effectLst>
        </p:spPr>
      </p:pic>
      <p:sp>
        <p:nvSpPr>
          <p:cNvPr id="7" name="Rectangle 6">
            <a:extLst>
              <a:ext uri="{FF2B5EF4-FFF2-40B4-BE49-F238E27FC236}">
                <a16:creationId xmlns:a16="http://schemas.microsoft.com/office/drawing/2014/main" id="{54638150-047D-134F-91A8-E2CF2CF6892A}"/>
              </a:ext>
            </a:extLst>
          </p:cNvPr>
          <p:cNvSpPr/>
          <p:nvPr/>
        </p:nvSpPr>
        <p:spPr>
          <a:xfrm>
            <a:off x="1502978" y="2687646"/>
            <a:ext cx="563159" cy="127461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D6E83029-1FC6-476D-BE34-70143F8DC552}"/>
              </a:ext>
            </a:extLst>
          </p:cNvPr>
          <p:cNvSpPr txBox="1"/>
          <p:nvPr/>
        </p:nvSpPr>
        <p:spPr>
          <a:xfrm>
            <a:off x="4724400" y="320040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t>Click to add text</a:t>
            </a:r>
          </a:p>
        </p:txBody>
      </p:sp>
      <p:sp>
        <p:nvSpPr>
          <p:cNvPr id="3" name="TextBox 2">
            <a:extLst>
              <a:ext uri="{FF2B5EF4-FFF2-40B4-BE49-F238E27FC236}">
                <a16:creationId xmlns:a16="http://schemas.microsoft.com/office/drawing/2014/main" id="{C815C8FE-447B-4A31-ACB3-C25D905AA430}"/>
              </a:ext>
            </a:extLst>
          </p:cNvPr>
          <p:cNvSpPr txBox="1"/>
          <p:nvPr/>
        </p:nvSpPr>
        <p:spPr>
          <a:xfrm>
            <a:off x="418260" y="6354375"/>
            <a:ext cx="11649075" cy="461665"/>
          </a:xfrm>
          <a:prstGeom prst="rect">
            <a:avLst/>
          </a:prstGeom>
          <a:noFill/>
        </p:spPr>
        <p:txBody>
          <a:bodyPr wrap="square" rtlCol="0" anchor="t">
            <a:spAutoFit/>
          </a:bodyPr>
          <a:lstStyle/>
          <a:p>
            <a:pPr algn="ctr"/>
            <a:r>
              <a:rPr lang="en-US" sz="1200"/>
              <a:t>Centers for Disease Control and Prevention. National Center for Chronic Disease Prevention and Health Promotion, Division of Nutrition, Physical Activity, and Obesity. Data, Trend and Maps [online]. [accessed Nov 26, 2019]. URL: https://</a:t>
            </a:r>
            <a:r>
              <a:rPr lang="en-US" sz="1200" err="1"/>
              <a:t>www.cdc.gov</a:t>
            </a:r>
            <a:r>
              <a:rPr lang="en-US" sz="1200"/>
              <a:t>/</a:t>
            </a:r>
            <a:r>
              <a:rPr lang="en-US" sz="1200" err="1"/>
              <a:t>nccdphp</a:t>
            </a:r>
            <a:r>
              <a:rPr lang="en-US" sz="1200"/>
              <a:t>/</a:t>
            </a:r>
            <a:r>
              <a:rPr lang="en-US" sz="1200" err="1"/>
              <a:t>dnpao</a:t>
            </a:r>
            <a:r>
              <a:rPr lang="en-US" sz="1200"/>
              <a:t>/data-trends-maps/</a:t>
            </a:r>
            <a:r>
              <a:rPr lang="en-US" sz="1200" err="1"/>
              <a:t>index.html</a:t>
            </a:r>
            <a:r>
              <a:rPr lang="en-US" sz="1200"/>
              <a:t>.</a:t>
            </a:r>
          </a:p>
        </p:txBody>
      </p:sp>
    </p:spTree>
    <p:extLst>
      <p:ext uri="{BB962C8B-B14F-4D97-AF65-F5344CB8AC3E}">
        <p14:creationId xmlns:p14="http://schemas.microsoft.com/office/powerpoint/2010/main" val="311618329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FB61BC91-38AF-1643-9650-B5DCD8C4D395}"/>
              </a:ext>
            </a:extLst>
          </p:cNvPr>
          <p:cNvSpPr>
            <a:spLocks noGrp="1"/>
          </p:cNvSpPr>
          <p:nvPr>
            <p:ph type="title"/>
          </p:nvPr>
        </p:nvSpPr>
        <p:spPr/>
        <p:txBody>
          <a:bodyPr>
            <a:normAutofit/>
          </a:bodyPr>
          <a:lstStyle/>
          <a:p>
            <a:r>
              <a:rPr lang="en-US" sz="4800">
                <a:solidFill>
                  <a:schemeClr val="tx1"/>
                </a:solidFill>
              </a:rPr>
              <a:t>Who is meeting the guidelines?</a:t>
            </a:r>
          </a:p>
        </p:txBody>
      </p:sp>
      <p:pic>
        <p:nvPicPr>
          <p:cNvPr id="3" name="Picture 2"/>
          <p:cNvPicPr>
            <a:picLocks noChangeAspect="1"/>
          </p:cNvPicPr>
          <p:nvPr/>
        </p:nvPicPr>
        <p:blipFill>
          <a:blip r:embed="rId3"/>
          <a:stretch>
            <a:fillRect/>
          </a:stretch>
        </p:blipFill>
        <p:spPr>
          <a:xfrm>
            <a:off x="1475120" y="1514651"/>
            <a:ext cx="9241759" cy="4302910"/>
          </a:xfrm>
          <a:prstGeom prst="rect">
            <a:avLst/>
          </a:prstGeom>
          <a:ln>
            <a:noFill/>
          </a:ln>
          <a:effectLst>
            <a:outerShdw blurRad="190500" algn="tl" rotWithShape="0">
              <a:srgbClr val="000000">
                <a:alpha val="70000"/>
              </a:srgbClr>
            </a:outerShdw>
          </a:effectLst>
        </p:spPr>
      </p:pic>
      <p:sp>
        <p:nvSpPr>
          <p:cNvPr id="2" name="TextBox 1">
            <a:extLst>
              <a:ext uri="{FF2B5EF4-FFF2-40B4-BE49-F238E27FC236}">
                <a16:creationId xmlns:a16="http://schemas.microsoft.com/office/drawing/2014/main" id="{B5692F45-49DA-4C23-A130-DC47F5B4357E}"/>
              </a:ext>
            </a:extLst>
          </p:cNvPr>
          <p:cNvSpPr txBox="1"/>
          <p:nvPr/>
        </p:nvSpPr>
        <p:spPr>
          <a:xfrm>
            <a:off x="418260" y="6354375"/>
            <a:ext cx="11649075" cy="461665"/>
          </a:xfrm>
          <a:prstGeom prst="rect">
            <a:avLst/>
          </a:prstGeom>
          <a:noFill/>
        </p:spPr>
        <p:txBody>
          <a:bodyPr wrap="square" rtlCol="0" anchor="t">
            <a:spAutoFit/>
          </a:bodyPr>
          <a:lstStyle/>
          <a:p>
            <a:pPr algn="ctr"/>
            <a:r>
              <a:rPr lang="en-US" sz="1200"/>
              <a:t>Centers for Disease Control and Prevention. National Center for Chronic Disease Prevention and Health Promotion, Division of Nutrition, Physical Activity, and Obesity. Data, Trend and Maps [online]. [accessed Nov 26, 2019]. URL: https://</a:t>
            </a:r>
            <a:r>
              <a:rPr lang="en-US" sz="1200" err="1"/>
              <a:t>www.cdc.gov</a:t>
            </a:r>
            <a:r>
              <a:rPr lang="en-US" sz="1200"/>
              <a:t>/</a:t>
            </a:r>
            <a:r>
              <a:rPr lang="en-US" sz="1200" err="1"/>
              <a:t>nccdphp</a:t>
            </a:r>
            <a:r>
              <a:rPr lang="en-US" sz="1200"/>
              <a:t>/</a:t>
            </a:r>
            <a:r>
              <a:rPr lang="en-US" sz="1200" err="1"/>
              <a:t>dnpao</a:t>
            </a:r>
            <a:r>
              <a:rPr lang="en-US" sz="1200"/>
              <a:t>/data-trends-maps/</a:t>
            </a:r>
            <a:r>
              <a:rPr lang="en-US" sz="1200" err="1"/>
              <a:t>index.html</a:t>
            </a:r>
            <a:r>
              <a:rPr lang="en-US" sz="1200"/>
              <a:t>.</a:t>
            </a:r>
          </a:p>
        </p:txBody>
      </p:sp>
    </p:spTree>
    <p:extLst>
      <p:ext uri="{BB962C8B-B14F-4D97-AF65-F5344CB8AC3E}">
        <p14:creationId xmlns:p14="http://schemas.microsoft.com/office/powerpoint/2010/main" val="95428029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Implementation of the Guidelines</a:t>
            </a:r>
            <a:endParaRPr lang="en-US" sz="3600">
              <a:solidFill>
                <a:schemeClr val="tx1"/>
              </a:solidFill>
            </a:endParaRPr>
          </a:p>
        </p:txBody>
      </p:sp>
      <p:sp>
        <p:nvSpPr>
          <p:cNvPr id="5" name="Content Placeholder 4"/>
          <p:cNvSpPr>
            <a:spLocks noGrp="1"/>
          </p:cNvSpPr>
          <p:nvPr>
            <p:ph idx="1"/>
          </p:nvPr>
        </p:nvSpPr>
        <p:spPr>
          <a:xfrm>
            <a:off x="1120000" y="1825625"/>
            <a:ext cx="10233800" cy="3810677"/>
          </a:xfrm>
        </p:spPr>
        <p:txBody>
          <a:bodyPr>
            <a:normAutofit/>
          </a:bodyPr>
          <a:lstStyle/>
          <a:p>
            <a:pPr marL="0" indent="0">
              <a:buNone/>
            </a:pPr>
            <a:br>
              <a:rPr lang="en-US"/>
            </a:br>
            <a:endParaRPr lang="en-US"/>
          </a:p>
        </p:txBody>
      </p:sp>
      <p:pic>
        <p:nvPicPr>
          <p:cNvPr id="4" name="Picture 3"/>
          <p:cNvPicPr>
            <a:picLocks noChangeAspect="1"/>
          </p:cNvPicPr>
          <p:nvPr/>
        </p:nvPicPr>
        <p:blipFill>
          <a:blip r:embed="rId3"/>
          <a:stretch>
            <a:fillRect/>
          </a:stretch>
        </p:blipFill>
        <p:spPr>
          <a:xfrm>
            <a:off x="3827813" y="1398535"/>
            <a:ext cx="4536374" cy="4664855"/>
          </a:xfrm>
          <a:prstGeom prst="rect">
            <a:avLst/>
          </a:prstGeom>
          <a:ln>
            <a:noFill/>
          </a:ln>
          <a:effectLst>
            <a:outerShdw blurRad="190500" algn="tl" rotWithShape="0">
              <a:srgbClr val="000000">
                <a:alpha val="70000"/>
              </a:srgbClr>
            </a:outerShdw>
          </a:effectLst>
        </p:spPr>
      </p:pic>
      <p:sp>
        <p:nvSpPr>
          <p:cNvPr id="6" name="TextBox 5">
            <a:extLst>
              <a:ext uri="{FF2B5EF4-FFF2-40B4-BE49-F238E27FC236}">
                <a16:creationId xmlns:a16="http://schemas.microsoft.com/office/drawing/2014/main" id="{1829A6C8-4922-CD4E-AB13-90DD2A333647}"/>
              </a:ext>
            </a:extLst>
          </p:cNvPr>
          <p:cNvSpPr txBox="1"/>
          <p:nvPr/>
        </p:nvSpPr>
        <p:spPr>
          <a:xfrm>
            <a:off x="226625" y="6231265"/>
            <a:ext cx="12020549" cy="523220"/>
          </a:xfrm>
          <a:prstGeom prst="rect">
            <a:avLst/>
          </a:prstGeom>
          <a:noFill/>
        </p:spPr>
        <p:txBody>
          <a:bodyPr wrap="square" rtlCol="0" anchor="t">
            <a:spAutoFit/>
          </a:bodyPr>
          <a:lstStyle/>
          <a:p>
            <a:pPr algn="ctr"/>
            <a:r>
              <a:rPr lang="en-US" sz="1400">
                <a:ea typeface="+mn-lt"/>
                <a:cs typeface="+mn-lt"/>
              </a:rPr>
              <a:t>Move Your Way Campaign Materials. U.S. Department of Health and Human Services website. </a:t>
            </a:r>
            <a:r>
              <a:rPr lang="en-US" sz="1400">
                <a:hlinkClick r:id="rId4"/>
              </a:rPr>
              <a:t>https://health.gov/paguidelines/moveyourway/</a:t>
            </a:r>
            <a:r>
              <a:rPr lang="en-US" sz="1400">
                <a:ea typeface="+mn-lt"/>
                <a:cs typeface="+mn-lt"/>
              </a:rPr>
              <a:t>. Updated November 26, 2019. Accessed November 26, 2019.</a:t>
            </a:r>
            <a:endParaRPr lang="en-US">
              <a:ea typeface="+mn-lt"/>
              <a:cs typeface="+mn-lt"/>
            </a:endParaRPr>
          </a:p>
        </p:txBody>
      </p:sp>
    </p:spTree>
    <p:extLst>
      <p:ext uri="{BB962C8B-B14F-4D97-AF65-F5344CB8AC3E}">
        <p14:creationId xmlns:p14="http://schemas.microsoft.com/office/powerpoint/2010/main" val="142191252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The Physician’s Role</a:t>
            </a:r>
          </a:p>
        </p:txBody>
      </p:sp>
      <p:sp>
        <p:nvSpPr>
          <p:cNvPr id="3" name="Content Placeholder 2"/>
          <p:cNvSpPr>
            <a:spLocks noGrp="1"/>
          </p:cNvSpPr>
          <p:nvPr>
            <p:ph idx="1"/>
          </p:nvPr>
        </p:nvSpPr>
        <p:spPr>
          <a:xfrm>
            <a:off x="838199" y="1733285"/>
            <a:ext cx="9334491" cy="4184039"/>
          </a:xfrm>
        </p:spPr>
        <p:txBody>
          <a:bodyPr>
            <a:normAutofit/>
          </a:bodyPr>
          <a:lstStyle/>
          <a:p>
            <a:r>
              <a:rPr lang="en-US" sz="2400" b="1"/>
              <a:t>Health People 2020 </a:t>
            </a:r>
            <a:r>
              <a:rPr lang="en-US" sz="2400"/>
              <a:t>recommends an increase in the proportion of physician office visits that include counseling or education related to physical activity</a:t>
            </a:r>
          </a:p>
          <a:p>
            <a:endParaRPr lang="en-US" sz="2400"/>
          </a:p>
          <a:p>
            <a:endParaRPr lang="en-US" sz="2000"/>
          </a:p>
          <a:p>
            <a:endParaRPr lang="en-US" sz="2000"/>
          </a:p>
        </p:txBody>
      </p:sp>
    </p:spTree>
    <p:extLst>
      <p:ext uri="{BB962C8B-B14F-4D97-AF65-F5344CB8AC3E}">
        <p14:creationId xmlns:p14="http://schemas.microsoft.com/office/powerpoint/2010/main" val="43294034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The Physician’s Role</a:t>
            </a:r>
          </a:p>
        </p:txBody>
      </p:sp>
      <p:sp>
        <p:nvSpPr>
          <p:cNvPr id="3" name="Content Placeholder 2"/>
          <p:cNvSpPr>
            <a:spLocks noGrp="1"/>
          </p:cNvSpPr>
          <p:nvPr>
            <p:ph idx="1"/>
          </p:nvPr>
        </p:nvSpPr>
        <p:spPr>
          <a:xfrm>
            <a:off x="838199" y="1733285"/>
            <a:ext cx="9334491" cy="4677599"/>
          </a:xfrm>
        </p:spPr>
        <p:txBody>
          <a:bodyPr vert="horz" lIns="91440" tIns="45720" rIns="91440" bIns="45720" rtlCol="0" anchor="t">
            <a:normAutofit/>
          </a:bodyPr>
          <a:lstStyle/>
          <a:p>
            <a:r>
              <a:rPr lang="en-US" sz="2400" b="1"/>
              <a:t>Health People 2020 </a:t>
            </a:r>
            <a:r>
              <a:rPr lang="en-US" sz="2400"/>
              <a:t>recommends an increase in the proportion of physician office visits that include counseling or education related to physical activity</a:t>
            </a:r>
          </a:p>
          <a:p>
            <a:endParaRPr lang="en-US" sz="2400">
              <a:ea typeface="+mn-lt"/>
              <a:cs typeface="+mn-lt"/>
            </a:endParaRPr>
          </a:p>
          <a:p>
            <a:r>
              <a:rPr lang="en-US" sz="2400">
                <a:ea typeface="+mn-lt"/>
                <a:cs typeface="+mn-lt"/>
              </a:rPr>
              <a:t>Only about 58% of primary care physicians counsel MOST of their high risk patients on physical activity</a:t>
            </a:r>
            <a:endParaRPr lang="en-US" sz="2400">
              <a:cs typeface="Arial"/>
            </a:endParaRPr>
          </a:p>
          <a:p>
            <a:endParaRPr lang="en-US" sz="2400"/>
          </a:p>
          <a:p>
            <a:endParaRPr lang="en-US" sz="2400">
              <a:cs typeface="Arial"/>
            </a:endParaRPr>
          </a:p>
          <a:p>
            <a:endParaRPr lang="en-US" sz="2400"/>
          </a:p>
          <a:p>
            <a:endParaRPr lang="en-US" sz="2400">
              <a:cs typeface="Arial"/>
            </a:endParaRPr>
          </a:p>
          <a:p>
            <a:endParaRPr lang="en-US" sz="2000"/>
          </a:p>
          <a:p>
            <a:endParaRPr lang="en-US" sz="2000"/>
          </a:p>
        </p:txBody>
      </p:sp>
    </p:spTree>
    <p:extLst>
      <p:ext uri="{BB962C8B-B14F-4D97-AF65-F5344CB8AC3E}">
        <p14:creationId xmlns:p14="http://schemas.microsoft.com/office/powerpoint/2010/main" val="20666417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The Physician’s Role</a:t>
            </a:r>
          </a:p>
        </p:txBody>
      </p:sp>
      <p:sp>
        <p:nvSpPr>
          <p:cNvPr id="3" name="Content Placeholder 2"/>
          <p:cNvSpPr>
            <a:spLocks noGrp="1"/>
          </p:cNvSpPr>
          <p:nvPr>
            <p:ph idx="1"/>
          </p:nvPr>
        </p:nvSpPr>
        <p:spPr>
          <a:xfrm>
            <a:off x="838199" y="1733285"/>
            <a:ext cx="9334491" cy="4677599"/>
          </a:xfrm>
        </p:spPr>
        <p:txBody>
          <a:bodyPr vert="horz" lIns="91440" tIns="45720" rIns="91440" bIns="45720" rtlCol="0" anchor="t">
            <a:normAutofit/>
          </a:bodyPr>
          <a:lstStyle/>
          <a:p>
            <a:r>
              <a:rPr lang="en-US" sz="2400" b="1"/>
              <a:t>Health People 2020 </a:t>
            </a:r>
            <a:r>
              <a:rPr lang="en-US" sz="2400"/>
              <a:t>recommends an increase in the proportion of physician office visits that include counseling or education related to physical activity</a:t>
            </a:r>
          </a:p>
          <a:p>
            <a:endParaRPr lang="en-US" sz="2400">
              <a:ea typeface="+mn-lt"/>
              <a:cs typeface="+mn-lt"/>
            </a:endParaRPr>
          </a:p>
          <a:p>
            <a:r>
              <a:rPr lang="en-US" sz="2400">
                <a:ea typeface="+mn-lt"/>
                <a:cs typeface="+mn-lt"/>
              </a:rPr>
              <a:t>Only about 58% of primary care physicians counsel MOST of their high risk patients on physical activity</a:t>
            </a:r>
            <a:endParaRPr lang="en-US" sz="2400">
              <a:cs typeface="Arial"/>
            </a:endParaRPr>
          </a:p>
          <a:p>
            <a:endParaRPr lang="en-US" sz="2400">
              <a:ea typeface="+mn-lt"/>
              <a:cs typeface="+mn-lt"/>
            </a:endParaRPr>
          </a:p>
          <a:p>
            <a:r>
              <a:rPr lang="en-US" sz="2400" b="1">
                <a:ea typeface="+mn-lt"/>
                <a:cs typeface="+mn-lt"/>
              </a:rPr>
              <a:t>National Activity Plan </a:t>
            </a:r>
            <a:r>
              <a:rPr lang="en-US" sz="2400">
                <a:ea typeface="+mn-lt"/>
                <a:cs typeface="+mn-lt"/>
              </a:rPr>
              <a:t>advocates making physical activity a vital sign</a:t>
            </a:r>
            <a:endParaRPr lang="en-US" sz="2400">
              <a:cs typeface="Arial"/>
            </a:endParaRPr>
          </a:p>
          <a:p>
            <a:endParaRPr lang="en-US" sz="2400">
              <a:cs typeface="Arial"/>
            </a:endParaRPr>
          </a:p>
          <a:p>
            <a:endParaRPr lang="en-US" sz="2400">
              <a:cs typeface="Arial"/>
            </a:endParaRPr>
          </a:p>
          <a:p>
            <a:endParaRPr lang="en-US" sz="2400">
              <a:cs typeface="Arial"/>
            </a:endParaRPr>
          </a:p>
          <a:p>
            <a:endParaRPr lang="en-US" sz="2400">
              <a:cs typeface="Arial"/>
            </a:endParaRPr>
          </a:p>
          <a:p>
            <a:endParaRPr lang="en-US" sz="2000"/>
          </a:p>
          <a:p>
            <a:endParaRPr lang="en-US" sz="2000">
              <a:cs typeface="Arial"/>
            </a:endParaRPr>
          </a:p>
        </p:txBody>
      </p:sp>
    </p:spTree>
    <p:extLst>
      <p:ext uri="{BB962C8B-B14F-4D97-AF65-F5344CB8AC3E}">
        <p14:creationId xmlns:p14="http://schemas.microsoft.com/office/powerpoint/2010/main" val="37961211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Learning Objectives</a:t>
            </a:r>
          </a:p>
        </p:txBody>
      </p:sp>
      <p:sp>
        <p:nvSpPr>
          <p:cNvPr id="3" name="Content Placeholder 2"/>
          <p:cNvSpPr>
            <a:spLocks noGrp="1"/>
          </p:cNvSpPr>
          <p:nvPr>
            <p:ph idx="1"/>
          </p:nvPr>
        </p:nvSpPr>
        <p:spPr/>
        <p:txBody>
          <a:bodyPr>
            <a:normAutofit/>
          </a:bodyPr>
          <a:lstStyle/>
          <a:p>
            <a:r>
              <a:rPr lang="en-US" sz="2400"/>
              <a:t>Recognize the health and quality of life benefits of physical activity</a:t>
            </a:r>
          </a:p>
          <a:p>
            <a:endParaRPr lang="en-US" sz="2400"/>
          </a:p>
          <a:p>
            <a:r>
              <a:rPr lang="en-US" sz="2400"/>
              <a:t>Review evidence-based recommendations for physical activity </a:t>
            </a:r>
          </a:p>
          <a:p>
            <a:pPr marL="0" indent="0">
              <a:spcAft>
                <a:spcPts val="600"/>
              </a:spcAft>
              <a:buNone/>
            </a:pPr>
            <a:endParaRPr lang="en-US" sz="2400"/>
          </a:p>
          <a:p>
            <a:r>
              <a:rPr lang="en-US" sz="2400"/>
              <a:t>Describe the steps needed to prescribe physical activity to patients</a:t>
            </a:r>
          </a:p>
          <a:p>
            <a:endParaRPr lang="en-US" sz="2400"/>
          </a:p>
          <a:p>
            <a:r>
              <a:rPr lang="en-US" sz="2400"/>
              <a:t>Reflect on how to incorporate more physical activity into your own life</a:t>
            </a:r>
          </a:p>
        </p:txBody>
      </p:sp>
    </p:spTree>
    <p:extLst>
      <p:ext uri="{BB962C8B-B14F-4D97-AF65-F5344CB8AC3E}">
        <p14:creationId xmlns:p14="http://schemas.microsoft.com/office/powerpoint/2010/main" val="17436023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The Physician’s Role</a:t>
            </a:r>
          </a:p>
        </p:txBody>
      </p:sp>
      <p:sp>
        <p:nvSpPr>
          <p:cNvPr id="3" name="Content Placeholder 2"/>
          <p:cNvSpPr>
            <a:spLocks noGrp="1"/>
          </p:cNvSpPr>
          <p:nvPr>
            <p:ph idx="1"/>
          </p:nvPr>
        </p:nvSpPr>
        <p:spPr>
          <a:xfrm>
            <a:off x="838199" y="1733285"/>
            <a:ext cx="9334491" cy="4677599"/>
          </a:xfrm>
        </p:spPr>
        <p:txBody>
          <a:bodyPr vert="horz" lIns="91440" tIns="45720" rIns="91440" bIns="45720" rtlCol="0" anchor="t">
            <a:normAutofit lnSpcReduction="10000"/>
          </a:bodyPr>
          <a:lstStyle/>
          <a:p>
            <a:r>
              <a:rPr lang="en-US" sz="2400" b="1"/>
              <a:t>Health People 2020 </a:t>
            </a:r>
            <a:r>
              <a:rPr lang="en-US" sz="2400"/>
              <a:t>recommends an increase in the proportion of physician office visits that include counseling or education related to physical activity</a:t>
            </a:r>
          </a:p>
          <a:p>
            <a:endParaRPr lang="en-US" sz="2400">
              <a:ea typeface="+mn-lt"/>
              <a:cs typeface="+mn-lt"/>
            </a:endParaRPr>
          </a:p>
          <a:p>
            <a:r>
              <a:rPr lang="en-US" sz="2400">
                <a:ea typeface="+mn-lt"/>
                <a:cs typeface="+mn-lt"/>
              </a:rPr>
              <a:t>Only about 58% of primary care physicians counsel MOST of their high risk patients on physical activity</a:t>
            </a:r>
            <a:endParaRPr lang="en-US" sz="2400">
              <a:cs typeface="Arial"/>
            </a:endParaRPr>
          </a:p>
          <a:p>
            <a:endParaRPr lang="en-US" sz="2400"/>
          </a:p>
          <a:p>
            <a:r>
              <a:rPr lang="en-US" sz="2400" b="1"/>
              <a:t>National Activity Plan </a:t>
            </a:r>
            <a:r>
              <a:rPr lang="en-US" sz="2400"/>
              <a:t>advocates making physical activity a vital sign</a:t>
            </a:r>
            <a:endParaRPr lang="en-US" sz="2400">
              <a:cs typeface="Arial"/>
            </a:endParaRPr>
          </a:p>
          <a:p>
            <a:endParaRPr lang="en-US" sz="2400"/>
          </a:p>
          <a:p>
            <a:r>
              <a:rPr lang="en-US" sz="2400"/>
              <a:t>Physicians (and medical students!) who are </a:t>
            </a:r>
            <a:r>
              <a:rPr lang="en-US" sz="2400" b="1"/>
              <a:t>personally active </a:t>
            </a:r>
            <a:r>
              <a:rPr lang="en-US" sz="2400"/>
              <a:t>are more likely to counsel patients about physical activity</a:t>
            </a:r>
            <a:endParaRPr lang="en-US" sz="2400">
              <a:cs typeface="Arial"/>
            </a:endParaRPr>
          </a:p>
          <a:p>
            <a:endParaRPr lang="en-US" sz="2400"/>
          </a:p>
          <a:p>
            <a:endParaRPr lang="en-US" sz="2400">
              <a:cs typeface="Arial"/>
            </a:endParaRPr>
          </a:p>
          <a:p>
            <a:endParaRPr lang="en-US" sz="2000"/>
          </a:p>
          <a:p>
            <a:endParaRPr lang="en-US" sz="2000"/>
          </a:p>
        </p:txBody>
      </p:sp>
    </p:spTree>
    <p:extLst>
      <p:ext uri="{BB962C8B-B14F-4D97-AF65-F5344CB8AC3E}">
        <p14:creationId xmlns:p14="http://schemas.microsoft.com/office/powerpoint/2010/main" val="378305049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a:xfrm>
            <a:off x="972752" y="1825625"/>
            <a:ext cx="10233800" cy="4351338"/>
          </a:xfrm>
        </p:spPr>
        <p:txBody>
          <a:bodyPr/>
          <a:lstStyle/>
          <a:p>
            <a:pPr marL="457200" indent="-457200">
              <a:buFont typeface="+mj-lt"/>
              <a:buAutoNum type="arabicPeriod"/>
            </a:pPr>
            <a:r>
              <a:rPr lang="en-US"/>
              <a:t>Determine patient’s level of physical activity</a:t>
            </a:r>
          </a:p>
          <a:p>
            <a:pPr marL="457200" indent="-457200">
              <a:buFont typeface="+mj-lt"/>
              <a:buAutoNum type="arabicPeriod"/>
            </a:pPr>
            <a:r>
              <a:rPr lang="en-US"/>
              <a:t>Assess readiness for change</a:t>
            </a:r>
          </a:p>
          <a:p>
            <a:pPr marL="457200" indent="-457200">
              <a:buFont typeface="+mj-lt"/>
              <a:buAutoNum type="arabicPeriod"/>
            </a:pPr>
            <a:r>
              <a:rPr lang="en-US"/>
              <a:t>Safety screen</a:t>
            </a:r>
          </a:p>
          <a:p>
            <a:pPr marL="457200" indent="-457200">
              <a:buFont typeface="+mj-lt"/>
              <a:buAutoNum type="arabicPeriod"/>
            </a:pPr>
            <a:r>
              <a:rPr lang="en-US"/>
              <a:t>Provide appropriate exercise prescription and/or referral</a:t>
            </a:r>
          </a:p>
          <a:p>
            <a:pPr marL="0" indent="0">
              <a:buNone/>
            </a:pPr>
            <a:endParaRPr lang="en-US"/>
          </a:p>
        </p:txBody>
      </p:sp>
      <p:sp>
        <p:nvSpPr>
          <p:cNvPr id="5" name="Title 3">
            <a:extLst>
              <a:ext uri="{FF2B5EF4-FFF2-40B4-BE49-F238E27FC236}">
                <a16:creationId xmlns:a16="http://schemas.microsoft.com/office/drawing/2014/main" id="{6A72E5E0-C96F-B540-B06D-72390EFAE9AC}"/>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rPr>
              <a:t>Prescribing Exercise</a:t>
            </a:r>
          </a:p>
        </p:txBody>
      </p:sp>
      <p:sp>
        <p:nvSpPr>
          <p:cNvPr id="4" name="TextBox 3">
            <a:extLst>
              <a:ext uri="{FF2B5EF4-FFF2-40B4-BE49-F238E27FC236}">
                <a16:creationId xmlns:a16="http://schemas.microsoft.com/office/drawing/2014/main" id="{2FF894FD-7D7A-4544-8140-D0CEE1DB7637}"/>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260254453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a:xfrm>
            <a:off x="972752" y="1825625"/>
            <a:ext cx="10233800" cy="4351338"/>
          </a:xfrm>
        </p:spPr>
        <p:txBody>
          <a:bodyPr/>
          <a:lstStyle/>
          <a:p>
            <a:pPr marL="457200" indent="-457200">
              <a:buFont typeface="+mj-lt"/>
              <a:buAutoNum type="arabicPeriod"/>
            </a:pPr>
            <a:r>
              <a:rPr lang="en-US">
                <a:solidFill>
                  <a:srgbClr val="FFFF00"/>
                </a:solidFill>
              </a:rPr>
              <a:t>Determine patient’s level of physical activity</a:t>
            </a:r>
          </a:p>
          <a:p>
            <a:pPr marL="457200" indent="-457200">
              <a:buFont typeface="+mj-lt"/>
              <a:buAutoNum type="arabicPeriod"/>
            </a:pPr>
            <a:r>
              <a:rPr lang="en-US"/>
              <a:t>Assess readiness for change</a:t>
            </a:r>
          </a:p>
          <a:p>
            <a:pPr marL="457200" indent="-457200">
              <a:buFont typeface="+mj-lt"/>
              <a:buAutoNum type="arabicPeriod"/>
            </a:pPr>
            <a:r>
              <a:rPr lang="en-US"/>
              <a:t>Safety screen</a:t>
            </a:r>
          </a:p>
          <a:p>
            <a:pPr marL="457200" indent="-457200">
              <a:buFont typeface="+mj-lt"/>
              <a:buAutoNum type="arabicPeriod"/>
            </a:pPr>
            <a:r>
              <a:rPr lang="en-US"/>
              <a:t>Provide appropriate exercise prescription and/or referral</a:t>
            </a:r>
          </a:p>
          <a:p>
            <a:endParaRPr lang="en-US"/>
          </a:p>
        </p:txBody>
      </p:sp>
      <p:sp>
        <p:nvSpPr>
          <p:cNvPr id="5" name="Title 3">
            <a:extLst>
              <a:ext uri="{FF2B5EF4-FFF2-40B4-BE49-F238E27FC236}">
                <a16:creationId xmlns:a16="http://schemas.microsoft.com/office/drawing/2014/main" id="{6A72E5E0-C96F-B540-B06D-72390EFAE9AC}"/>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rPr>
              <a:t>Prescribing Exercise</a:t>
            </a:r>
          </a:p>
        </p:txBody>
      </p:sp>
      <p:sp>
        <p:nvSpPr>
          <p:cNvPr id="4" name="TextBox 3">
            <a:extLst>
              <a:ext uri="{FF2B5EF4-FFF2-40B4-BE49-F238E27FC236}">
                <a16:creationId xmlns:a16="http://schemas.microsoft.com/office/drawing/2014/main" id="{E8FB79E5-FE6F-CE49-AA0E-98F41C39BDEE}"/>
              </a:ext>
            </a:extLst>
          </p:cNvPr>
          <p:cNvSpPr txBox="1"/>
          <p:nvPr/>
        </p:nvSpPr>
        <p:spPr>
          <a:xfrm>
            <a:off x="841513" y="6092194"/>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75540228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57969BA2-7D36-9945-96BD-482A6120FFE2}"/>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latin typeface="Arial" panose="020B0604020202020204" pitchFamily="34" charset="0"/>
                <a:cs typeface="Arial" panose="020B0604020202020204" pitchFamily="34" charset="0"/>
              </a:rPr>
              <a:t>Determining Level of Physical Activity</a:t>
            </a:r>
          </a:p>
        </p:txBody>
      </p:sp>
      <p:sp>
        <p:nvSpPr>
          <p:cNvPr id="3" name="Content Placeholder 2"/>
          <p:cNvSpPr>
            <a:spLocks noGrp="1"/>
          </p:cNvSpPr>
          <p:nvPr>
            <p:ph idx="1"/>
          </p:nvPr>
        </p:nvSpPr>
        <p:spPr/>
        <p:txBody>
          <a:bodyPr/>
          <a:lstStyle/>
          <a:p>
            <a:pPr marL="514350" indent="-514350">
              <a:buFont typeface="+mj-lt"/>
              <a:buAutoNum type="arabicPeriod"/>
            </a:pPr>
            <a:r>
              <a:rPr lang="en-US">
                <a:solidFill>
                  <a:srgbClr val="FAECA8"/>
                </a:solidFill>
              </a:rPr>
              <a:t>“On average, how many days per week do you engage in moderate to strenuous exercise?   _____</a:t>
            </a:r>
          </a:p>
          <a:p>
            <a:pPr marL="514350" indent="-514350">
              <a:buFont typeface="+mj-lt"/>
              <a:buAutoNum type="arabicPeriod"/>
            </a:pPr>
            <a:endParaRPr lang="en-US"/>
          </a:p>
          <a:p>
            <a:pPr marL="514350" indent="-514350">
              <a:buFont typeface="+mj-lt"/>
              <a:buAutoNum type="arabicPeriod"/>
            </a:pPr>
            <a:r>
              <a:rPr lang="en-US">
                <a:solidFill>
                  <a:srgbClr val="FAECA8"/>
                </a:solidFill>
              </a:rPr>
              <a:t>“On average, how many minutes do you engage at this level?  _____</a:t>
            </a:r>
          </a:p>
          <a:p>
            <a:pPr marL="514350" indent="-514350">
              <a:buFont typeface="+mj-lt"/>
              <a:buAutoNum type="arabicPeriod"/>
            </a:pPr>
            <a:endParaRPr lang="en-US"/>
          </a:p>
          <a:p>
            <a:pPr marL="514350" indent="-514350">
              <a:buFont typeface="+mj-lt"/>
              <a:buAutoNum type="arabicPeriod"/>
            </a:pPr>
            <a:r>
              <a:rPr lang="en-US">
                <a:solidFill>
                  <a:srgbClr val="FAECA8"/>
                </a:solidFill>
              </a:rPr>
              <a:t>Total minutes per week of physical activity = (1x2)  _____</a:t>
            </a:r>
          </a:p>
        </p:txBody>
      </p:sp>
      <p:sp>
        <p:nvSpPr>
          <p:cNvPr id="4" name="TextBox 3">
            <a:extLst>
              <a:ext uri="{FF2B5EF4-FFF2-40B4-BE49-F238E27FC236}">
                <a16:creationId xmlns:a16="http://schemas.microsoft.com/office/drawing/2014/main" id="{35455D60-9668-FA41-87A2-41CB745580B2}"/>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408886605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a:xfrm>
            <a:off x="972752" y="1825625"/>
            <a:ext cx="10233800" cy="4351338"/>
          </a:xfrm>
        </p:spPr>
        <p:txBody>
          <a:bodyPr/>
          <a:lstStyle/>
          <a:p>
            <a:pPr marL="457200" indent="-457200">
              <a:buFont typeface="+mj-lt"/>
              <a:buAutoNum type="arabicPeriod"/>
            </a:pPr>
            <a:r>
              <a:rPr lang="en-US"/>
              <a:t>Determine patient’s level of physical activity</a:t>
            </a:r>
          </a:p>
          <a:p>
            <a:pPr marL="457200" indent="-457200">
              <a:buFont typeface="+mj-lt"/>
              <a:buAutoNum type="arabicPeriod"/>
            </a:pPr>
            <a:r>
              <a:rPr lang="en-US">
                <a:solidFill>
                  <a:srgbClr val="FFFF00"/>
                </a:solidFill>
              </a:rPr>
              <a:t>Assess readiness for change</a:t>
            </a:r>
          </a:p>
          <a:p>
            <a:pPr marL="457200" indent="-457200">
              <a:buFont typeface="+mj-lt"/>
              <a:buAutoNum type="arabicPeriod"/>
            </a:pPr>
            <a:r>
              <a:rPr lang="en-US"/>
              <a:t>Safety screen</a:t>
            </a:r>
          </a:p>
          <a:p>
            <a:pPr marL="457200" indent="-457200">
              <a:buFont typeface="+mj-lt"/>
              <a:buAutoNum type="arabicPeriod"/>
            </a:pPr>
            <a:r>
              <a:rPr lang="en-US"/>
              <a:t>Provide appropriate exercise prescription and/or referral</a:t>
            </a:r>
          </a:p>
          <a:p>
            <a:endParaRPr lang="en-US"/>
          </a:p>
        </p:txBody>
      </p:sp>
      <p:sp>
        <p:nvSpPr>
          <p:cNvPr id="5" name="Title 3">
            <a:extLst>
              <a:ext uri="{FF2B5EF4-FFF2-40B4-BE49-F238E27FC236}">
                <a16:creationId xmlns:a16="http://schemas.microsoft.com/office/drawing/2014/main" id="{6A72E5E0-C96F-B540-B06D-72390EFAE9AC}"/>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rPr>
              <a:t>Prescribing Exercise</a:t>
            </a:r>
          </a:p>
        </p:txBody>
      </p:sp>
      <p:sp>
        <p:nvSpPr>
          <p:cNvPr id="4" name="TextBox 3">
            <a:extLst>
              <a:ext uri="{FF2B5EF4-FFF2-40B4-BE49-F238E27FC236}">
                <a16:creationId xmlns:a16="http://schemas.microsoft.com/office/drawing/2014/main" id="{90F5931C-5254-734A-B654-F9167ED5D91C}"/>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153361295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B9898C-21EF-4304-BC5A-BC227DC8CA6F}"/>
              </a:ext>
            </a:extLst>
          </p:cNvPr>
          <p:cNvSpPr>
            <a:spLocks noGrp="1"/>
          </p:cNvSpPr>
          <p:nvPr>
            <p:ph type="title"/>
          </p:nvPr>
        </p:nvSpPr>
        <p:spPr/>
        <p:txBody>
          <a:bodyPr/>
          <a:lstStyle/>
          <a:p>
            <a:r>
              <a:rPr lang="en-US">
                <a:cs typeface="Arial"/>
              </a:rPr>
              <a:t>Readiness for Change Stages</a:t>
            </a:r>
            <a:endParaRPr lang="en-US"/>
          </a:p>
        </p:txBody>
      </p:sp>
      <p:sp>
        <p:nvSpPr>
          <p:cNvPr id="5" name="Content Placeholder 4">
            <a:extLst>
              <a:ext uri="{FF2B5EF4-FFF2-40B4-BE49-F238E27FC236}">
                <a16:creationId xmlns:a16="http://schemas.microsoft.com/office/drawing/2014/main" id="{CC84385C-BD8B-444E-9164-8406A73AB2CB}"/>
              </a:ext>
            </a:extLst>
          </p:cNvPr>
          <p:cNvSpPr>
            <a:spLocks noGrp="1"/>
          </p:cNvSpPr>
          <p:nvPr>
            <p:ph idx="1"/>
          </p:nvPr>
        </p:nvSpPr>
        <p:spPr/>
        <p:txBody>
          <a:bodyPr vert="horz" lIns="91440" tIns="45720" rIns="91440" bIns="45720" rtlCol="0" anchor="t">
            <a:normAutofit/>
          </a:bodyPr>
          <a:lstStyle/>
          <a:p>
            <a:pPr marL="0" indent="0">
              <a:buNone/>
            </a:pPr>
            <a:r>
              <a:rPr lang="en-US">
                <a:cs typeface="Arial"/>
              </a:rPr>
              <a:t>Answer 'yes' or 'no' to each question:</a:t>
            </a:r>
          </a:p>
          <a:p>
            <a:pPr marL="0" indent="0">
              <a:buNone/>
            </a:pPr>
            <a:endParaRPr lang="en-US">
              <a:cs typeface="Arial"/>
            </a:endParaRPr>
          </a:p>
          <a:p>
            <a:pPr marL="514350" indent="-514350">
              <a:buAutoNum type="arabicPeriod"/>
            </a:pPr>
            <a:r>
              <a:rPr lang="en-US">
                <a:cs typeface="Arial"/>
              </a:rPr>
              <a:t>I am currently physically active (at least 30 min/week).</a:t>
            </a:r>
          </a:p>
          <a:p>
            <a:pPr marL="514350" indent="-514350">
              <a:buAutoNum type="arabicPeriod"/>
            </a:pPr>
            <a:r>
              <a:rPr lang="en-US">
                <a:cs typeface="Arial"/>
              </a:rPr>
              <a:t>I intend to become physical active in the next six months.</a:t>
            </a:r>
          </a:p>
          <a:p>
            <a:pPr marL="514350" indent="-514350">
              <a:buAutoNum type="arabicPeriod"/>
            </a:pPr>
            <a:r>
              <a:rPr lang="en-US">
                <a:cs typeface="Arial"/>
              </a:rPr>
              <a:t>I currently engage in regular physical activity.</a:t>
            </a:r>
          </a:p>
          <a:p>
            <a:pPr marL="514350" indent="-514350">
              <a:buAutoNum type="arabicPeriod"/>
            </a:pPr>
            <a:r>
              <a:rPr lang="en-US">
                <a:cs typeface="Arial"/>
              </a:rPr>
              <a:t>I have been regularly engaged in physical </a:t>
            </a:r>
            <a:r>
              <a:rPr lang="en-US" err="1">
                <a:cs typeface="Arial"/>
              </a:rPr>
              <a:t>activty</a:t>
            </a:r>
            <a:r>
              <a:rPr lang="en-US">
                <a:cs typeface="Arial"/>
              </a:rPr>
              <a:t> for the last six months.</a:t>
            </a:r>
          </a:p>
          <a:p>
            <a:endParaRPr lang="en-US">
              <a:cs typeface="Arial"/>
            </a:endParaRPr>
          </a:p>
          <a:p>
            <a:endParaRPr lang="en-US">
              <a:cs typeface="Arial"/>
            </a:endParaRPr>
          </a:p>
          <a:p>
            <a:endParaRPr lang="en-US">
              <a:cs typeface="Arial"/>
            </a:endParaRPr>
          </a:p>
        </p:txBody>
      </p:sp>
      <p:sp>
        <p:nvSpPr>
          <p:cNvPr id="4" name="TextBox 3">
            <a:extLst>
              <a:ext uri="{FF2B5EF4-FFF2-40B4-BE49-F238E27FC236}">
                <a16:creationId xmlns:a16="http://schemas.microsoft.com/office/drawing/2014/main" id="{F016796E-617E-1341-86C3-B668BD872908}"/>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146399261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18100" y="1709171"/>
            <a:ext cx="10260600" cy="4698062"/>
          </a:xfrm>
        </p:spPr>
        <p:txBody>
          <a:bodyPr>
            <a:normAutofit/>
          </a:bodyPr>
          <a:lstStyle/>
          <a:p>
            <a:pPr marL="0" indent="0">
              <a:lnSpc>
                <a:spcPct val="100000"/>
              </a:lnSpc>
              <a:spcBef>
                <a:spcPts val="0"/>
              </a:spcBef>
              <a:buNone/>
              <a:defRPr/>
            </a:pPr>
            <a:r>
              <a:rPr lang="en-US" b="1"/>
              <a:t>Precontemplative: </a:t>
            </a:r>
          </a:p>
          <a:p>
            <a:pPr marL="457200" lvl="1" indent="0">
              <a:lnSpc>
                <a:spcPct val="100000"/>
              </a:lnSpc>
              <a:spcBef>
                <a:spcPts val="0"/>
              </a:spcBef>
              <a:buNone/>
              <a:defRPr/>
            </a:pPr>
            <a:r>
              <a:rPr lang="en-US" i="1">
                <a:solidFill>
                  <a:srgbClr val="FAECA8"/>
                </a:solidFill>
                <a:latin typeface="Arial" pitchFamily="34" charset="0"/>
                <a:cs typeface="Arial" pitchFamily="34" charset="0"/>
              </a:rPr>
              <a:t>“What warning signs would tell you that not being physically active is a problem?”</a:t>
            </a:r>
          </a:p>
          <a:p>
            <a:pPr marL="457200" lvl="1" indent="0">
              <a:lnSpc>
                <a:spcPct val="100000"/>
              </a:lnSpc>
              <a:spcBef>
                <a:spcPts val="0"/>
              </a:spcBef>
              <a:buNone/>
              <a:defRPr/>
            </a:pPr>
            <a:r>
              <a:rPr lang="en-US" i="1">
                <a:solidFill>
                  <a:srgbClr val="FAECA8"/>
                </a:solidFill>
                <a:latin typeface="Arial" pitchFamily="34" charset="0"/>
                <a:cs typeface="Arial" pitchFamily="34" charset="0"/>
              </a:rPr>
              <a:t>“Have you tried to start exercising in the past?”</a:t>
            </a:r>
          </a:p>
          <a:p>
            <a:pPr marL="0" indent="0">
              <a:lnSpc>
                <a:spcPct val="100000"/>
              </a:lnSpc>
              <a:spcBef>
                <a:spcPts val="0"/>
              </a:spcBef>
              <a:buNone/>
              <a:defRPr/>
            </a:pPr>
            <a:endParaRPr lang="en-US" sz="1700" i="1">
              <a:latin typeface="Arial" pitchFamily="34" charset="0"/>
              <a:cs typeface="Arial" pitchFamily="34" charset="0"/>
            </a:endParaRPr>
          </a:p>
          <a:p>
            <a:pPr marL="0" indent="0">
              <a:lnSpc>
                <a:spcPct val="100000"/>
              </a:lnSpc>
              <a:spcBef>
                <a:spcPts val="0"/>
              </a:spcBef>
              <a:buNone/>
              <a:defRPr/>
            </a:pPr>
            <a:endParaRPr lang="en-US" sz="1700" i="1">
              <a:latin typeface="Arial" pitchFamily="34" charset="0"/>
              <a:cs typeface="Arial" pitchFamily="34" charset="0"/>
            </a:endParaRPr>
          </a:p>
          <a:p>
            <a:pPr marL="0" indent="0">
              <a:lnSpc>
                <a:spcPct val="100000"/>
              </a:lnSpc>
              <a:spcBef>
                <a:spcPts val="0"/>
              </a:spcBef>
              <a:buNone/>
              <a:defRPr/>
            </a:pPr>
            <a:r>
              <a:rPr lang="en-US" b="1">
                <a:latin typeface="Arial" pitchFamily="34" charset="0"/>
                <a:cs typeface="Arial" pitchFamily="34" charset="0"/>
              </a:rPr>
              <a:t>Contemplative: </a:t>
            </a:r>
          </a:p>
          <a:p>
            <a:pPr marL="457200" lvl="1" indent="0">
              <a:lnSpc>
                <a:spcPct val="100000"/>
              </a:lnSpc>
              <a:spcBef>
                <a:spcPts val="0"/>
              </a:spcBef>
              <a:buNone/>
              <a:defRPr/>
            </a:pPr>
            <a:r>
              <a:rPr lang="en-US" i="1">
                <a:solidFill>
                  <a:srgbClr val="FAECA8"/>
                </a:solidFill>
                <a:latin typeface="Arial" pitchFamily="34" charset="0"/>
                <a:cs typeface="Arial" pitchFamily="34" charset="0"/>
              </a:rPr>
              <a:t>“Why do you want to increase your physical activity at this time?”</a:t>
            </a:r>
          </a:p>
          <a:p>
            <a:pPr marL="457200" lvl="1" indent="0">
              <a:lnSpc>
                <a:spcPct val="100000"/>
              </a:lnSpc>
              <a:spcBef>
                <a:spcPts val="0"/>
              </a:spcBef>
              <a:buNone/>
              <a:defRPr/>
            </a:pPr>
            <a:r>
              <a:rPr lang="en-US" i="1">
                <a:solidFill>
                  <a:srgbClr val="FAECA8"/>
                </a:solidFill>
                <a:latin typeface="Arial" pitchFamily="34" charset="0"/>
                <a:cs typeface="Arial" pitchFamily="34" charset="0"/>
              </a:rPr>
              <a:t>“Yes, regular physical activity can be difficult. What would help you at this time?”</a:t>
            </a:r>
          </a:p>
          <a:p>
            <a:pPr marL="457200" lvl="1" indent="0">
              <a:lnSpc>
                <a:spcPct val="100000"/>
              </a:lnSpc>
              <a:spcBef>
                <a:spcPts val="0"/>
              </a:spcBef>
              <a:buNone/>
              <a:defRPr/>
            </a:pPr>
            <a:r>
              <a:rPr lang="en-US" i="1">
                <a:solidFill>
                  <a:srgbClr val="FAECA8"/>
                </a:solidFill>
                <a:latin typeface="Arial" pitchFamily="34" charset="0"/>
                <a:cs typeface="Arial" pitchFamily="34" charset="0"/>
              </a:rPr>
              <a:t>“What are some barriers today that keep you from being physically active?”</a:t>
            </a:r>
          </a:p>
          <a:p>
            <a:pPr marL="914400" lvl="2" indent="0">
              <a:lnSpc>
                <a:spcPct val="100000"/>
              </a:lnSpc>
              <a:spcBef>
                <a:spcPts val="0"/>
              </a:spcBef>
              <a:buNone/>
              <a:defRPr/>
            </a:pPr>
            <a:endParaRPr lang="en-US" sz="1600" i="1">
              <a:latin typeface="Arial" pitchFamily="34" charset="0"/>
              <a:cs typeface="Arial" pitchFamily="34" charset="0"/>
            </a:endParaRPr>
          </a:p>
          <a:p>
            <a:pPr marL="914400" lvl="2" indent="0">
              <a:lnSpc>
                <a:spcPct val="100000"/>
              </a:lnSpc>
              <a:spcBef>
                <a:spcPts val="0"/>
              </a:spcBef>
              <a:buNone/>
              <a:defRPr/>
            </a:pPr>
            <a:endParaRPr lang="en-US" sz="1600" i="1">
              <a:latin typeface="Arial" pitchFamily="34" charset="0"/>
              <a:cs typeface="Arial" pitchFamily="34" charset="0"/>
            </a:endParaRPr>
          </a:p>
          <a:p>
            <a:pPr marL="914400" lvl="2" indent="0">
              <a:lnSpc>
                <a:spcPct val="100000"/>
              </a:lnSpc>
              <a:spcBef>
                <a:spcPts val="0"/>
              </a:spcBef>
              <a:buNone/>
              <a:defRPr/>
            </a:pPr>
            <a:endParaRPr lang="en-US" sz="1600">
              <a:latin typeface="Arial" pitchFamily="34" charset="0"/>
              <a:cs typeface="Arial" pitchFamily="34" charset="0"/>
            </a:endParaRPr>
          </a:p>
          <a:p>
            <a:pPr marL="0" indent="0">
              <a:lnSpc>
                <a:spcPct val="100000"/>
              </a:lnSpc>
              <a:spcBef>
                <a:spcPts val="0"/>
              </a:spcBef>
              <a:buNone/>
              <a:defRPr/>
            </a:pPr>
            <a:endParaRPr lang="en-US" sz="1700" i="1">
              <a:latin typeface="Arial" pitchFamily="34" charset="0"/>
              <a:cs typeface="Arial" pitchFamily="34" charset="0"/>
            </a:endParaRPr>
          </a:p>
          <a:p>
            <a:pPr marL="0" indent="0">
              <a:lnSpc>
                <a:spcPct val="100000"/>
              </a:lnSpc>
              <a:spcBef>
                <a:spcPts val="0"/>
              </a:spcBef>
              <a:buNone/>
              <a:defRPr/>
            </a:pPr>
            <a:endParaRPr lang="en-US" sz="1700">
              <a:latin typeface="Arial" pitchFamily="34" charset="0"/>
              <a:cs typeface="Arial" pitchFamily="34" charset="0"/>
            </a:endParaRPr>
          </a:p>
          <a:p>
            <a:endParaRPr lang="en-US"/>
          </a:p>
        </p:txBody>
      </p:sp>
      <p:sp>
        <p:nvSpPr>
          <p:cNvPr id="4" name="Title 1">
            <a:extLst>
              <a:ext uri="{FF2B5EF4-FFF2-40B4-BE49-F238E27FC236}">
                <a16:creationId xmlns:a16="http://schemas.microsoft.com/office/drawing/2014/main" id="{404EAADF-6B69-974B-98E6-62888B927207}"/>
              </a:ext>
            </a:extLst>
          </p:cNvPr>
          <p:cNvSpPr txBox="1">
            <a:spLocks/>
          </p:cNvSpPr>
          <p:nvPr/>
        </p:nvSpPr>
        <p:spPr>
          <a:xfrm>
            <a:off x="873848" y="15873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latin typeface="Arial" panose="020B0604020202020204" pitchFamily="34" charset="0"/>
                <a:cs typeface="Arial" panose="020B0604020202020204" pitchFamily="34" charset="0"/>
              </a:rPr>
              <a:t>Questions to move patients forward</a:t>
            </a:r>
          </a:p>
        </p:txBody>
      </p:sp>
      <p:sp>
        <p:nvSpPr>
          <p:cNvPr id="5" name="TextBox 4">
            <a:extLst>
              <a:ext uri="{FF2B5EF4-FFF2-40B4-BE49-F238E27FC236}">
                <a16:creationId xmlns:a16="http://schemas.microsoft.com/office/drawing/2014/main" id="{FC3F6B69-8CDE-D246-BD55-DF054BCD4379}"/>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11795512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90600" y="1589308"/>
            <a:ext cx="10292752" cy="4730212"/>
          </a:xfrm>
        </p:spPr>
        <p:txBody>
          <a:bodyPr>
            <a:normAutofit/>
          </a:bodyPr>
          <a:lstStyle/>
          <a:p>
            <a:pPr marL="0" indent="0">
              <a:lnSpc>
                <a:spcPct val="100000"/>
              </a:lnSpc>
              <a:spcBef>
                <a:spcPts val="0"/>
              </a:spcBef>
              <a:buNone/>
              <a:defRPr/>
            </a:pPr>
            <a:r>
              <a:rPr lang="en-US" b="1">
                <a:latin typeface="Arial" pitchFamily="34" charset="0"/>
                <a:cs typeface="Arial" pitchFamily="34" charset="0"/>
              </a:rPr>
              <a:t>Preparation:</a:t>
            </a:r>
          </a:p>
          <a:p>
            <a:pPr marL="457200" lvl="1" indent="0">
              <a:lnSpc>
                <a:spcPct val="100000"/>
              </a:lnSpc>
              <a:spcBef>
                <a:spcPts val="0"/>
              </a:spcBef>
              <a:buNone/>
              <a:defRPr/>
            </a:pPr>
            <a:r>
              <a:rPr lang="en-US" i="1">
                <a:solidFill>
                  <a:srgbClr val="FAECA8"/>
                </a:solidFill>
                <a:latin typeface="Arial" pitchFamily="34" charset="0"/>
                <a:cs typeface="Arial" pitchFamily="34" charset="0"/>
              </a:rPr>
              <a:t>“You’ve put a lot of thought into your goals. How do you feel about the steps in the plan we’ve made?”</a:t>
            </a:r>
          </a:p>
          <a:p>
            <a:pPr marL="0" indent="0">
              <a:buNone/>
            </a:pPr>
            <a:r>
              <a:rPr lang="en-US" b="1"/>
              <a:t>Action:</a:t>
            </a:r>
          </a:p>
          <a:p>
            <a:pPr marL="457200" lvl="1" indent="0">
              <a:lnSpc>
                <a:spcPct val="100000"/>
              </a:lnSpc>
              <a:spcBef>
                <a:spcPts val="0"/>
              </a:spcBef>
              <a:buNone/>
              <a:defRPr/>
            </a:pPr>
            <a:r>
              <a:rPr lang="en-US" i="1">
                <a:solidFill>
                  <a:srgbClr val="FAECA8"/>
                </a:solidFill>
                <a:latin typeface="Arial" pitchFamily="34" charset="0"/>
                <a:cs typeface="Arial" pitchFamily="34" charset="0"/>
              </a:rPr>
              <a:t>“You’ve been physically active for two months – congratulations! What is making it work? What else would help?”</a:t>
            </a:r>
          </a:p>
          <a:p>
            <a:pPr marL="0" indent="0">
              <a:lnSpc>
                <a:spcPct val="100000"/>
              </a:lnSpc>
              <a:spcBef>
                <a:spcPts val="0"/>
              </a:spcBef>
              <a:buNone/>
              <a:defRPr/>
            </a:pPr>
            <a:endParaRPr lang="en-US" sz="1600" b="1">
              <a:latin typeface="Arial" pitchFamily="34" charset="0"/>
              <a:cs typeface="Arial" pitchFamily="34" charset="0"/>
            </a:endParaRPr>
          </a:p>
          <a:p>
            <a:pPr marL="0" indent="0">
              <a:lnSpc>
                <a:spcPct val="100000"/>
              </a:lnSpc>
              <a:spcBef>
                <a:spcPts val="0"/>
              </a:spcBef>
              <a:buNone/>
              <a:defRPr/>
            </a:pPr>
            <a:r>
              <a:rPr lang="en-US" b="1">
                <a:latin typeface="Arial" pitchFamily="34" charset="0"/>
                <a:cs typeface="Arial" pitchFamily="34" charset="0"/>
              </a:rPr>
              <a:t>Maintenance:</a:t>
            </a:r>
          </a:p>
          <a:p>
            <a:pPr marL="457200" lvl="1" indent="0">
              <a:lnSpc>
                <a:spcPct val="100000"/>
              </a:lnSpc>
              <a:spcBef>
                <a:spcPts val="0"/>
              </a:spcBef>
              <a:buNone/>
              <a:defRPr/>
            </a:pPr>
            <a:r>
              <a:rPr lang="en-US" i="1">
                <a:solidFill>
                  <a:srgbClr val="FAECA8"/>
                </a:solidFill>
                <a:latin typeface="Arial" pitchFamily="34" charset="0"/>
                <a:cs typeface="Arial" pitchFamily="34" charset="0"/>
              </a:rPr>
              <a:t>What helps you be successful in maintaining regular physical activity?”</a:t>
            </a:r>
          </a:p>
          <a:p>
            <a:pPr marL="457200" lvl="1" indent="0">
              <a:lnSpc>
                <a:spcPct val="100000"/>
              </a:lnSpc>
              <a:spcBef>
                <a:spcPts val="0"/>
              </a:spcBef>
              <a:buNone/>
              <a:defRPr/>
            </a:pPr>
            <a:r>
              <a:rPr lang="en-US" i="1">
                <a:solidFill>
                  <a:srgbClr val="FAECA8"/>
                </a:solidFill>
                <a:latin typeface="Arial" pitchFamily="34" charset="0"/>
                <a:cs typeface="Arial" pitchFamily="34" charset="0"/>
              </a:rPr>
              <a:t>“Does being physically active seem permanent now? What makes you believe this?”</a:t>
            </a:r>
          </a:p>
          <a:p>
            <a:pPr marL="0" indent="0">
              <a:lnSpc>
                <a:spcPct val="100000"/>
              </a:lnSpc>
              <a:spcBef>
                <a:spcPts val="0"/>
              </a:spcBef>
              <a:buNone/>
              <a:defRPr/>
            </a:pPr>
            <a:endParaRPr lang="en-US" sz="1600" b="1">
              <a:latin typeface="Arial" pitchFamily="34" charset="0"/>
              <a:cs typeface="Arial" pitchFamily="34" charset="0"/>
            </a:endParaRPr>
          </a:p>
          <a:p>
            <a:pPr marL="0" indent="0">
              <a:lnSpc>
                <a:spcPct val="100000"/>
              </a:lnSpc>
              <a:spcBef>
                <a:spcPts val="0"/>
              </a:spcBef>
              <a:buNone/>
              <a:defRPr/>
            </a:pPr>
            <a:endParaRPr lang="en-US" sz="1600">
              <a:latin typeface="Arial" pitchFamily="34" charset="0"/>
              <a:cs typeface="Arial" pitchFamily="34" charset="0"/>
            </a:endParaRPr>
          </a:p>
          <a:p>
            <a:endParaRPr lang="en-US"/>
          </a:p>
        </p:txBody>
      </p:sp>
      <p:sp>
        <p:nvSpPr>
          <p:cNvPr id="4" name="Title 1">
            <a:extLst>
              <a:ext uri="{FF2B5EF4-FFF2-40B4-BE49-F238E27FC236}">
                <a16:creationId xmlns:a16="http://schemas.microsoft.com/office/drawing/2014/main" id="{888EA346-9E56-0C47-B18B-45DA3C476252}"/>
              </a:ext>
            </a:extLst>
          </p:cNvPr>
          <p:cNvSpPr txBox="1">
            <a:spLocks/>
          </p:cNvSpPr>
          <p:nvPr/>
        </p:nvSpPr>
        <p:spPr>
          <a:xfrm>
            <a:off x="879176" y="12658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latin typeface="Arial" panose="020B0604020202020204" pitchFamily="34" charset="0"/>
                <a:cs typeface="Arial" panose="020B0604020202020204" pitchFamily="34" charset="0"/>
              </a:rPr>
              <a:t>Questions to move patients forward</a:t>
            </a:r>
          </a:p>
        </p:txBody>
      </p:sp>
      <p:sp>
        <p:nvSpPr>
          <p:cNvPr id="5" name="TextBox 4">
            <a:extLst>
              <a:ext uri="{FF2B5EF4-FFF2-40B4-BE49-F238E27FC236}">
                <a16:creationId xmlns:a16="http://schemas.microsoft.com/office/drawing/2014/main" id="{279303D9-D85D-6145-B2A1-6309257CB12F}"/>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297472139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a:xfrm>
            <a:off x="972752" y="1825625"/>
            <a:ext cx="10233800" cy="4351338"/>
          </a:xfrm>
        </p:spPr>
        <p:txBody>
          <a:bodyPr/>
          <a:lstStyle/>
          <a:p>
            <a:pPr marL="457200" indent="-457200">
              <a:buFont typeface="+mj-lt"/>
              <a:buAutoNum type="arabicPeriod"/>
            </a:pPr>
            <a:r>
              <a:rPr lang="en-US"/>
              <a:t>Determine patient’s level of physical activity</a:t>
            </a:r>
          </a:p>
          <a:p>
            <a:pPr marL="457200" indent="-457200">
              <a:buFont typeface="+mj-lt"/>
              <a:buAutoNum type="arabicPeriod"/>
            </a:pPr>
            <a:r>
              <a:rPr lang="en-US"/>
              <a:t>Assess readiness for change</a:t>
            </a:r>
          </a:p>
          <a:p>
            <a:pPr marL="457200" indent="-457200">
              <a:buFont typeface="+mj-lt"/>
              <a:buAutoNum type="arabicPeriod"/>
            </a:pPr>
            <a:r>
              <a:rPr lang="en-US">
                <a:solidFill>
                  <a:srgbClr val="FFFF00"/>
                </a:solidFill>
              </a:rPr>
              <a:t>Safety screen</a:t>
            </a:r>
          </a:p>
          <a:p>
            <a:pPr marL="457200" indent="-457200">
              <a:buFont typeface="+mj-lt"/>
              <a:buAutoNum type="arabicPeriod"/>
            </a:pPr>
            <a:r>
              <a:rPr lang="en-US"/>
              <a:t>Provide appropriate exercise prescription and/or referral</a:t>
            </a:r>
          </a:p>
          <a:p>
            <a:endParaRPr lang="en-US"/>
          </a:p>
        </p:txBody>
      </p:sp>
      <p:sp>
        <p:nvSpPr>
          <p:cNvPr id="5" name="Title 3">
            <a:extLst>
              <a:ext uri="{FF2B5EF4-FFF2-40B4-BE49-F238E27FC236}">
                <a16:creationId xmlns:a16="http://schemas.microsoft.com/office/drawing/2014/main" id="{6A72E5E0-C96F-B540-B06D-72390EFAE9AC}"/>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rPr>
              <a:t>Prescribing Exercise</a:t>
            </a:r>
          </a:p>
        </p:txBody>
      </p:sp>
      <p:sp>
        <p:nvSpPr>
          <p:cNvPr id="4" name="TextBox 3">
            <a:extLst>
              <a:ext uri="{FF2B5EF4-FFF2-40B4-BE49-F238E27FC236}">
                <a16:creationId xmlns:a16="http://schemas.microsoft.com/office/drawing/2014/main" id="{5D473BCD-BB95-AA41-BBAF-EEEF950275D1}"/>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78170488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Safety Screen</a:t>
            </a:r>
          </a:p>
        </p:txBody>
      </p:sp>
      <p:sp>
        <p:nvSpPr>
          <p:cNvPr id="3" name="Content Placeholder 5">
            <a:extLst>
              <a:ext uri="{FF2B5EF4-FFF2-40B4-BE49-F238E27FC236}">
                <a16:creationId xmlns:a16="http://schemas.microsoft.com/office/drawing/2014/main" id="{60549520-1119-4687-8F89-050540538F38}"/>
              </a:ext>
            </a:extLst>
          </p:cNvPr>
          <p:cNvSpPr>
            <a:spLocks noGrp="1"/>
          </p:cNvSpPr>
          <p:nvPr>
            <p:ph idx="1"/>
          </p:nvPr>
        </p:nvSpPr>
        <p:spPr>
          <a:xfrm>
            <a:off x="972752" y="1825625"/>
            <a:ext cx="10233800" cy="4351338"/>
          </a:xfrm>
        </p:spPr>
        <p:txBody>
          <a:bodyPr vert="horz" lIns="91440" tIns="45720" rIns="91440" bIns="45720" rtlCol="0" anchor="t">
            <a:normAutofit/>
          </a:bodyPr>
          <a:lstStyle/>
          <a:p>
            <a:pPr marL="457200" indent="-457200"/>
            <a:r>
              <a:rPr lang="en-US">
                <a:cs typeface="Arial"/>
              </a:rPr>
              <a:t>Algorithms are available to screen patients</a:t>
            </a:r>
          </a:p>
          <a:p>
            <a:pPr marL="457200" indent="-457200"/>
            <a:endParaRPr lang="en-US">
              <a:cs typeface="Arial"/>
            </a:endParaRPr>
          </a:p>
          <a:p>
            <a:pPr marL="457200" indent="-457200"/>
            <a:r>
              <a:rPr lang="en-US">
                <a:cs typeface="Arial"/>
              </a:rPr>
              <a:t>Account for: </a:t>
            </a:r>
          </a:p>
          <a:p>
            <a:pPr marL="914400" lvl="1"/>
            <a:r>
              <a:rPr lang="en-US">
                <a:cs typeface="Arial"/>
              </a:rPr>
              <a:t>Baseline physical activity</a:t>
            </a:r>
          </a:p>
          <a:p>
            <a:pPr marL="914400" lvl="1"/>
            <a:r>
              <a:rPr lang="en-US">
                <a:cs typeface="Arial"/>
              </a:rPr>
              <a:t>Comorbidities or symptoms </a:t>
            </a:r>
          </a:p>
          <a:p>
            <a:pPr marL="914400" lvl="1"/>
            <a:r>
              <a:rPr lang="en-US">
                <a:cs typeface="Arial"/>
              </a:rPr>
              <a:t>Intensity of exercise</a:t>
            </a:r>
          </a:p>
          <a:p>
            <a:pPr marL="914400" lvl="1"/>
            <a:endParaRPr lang="en-US">
              <a:cs typeface="Arial"/>
            </a:endParaRPr>
          </a:p>
          <a:p>
            <a:pPr marL="457200" indent="-457200"/>
            <a:r>
              <a:rPr lang="en-US">
                <a:cs typeface="Arial"/>
              </a:rPr>
              <a:t>Some patients may need medical clearance prior to starting physical activity</a:t>
            </a:r>
          </a:p>
        </p:txBody>
      </p:sp>
      <p:sp>
        <p:nvSpPr>
          <p:cNvPr id="6" name="TextBox 5">
            <a:extLst>
              <a:ext uri="{FF2B5EF4-FFF2-40B4-BE49-F238E27FC236}">
                <a16:creationId xmlns:a16="http://schemas.microsoft.com/office/drawing/2014/main" id="{72025FD6-8F62-2448-B890-FBAEFA869D21}"/>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pic>
        <p:nvPicPr>
          <p:cNvPr id="4" name="Picture 4" descr="A picture containing racket, player, hitting, swinging&#10;&#10;Description generated with very high confidence">
            <a:extLst>
              <a:ext uri="{FF2B5EF4-FFF2-40B4-BE49-F238E27FC236}">
                <a16:creationId xmlns:a16="http://schemas.microsoft.com/office/drawing/2014/main" id="{15243F29-0C6B-4B17-9003-6609027B98A7}"/>
              </a:ext>
            </a:extLst>
          </p:cNvPr>
          <p:cNvPicPr>
            <a:picLocks noChangeAspect="1"/>
          </p:cNvPicPr>
          <p:nvPr/>
        </p:nvPicPr>
        <p:blipFill>
          <a:blip r:embed="rId4"/>
          <a:stretch>
            <a:fillRect/>
          </a:stretch>
        </p:blipFill>
        <p:spPr>
          <a:xfrm>
            <a:off x="8662374" y="1660985"/>
            <a:ext cx="2749447" cy="2749447"/>
          </a:xfrm>
          <a:prstGeom prst="rect">
            <a:avLst/>
          </a:prstGeom>
        </p:spPr>
      </p:pic>
    </p:spTree>
    <p:extLst>
      <p:ext uri="{BB962C8B-B14F-4D97-AF65-F5344CB8AC3E}">
        <p14:creationId xmlns:p14="http://schemas.microsoft.com/office/powerpoint/2010/main" val="768439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03BCF849-25F9-2F48-8AC6-7C7107995915}"/>
              </a:ext>
            </a:extLst>
          </p:cNvPr>
          <p:cNvSpPr>
            <a:spLocks noGrp="1"/>
          </p:cNvSpPr>
          <p:nvPr>
            <p:ph type="title"/>
          </p:nvPr>
        </p:nvSpPr>
        <p:spPr>
          <a:xfrm>
            <a:off x="838200" y="365125"/>
            <a:ext cx="11122152" cy="1325563"/>
          </a:xfrm>
        </p:spPr>
        <p:txBody>
          <a:bodyPr>
            <a:normAutofit fontScale="90000"/>
          </a:bodyPr>
          <a:lstStyle/>
          <a:p>
            <a:r>
              <a:rPr lang="en-US" sz="5300">
                <a:solidFill>
                  <a:schemeClr val="tx1"/>
                </a:solidFill>
              </a:rPr>
              <a:t>Benefits of Physical Activity on Health</a:t>
            </a:r>
            <a:endParaRPr lang="en-US" sz="4800">
              <a:solidFill>
                <a:schemeClr val="tx1"/>
              </a:solidFill>
            </a:endParaRPr>
          </a:p>
        </p:txBody>
      </p:sp>
      <p:sp>
        <p:nvSpPr>
          <p:cNvPr id="4" name="Title 1">
            <a:extLst>
              <a:ext uri="{FF2B5EF4-FFF2-40B4-BE49-F238E27FC236}">
                <a16:creationId xmlns:a16="http://schemas.microsoft.com/office/drawing/2014/main" id="{40AEF49A-9A5B-FD4A-AF4D-44BA35D7961A}"/>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endParaRPr lang="en-US" sz="4800">
              <a:solidFill>
                <a:schemeClr val="tx2"/>
              </a:solidFill>
            </a:endParaRPr>
          </a:p>
        </p:txBody>
      </p:sp>
      <p:pic>
        <p:nvPicPr>
          <p:cNvPr id="2050" name="Picture 2" descr="mage result for physical activity guidelines for americans"/>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332179" y="1446273"/>
            <a:ext cx="3776757" cy="4886462"/>
          </a:xfrm>
          <a:prstGeom prst="rect">
            <a:avLst/>
          </a:prstGeom>
          <a:ln>
            <a:noFill/>
          </a:ln>
          <a:effectLst>
            <a:outerShdw blurRad="190500" algn="tl" rotWithShape="0">
              <a:srgbClr val="000000">
                <a:alpha val="70000"/>
              </a:srgbClr>
            </a:outerShdw>
          </a:effectLst>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E9E62D93-103E-7C4F-9BE0-BEE05DB7D845}"/>
              </a:ext>
            </a:extLst>
          </p:cNvPr>
          <p:cNvSpPr txBox="1"/>
          <p:nvPr/>
        </p:nvSpPr>
        <p:spPr>
          <a:xfrm>
            <a:off x="85725" y="6363632"/>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4"/>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1599298893"/>
      </p:ext>
    </p:extLst>
  </p:cSld>
  <p:clrMapOvr>
    <a:masterClrMapping/>
  </p:clrMapOvr>
  <p:transition spd="med">
    <p:pull/>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a:xfrm>
            <a:off x="972752" y="1825625"/>
            <a:ext cx="10233800" cy="4351338"/>
          </a:xfrm>
        </p:spPr>
        <p:txBody>
          <a:bodyPr/>
          <a:lstStyle/>
          <a:p>
            <a:pPr marL="457200" indent="-457200">
              <a:buFont typeface="+mj-lt"/>
              <a:buAutoNum type="arabicPeriod"/>
            </a:pPr>
            <a:r>
              <a:rPr lang="en-US"/>
              <a:t>Determine patient’s level of physical activity</a:t>
            </a:r>
          </a:p>
          <a:p>
            <a:pPr marL="457200" indent="-457200">
              <a:buFont typeface="+mj-lt"/>
              <a:buAutoNum type="arabicPeriod"/>
            </a:pPr>
            <a:r>
              <a:rPr lang="en-US"/>
              <a:t>Assess readiness for change</a:t>
            </a:r>
          </a:p>
          <a:p>
            <a:pPr marL="457200" indent="-457200">
              <a:buFont typeface="+mj-lt"/>
              <a:buAutoNum type="arabicPeriod"/>
            </a:pPr>
            <a:r>
              <a:rPr lang="en-US"/>
              <a:t>Safety screen</a:t>
            </a:r>
          </a:p>
          <a:p>
            <a:pPr marL="457200" indent="-457200">
              <a:buFont typeface="+mj-lt"/>
              <a:buAutoNum type="arabicPeriod"/>
            </a:pPr>
            <a:r>
              <a:rPr lang="en-US">
                <a:solidFill>
                  <a:srgbClr val="FFFF00"/>
                </a:solidFill>
              </a:rPr>
              <a:t>Provide appropriate exercise prescription and/or referral</a:t>
            </a:r>
          </a:p>
          <a:p>
            <a:endParaRPr lang="en-US"/>
          </a:p>
        </p:txBody>
      </p:sp>
      <p:sp>
        <p:nvSpPr>
          <p:cNvPr id="5" name="Title 3">
            <a:extLst>
              <a:ext uri="{FF2B5EF4-FFF2-40B4-BE49-F238E27FC236}">
                <a16:creationId xmlns:a16="http://schemas.microsoft.com/office/drawing/2014/main" id="{6A72E5E0-C96F-B540-B06D-72390EFAE9AC}"/>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rPr>
              <a:t>Prescribing Exercise</a:t>
            </a:r>
          </a:p>
        </p:txBody>
      </p:sp>
      <p:sp>
        <p:nvSpPr>
          <p:cNvPr id="4" name="TextBox 3">
            <a:extLst>
              <a:ext uri="{FF2B5EF4-FFF2-40B4-BE49-F238E27FC236}">
                <a16:creationId xmlns:a16="http://schemas.microsoft.com/office/drawing/2014/main" id="{A487708C-CD97-1949-ABE1-1300C848E308}"/>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75953825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14350" y="1843088"/>
            <a:ext cx="11525285" cy="4459417"/>
          </a:xfrm>
        </p:spPr>
        <p:txBody>
          <a:bodyPr/>
          <a:lstStyle/>
          <a:p>
            <a:pPr marL="285750" indent="-285750">
              <a:buFont typeface="Arial"/>
              <a:buChar char="•"/>
            </a:pPr>
            <a:r>
              <a:rPr lang="en-US"/>
              <a:t>Write prescriptions for patients who are in the </a:t>
            </a:r>
            <a:r>
              <a:rPr lang="en-US" i="1"/>
              <a:t>preparation</a:t>
            </a:r>
            <a:r>
              <a:rPr lang="en-US"/>
              <a:t>, </a:t>
            </a:r>
            <a:r>
              <a:rPr lang="en-US" i="1"/>
              <a:t>action</a:t>
            </a:r>
            <a:r>
              <a:rPr lang="en-US"/>
              <a:t> and </a:t>
            </a:r>
            <a:r>
              <a:rPr lang="en-US" i="1"/>
              <a:t>maintenance</a:t>
            </a:r>
            <a:r>
              <a:rPr lang="en-US"/>
              <a:t> stages </a:t>
            </a:r>
          </a:p>
          <a:p>
            <a:pPr marL="285750" indent="-285750">
              <a:buFont typeface="Arial"/>
              <a:buChar char="•"/>
            </a:pPr>
            <a:endParaRPr lang="en-US"/>
          </a:p>
          <a:p>
            <a:pPr marL="285750" indent="-285750">
              <a:buFont typeface="Arial"/>
              <a:buChar char="•"/>
            </a:pPr>
            <a:r>
              <a:rPr lang="en-US"/>
              <a:t>Consider prescriptions for patients in </a:t>
            </a:r>
            <a:r>
              <a:rPr lang="en-US" i="1"/>
              <a:t>contemplative</a:t>
            </a:r>
            <a:r>
              <a:rPr lang="en-US"/>
              <a:t> stage</a:t>
            </a:r>
          </a:p>
          <a:p>
            <a:endParaRPr lang="en-US"/>
          </a:p>
        </p:txBody>
      </p:sp>
      <p:sp>
        <p:nvSpPr>
          <p:cNvPr id="5" name="Title 1">
            <a:extLst>
              <a:ext uri="{FF2B5EF4-FFF2-40B4-BE49-F238E27FC236}">
                <a16:creationId xmlns:a16="http://schemas.microsoft.com/office/drawing/2014/main" id="{67A79728-E9F3-0F41-8613-996507D1D96A}"/>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latin typeface="Arial" panose="020B0604020202020204" pitchFamily="34" charset="0"/>
                <a:cs typeface="Arial" panose="020B0604020202020204" pitchFamily="34" charset="0"/>
              </a:rPr>
              <a:t>Writing a Prescription</a:t>
            </a:r>
          </a:p>
        </p:txBody>
      </p:sp>
      <p:sp>
        <p:nvSpPr>
          <p:cNvPr id="7" name="TextBox 6">
            <a:extLst>
              <a:ext uri="{FF2B5EF4-FFF2-40B4-BE49-F238E27FC236}">
                <a16:creationId xmlns:a16="http://schemas.microsoft.com/office/drawing/2014/main" id="{63DD1EA6-777D-4553-8F90-B65D976E819D}"/>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121462380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4800" dirty="0">
                <a:solidFill>
                  <a:schemeClr val="tx1"/>
                </a:solidFill>
              </a:rPr>
              <a:t>What intensity?</a:t>
            </a:r>
          </a:p>
        </p:txBody>
      </p:sp>
      <p:sp>
        <p:nvSpPr>
          <p:cNvPr id="5" name="Content Placeholder 4"/>
          <p:cNvSpPr>
            <a:spLocks noGrp="1"/>
          </p:cNvSpPr>
          <p:nvPr>
            <p:ph idx="1"/>
          </p:nvPr>
        </p:nvSpPr>
        <p:spPr>
          <a:xfrm>
            <a:off x="838199" y="1989538"/>
            <a:ext cx="10515599" cy="4868462"/>
          </a:xfrm>
        </p:spPr>
        <p:txBody>
          <a:bodyPr/>
          <a:lstStyle/>
          <a:p>
            <a:r>
              <a:rPr lang="en-US"/>
              <a:t>Base it on their current level of activity</a:t>
            </a:r>
          </a:p>
          <a:p>
            <a:r>
              <a:rPr lang="en-US"/>
              <a:t>They can increase as their fitness level improves</a:t>
            </a:r>
          </a:p>
        </p:txBody>
      </p:sp>
      <p:sp>
        <p:nvSpPr>
          <p:cNvPr id="6" name="TextBox 5">
            <a:extLst>
              <a:ext uri="{FF2B5EF4-FFF2-40B4-BE49-F238E27FC236}">
                <a16:creationId xmlns:a16="http://schemas.microsoft.com/office/drawing/2014/main" id="{13B411DE-07E0-5846-8433-E4F2A8F2F1B6}"/>
              </a:ext>
            </a:extLst>
          </p:cNvPr>
          <p:cNvSpPr txBox="1"/>
          <p:nvPr/>
        </p:nvSpPr>
        <p:spPr>
          <a:xfrm>
            <a:off x="841513" y="6106482"/>
            <a:ext cx="10515600" cy="646331"/>
          </a:xfrm>
          <a:prstGeom prst="rect">
            <a:avLst/>
          </a:prstGeom>
          <a:noFill/>
        </p:spPr>
        <p:txBody>
          <a:bodyPr wrap="square" rtlCol="0" anchor="t">
            <a:spAutoFit/>
          </a:bodyPr>
          <a:lstStyle/>
          <a:p>
            <a:pPr algn="ctr"/>
            <a:r>
              <a:rPr lang="en-US" sz="1200"/>
              <a:t>Health Care Provider’s Action Guide.  Exercise is Medicine, American College of Sports Medicine. </a:t>
            </a:r>
            <a:r>
              <a:rPr lang="en-US" sz="1200">
                <a:hlinkClick r:id="rId3"/>
              </a:rPr>
              <a:t>https://www.exerciseismedicine.org/assets/page_documents/EIM%20Health%20Care%20Providers%20Action%20Guide%20clickable%20links.pdf</a:t>
            </a:r>
            <a:r>
              <a:rPr lang="en-US" sz="1200"/>
              <a:t>.  Updated 2019, retrieved November 25 2019.</a:t>
            </a:r>
          </a:p>
        </p:txBody>
      </p:sp>
    </p:spTree>
    <p:extLst>
      <p:ext uri="{BB962C8B-B14F-4D97-AF65-F5344CB8AC3E}">
        <p14:creationId xmlns:p14="http://schemas.microsoft.com/office/powerpoint/2010/main" val="386918034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90600" y="2109404"/>
            <a:ext cx="10233800" cy="4351338"/>
          </a:xfrm>
        </p:spPr>
        <p:txBody>
          <a:bodyPr/>
          <a:lstStyle/>
          <a:p>
            <a:r>
              <a:rPr lang="en-US"/>
              <a:t>Patient’s self-efficacy</a:t>
            </a:r>
          </a:p>
          <a:p>
            <a:endParaRPr lang="en-US"/>
          </a:p>
          <a:p>
            <a:r>
              <a:rPr lang="en-US"/>
              <a:t>Patient’s motivation</a:t>
            </a:r>
          </a:p>
          <a:p>
            <a:endParaRPr lang="en-US"/>
          </a:p>
          <a:p>
            <a:r>
              <a:rPr lang="en-US"/>
              <a:t>Provider’s competence</a:t>
            </a:r>
          </a:p>
        </p:txBody>
      </p:sp>
      <p:sp>
        <p:nvSpPr>
          <p:cNvPr id="5" name="Title 1">
            <a:extLst>
              <a:ext uri="{FF2B5EF4-FFF2-40B4-BE49-F238E27FC236}">
                <a16:creationId xmlns:a16="http://schemas.microsoft.com/office/drawing/2014/main" id="{83C03AA4-06FB-E740-B54D-FBAB6859E288}"/>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latin typeface="Arial" panose="020B0604020202020204" pitchFamily="34" charset="0"/>
                <a:cs typeface="Arial" panose="020B0604020202020204" pitchFamily="34" charset="0"/>
              </a:rPr>
              <a:t>Predictors of Success</a:t>
            </a:r>
          </a:p>
        </p:txBody>
      </p:sp>
    </p:spTree>
    <p:extLst>
      <p:ext uri="{BB962C8B-B14F-4D97-AF65-F5344CB8AC3E}">
        <p14:creationId xmlns:p14="http://schemas.microsoft.com/office/powerpoint/2010/main" val="189958904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4800">
                <a:solidFill>
                  <a:schemeClr val="tx1"/>
                </a:solidFill>
              </a:rPr>
              <a:t>Physical Activity for Medical Students</a:t>
            </a:r>
          </a:p>
        </p:txBody>
      </p:sp>
      <p:sp>
        <p:nvSpPr>
          <p:cNvPr id="3" name="Content Placeholder 2"/>
          <p:cNvSpPr>
            <a:spLocks noGrp="1"/>
          </p:cNvSpPr>
          <p:nvPr>
            <p:ph idx="1"/>
          </p:nvPr>
        </p:nvSpPr>
        <p:spPr>
          <a:xfrm>
            <a:off x="900192" y="1808922"/>
            <a:ext cx="10233800" cy="3809146"/>
          </a:xfrm>
        </p:spPr>
        <p:txBody>
          <a:bodyPr vert="horz" lIns="91440" tIns="45720" rIns="91440" bIns="45720" rtlCol="0" anchor="t">
            <a:normAutofit/>
          </a:bodyPr>
          <a:lstStyle/>
          <a:p>
            <a:pPr marL="0" indent="0">
              <a:buNone/>
            </a:pPr>
            <a:r>
              <a:rPr lang="en-US">
                <a:solidFill>
                  <a:schemeClr val="tx2">
                    <a:lumMod val="20000"/>
                    <a:lumOff val="80000"/>
                  </a:schemeClr>
                </a:solidFill>
                <a:cs typeface="Arial"/>
              </a:rPr>
              <a:t>Medical students with higher levels of Physical Activity:</a:t>
            </a:r>
          </a:p>
          <a:p>
            <a:pPr marL="0" indent="0">
              <a:buNone/>
            </a:pPr>
            <a:endParaRPr lang="en-US">
              <a:solidFill>
                <a:schemeClr val="tx2">
                  <a:lumMod val="20000"/>
                  <a:lumOff val="80000"/>
                </a:schemeClr>
              </a:solidFill>
              <a:cs typeface="Arial"/>
            </a:endParaRPr>
          </a:p>
          <a:p>
            <a:pPr lvl="1"/>
            <a:r>
              <a:rPr lang="en-US">
                <a:solidFill>
                  <a:schemeClr val="tx2">
                    <a:lumMod val="20000"/>
                    <a:lumOff val="80000"/>
                  </a:schemeClr>
                </a:solidFill>
                <a:cs typeface="Arial"/>
              </a:rPr>
              <a:t> </a:t>
            </a:r>
            <a:r>
              <a:rPr lang="en-US" sz="2800">
                <a:solidFill>
                  <a:schemeClr val="tx2">
                    <a:lumMod val="20000"/>
                    <a:lumOff val="80000"/>
                  </a:schemeClr>
                </a:solidFill>
                <a:cs typeface="Arial"/>
              </a:rPr>
              <a:t>Achieved higher GPAs</a:t>
            </a:r>
          </a:p>
          <a:p>
            <a:pPr marL="457200" lvl="1" indent="0">
              <a:buNone/>
            </a:pPr>
            <a:endParaRPr lang="en-US" sz="2800">
              <a:solidFill>
                <a:schemeClr val="tx2">
                  <a:lumMod val="20000"/>
                  <a:lumOff val="80000"/>
                </a:schemeClr>
              </a:solidFill>
              <a:cs typeface="Arial"/>
            </a:endParaRPr>
          </a:p>
          <a:p>
            <a:pPr lvl="1"/>
            <a:r>
              <a:rPr lang="en-US" sz="2800">
                <a:solidFill>
                  <a:schemeClr val="tx2">
                    <a:lumMod val="20000"/>
                    <a:lumOff val="80000"/>
                  </a:schemeClr>
                </a:solidFill>
                <a:cs typeface="Arial"/>
              </a:rPr>
              <a:t>Reported less stress </a:t>
            </a:r>
          </a:p>
          <a:p>
            <a:pPr marL="457200" lvl="1" indent="0">
              <a:buNone/>
            </a:pPr>
            <a:endParaRPr lang="en-US" sz="2800">
              <a:solidFill>
                <a:schemeClr val="tx2">
                  <a:lumMod val="20000"/>
                  <a:lumOff val="80000"/>
                </a:schemeClr>
              </a:solidFill>
              <a:cs typeface="Arial"/>
            </a:endParaRPr>
          </a:p>
          <a:p>
            <a:pPr lvl="1"/>
            <a:r>
              <a:rPr lang="en-US" sz="2800">
                <a:solidFill>
                  <a:schemeClr val="tx2">
                    <a:lumMod val="20000"/>
                    <a:lumOff val="80000"/>
                  </a:schemeClr>
                </a:solidFill>
                <a:cs typeface="Arial"/>
              </a:rPr>
              <a:t>Were more likely to recommend physical activity to patients</a:t>
            </a:r>
          </a:p>
        </p:txBody>
      </p:sp>
      <p:sp>
        <p:nvSpPr>
          <p:cNvPr id="8" name="TextBox 7"/>
          <p:cNvSpPr txBox="1"/>
          <p:nvPr/>
        </p:nvSpPr>
        <p:spPr>
          <a:xfrm>
            <a:off x="900192" y="6262042"/>
            <a:ext cx="10515600" cy="461665"/>
          </a:xfrm>
          <a:prstGeom prst="rect">
            <a:avLst/>
          </a:prstGeom>
          <a:noFill/>
        </p:spPr>
        <p:txBody>
          <a:bodyPr wrap="square" rtlCol="0">
            <a:spAutoFit/>
          </a:bodyPr>
          <a:lstStyle/>
          <a:p>
            <a:pPr algn="ctr"/>
            <a:r>
              <a:rPr lang="en-US" sz="1200"/>
              <a:t>Al-Drees A et al. Physical activity and academic achievement among the medical students: A cross-sectional study. Med Teach. 2016;38 Suppl 1:S66-72 </a:t>
            </a:r>
          </a:p>
          <a:p>
            <a:pPr algn="ctr"/>
            <a:r>
              <a:rPr lang="en-US" sz="1200">
                <a:cs typeface="Arial"/>
              </a:rPr>
              <a:t>Frank E et al. Physical activity levels and counseling practices of U.S. medical students.  Med Sci Sports </a:t>
            </a:r>
            <a:r>
              <a:rPr lang="en-US" sz="1200" err="1">
                <a:cs typeface="Arial"/>
              </a:rPr>
              <a:t>Exerc</a:t>
            </a:r>
            <a:r>
              <a:rPr lang="en-US" sz="1200">
                <a:cs typeface="Arial"/>
              </a:rPr>
              <a:t>. 2008 Mar;40(3):413-21.</a:t>
            </a:r>
          </a:p>
        </p:txBody>
      </p:sp>
    </p:spTree>
    <p:extLst>
      <p:ext uri="{BB962C8B-B14F-4D97-AF65-F5344CB8AC3E}">
        <p14:creationId xmlns:p14="http://schemas.microsoft.com/office/powerpoint/2010/main" val="366489078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9057A2-1F55-4A58-B417-14A7593970EB}"/>
              </a:ext>
            </a:extLst>
          </p:cNvPr>
          <p:cNvSpPr>
            <a:spLocks noGrp="1"/>
          </p:cNvSpPr>
          <p:nvPr>
            <p:ph type="title"/>
          </p:nvPr>
        </p:nvSpPr>
        <p:spPr>
          <a:xfrm>
            <a:off x="838200" y="365125"/>
            <a:ext cx="10515600" cy="1325563"/>
          </a:xfrm>
        </p:spPr>
        <p:txBody>
          <a:bodyPr/>
          <a:lstStyle/>
          <a:p>
            <a:pPr algn="ctr"/>
            <a:r>
              <a:rPr lang="en-US">
                <a:cs typeface="Arial"/>
              </a:rPr>
              <a:t>What can WE do?</a:t>
            </a:r>
          </a:p>
        </p:txBody>
      </p:sp>
      <p:sp>
        <p:nvSpPr>
          <p:cNvPr id="3" name="Content Placeholder 2"/>
          <p:cNvSpPr>
            <a:spLocks noGrp="1"/>
          </p:cNvSpPr>
          <p:nvPr>
            <p:ph idx="1"/>
          </p:nvPr>
        </p:nvSpPr>
        <p:spPr>
          <a:noFill/>
          <a:ln w="28575">
            <a:solidFill>
              <a:srgbClr val="FFFF00"/>
            </a:solidFill>
          </a:ln>
        </p:spPr>
        <p:style>
          <a:lnRef idx="0">
            <a:schemeClr val="dk1"/>
          </a:lnRef>
          <a:fillRef idx="3">
            <a:schemeClr val="dk1"/>
          </a:fillRef>
          <a:effectRef idx="3">
            <a:schemeClr val="dk1"/>
          </a:effectRef>
          <a:fontRef idx="minor">
            <a:schemeClr val="lt1"/>
          </a:fontRef>
        </p:style>
        <p:txBody>
          <a:bodyPr/>
          <a:lstStyle/>
          <a:p>
            <a:pPr marL="0" indent="0" algn="ctr">
              <a:buNone/>
            </a:pPr>
            <a:endParaRPr lang="en-US"/>
          </a:p>
          <a:p>
            <a:pPr marL="0" indent="0" algn="ctr">
              <a:buNone/>
            </a:pPr>
            <a:endParaRPr lang="en-US"/>
          </a:p>
          <a:p>
            <a:pPr marL="0" indent="0" algn="ctr">
              <a:buNone/>
            </a:pPr>
            <a:endParaRPr lang="en-US"/>
          </a:p>
          <a:p>
            <a:pPr marL="0" indent="0" algn="ctr">
              <a:buNone/>
            </a:pPr>
            <a:r>
              <a:rPr lang="en-US"/>
              <a:t>INSERT IMAGE OF YOUR SCHOOL HERE</a:t>
            </a:r>
          </a:p>
        </p:txBody>
      </p:sp>
    </p:spTree>
    <p:extLst>
      <p:ext uri="{BB962C8B-B14F-4D97-AF65-F5344CB8AC3E}">
        <p14:creationId xmlns:p14="http://schemas.microsoft.com/office/powerpoint/2010/main" val="32684055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1423E78-C871-A347-B735-FF5346676ADF}"/>
              </a:ext>
            </a:extLst>
          </p:cNvPr>
          <p:cNvPicPr>
            <a:picLocks noChangeAspect="1"/>
          </p:cNvPicPr>
          <p:nvPr/>
        </p:nvPicPr>
        <p:blipFill>
          <a:blip r:embed="rId3"/>
          <a:stretch>
            <a:fillRect/>
          </a:stretch>
        </p:blipFill>
        <p:spPr>
          <a:xfrm>
            <a:off x="7845274" y="3243938"/>
            <a:ext cx="1207008" cy="1207008"/>
          </a:xfrm>
          <a:prstGeom prst="rect">
            <a:avLst/>
          </a:prstGeom>
        </p:spPr>
      </p:pic>
      <p:sp>
        <p:nvSpPr>
          <p:cNvPr id="2" name="TextBox 1">
            <a:extLst>
              <a:ext uri="{FF2B5EF4-FFF2-40B4-BE49-F238E27FC236}">
                <a16:creationId xmlns:a16="http://schemas.microsoft.com/office/drawing/2014/main" id="{548C566F-0721-2C44-B792-0D9CE2F3CD11}"/>
              </a:ext>
            </a:extLst>
          </p:cNvPr>
          <p:cNvSpPr txBox="1"/>
          <p:nvPr/>
        </p:nvSpPr>
        <p:spPr>
          <a:xfrm>
            <a:off x="8002664" y="4545783"/>
            <a:ext cx="4056888" cy="1477328"/>
          </a:xfrm>
          <a:prstGeom prst="rect">
            <a:avLst/>
          </a:prstGeom>
          <a:noFill/>
          <a:ln w="28575">
            <a:solidFill>
              <a:srgbClr val="F6D332"/>
            </a:solidFill>
          </a:ln>
        </p:spPr>
        <p:style>
          <a:lnRef idx="0">
            <a:schemeClr val="accent3"/>
          </a:lnRef>
          <a:fillRef idx="3">
            <a:schemeClr val="accent3"/>
          </a:fillRef>
          <a:effectRef idx="3">
            <a:schemeClr val="accent3"/>
          </a:effectRef>
          <a:fontRef idx="minor">
            <a:schemeClr val="lt1"/>
          </a:fontRef>
        </p:style>
        <p:txBody>
          <a:bodyPr wrap="square" rtlCol="0">
            <a:spAutoFit/>
          </a:bodyPr>
          <a:lstStyle/>
          <a:p>
            <a:pPr algn="ctr"/>
            <a:r>
              <a:rPr lang="en-US"/>
              <a:t>According to WHO, </a:t>
            </a:r>
            <a:r>
              <a:rPr lang="en-US" b="1"/>
              <a:t>Physical Inactivity is a Global Public Health problem</a:t>
            </a:r>
            <a:r>
              <a:rPr lang="en-US"/>
              <a:t>: Approximately 3.2 million deaths each year are attributable to insufficient physical activity.</a:t>
            </a:r>
          </a:p>
        </p:txBody>
      </p:sp>
      <p:sp>
        <p:nvSpPr>
          <p:cNvPr id="6" name="Title 1">
            <a:extLst>
              <a:ext uri="{FF2B5EF4-FFF2-40B4-BE49-F238E27FC236}">
                <a16:creationId xmlns:a16="http://schemas.microsoft.com/office/drawing/2014/main" id="{2FE06CBE-62F1-2E4B-9499-316D421D907F}"/>
              </a:ext>
            </a:extLst>
          </p:cNvPr>
          <p:cNvSpPr>
            <a:spLocks noGrp="1"/>
          </p:cNvSpPr>
          <p:nvPr>
            <p:ph type="title"/>
          </p:nvPr>
        </p:nvSpPr>
        <p:spPr>
          <a:xfrm>
            <a:off x="838200" y="365125"/>
            <a:ext cx="11122152" cy="1325563"/>
          </a:xfrm>
        </p:spPr>
        <p:txBody>
          <a:bodyPr>
            <a:normAutofit fontScale="90000"/>
          </a:bodyPr>
          <a:lstStyle/>
          <a:p>
            <a:r>
              <a:rPr lang="en-US" sz="5300">
                <a:solidFill>
                  <a:schemeClr val="tx1"/>
                </a:solidFill>
              </a:rPr>
              <a:t>Benefits of Physical Activity on Health</a:t>
            </a:r>
            <a:endParaRPr lang="en-US" sz="4800">
              <a:solidFill>
                <a:schemeClr val="tx1"/>
              </a:solidFill>
            </a:endParaRPr>
          </a:p>
        </p:txBody>
      </p:sp>
      <p:pic>
        <p:nvPicPr>
          <p:cNvPr id="9" name="Picture 9" descr="A screenshot of a cell phone&#10;&#10;Description generated with very high confidence">
            <a:extLst>
              <a:ext uri="{FF2B5EF4-FFF2-40B4-BE49-F238E27FC236}">
                <a16:creationId xmlns:a16="http://schemas.microsoft.com/office/drawing/2014/main" id="{9BDA4E6B-B6CF-44AC-8556-8418FD97AFC7}"/>
              </a:ext>
            </a:extLst>
          </p:cNvPr>
          <p:cNvPicPr>
            <a:picLocks noGrp="1" noChangeAspect="1"/>
          </p:cNvPicPr>
          <p:nvPr>
            <p:ph idx="1"/>
          </p:nvPr>
        </p:nvPicPr>
        <p:blipFill>
          <a:blip r:embed="rId4"/>
          <a:stretch>
            <a:fillRect/>
          </a:stretch>
        </p:blipFill>
        <p:spPr>
          <a:xfrm>
            <a:off x="1475264" y="1717951"/>
            <a:ext cx="6011446" cy="4351338"/>
          </a:xfrm>
        </p:spPr>
      </p:pic>
      <p:sp>
        <p:nvSpPr>
          <p:cNvPr id="11" name="TextBox 10">
            <a:extLst>
              <a:ext uri="{FF2B5EF4-FFF2-40B4-BE49-F238E27FC236}">
                <a16:creationId xmlns:a16="http://schemas.microsoft.com/office/drawing/2014/main" id="{F5EA22B2-CD55-4CDC-8F42-61D33293755B}"/>
              </a:ext>
            </a:extLst>
          </p:cNvPr>
          <p:cNvSpPr txBox="1"/>
          <p:nvPr/>
        </p:nvSpPr>
        <p:spPr>
          <a:xfrm>
            <a:off x="4724400" y="320040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t>Click to add text</a:t>
            </a:r>
          </a:p>
        </p:txBody>
      </p:sp>
      <p:sp>
        <p:nvSpPr>
          <p:cNvPr id="12" name="TextBox 11">
            <a:extLst>
              <a:ext uri="{FF2B5EF4-FFF2-40B4-BE49-F238E27FC236}">
                <a16:creationId xmlns:a16="http://schemas.microsoft.com/office/drawing/2014/main" id="{3E7A736E-981B-43A6-9AA8-9DC6255B88FE}"/>
              </a:ext>
            </a:extLst>
          </p:cNvPr>
          <p:cNvSpPr txBox="1"/>
          <p:nvPr/>
        </p:nvSpPr>
        <p:spPr>
          <a:xfrm>
            <a:off x="516835" y="6438899"/>
            <a:ext cx="11771243"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fontAlgn="base"/>
            <a:r>
              <a:rPr lang="en-US" sz="1200"/>
              <a:t>Physical Activity Guidelines Advisory Committee Report.</a:t>
            </a:r>
            <a:r>
              <a:rPr lang="en-US" sz="1200">
                <a:ea typeface="+mn-lt"/>
                <a:cs typeface="+mn-lt"/>
              </a:rPr>
              <a:t> U.S. Department of Health and Human Services website. </a:t>
            </a:r>
            <a:r>
              <a:rPr lang="en-US" sz="1200">
                <a:solidFill>
                  <a:srgbClr val="F49100"/>
                </a:solidFill>
                <a:cs typeface="Calibri"/>
                <a:hlinkClick r:id="rId5"/>
              </a:rPr>
              <a:t>https://health.gov/paguidelines/2008/report/pdf/G1_allcause.pdf</a:t>
            </a:r>
            <a:r>
              <a:rPr lang="en-US" sz="1200">
                <a:solidFill>
                  <a:srgbClr val="F49100"/>
                </a:solidFill>
                <a:cs typeface="Calibri"/>
              </a:rPr>
              <a:t>. </a:t>
            </a:r>
            <a:r>
              <a:rPr lang="en-US" sz="1200">
                <a:ea typeface="+mn-lt"/>
                <a:cs typeface="+mn-lt"/>
              </a:rPr>
              <a:t>Updated October 2018. Accessed November 25, 2019.</a:t>
            </a:r>
            <a:endParaRPr lang="en-US" sz="1200">
              <a:cs typeface="Calibri"/>
            </a:endParaRPr>
          </a:p>
        </p:txBody>
      </p:sp>
    </p:spTree>
    <p:extLst>
      <p:ext uri="{BB962C8B-B14F-4D97-AF65-F5344CB8AC3E}">
        <p14:creationId xmlns:p14="http://schemas.microsoft.com/office/powerpoint/2010/main" val="37371797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p:cNvSpPr>
            <a:spLocks noGrp="1"/>
          </p:cNvSpPr>
          <p:nvPr>
            <p:ph idx="1"/>
          </p:nvPr>
        </p:nvSpPr>
        <p:spPr>
          <a:xfrm>
            <a:off x="1120000" y="1825625"/>
            <a:ext cx="10233800" cy="3076159"/>
          </a:xfrm>
        </p:spPr>
        <p:txBody>
          <a:bodyPr/>
          <a:lstStyle/>
          <a:p>
            <a:pPr marL="0" indent="0">
              <a:buNone/>
            </a:pPr>
            <a:r>
              <a:rPr lang="en-US">
                <a:solidFill>
                  <a:schemeClr val="tx2">
                    <a:lumMod val="20000"/>
                    <a:lumOff val="80000"/>
                  </a:schemeClr>
                </a:solidFill>
              </a:rPr>
              <a:t>Compared to inactive people, physically active individuals have:</a:t>
            </a:r>
          </a:p>
          <a:p>
            <a:pPr marL="0" indent="0">
              <a:buNone/>
            </a:pPr>
            <a:endParaRPr lang="en-US"/>
          </a:p>
          <a:p>
            <a:pPr lvl="1"/>
            <a:r>
              <a:rPr lang="en-US"/>
              <a:t>Lower rates of chronic disease</a:t>
            </a:r>
          </a:p>
          <a:p>
            <a:pPr lvl="1"/>
            <a:endParaRPr lang="en-US"/>
          </a:p>
          <a:p>
            <a:pPr lvl="1"/>
            <a:r>
              <a:rPr lang="en-US"/>
              <a:t>Lower risk profile for developing disabling medical conditions</a:t>
            </a:r>
          </a:p>
          <a:p>
            <a:pPr lvl="1"/>
            <a:endParaRPr lang="en-US"/>
          </a:p>
          <a:p>
            <a:pPr lvl="1"/>
            <a:r>
              <a:rPr lang="en-US"/>
              <a:t>Higher levels of health-related fitness</a:t>
            </a:r>
          </a:p>
          <a:p>
            <a:pPr lvl="1"/>
            <a:endParaRPr lang="en-US"/>
          </a:p>
          <a:p>
            <a:pPr lvl="1"/>
            <a:endParaRPr lang="en-US"/>
          </a:p>
        </p:txBody>
      </p:sp>
      <p:sp>
        <p:nvSpPr>
          <p:cNvPr id="6" name="Title 1">
            <a:extLst>
              <a:ext uri="{FF2B5EF4-FFF2-40B4-BE49-F238E27FC236}">
                <a16:creationId xmlns:a16="http://schemas.microsoft.com/office/drawing/2014/main" id="{03BCF849-25F9-2F48-8AC6-7C7107995915}"/>
              </a:ext>
            </a:extLst>
          </p:cNvPr>
          <p:cNvSpPr>
            <a:spLocks noGrp="1"/>
          </p:cNvSpPr>
          <p:nvPr>
            <p:ph type="title"/>
          </p:nvPr>
        </p:nvSpPr>
        <p:spPr>
          <a:xfrm>
            <a:off x="838200" y="365125"/>
            <a:ext cx="11122152" cy="1325563"/>
          </a:xfrm>
        </p:spPr>
        <p:txBody>
          <a:bodyPr>
            <a:normAutofit fontScale="90000"/>
          </a:bodyPr>
          <a:lstStyle/>
          <a:p>
            <a:r>
              <a:rPr lang="en-US" sz="5300">
                <a:solidFill>
                  <a:schemeClr val="tx1"/>
                </a:solidFill>
              </a:rPr>
              <a:t>Benefits of Physical Activity on Health</a:t>
            </a:r>
            <a:endParaRPr lang="en-US" sz="4800">
              <a:solidFill>
                <a:schemeClr val="tx1"/>
              </a:solidFill>
            </a:endParaRPr>
          </a:p>
        </p:txBody>
      </p:sp>
      <p:sp>
        <p:nvSpPr>
          <p:cNvPr id="4" name="Title 1">
            <a:extLst>
              <a:ext uri="{FF2B5EF4-FFF2-40B4-BE49-F238E27FC236}">
                <a16:creationId xmlns:a16="http://schemas.microsoft.com/office/drawing/2014/main" id="{40AEF49A-9A5B-FD4A-AF4D-44BA35D7961A}"/>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endParaRPr lang="en-US" sz="4800">
              <a:solidFill>
                <a:schemeClr val="tx2"/>
              </a:solidFill>
            </a:endParaRPr>
          </a:p>
        </p:txBody>
      </p:sp>
      <p:sp>
        <p:nvSpPr>
          <p:cNvPr id="3" name="TextBox 2">
            <a:extLst>
              <a:ext uri="{FF2B5EF4-FFF2-40B4-BE49-F238E27FC236}">
                <a16:creationId xmlns:a16="http://schemas.microsoft.com/office/drawing/2014/main" id="{D7B70AED-5C58-40D6-A67E-2A09D381B525}"/>
              </a:ext>
            </a:extLst>
          </p:cNvPr>
          <p:cNvSpPr txBox="1"/>
          <p:nvPr/>
        </p:nvSpPr>
        <p:spPr>
          <a:xfrm>
            <a:off x="85725" y="6335056"/>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3"/>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7463579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20000" y="1825625"/>
            <a:ext cx="10233800" cy="3615805"/>
          </a:xfrm>
        </p:spPr>
        <p:txBody>
          <a:bodyPr>
            <a:normAutofit/>
          </a:bodyPr>
          <a:lstStyle/>
          <a:p>
            <a:r>
              <a:rPr lang="en-US" sz="2400"/>
              <a:t>Improved bone health &amp; weight status for children ages 3-5</a:t>
            </a:r>
          </a:p>
          <a:p>
            <a:endParaRPr lang="en-US" sz="2400"/>
          </a:p>
          <a:p>
            <a:r>
              <a:rPr lang="en-US" sz="2400"/>
              <a:t>Improved cognitive function for youth ages 6-13</a:t>
            </a:r>
          </a:p>
          <a:p>
            <a:endParaRPr lang="en-US" sz="2400"/>
          </a:p>
          <a:p>
            <a:r>
              <a:rPr lang="en-US" sz="2400"/>
              <a:t>Reduced risk of cancer at a greater number of sites</a:t>
            </a:r>
          </a:p>
          <a:p>
            <a:endParaRPr lang="en-US" sz="2400"/>
          </a:p>
          <a:p>
            <a:r>
              <a:rPr lang="en-US" sz="2400"/>
              <a:t>Brain health benefits, including possible improved cognitive function, reduced anxiety and depression risk, improved sleep &amp; quality of life</a:t>
            </a:r>
          </a:p>
        </p:txBody>
      </p:sp>
      <p:sp>
        <p:nvSpPr>
          <p:cNvPr id="4" name="Title 1">
            <a:extLst>
              <a:ext uri="{FF2B5EF4-FFF2-40B4-BE49-F238E27FC236}">
                <a16:creationId xmlns:a16="http://schemas.microsoft.com/office/drawing/2014/main" id="{03BCF849-25F9-2F48-8AC6-7C7107995915}"/>
              </a:ext>
            </a:extLst>
          </p:cNvPr>
          <p:cNvSpPr txBox="1">
            <a:spLocks/>
          </p:cNvSpPr>
          <p:nvPr/>
        </p:nvSpPr>
        <p:spPr>
          <a:xfrm>
            <a:off x="838200" y="365125"/>
            <a:ext cx="11122152" cy="1325563"/>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rPr>
              <a:t>Evidence of Physical Activity Benefits</a:t>
            </a:r>
          </a:p>
        </p:txBody>
      </p:sp>
      <p:sp>
        <p:nvSpPr>
          <p:cNvPr id="9" name="TextBox 8">
            <a:extLst>
              <a:ext uri="{FF2B5EF4-FFF2-40B4-BE49-F238E27FC236}">
                <a16:creationId xmlns:a16="http://schemas.microsoft.com/office/drawing/2014/main" id="{4B0153DB-B0AC-444E-8B24-3F80EF1ADC62}"/>
              </a:ext>
            </a:extLst>
          </p:cNvPr>
          <p:cNvSpPr txBox="1"/>
          <p:nvPr/>
        </p:nvSpPr>
        <p:spPr>
          <a:xfrm>
            <a:off x="85725" y="6335056"/>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3"/>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10126850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20000" y="1825625"/>
            <a:ext cx="10233800" cy="3196080"/>
          </a:xfrm>
        </p:spPr>
        <p:txBody>
          <a:bodyPr>
            <a:normAutofit lnSpcReduction="10000"/>
          </a:bodyPr>
          <a:lstStyle/>
          <a:p>
            <a:r>
              <a:rPr lang="en-US" sz="2400" b="1"/>
              <a:t>For pregnant women: </a:t>
            </a:r>
            <a:r>
              <a:rPr lang="en-US" sz="2400"/>
              <a:t>reduced risk of excessive weight gain, gestational diabetes &amp; postpartum depression</a:t>
            </a:r>
          </a:p>
          <a:p>
            <a:endParaRPr lang="en-US" sz="2400"/>
          </a:p>
          <a:p>
            <a:r>
              <a:rPr lang="en-US" sz="2400" b="1"/>
              <a:t>For older adults: </a:t>
            </a:r>
            <a:r>
              <a:rPr lang="en-US" sz="2400"/>
              <a:t>reduced risk of fall-related injuries</a:t>
            </a:r>
          </a:p>
          <a:p>
            <a:endParaRPr lang="en-US" sz="2400"/>
          </a:p>
          <a:p>
            <a:r>
              <a:rPr lang="en-US" sz="2400" b="1"/>
              <a:t>For people with various chronic medical conditions</a:t>
            </a:r>
            <a:r>
              <a:rPr lang="en-US" sz="2400"/>
              <a:t>: reduced risk of all-cause &amp; disease-specific mortality, improved physical function, and improved quality of life</a:t>
            </a:r>
          </a:p>
        </p:txBody>
      </p:sp>
      <p:sp>
        <p:nvSpPr>
          <p:cNvPr id="4" name="Title 1">
            <a:extLst>
              <a:ext uri="{FF2B5EF4-FFF2-40B4-BE49-F238E27FC236}">
                <a16:creationId xmlns:a16="http://schemas.microsoft.com/office/drawing/2014/main" id="{03BCF849-25F9-2F48-8AC6-7C7107995915}"/>
              </a:ext>
            </a:extLst>
          </p:cNvPr>
          <p:cNvSpPr txBox="1">
            <a:spLocks/>
          </p:cNvSpPr>
          <p:nvPr/>
        </p:nvSpPr>
        <p:spPr>
          <a:xfrm>
            <a:off x="838200" y="365125"/>
            <a:ext cx="11122152" cy="1325563"/>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sz="4800">
                <a:solidFill>
                  <a:schemeClr val="tx1"/>
                </a:solidFill>
              </a:rPr>
              <a:t>Evidence of Physical Activity Benefits</a:t>
            </a:r>
          </a:p>
        </p:txBody>
      </p:sp>
      <p:sp>
        <p:nvSpPr>
          <p:cNvPr id="5" name="TextBox 4"/>
          <p:cNvSpPr txBox="1"/>
          <p:nvPr/>
        </p:nvSpPr>
        <p:spPr>
          <a:xfrm>
            <a:off x="1120000" y="5905422"/>
            <a:ext cx="10515600" cy="276999"/>
          </a:xfrm>
          <a:prstGeom prst="rect">
            <a:avLst/>
          </a:prstGeom>
          <a:noFill/>
        </p:spPr>
        <p:txBody>
          <a:bodyPr wrap="square" rtlCol="0" anchor="t">
            <a:spAutoFit/>
          </a:bodyPr>
          <a:lstStyle/>
          <a:p>
            <a:pPr algn="ctr"/>
            <a:r>
              <a:rPr lang="en-US" sz="1200">
                <a:ea typeface="+mn-lt"/>
                <a:cs typeface="+mn-lt"/>
                <a:hlinkClick r:id="rId3"/>
              </a:rPr>
              <a:t> </a:t>
            </a:r>
            <a:endParaRPr lang="en-US">
              <a:ea typeface="+mn-lt"/>
              <a:cs typeface="+mn-lt"/>
              <a:hlinkClick r:id="rId3"/>
            </a:endParaRPr>
          </a:p>
        </p:txBody>
      </p:sp>
      <p:sp>
        <p:nvSpPr>
          <p:cNvPr id="6" name="TextBox 5">
            <a:extLst>
              <a:ext uri="{FF2B5EF4-FFF2-40B4-BE49-F238E27FC236}">
                <a16:creationId xmlns:a16="http://schemas.microsoft.com/office/drawing/2014/main" id="{DF2ECC5A-14D7-6B41-96B1-346C02BC447A}"/>
              </a:ext>
            </a:extLst>
          </p:cNvPr>
          <p:cNvSpPr txBox="1"/>
          <p:nvPr/>
        </p:nvSpPr>
        <p:spPr>
          <a:xfrm>
            <a:off x="85725" y="6335056"/>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3"/>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5863873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Key Guidelines: </a:t>
            </a:r>
            <a:r>
              <a:rPr lang="en-US" sz="3600">
                <a:solidFill>
                  <a:srgbClr val="F6D332"/>
                </a:solidFill>
              </a:rPr>
              <a:t>Preschool Aged Children</a:t>
            </a:r>
          </a:p>
        </p:txBody>
      </p:sp>
      <p:sp>
        <p:nvSpPr>
          <p:cNvPr id="5" name="Content Placeholder 4"/>
          <p:cNvSpPr>
            <a:spLocks noGrp="1"/>
          </p:cNvSpPr>
          <p:nvPr>
            <p:ph idx="1"/>
          </p:nvPr>
        </p:nvSpPr>
        <p:spPr/>
        <p:txBody>
          <a:bodyPr>
            <a:normAutofit/>
          </a:bodyPr>
          <a:lstStyle/>
          <a:p>
            <a:r>
              <a:rPr lang="en-US" sz="2400"/>
              <a:t>Ages 3-5 should be physically active </a:t>
            </a:r>
            <a:r>
              <a:rPr lang="en-US" sz="2400" i="1"/>
              <a:t>throughout the day </a:t>
            </a:r>
            <a:r>
              <a:rPr lang="en-US" sz="2400"/>
              <a:t>to enhance growth and development </a:t>
            </a:r>
          </a:p>
          <a:p>
            <a:endParaRPr lang="en-US" sz="2400"/>
          </a:p>
          <a:p>
            <a:r>
              <a:rPr lang="en-US" sz="2400"/>
              <a:t>Adult caregivers of preschool-aged children should encourage active play that includes a </a:t>
            </a:r>
            <a:r>
              <a:rPr lang="en-US" sz="2400" i="1"/>
              <a:t>variety</a:t>
            </a:r>
            <a:r>
              <a:rPr lang="en-US" sz="2400"/>
              <a:t> of activity types</a:t>
            </a:r>
          </a:p>
          <a:p>
            <a:endParaRPr lang="en-US"/>
          </a:p>
          <a:p>
            <a:pPr marL="0" indent="0">
              <a:buNone/>
            </a:pPr>
            <a:br>
              <a:rPr lang="en-US"/>
            </a:br>
            <a:endParaRPr lang="en-US"/>
          </a:p>
        </p:txBody>
      </p:sp>
      <p:sp>
        <p:nvSpPr>
          <p:cNvPr id="6" name="TextBox 5">
            <a:extLst>
              <a:ext uri="{FF2B5EF4-FFF2-40B4-BE49-F238E27FC236}">
                <a16:creationId xmlns:a16="http://schemas.microsoft.com/office/drawing/2014/main" id="{09ADDFDC-137E-7B4C-B49E-89AF358B499F}"/>
              </a:ext>
            </a:extLst>
          </p:cNvPr>
          <p:cNvSpPr txBox="1"/>
          <p:nvPr/>
        </p:nvSpPr>
        <p:spPr>
          <a:xfrm>
            <a:off x="85725" y="6335056"/>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3"/>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11604708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800">
                <a:solidFill>
                  <a:schemeClr val="tx1"/>
                </a:solidFill>
              </a:rPr>
              <a:t>Key Guidelines: </a:t>
            </a:r>
            <a:r>
              <a:rPr lang="en-US" sz="3600">
                <a:solidFill>
                  <a:srgbClr val="F6D332"/>
                </a:solidFill>
              </a:rPr>
              <a:t>Children &amp; Adolescents</a:t>
            </a:r>
          </a:p>
        </p:txBody>
      </p:sp>
      <p:sp>
        <p:nvSpPr>
          <p:cNvPr id="5" name="Content Placeholder 4"/>
          <p:cNvSpPr>
            <a:spLocks noGrp="1"/>
          </p:cNvSpPr>
          <p:nvPr>
            <p:ph idx="1"/>
          </p:nvPr>
        </p:nvSpPr>
        <p:spPr/>
        <p:txBody>
          <a:bodyPr>
            <a:normAutofit fontScale="92500" lnSpcReduction="20000"/>
          </a:bodyPr>
          <a:lstStyle/>
          <a:p>
            <a:r>
              <a:rPr lang="en-US" sz="3000"/>
              <a:t>Ages 6-17 should do &gt;60 minutes of moderate-to-vigorous physical activity daily: </a:t>
            </a:r>
          </a:p>
          <a:p>
            <a:endParaRPr lang="en-US" sz="2600"/>
          </a:p>
          <a:p>
            <a:pPr lvl="1"/>
            <a:r>
              <a:rPr lang="en-US" sz="2600" b="1"/>
              <a:t>Aerobic: </a:t>
            </a:r>
            <a:r>
              <a:rPr lang="en-US" sz="2600"/>
              <a:t>Most of the 60 minutes or more per day should be either moderate or vigorous-intensity aerobic physical activity &amp; should include vigorous intensity physical activity on at least 3 days a week </a:t>
            </a:r>
          </a:p>
          <a:p>
            <a:pPr lvl="1"/>
            <a:endParaRPr lang="en-US" sz="2600"/>
          </a:p>
          <a:p>
            <a:pPr lvl="1"/>
            <a:r>
              <a:rPr lang="en-US" sz="2600" b="1"/>
              <a:t>Muscle-strengthening: </a:t>
            </a:r>
            <a:r>
              <a:rPr lang="en-US" sz="2600"/>
              <a:t>At least 3 days/week</a:t>
            </a:r>
          </a:p>
          <a:p>
            <a:pPr lvl="1"/>
            <a:endParaRPr lang="en-US" sz="2600"/>
          </a:p>
          <a:p>
            <a:pPr lvl="1"/>
            <a:r>
              <a:rPr lang="en-US" sz="2600" b="1"/>
              <a:t>Bone-strengthening: </a:t>
            </a:r>
            <a:r>
              <a:rPr lang="en-US" sz="2600"/>
              <a:t>At least 3 days/week</a:t>
            </a:r>
          </a:p>
          <a:p>
            <a:endParaRPr lang="en-US"/>
          </a:p>
          <a:p>
            <a:pPr marL="0" indent="0">
              <a:buNone/>
            </a:pPr>
            <a:br>
              <a:rPr lang="en-US"/>
            </a:br>
            <a:endParaRPr lang="en-US"/>
          </a:p>
        </p:txBody>
      </p:sp>
      <p:sp>
        <p:nvSpPr>
          <p:cNvPr id="6" name="TextBox 5">
            <a:extLst>
              <a:ext uri="{FF2B5EF4-FFF2-40B4-BE49-F238E27FC236}">
                <a16:creationId xmlns:a16="http://schemas.microsoft.com/office/drawing/2014/main" id="{473D8410-4C25-344D-AA25-147520B8B4EC}"/>
              </a:ext>
            </a:extLst>
          </p:cNvPr>
          <p:cNvSpPr txBox="1"/>
          <p:nvPr/>
        </p:nvSpPr>
        <p:spPr>
          <a:xfrm>
            <a:off x="85725" y="6335056"/>
            <a:ext cx="12020549" cy="523220"/>
          </a:xfrm>
          <a:prstGeom prst="rect">
            <a:avLst/>
          </a:prstGeom>
          <a:noFill/>
        </p:spPr>
        <p:txBody>
          <a:bodyPr wrap="square" rtlCol="0" anchor="t">
            <a:spAutoFit/>
          </a:bodyPr>
          <a:lstStyle/>
          <a:p>
            <a:pPr algn="ctr"/>
            <a:r>
              <a:rPr lang="en-US" sz="1400">
                <a:ea typeface="+mn-lt"/>
                <a:cs typeface="+mn-lt"/>
              </a:rPr>
              <a:t>Physical Activity Guidelines for Americans, 2nd Edition. U.S. Department of Health and Human Services website. </a:t>
            </a:r>
            <a:r>
              <a:rPr lang="en-US" sz="1400">
                <a:ea typeface="+mn-lt"/>
                <a:cs typeface="+mn-lt"/>
                <a:hlinkClick r:id="rId3"/>
              </a:rPr>
              <a:t>https://health.gov/paguidelines/second-edition/pdf/PAG_ExecutiveSummary.pdf</a:t>
            </a:r>
            <a:r>
              <a:rPr lang="en-US" sz="1400">
                <a:ea typeface="+mn-lt"/>
                <a:cs typeface="+mn-lt"/>
              </a:rPr>
              <a:t>. Updated October 2018. Accessed November 25, 2019.</a:t>
            </a:r>
            <a:endParaRPr lang="en-US">
              <a:ea typeface="+mn-lt"/>
              <a:cs typeface="+mn-lt"/>
            </a:endParaRPr>
          </a:p>
        </p:txBody>
      </p:sp>
    </p:spTree>
    <p:extLst>
      <p:ext uri="{BB962C8B-B14F-4D97-AF65-F5344CB8AC3E}">
        <p14:creationId xmlns:p14="http://schemas.microsoft.com/office/powerpoint/2010/main" val="1635000195"/>
      </p:ext>
    </p:extLst>
  </p:cSld>
  <p:clrMapOvr>
    <a:masterClrMapping/>
  </p:clrMapOvr>
</p:sld>
</file>

<file path=ppt/theme/theme1.xml><?xml version="1.0" encoding="utf-8"?>
<a:theme xmlns:a="http://schemas.openxmlformats.org/drawingml/2006/main" name="Depth">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Arial">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Depth">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Depth" id="{7BEAFC2A-325C-49C4-AC08-2B765DA903F9}" vid="{1735E755-43E6-43AA-ABA2-C989ECC79AF5}"/>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989</Words>
  <Application>Microsoft Office PowerPoint</Application>
  <PresentationFormat>Widescreen</PresentationFormat>
  <Paragraphs>347</Paragraphs>
  <Slides>35</Slides>
  <Notes>3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5</vt:i4>
      </vt:variant>
    </vt:vector>
  </HeadingPairs>
  <TitlesOfParts>
    <vt:vector size="39" baseType="lpstr">
      <vt:lpstr>arial</vt:lpstr>
      <vt:lpstr>arial</vt:lpstr>
      <vt:lpstr>Calibri</vt:lpstr>
      <vt:lpstr>Depth</vt:lpstr>
      <vt:lpstr>PowerPoint Presentation</vt:lpstr>
      <vt:lpstr>Learning Objectives</vt:lpstr>
      <vt:lpstr>Benefits of Physical Activity on Health</vt:lpstr>
      <vt:lpstr>Benefits of Physical Activity on Health</vt:lpstr>
      <vt:lpstr>Benefits of Physical Activity on Health</vt:lpstr>
      <vt:lpstr>PowerPoint Presentation</vt:lpstr>
      <vt:lpstr>PowerPoint Presentation</vt:lpstr>
      <vt:lpstr>Key Guidelines: Preschool Aged Children</vt:lpstr>
      <vt:lpstr>Key Guidelines: Children &amp; Adolescents</vt:lpstr>
      <vt:lpstr>Key Guidelines: Adults</vt:lpstr>
      <vt:lpstr>Key Guidelines: Specific Recommendations</vt:lpstr>
      <vt:lpstr>Who is meeting the guidelines?</vt:lpstr>
      <vt:lpstr>Who is meeting the guidelines?</vt:lpstr>
      <vt:lpstr>Who is meeting the guidelines?</vt:lpstr>
      <vt:lpstr>Who is meeting the guidelines?</vt:lpstr>
      <vt:lpstr>Implementation of the Guidelines</vt:lpstr>
      <vt:lpstr>The Physician’s Role</vt:lpstr>
      <vt:lpstr>The Physician’s Role</vt:lpstr>
      <vt:lpstr>The Physician’s Role</vt:lpstr>
      <vt:lpstr>The Physician’s Role</vt:lpstr>
      <vt:lpstr>PowerPoint Presentation</vt:lpstr>
      <vt:lpstr>PowerPoint Presentation</vt:lpstr>
      <vt:lpstr>PowerPoint Presentation</vt:lpstr>
      <vt:lpstr>PowerPoint Presentation</vt:lpstr>
      <vt:lpstr>Readiness for Change Stages</vt:lpstr>
      <vt:lpstr>PowerPoint Presentation</vt:lpstr>
      <vt:lpstr>PowerPoint Presentation</vt:lpstr>
      <vt:lpstr>PowerPoint Presentation</vt:lpstr>
      <vt:lpstr>Safety Screen</vt:lpstr>
      <vt:lpstr>PowerPoint Presentation</vt:lpstr>
      <vt:lpstr>PowerPoint Presentation</vt:lpstr>
      <vt:lpstr>What intensity?</vt:lpstr>
      <vt:lpstr>PowerPoint Presentation</vt:lpstr>
      <vt:lpstr>Physical Activity for Medical Students</vt:lpstr>
      <vt:lpstr>What can WE do?</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ifestyle Medicine &amp; Medical Student Wellness:  Physical Activity</dc:title>
  <cp:lastModifiedBy>Jonathan Oloughlin</cp:lastModifiedBy>
  <cp:revision>5</cp:revision>
  <dcterms:modified xsi:type="dcterms:W3CDTF">2020-06-19T17:25:36Z</dcterms:modified>
</cp:coreProperties>
</file>